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735763" cy="986948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CC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176" autoAdjust="0"/>
    <p:restoredTop sz="94424" autoAdjust="0"/>
  </p:normalViewPr>
  <p:slideViewPr>
    <p:cSldViewPr>
      <p:cViewPr varScale="1">
        <p:scale>
          <a:sx n="66" d="100"/>
          <a:sy n="66" d="100"/>
        </p:scale>
        <p:origin x="1618" y="5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91E9CBD-4AF3-42BA-84D7-3668DA7B387C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17FDE89-2A0C-4079-9DD0-C2C82A394FD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023935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37796B-2029-4AF4-922A-75417F864A75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F7E6E7-71B8-438F-A6BA-CC52B07FB28C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263732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F8E699-F2C6-43DD-B1F6-E96E316C1B1E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59990D-BAFC-4C5A-83F3-9D27F49257A3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596847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699EB2-B8B5-4797-A7A8-618945800890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F9E308-4962-4F44-9733-0A42759E7C0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46792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B53D7F-5A83-424F-A38A-AC5716EDBC39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A7FA244-395C-4BD5-944D-652F912A460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23570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7C3C8-C309-4C4A-9BFB-93FABFD0C420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27A3BE-D94C-4963-B698-E23BD28A487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488160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27AB36-9DE7-46D8-8283-2A3A0FBED2EA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28EDC5-2AC3-4A47-9841-F3149AAAB50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05303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33A945-A68D-4913-9775-F9CBB6C97959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A25ED3-F34E-4082-9F10-10BFD7B669D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422182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6564B6-BE3B-4C6D-B0C4-27916A6E2595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F5FCA7-FB3C-4055-A2A6-786B3251544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898546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357D34-E47B-436C-B1C1-D4B041839640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CB5689-54FB-4AA8-8376-DCEDCD11DA4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13309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87148F-390E-4034-A69C-5CE6F6E6597F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44C5B75-7AB9-4C94-B471-1A2E30799E3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201548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0A9E75C-DF9F-4010-9271-997F9800F76C}" type="datetimeFigureOut">
              <a:rPr lang="ja-JP" altLang="en-US"/>
              <a:pPr>
                <a:defRPr/>
              </a:pPr>
              <a:t>2016/7/9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E270A9F2-4E9D-4423-85F4-19BAEFA43C3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/>
          <p:cNvGrpSpPr/>
          <p:nvPr/>
        </p:nvGrpSpPr>
        <p:grpSpPr>
          <a:xfrm>
            <a:off x="7224721" y="1859396"/>
            <a:ext cx="1094389" cy="1065489"/>
            <a:chOff x="7629863" y="1859396"/>
            <a:chExt cx="1094389" cy="1065489"/>
          </a:xfrm>
        </p:grpSpPr>
        <p:cxnSp>
          <p:nvCxnSpPr>
            <p:cNvPr id="359" name="直線コネクタ 358"/>
            <p:cNvCxnSpPr/>
            <p:nvPr/>
          </p:nvCxnSpPr>
          <p:spPr>
            <a:xfrm>
              <a:off x="8308224" y="2676218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0" name="テキスト ボックス 88"/>
            <p:cNvSpPr txBox="1">
              <a:spLocks noChangeArrowheads="1"/>
            </p:cNvSpPr>
            <p:nvPr/>
          </p:nvSpPr>
          <p:spPr bwMode="auto">
            <a:xfrm>
              <a:off x="7901960" y="2709441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0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61" name="テキスト ボックス 88"/>
            <p:cNvSpPr txBox="1">
              <a:spLocks noChangeArrowheads="1"/>
            </p:cNvSpPr>
            <p:nvPr/>
          </p:nvSpPr>
          <p:spPr bwMode="auto">
            <a:xfrm>
              <a:off x="8108917" y="2709441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1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62" name="テキスト ボックス 88"/>
            <p:cNvSpPr txBox="1">
              <a:spLocks noChangeArrowheads="1"/>
            </p:cNvSpPr>
            <p:nvPr/>
          </p:nvSpPr>
          <p:spPr bwMode="auto">
            <a:xfrm>
              <a:off x="8326568" y="2709441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2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cxnSp>
          <p:nvCxnSpPr>
            <p:cNvPr id="363" name="直線コネクタ 362"/>
            <p:cNvCxnSpPr/>
            <p:nvPr/>
          </p:nvCxnSpPr>
          <p:spPr>
            <a:xfrm rot="5400000">
              <a:off x="8128248" y="2322203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4" name="テキスト ボックス 88"/>
            <p:cNvSpPr txBox="1">
              <a:spLocks noChangeArrowheads="1"/>
            </p:cNvSpPr>
            <p:nvPr/>
          </p:nvSpPr>
          <p:spPr bwMode="auto">
            <a:xfrm>
              <a:off x="7769807" y="2625469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4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65" name="テキスト ボックス 88"/>
            <p:cNvSpPr txBox="1">
              <a:spLocks noChangeArrowheads="1"/>
            </p:cNvSpPr>
            <p:nvPr/>
          </p:nvSpPr>
          <p:spPr bwMode="auto">
            <a:xfrm>
              <a:off x="7769807" y="2243250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3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66" name="テキスト ボックス 88"/>
            <p:cNvSpPr txBox="1">
              <a:spLocks noChangeArrowheads="1"/>
            </p:cNvSpPr>
            <p:nvPr/>
          </p:nvSpPr>
          <p:spPr bwMode="auto">
            <a:xfrm>
              <a:off x="7769807" y="1859396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2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67" name="フリーフォーム 366"/>
            <p:cNvSpPr/>
            <p:nvPr/>
          </p:nvSpPr>
          <p:spPr>
            <a:xfrm>
              <a:off x="8172570" y="1969082"/>
              <a:ext cx="272716" cy="455987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510339"/>
                <a:gd name="connsiteX1" fmla="*/ 112294 w 272716"/>
                <a:gd name="connsiteY1" fmla="*/ 510339 h 510339"/>
                <a:gd name="connsiteX2" fmla="*/ 0 w 272716"/>
                <a:gd name="connsiteY2" fmla="*/ 2517 h 510339"/>
                <a:gd name="connsiteX0" fmla="*/ 272716 w 272716"/>
                <a:gd name="connsiteY0" fmla="*/ 0 h 475170"/>
                <a:gd name="connsiteX1" fmla="*/ 115491 w 272716"/>
                <a:gd name="connsiteY1" fmla="*/ 475170 h 475170"/>
                <a:gd name="connsiteX2" fmla="*/ 0 w 272716"/>
                <a:gd name="connsiteY2" fmla="*/ 2517 h 475170"/>
                <a:gd name="connsiteX0" fmla="*/ 272716 w 272716"/>
                <a:gd name="connsiteY0" fmla="*/ 0 h 455987"/>
                <a:gd name="connsiteX1" fmla="*/ 115491 w 272716"/>
                <a:gd name="connsiteY1" fmla="*/ 455987 h 455987"/>
                <a:gd name="connsiteX2" fmla="*/ 0 w 272716"/>
                <a:gd name="connsiteY2" fmla="*/ 2517 h 45598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72716" h="455987">
                  <a:moveTo>
                    <a:pt x="272716" y="0"/>
                  </a:moveTo>
                  <a:cubicBezTo>
                    <a:pt x="253109" y="92688"/>
                    <a:pt x="160944" y="455568"/>
                    <a:pt x="115491" y="455987"/>
                  </a:cubicBezTo>
                  <a:cubicBezTo>
                    <a:pt x="70038" y="456406"/>
                    <a:pt x="21389" y="88966"/>
                    <a:pt x="0" y="2517"/>
                  </a:cubicBezTo>
                </a:path>
              </a:pathLst>
            </a:cu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8" name="フリーフォーム 367"/>
            <p:cNvSpPr/>
            <p:nvPr/>
          </p:nvSpPr>
          <p:spPr>
            <a:xfrm>
              <a:off x="8225222" y="1967332"/>
              <a:ext cx="181810" cy="324704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90904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7751 w 187751"/>
                <a:gd name="connsiteY0" fmla="*/ 5560 h 208774"/>
                <a:gd name="connsiteX1" fmla="*/ 86151 w 187751"/>
                <a:gd name="connsiteY1" fmla="*/ 208760 h 208774"/>
                <a:gd name="connsiteX2" fmla="*/ 5941 w 187751"/>
                <a:gd name="connsiteY2" fmla="*/ 16255 h 208774"/>
                <a:gd name="connsiteX3" fmla="*/ 5941 w 187751"/>
                <a:gd name="connsiteY3" fmla="*/ 9112 h 20877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0" fmla="*/ 181810 w 181810"/>
                <a:gd name="connsiteY0" fmla="*/ 0 h 203201"/>
                <a:gd name="connsiteX1" fmla="*/ 80210 w 181810"/>
                <a:gd name="connsiteY1" fmla="*/ 203200 h 203201"/>
                <a:gd name="connsiteX2" fmla="*/ 0 w 181810"/>
                <a:gd name="connsiteY2" fmla="*/ 3551 h 203201"/>
                <a:gd name="connsiteX0" fmla="*/ 181810 w 181810"/>
                <a:gd name="connsiteY0" fmla="*/ 0 h 203221"/>
                <a:gd name="connsiteX1" fmla="*/ 80210 w 181810"/>
                <a:gd name="connsiteY1" fmla="*/ 203200 h 203221"/>
                <a:gd name="connsiteX2" fmla="*/ 0 w 181810"/>
                <a:gd name="connsiteY2" fmla="*/ 3551 h 203221"/>
                <a:gd name="connsiteX0" fmla="*/ 181810 w 181810"/>
                <a:gd name="connsiteY0" fmla="*/ 0 h 324704"/>
                <a:gd name="connsiteX1" fmla="*/ 67421 w 181810"/>
                <a:gd name="connsiteY1" fmla="*/ 324694 h 324704"/>
                <a:gd name="connsiteX2" fmla="*/ 0 w 181810"/>
                <a:gd name="connsiteY2" fmla="*/ 3551 h 32470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1810" h="324704">
                  <a:moveTo>
                    <a:pt x="181810" y="0"/>
                  </a:moveTo>
                  <a:cubicBezTo>
                    <a:pt x="162203" y="92688"/>
                    <a:pt x="102485" y="326483"/>
                    <a:pt x="67421" y="324694"/>
                  </a:cubicBezTo>
                  <a:cubicBezTo>
                    <a:pt x="32357" y="322905"/>
                    <a:pt x="13368" y="36826"/>
                    <a:pt x="0" y="3551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9" name="フリーフォーム 368"/>
            <p:cNvSpPr/>
            <p:nvPr/>
          </p:nvSpPr>
          <p:spPr>
            <a:xfrm>
              <a:off x="8181640" y="1970112"/>
              <a:ext cx="256484" cy="434029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70082"/>
                <a:gd name="connsiteX1" fmla="*/ 106883 w 256484"/>
                <a:gd name="connsiteY1" fmla="*/ 470082 h 470082"/>
                <a:gd name="connsiteX2" fmla="*/ 0 w 256484"/>
                <a:gd name="connsiteY2" fmla="*/ 2517 h 470082"/>
                <a:gd name="connsiteX0" fmla="*/ 256484 w 256484"/>
                <a:gd name="connsiteY0" fmla="*/ 0 h 481988"/>
                <a:gd name="connsiteX1" fmla="*/ 106883 w 256484"/>
                <a:gd name="connsiteY1" fmla="*/ 481988 h 481988"/>
                <a:gd name="connsiteX2" fmla="*/ 0 w 256484"/>
                <a:gd name="connsiteY2" fmla="*/ 2517 h 481988"/>
                <a:gd name="connsiteX0" fmla="*/ 256484 w 256484"/>
                <a:gd name="connsiteY0" fmla="*/ 0 h 453213"/>
                <a:gd name="connsiteX1" fmla="*/ 106883 w 256484"/>
                <a:gd name="connsiteY1" fmla="*/ 453213 h 453213"/>
                <a:gd name="connsiteX2" fmla="*/ 0 w 256484"/>
                <a:gd name="connsiteY2" fmla="*/ 2517 h 453213"/>
                <a:gd name="connsiteX0" fmla="*/ 256484 w 256484"/>
                <a:gd name="connsiteY0" fmla="*/ 0 h 434029"/>
                <a:gd name="connsiteX1" fmla="*/ 106883 w 256484"/>
                <a:gd name="connsiteY1" fmla="*/ 434029 h 434029"/>
                <a:gd name="connsiteX2" fmla="*/ 0 w 256484"/>
                <a:gd name="connsiteY2" fmla="*/ 2517 h 43402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6484" h="434029">
                  <a:moveTo>
                    <a:pt x="256484" y="0"/>
                  </a:moveTo>
                  <a:cubicBezTo>
                    <a:pt x="236877" y="92688"/>
                    <a:pt x="149630" y="433610"/>
                    <a:pt x="106883" y="434029"/>
                  </a:cubicBezTo>
                  <a:cubicBezTo>
                    <a:pt x="64136" y="434449"/>
                    <a:pt x="21389" y="88966"/>
                    <a:pt x="0" y="2517"/>
                  </a:cubicBezTo>
                </a:path>
              </a:pathLst>
            </a:custGeom>
            <a:noFill/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0" name="フリーフォーム 369"/>
            <p:cNvSpPr/>
            <p:nvPr/>
          </p:nvSpPr>
          <p:spPr>
            <a:xfrm>
              <a:off x="8188006" y="1970952"/>
              <a:ext cx="242957" cy="413125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419519"/>
                <a:gd name="connsiteX1" fmla="*/ 101472 w 242957"/>
                <a:gd name="connsiteY1" fmla="*/ 419519 h 419519"/>
                <a:gd name="connsiteX2" fmla="*/ 0 w 242957"/>
                <a:gd name="connsiteY2" fmla="*/ 0 h 419519"/>
                <a:gd name="connsiteX0" fmla="*/ 242957 w 242957"/>
                <a:gd name="connsiteY0" fmla="*/ 189 h 429111"/>
                <a:gd name="connsiteX1" fmla="*/ 101472 w 242957"/>
                <a:gd name="connsiteY1" fmla="*/ 429111 h 429111"/>
                <a:gd name="connsiteX2" fmla="*/ 0 w 242957"/>
                <a:gd name="connsiteY2" fmla="*/ 0 h 429111"/>
                <a:gd name="connsiteX0" fmla="*/ 242957 w 242957"/>
                <a:gd name="connsiteY0" fmla="*/ 189 h 409928"/>
                <a:gd name="connsiteX1" fmla="*/ 101472 w 242957"/>
                <a:gd name="connsiteY1" fmla="*/ 409928 h 409928"/>
                <a:gd name="connsiteX2" fmla="*/ 0 w 242957"/>
                <a:gd name="connsiteY2" fmla="*/ 0 h 409928"/>
                <a:gd name="connsiteX0" fmla="*/ 242957 w 242957"/>
                <a:gd name="connsiteY0" fmla="*/ 189 h 413125"/>
                <a:gd name="connsiteX1" fmla="*/ 101472 w 242957"/>
                <a:gd name="connsiteY1" fmla="*/ 413125 h 413125"/>
                <a:gd name="connsiteX2" fmla="*/ 0 w 242957"/>
                <a:gd name="connsiteY2" fmla="*/ 0 h 41312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42957" h="413125">
                  <a:moveTo>
                    <a:pt x="242957" y="189"/>
                  </a:moveTo>
                  <a:cubicBezTo>
                    <a:pt x="223350" y="92877"/>
                    <a:pt x="141965" y="413156"/>
                    <a:pt x="101472" y="413125"/>
                  </a:cubicBezTo>
                  <a:cubicBezTo>
                    <a:pt x="60979" y="413094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00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1" name="フリーフォーム 370"/>
            <p:cNvSpPr/>
            <p:nvPr/>
          </p:nvSpPr>
          <p:spPr>
            <a:xfrm>
              <a:off x="8197079" y="1971793"/>
              <a:ext cx="224020" cy="396278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405870"/>
                <a:gd name="connsiteX1" fmla="*/ 90158 w 224020"/>
                <a:gd name="connsiteY1" fmla="*/ 405870 h 405870"/>
                <a:gd name="connsiteX2" fmla="*/ 0 w 224020"/>
                <a:gd name="connsiteY2" fmla="*/ 0 h 405870"/>
                <a:gd name="connsiteX0" fmla="*/ 224020 w 224020"/>
                <a:gd name="connsiteY0" fmla="*/ 189 h 383489"/>
                <a:gd name="connsiteX1" fmla="*/ 90158 w 224020"/>
                <a:gd name="connsiteY1" fmla="*/ 383489 h 383489"/>
                <a:gd name="connsiteX2" fmla="*/ 0 w 224020"/>
                <a:gd name="connsiteY2" fmla="*/ 0 h 383489"/>
                <a:gd name="connsiteX0" fmla="*/ 224020 w 224020"/>
                <a:gd name="connsiteY0" fmla="*/ 189 h 396278"/>
                <a:gd name="connsiteX1" fmla="*/ 90158 w 224020"/>
                <a:gd name="connsiteY1" fmla="*/ 396278 h 396278"/>
                <a:gd name="connsiteX2" fmla="*/ 0 w 224020"/>
                <a:gd name="connsiteY2" fmla="*/ 0 h 3962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4020" h="396278">
                  <a:moveTo>
                    <a:pt x="224020" y="189"/>
                  </a:moveTo>
                  <a:cubicBezTo>
                    <a:pt x="204413" y="92877"/>
                    <a:pt x="127495" y="396310"/>
                    <a:pt x="90158" y="396278"/>
                  </a:cubicBezTo>
                  <a:cubicBezTo>
                    <a:pt x="52821" y="396247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2" name="フリーフォーム 371"/>
            <p:cNvSpPr/>
            <p:nvPr/>
          </p:nvSpPr>
          <p:spPr>
            <a:xfrm>
              <a:off x="8209506" y="1970251"/>
              <a:ext cx="206167" cy="359556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264455"/>
                <a:gd name="connsiteX1" fmla="*/ 101472 w 224020"/>
                <a:gd name="connsiteY1" fmla="*/ 264455 h 264455"/>
                <a:gd name="connsiteX2" fmla="*/ 0 w 224020"/>
                <a:gd name="connsiteY2" fmla="*/ 0 h 264455"/>
                <a:gd name="connsiteX0" fmla="*/ 207788 w 207788"/>
                <a:gd name="connsiteY0" fmla="*/ 189 h 264455"/>
                <a:gd name="connsiteX1" fmla="*/ 85240 w 207788"/>
                <a:gd name="connsiteY1" fmla="*/ 264455 h 264455"/>
                <a:gd name="connsiteX2" fmla="*/ 0 w 207788"/>
                <a:gd name="connsiteY2" fmla="*/ 0 h 264455"/>
                <a:gd name="connsiteX0" fmla="*/ 194261 w 194261"/>
                <a:gd name="connsiteY0" fmla="*/ 189 h 264455"/>
                <a:gd name="connsiteX1" fmla="*/ 85240 w 194261"/>
                <a:gd name="connsiteY1" fmla="*/ 264455 h 264455"/>
                <a:gd name="connsiteX2" fmla="*/ 0 w 194261"/>
                <a:gd name="connsiteY2" fmla="*/ 0 h 264455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206167 w 206167"/>
                <a:gd name="connsiteY0" fmla="*/ 189 h 266836"/>
                <a:gd name="connsiteX1" fmla="*/ 90002 w 206167"/>
                <a:gd name="connsiteY1" fmla="*/ 266836 h 266836"/>
                <a:gd name="connsiteX2" fmla="*/ 0 w 206167"/>
                <a:gd name="connsiteY2" fmla="*/ 0 h 266836"/>
                <a:gd name="connsiteX0" fmla="*/ 206167 w 206167"/>
                <a:gd name="connsiteY0" fmla="*/ 189 h 356358"/>
                <a:gd name="connsiteX1" fmla="*/ 80410 w 206167"/>
                <a:gd name="connsiteY1" fmla="*/ 356358 h 356358"/>
                <a:gd name="connsiteX2" fmla="*/ 0 w 206167"/>
                <a:gd name="connsiteY2" fmla="*/ 0 h 356358"/>
                <a:gd name="connsiteX0" fmla="*/ 206167 w 206167"/>
                <a:gd name="connsiteY0" fmla="*/ 189 h 378738"/>
                <a:gd name="connsiteX1" fmla="*/ 77213 w 206167"/>
                <a:gd name="connsiteY1" fmla="*/ 378738 h 378738"/>
                <a:gd name="connsiteX2" fmla="*/ 0 w 206167"/>
                <a:gd name="connsiteY2" fmla="*/ 0 h 378738"/>
                <a:gd name="connsiteX0" fmla="*/ 206167 w 206167"/>
                <a:gd name="connsiteY0" fmla="*/ 189 h 353161"/>
                <a:gd name="connsiteX1" fmla="*/ 80410 w 206167"/>
                <a:gd name="connsiteY1" fmla="*/ 353161 h 353161"/>
                <a:gd name="connsiteX2" fmla="*/ 0 w 206167"/>
                <a:gd name="connsiteY2" fmla="*/ 0 h 353161"/>
                <a:gd name="connsiteX0" fmla="*/ 206167 w 206167"/>
                <a:gd name="connsiteY0" fmla="*/ 189 h 359556"/>
                <a:gd name="connsiteX1" fmla="*/ 80410 w 206167"/>
                <a:gd name="connsiteY1" fmla="*/ 359556 h 359556"/>
                <a:gd name="connsiteX2" fmla="*/ 0 w 206167"/>
                <a:gd name="connsiteY2" fmla="*/ 0 h 35955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6167" h="359556">
                  <a:moveTo>
                    <a:pt x="206167" y="189"/>
                  </a:moveTo>
                  <a:cubicBezTo>
                    <a:pt x="186560" y="92877"/>
                    <a:pt x="114771" y="359587"/>
                    <a:pt x="80410" y="359556"/>
                  </a:cubicBezTo>
                  <a:cubicBezTo>
                    <a:pt x="46049" y="359525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73" name="正方形/長方形 372"/>
            <p:cNvSpPr/>
            <p:nvPr/>
          </p:nvSpPr>
          <p:spPr>
            <a:xfrm>
              <a:off x="8097137" y="1962430"/>
              <a:ext cx="422174" cy="77354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374" name="グループ化 373"/>
            <p:cNvGrpSpPr/>
            <p:nvPr/>
          </p:nvGrpSpPr>
          <p:grpSpPr>
            <a:xfrm>
              <a:off x="7629863" y="2197509"/>
              <a:ext cx="127437" cy="356672"/>
              <a:chOff x="3073698" y="2256656"/>
              <a:chExt cx="127437" cy="356672"/>
            </a:xfrm>
          </p:grpSpPr>
          <p:sp>
            <p:nvSpPr>
              <p:cNvPr id="375" name="Rectangle 4334"/>
              <p:cNvSpPr>
                <a:spLocks noChangeArrowheads="1"/>
              </p:cNvSpPr>
              <p:nvPr/>
            </p:nvSpPr>
            <p:spPr bwMode="auto">
              <a:xfrm rot="16200000">
                <a:off x="3109139" y="2525103"/>
                <a:ext cx="52784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i="1" dirty="0">
                    <a:solidFill>
                      <a:srgbClr val="000000"/>
                    </a:solidFill>
                    <a:latin typeface="Symbol" pitchFamily="18" charset="2"/>
                    <a:cs typeface="Arial" charset="0"/>
                  </a:rPr>
                  <a:t>q</a:t>
                </a:r>
                <a:endParaRPr lang="en-US" altLang="ja-JP" sz="800" b="1" i="1" dirty="0">
                  <a:latin typeface="Symbol" pitchFamily="18" charset="2"/>
                  <a:cs typeface="Arial" charset="0"/>
                </a:endParaRPr>
              </a:p>
            </p:txBody>
          </p:sp>
          <p:sp>
            <p:nvSpPr>
              <p:cNvPr id="376" name="Rectangle 4335"/>
              <p:cNvSpPr>
                <a:spLocks noChangeArrowheads="1"/>
              </p:cNvSpPr>
              <p:nvPr/>
            </p:nvSpPr>
            <p:spPr bwMode="auto">
              <a:xfrm rot="16200000">
                <a:off x="2999046" y="2335079"/>
                <a:ext cx="280512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X 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10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5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</p:grpSp>
        <p:grpSp>
          <p:nvGrpSpPr>
            <p:cNvPr id="377" name="グループ化 376"/>
            <p:cNvGrpSpPr/>
            <p:nvPr/>
          </p:nvGrpSpPr>
          <p:grpSpPr>
            <a:xfrm>
              <a:off x="7766716" y="1947490"/>
              <a:ext cx="123666" cy="856711"/>
              <a:chOff x="3077093" y="1408239"/>
              <a:chExt cx="123666" cy="856711"/>
            </a:xfrm>
          </p:grpSpPr>
          <p:sp>
            <p:nvSpPr>
              <p:cNvPr id="378" name="Rectangle 4337"/>
              <p:cNvSpPr>
                <a:spLocks noChangeArrowheads="1"/>
              </p:cNvSpPr>
              <p:nvPr/>
            </p:nvSpPr>
            <p:spPr bwMode="auto">
              <a:xfrm rot="16200000">
                <a:off x="2922509" y="1986701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(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egcm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2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79" name="Rectangle 4339"/>
              <p:cNvSpPr>
                <a:spLocks noChangeArrowheads="1"/>
              </p:cNvSpPr>
              <p:nvPr/>
            </p:nvSpPr>
            <p:spPr bwMode="auto">
              <a:xfrm rot="16200000">
                <a:off x="2922509" y="1605145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ja-JP" altLang="en-US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　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mole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-1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380" name="Rectangle 4341"/>
              <p:cNvSpPr>
                <a:spLocks noChangeArrowheads="1"/>
              </p:cNvSpPr>
              <p:nvPr/>
            </p:nvSpPr>
            <p:spPr bwMode="auto">
              <a:xfrm rot="16200000">
                <a:off x="3122336" y="1362996"/>
                <a:ext cx="33179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)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381" name="テキスト ボックス 88"/>
            <p:cNvSpPr txBox="1">
              <a:spLocks noChangeArrowheads="1"/>
            </p:cNvSpPr>
            <p:nvPr/>
          </p:nvSpPr>
          <p:spPr bwMode="auto">
            <a:xfrm>
              <a:off x="8106970" y="2490140"/>
              <a:ext cx="4123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(nm)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</p:grpSp>
      <p:grpSp>
        <p:nvGrpSpPr>
          <p:cNvPr id="11" name="グループ化 10"/>
          <p:cNvGrpSpPr/>
          <p:nvPr/>
        </p:nvGrpSpPr>
        <p:grpSpPr>
          <a:xfrm>
            <a:off x="2978807" y="1839217"/>
            <a:ext cx="1094389" cy="1065489"/>
            <a:chOff x="3059832" y="1839217"/>
            <a:chExt cx="1094389" cy="1065489"/>
          </a:xfrm>
        </p:grpSpPr>
        <p:cxnSp>
          <p:nvCxnSpPr>
            <p:cNvPr id="267" name="直線コネクタ 266"/>
            <p:cNvCxnSpPr/>
            <p:nvPr/>
          </p:nvCxnSpPr>
          <p:spPr>
            <a:xfrm>
              <a:off x="3738193" y="2656039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テキスト ボックス 88"/>
            <p:cNvSpPr txBox="1">
              <a:spLocks noChangeArrowheads="1"/>
            </p:cNvSpPr>
            <p:nvPr/>
          </p:nvSpPr>
          <p:spPr bwMode="auto">
            <a:xfrm>
              <a:off x="3331929" y="2689262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0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269" name="テキスト ボックス 88"/>
            <p:cNvSpPr txBox="1">
              <a:spLocks noChangeArrowheads="1"/>
            </p:cNvSpPr>
            <p:nvPr/>
          </p:nvSpPr>
          <p:spPr bwMode="auto">
            <a:xfrm>
              <a:off x="3538886" y="2689262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1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270" name="テキスト ボックス 88"/>
            <p:cNvSpPr txBox="1">
              <a:spLocks noChangeArrowheads="1"/>
            </p:cNvSpPr>
            <p:nvPr/>
          </p:nvSpPr>
          <p:spPr bwMode="auto">
            <a:xfrm>
              <a:off x="3756537" y="2689262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2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cxnSp>
          <p:nvCxnSpPr>
            <p:cNvPr id="271" name="直線コネクタ 270"/>
            <p:cNvCxnSpPr/>
            <p:nvPr/>
          </p:nvCxnSpPr>
          <p:spPr>
            <a:xfrm rot="5400000">
              <a:off x="3558217" y="2302024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2" name="テキスト ボックス 88"/>
            <p:cNvSpPr txBox="1">
              <a:spLocks noChangeArrowheads="1"/>
            </p:cNvSpPr>
            <p:nvPr/>
          </p:nvSpPr>
          <p:spPr bwMode="auto">
            <a:xfrm>
              <a:off x="3199776" y="2605290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4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273" name="テキスト ボックス 88"/>
            <p:cNvSpPr txBox="1">
              <a:spLocks noChangeArrowheads="1"/>
            </p:cNvSpPr>
            <p:nvPr/>
          </p:nvSpPr>
          <p:spPr bwMode="auto">
            <a:xfrm>
              <a:off x="3199776" y="2223071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3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274" name="テキスト ボックス 88"/>
            <p:cNvSpPr txBox="1">
              <a:spLocks noChangeArrowheads="1"/>
            </p:cNvSpPr>
            <p:nvPr/>
          </p:nvSpPr>
          <p:spPr bwMode="auto">
            <a:xfrm>
              <a:off x="3199776" y="1839217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2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4" name="フリーフォーム 3"/>
            <p:cNvSpPr/>
            <p:nvPr/>
          </p:nvSpPr>
          <p:spPr>
            <a:xfrm>
              <a:off x="3602539" y="1948904"/>
              <a:ext cx="272716" cy="510339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510339"/>
                <a:gd name="connsiteX1" fmla="*/ 112294 w 272716"/>
                <a:gd name="connsiteY1" fmla="*/ 510339 h 510339"/>
                <a:gd name="connsiteX2" fmla="*/ 0 w 272716"/>
                <a:gd name="connsiteY2" fmla="*/ 2517 h 51033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72716" h="510339">
                  <a:moveTo>
                    <a:pt x="272716" y="0"/>
                  </a:moveTo>
                  <a:cubicBezTo>
                    <a:pt x="253109" y="92688"/>
                    <a:pt x="157747" y="509920"/>
                    <a:pt x="112294" y="510339"/>
                  </a:cubicBezTo>
                  <a:cubicBezTo>
                    <a:pt x="66841" y="510758"/>
                    <a:pt x="21389" y="88966"/>
                    <a:pt x="0" y="2517"/>
                  </a:cubicBezTo>
                </a:path>
              </a:pathLst>
            </a:cu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6" name="フリーフォーム 275"/>
            <p:cNvSpPr/>
            <p:nvPr/>
          </p:nvSpPr>
          <p:spPr>
            <a:xfrm>
              <a:off x="3655191" y="1947152"/>
              <a:ext cx="181810" cy="203221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90904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7751 w 187751"/>
                <a:gd name="connsiteY0" fmla="*/ 5560 h 208774"/>
                <a:gd name="connsiteX1" fmla="*/ 86151 w 187751"/>
                <a:gd name="connsiteY1" fmla="*/ 208760 h 208774"/>
                <a:gd name="connsiteX2" fmla="*/ 5941 w 187751"/>
                <a:gd name="connsiteY2" fmla="*/ 16255 h 208774"/>
                <a:gd name="connsiteX3" fmla="*/ 5941 w 187751"/>
                <a:gd name="connsiteY3" fmla="*/ 9112 h 20877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0" fmla="*/ 181810 w 181810"/>
                <a:gd name="connsiteY0" fmla="*/ 0 h 203201"/>
                <a:gd name="connsiteX1" fmla="*/ 80210 w 181810"/>
                <a:gd name="connsiteY1" fmla="*/ 203200 h 203201"/>
                <a:gd name="connsiteX2" fmla="*/ 0 w 181810"/>
                <a:gd name="connsiteY2" fmla="*/ 3551 h 203201"/>
                <a:gd name="connsiteX0" fmla="*/ 181810 w 181810"/>
                <a:gd name="connsiteY0" fmla="*/ 0 h 203221"/>
                <a:gd name="connsiteX1" fmla="*/ 80210 w 181810"/>
                <a:gd name="connsiteY1" fmla="*/ 203200 h 203221"/>
                <a:gd name="connsiteX2" fmla="*/ 0 w 181810"/>
                <a:gd name="connsiteY2" fmla="*/ 3551 h 2032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1810" h="203221">
                  <a:moveTo>
                    <a:pt x="181810" y="0"/>
                  </a:moveTo>
                  <a:cubicBezTo>
                    <a:pt x="162203" y="92688"/>
                    <a:pt x="115274" y="204989"/>
                    <a:pt x="80210" y="203200"/>
                  </a:cubicBezTo>
                  <a:cubicBezTo>
                    <a:pt x="45146" y="201411"/>
                    <a:pt x="13368" y="36826"/>
                    <a:pt x="0" y="3551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7" name="フリーフォーム 276"/>
            <p:cNvSpPr/>
            <p:nvPr/>
          </p:nvSpPr>
          <p:spPr>
            <a:xfrm>
              <a:off x="3611609" y="1949934"/>
              <a:ext cx="256484" cy="481988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70082"/>
                <a:gd name="connsiteX1" fmla="*/ 106883 w 256484"/>
                <a:gd name="connsiteY1" fmla="*/ 470082 h 470082"/>
                <a:gd name="connsiteX2" fmla="*/ 0 w 256484"/>
                <a:gd name="connsiteY2" fmla="*/ 2517 h 470082"/>
                <a:gd name="connsiteX0" fmla="*/ 256484 w 256484"/>
                <a:gd name="connsiteY0" fmla="*/ 0 h 481988"/>
                <a:gd name="connsiteX1" fmla="*/ 106883 w 256484"/>
                <a:gd name="connsiteY1" fmla="*/ 481988 h 481988"/>
                <a:gd name="connsiteX2" fmla="*/ 0 w 256484"/>
                <a:gd name="connsiteY2" fmla="*/ 2517 h 4819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6484" h="481988">
                  <a:moveTo>
                    <a:pt x="256484" y="0"/>
                  </a:moveTo>
                  <a:cubicBezTo>
                    <a:pt x="236877" y="92688"/>
                    <a:pt x="149630" y="481569"/>
                    <a:pt x="106883" y="481988"/>
                  </a:cubicBezTo>
                  <a:cubicBezTo>
                    <a:pt x="64136" y="482408"/>
                    <a:pt x="21389" y="88966"/>
                    <a:pt x="0" y="2517"/>
                  </a:cubicBezTo>
                </a:path>
              </a:pathLst>
            </a:custGeom>
            <a:noFill/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8" name="フリーフォーム 277"/>
            <p:cNvSpPr/>
            <p:nvPr/>
          </p:nvSpPr>
          <p:spPr>
            <a:xfrm>
              <a:off x="3617975" y="1950773"/>
              <a:ext cx="242957" cy="419519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419519"/>
                <a:gd name="connsiteX1" fmla="*/ 101472 w 242957"/>
                <a:gd name="connsiteY1" fmla="*/ 419519 h 419519"/>
                <a:gd name="connsiteX2" fmla="*/ 0 w 242957"/>
                <a:gd name="connsiteY2" fmla="*/ 0 h 4195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42957" h="419519">
                  <a:moveTo>
                    <a:pt x="242957" y="189"/>
                  </a:moveTo>
                  <a:cubicBezTo>
                    <a:pt x="223350" y="92877"/>
                    <a:pt x="141965" y="419550"/>
                    <a:pt x="101472" y="419519"/>
                  </a:cubicBezTo>
                  <a:cubicBezTo>
                    <a:pt x="60979" y="419488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00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9" name="フリーフォーム 278"/>
            <p:cNvSpPr/>
            <p:nvPr/>
          </p:nvSpPr>
          <p:spPr>
            <a:xfrm>
              <a:off x="3627048" y="1951614"/>
              <a:ext cx="224020" cy="348320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4020" h="348320">
                  <a:moveTo>
                    <a:pt x="224020" y="189"/>
                  </a:moveTo>
                  <a:cubicBezTo>
                    <a:pt x="204413" y="92877"/>
                    <a:pt x="130693" y="348352"/>
                    <a:pt x="93356" y="348320"/>
                  </a:cubicBezTo>
                  <a:cubicBezTo>
                    <a:pt x="56019" y="348289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80" name="フリーフォーム 279"/>
            <p:cNvSpPr/>
            <p:nvPr/>
          </p:nvSpPr>
          <p:spPr>
            <a:xfrm>
              <a:off x="3639475" y="1950072"/>
              <a:ext cx="206167" cy="266836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264455"/>
                <a:gd name="connsiteX1" fmla="*/ 101472 w 224020"/>
                <a:gd name="connsiteY1" fmla="*/ 264455 h 264455"/>
                <a:gd name="connsiteX2" fmla="*/ 0 w 224020"/>
                <a:gd name="connsiteY2" fmla="*/ 0 h 264455"/>
                <a:gd name="connsiteX0" fmla="*/ 207788 w 207788"/>
                <a:gd name="connsiteY0" fmla="*/ 189 h 264455"/>
                <a:gd name="connsiteX1" fmla="*/ 85240 w 207788"/>
                <a:gd name="connsiteY1" fmla="*/ 264455 h 264455"/>
                <a:gd name="connsiteX2" fmla="*/ 0 w 207788"/>
                <a:gd name="connsiteY2" fmla="*/ 0 h 264455"/>
                <a:gd name="connsiteX0" fmla="*/ 194261 w 194261"/>
                <a:gd name="connsiteY0" fmla="*/ 189 h 264455"/>
                <a:gd name="connsiteX1" fmla="*/ 85240 w 194261"/>
                <a:gd name="connsiteY1" fmla="*/ 264455 h 264455"/>
                <a:gd name="connsiteX2" fmla="*/ 0 w 194261"/>
                <a:gd name="connsiteY2" fmla="*/ 0 h 264455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206167 w 206167"/>
                <a:gd name="connsiteY0" fmla="*/ 189 h 266836"/>
                <a:gd name="connsiteX1" fmla="*/ 90002 w 206167"/>
                <a:gd name="connsiteY1" fmla="*/ 266836 h 266836"/>
                <a:gd name="connsiteX2" fmla="*/ 0 w 206167"/>
                <a:gd name="connsiteY2" fmla="*/ 0 h 2668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06167" h="266836">
                  <a:moveTo>
                    <a:pt x="206167" y="189"/>
                  </a:moveTo>
                  <a:cubicBezTo>
                    <a:pt x="186560" y="92877"/>
                    <a:pt x="124363" y="266867"/>
                    <a:pt x="90002" y="266836"/>
                  </a:cubicBezTo>
                  <a:cubicBezTo>
                    <a:pt x="55641" y="266805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6" name="正方形/長方形 265"/>
            <p:cNvSpPr/>
            <p:nvPr/>
          </p:nvSpPr>
          <p:spPr>
            <a:xfrm>
              <a:off x="3527106" y="1942251"/>
              <a:ext cx="422174" cy="77354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5" name="グループ化 4"/>
            <p:cNvGrpSpPr/>
            <p:nvPr/>
          </p:nvGrpSpPr>
          <p:grpSpPr>
            <a:xfrm>
              <a:off x="3059832" y="2177330"/>
              <a:ext cx="127437" cy="356672"/>
              <a:chOff x="3073698" y="2256656"/>
              <a:chExt cx="127437" cy="356672"/>
            </a:xfrm>
          </p:grpSpPr>
          <p:sp>
            <p:nvSpPr>
              <p:cNvPr id="282" name="Rectangle 4334"/>
              <p:cNvSpPr>
                <a:spLocks noChangeArrowheads="1"/>
              </p:cNvSpPr>
              <p:nvPr/>
            </p:nvSpPr>
            <p:spPr bwMode="auto">
              <a:xfrm rot="16200000">
                <a:off x="3109139" y="2525103"/>
                <a:ext cx="52784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i="1" dirty="0">
                    <a:solidFill>
                      <a:srgbClr val="000000"/>
                    </a:solidFill>
                    <a:latin typeface="Symbol" pitchFamily="18" charset="2"/>
                    <a:cs typeface="Arial" charset="0"/>
                  </a:rPr>
                  <a:t>q</a:t>
                </a:r>
                <a:endParaRPr lang="en-US" altLang="ja-JP" sz="800" b="1" i="1" dirty="0">
                  <a:latin typeface="Symbol" pitchFamily="18" charset="2"/>
                  <a:cs typeface="Arial" charset="0"/>
                </a:endParaRPr>
              </a:p>
            </p:txBody>
          </p:sp>
          <p:sp>
            <p:nvSpPr>
              <p:cNvPr id="283" name="Rectangle 4335"/>
              <p:cNvSpPr>
                <a:spLocks noChangeArrowheads="1"/>
              </p:cNvSpPr>
              <p:nvPr/>
            </p:nvSpPr>
            <p:spPr bwMode="auto">
              <a:xfrm rot="16200000">
                <a:off x="2999046" y="2335079"/>
                <a:ext cx="280512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X 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10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5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</p:grpSp>
        <p:grpSp>
          <p:nvGrpSpPr>
            <p:cNvPr id="6" name="グループ化 5"/>
            <p:cNvGrpSpPr/>
            <p:nvPr/>
          </p:nvGrpSpPr>
          <p:grpSpPr>
            <a:xfrm>
              <a:off x="3196685" y="1927311"/>
              <a:ext cx="123666" cy="856711"/>
              <a:chOff x="3077093" y="1408239"/>
              <a:chExt cx="123666" cy="856711"/>
            </a:xfrm>
          </p:grpSpPr>
          <p:sp>
            <p:nvSpPr>
              <p:cNvPr id="285" name="Rectangle 4337"/>
              <p:cNvSpPr>
                <a:spLocks noChangeArrowheads="1"/>
              </p:cNvSpPr>
              <p:nvPr/>
            </p:nvSpPr>
            <p:spPr bwMode="auto">
              <a:xfrm rot="16200000">
                <a:off x="2922509" y="1986701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(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egcm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2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87" name="Rectangle 4339"/>
              <p:cNvSpPr>
                <a:spLocks noChangeArrowheads="1"/>
              </p:cNvSpPr>
              <p:nvPr/>
            </p:nvSpPr>
            <p:spPr bwMode="auto">
              <a:xfrm rot="16200000">
                <a:off x="2922509" y="1605145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ja-JP" altLang="en-US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　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mole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-1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89" name="Rectangle 4341"/>
              <p:cNvSpPr>
                <a:spLocks noChangeArrowheads="1"/>
              </p:cNvSpPr>
              <p:nvPr/>
            </p:nvSpPr>
            <p:spPr bwMode="auto">
              <a:xfrm rot="16200000">
                <a:off x="3122336" y="1362996"/>
                <a:ext cx="33179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)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293" name="テキスト ボックス 88"/>
            <p:cNvSpPr txBox="1">
              <a:spLocks noChangeArrowheads="1"/>
            </p:cNvSpPr>
            <p:nvPr/>
          </p:nvSpPr>
          <p:spPr bwMode="auto">
            <a:xfrm>
              <a:off x="3536939" y="2469961"/>
              <a:ext cx="4123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(nm)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</p:grpSp>
      <p:sp>
        <p:nvSpPr>
          <p:cNvPr id="441" name="Rectangle 54"/>
          <p:cNvSpPr>
            <a:spLocks noChangeArrowheads="1"/>
          </p:cNvSpPr>
          <p:nvPr/>
        </p:nvSpPr>
        <p:spPr bwMode="auto">
          <a:xfrm>
            <a:off x="8467902" y="54236"/>
            <a:ext cx="64793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  <a:endParaRPr lang="en-US" altLang="ja-JP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6" name="テキスト ボックス 88"/>
          <p:cNvSpPr txBox="1">
            <a:spLocks noChangeArrowheads="1"/>
          </p:cNvSpPr>
          <p:nvPr/>
        </p:nvSpPr>
        <p:spPr bwMode="auto">
          <a:xfrm>
            <a:off x="1181207" y="3601630"/>
            <a:ext cx="28787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 smtClean="0">
                <a:latin typeface="Arial" charset="0"/>
                <a:cs typeface="Arial" charset="0"/>
              </a:rPr>
              <a:t>CD spectra of </a:t>
            </a:r>
            <a:r>
              <a:rPr lang="en-US" altLang="ja-JP" sz="1200" b="1" dirty="0" err="1" smtClean="0">
                <a:latin typeface="Arial" charset="0"/>
                <a:cs typeface="Arial" charset="0"/>
              </a:rPr>
              <a:t>RpoE</a:t>
            </a:r>
            <a:r>
              <a:rPr lang="en-US" altLang="ja-JP" sz="1200" b="1" dirty="0" smtClean="0">
                <a:latin typeface="Arial" charset="0"/>
                <a:cs typeface="Arial" charset="0"/>
              </a:rPr>
              <a:t> WT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sp>
        <p:nvSpPr>
          <p:cNvPr id="686" name="テキスト ボックス 88"/>
          <p:cNvSpPr txBox="1">
            <a:spLocks noChangeArrowheads="1"/>
          </p:cNvSpPr>
          <p:nvPr/>
        </p:nvSpPr>
        <p:spPr bwMode="auto">
          <a:xfrm>
            <a:off x="5418704" y="3601630"/>
            <a:ext cx="28787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 smtClean="0">
                <a:latin typeface="Arial" charset="0"/>
                <a:cs typeface="Arial" charset="0"/>
              </a:rPr>
              <a:t>CD spectra of </a:t>
            </a:r>
            <a:r>
              <a:rPr lang="en-US" altLang="ja-JP" sz="1200" b="1" dirty="0" err="1" smtClean="0">
                <a:latin typeface="Arial" charset="0"/>
                <a:cs typeface="Arial" charset="0"/>
              </a:rPr>
              <a:t>RpoE</a:t>
            </a:r>
            <a:r>
              <a:rPr lang="en-US" altLang="ja-JP" sz="1200" b="1" dirty="0" smtClean="0">
                <a:latin typeface="Arial" charset="0"/>
                <a:cs typeface="Arial" charset="0"/>
              </a:rPr>
              <a:t> -20 (</a:t>
            </a:r>
            <a:r>
              <a:rPr lang="en-US" altLang="ja-JP" sz="1200" b="1" dirty="0" smtClean="0">
                <a:latin typeface="Symbol" panose="05050102010706020507" pitchFamily="18" charset="2"/>
                <a:cs typeface="Arial" charset="0"/>
              </a:rPr>
              <a:t>D</a:t>
            </a:r>
            <a:r>
              <a:rPr lang="en-US" altLang="ja-JP" sz="1200" b="1" dirty="0" smtClean="0">
                <a:latin typeface="Arial" charset="0"/>
                <a:cs typeface="Arial" charset="0"/>
              </a:rPr>
              <a:t>U)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sp>
        <p:nvSpPr>
          <p:cNvPr id="687" name="Text Box 2208"/>
          <p:cNvSpPr txBox="1">
            <a:spLocks noChangeArrowheads="1"/>
          </p:cNvSpPr>
          <p:nvPr/>
        </p:nvSpPr>
        <p:spPr bwMode="auto">
          <a:xfrm>
            <a:off x="821279" y="3619174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Arial" charset="0"/>
                <a:cs typeface="Arial" charset="0"/>
              </a:rPr>
              <a:t>C</a:t>
            </a:r>
          </a:p>
        </p:txBody>
      </p:sp>
      <p:sp>
        <p:nvSpPr>
          <p:cNvPr id="688" name="Text Box 2208"/>
          <p:cNvSpPr txBox="1">
            <a:spLocks noChangeArrowheads="1"/>
          </p:cNvSpPr>
          <p:nvPr/>
        </p:nvSpPr>
        <p:spPr bwMode="auto">
          <a:xfrm>
            <a:off x="5076056" y="3622030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1" dirty="0" smtClean="0">
                <a:latin typeface="Arial" charset="0"/>
                <a:cs typeface="Arial" charset="0"/>
              </a:rPr>
              <a:t>D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cxnSp>
        <p:nvCxnSpPr>
          <p:cNvPr id="820" name="直線コネクタ 819"/>
          <p:cNvCxnSpPr/>
          <p:nvPr/>
        </p:nvCxnSpPr>
        <p:spPr>
          <a:xfrm>
            <a:off x="1569086" y="287217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1" name="直線コネクタ 820"/>
          <p:cNvCxnSpPr/>
          <p:nvPr/>
        </p:nvCxnSpPr>
        <p:spPr>
          <a:xfrm>
            <a:off x="2138972" y="287217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2" name="直線コネクタ 821"/>
          <p:cNvCxnSpPr/>
          <p:nvPr/>
        </p:nvCxnSpPr>
        <p:spPr>
          <a:xfrm>
            <a:off x="2708858" y="287217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3" name="直線コネクタ 822"/>
          <p:cNvCxnSpPr/>
          <p:nvPr/>
        </p:nvCxnSpPr>
        <p:spPr>
          <a:xfrm>
            <a:off x="3284922" y="287217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4" name="直線コネクタ 823"/>
          <p:cNvCxnSpPr/>
          <p:nvPr/>
        </p:nvCxnSpPr>
        <p:spPr>
          <a:xfrm>
            <a:off x="3860986" y="287217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5" name="直線コネクタ 824"/>
          <p:cNvCxnSpPr/>
          <p:nvPr/>
        </p:nvCxnSpPr>
        <p:spPr>
          <a:xfrm rot="5400000">
            <a:off x="1016666" y="1293684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6" name="直線コネクタ 825"/>
          <p:cNvCxnSpPr/>
          <p:nvPr/>
        </p:nvCxnSpPr>
        <p:spPr>
          <a:xfrm rot="5400000">
            <a:off x="1016666" y="1022278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7" name="直線コネクタ 826"/>
          <p:cNvCxnSpPr/>
          <p:nvPr/>
        </p:nvCxnSpPr>
        <p:spPr>
          <a:xfrm rot="5400000">
            <a:off x="1016666" y="1565128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8" name="直線コネクタ 827"/>
          <p:cNvCxnSpPr/>
          <p:nvPr/>
        </p:nvCxnSpPr>
        <p:spPr>
          <a:xfrm rot="5400000">
            <a:off x="1016666" y="2645210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9" name="直線コネクタ 828"/>
          <p:cNvCxnSpPr/>
          <p:nvPr/>
        </p:nvCxnSpPr>
        <p:spPr>
          <a:xfrm>
            <a:off x="982310" y="1872534"/>
            <a:ext cx="3454740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1" name="Rectangle 4334"/>
          <p:cNvSpPr>
            <a:spLocks noChangeArrowheads="1"/>
          </p:cNvSpPr>
          <p:nvPr/>
        </p:nvSpPr>
        <p:spPr bwMode="auto">
          <a:xfrm rot="16200000">
            <a:off x="560004" y="2550080"/>
            <a:ext cx="63341" cy="146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i="1" dirty="0">
                <a:solidFill>
                  <a:srgbClr val="000000"/>
                </a:solidFill>
                <a:latin typeface="Symbol" pitchFamily="18" charset="2"/>
                <a:cs typeface="Arial" charset="0"/>
              </a:rPr>
              <a:t>q</a:t>
            </a:r>
            <a:endParaRPr lang="en-US" altLang="ja-JP" b="1" i="1" dirty="0">
              <a:latin typeface="Symbol" pitchFamily="18" charset="2"/>
              <a:cs typeface="Arial" charset="0"/>
            </a:endParaRPr>
          </a:p>
        </p:txBody>
      </p:sp>
      <p:sp>
        <p:nvSpPr>
          <p:cNvPr id="832" name="Rectangle 4335"/>
          <p:cNvSpPr>
            <a:spLocks noChangeArrowheads="1"/>
          </p:cNvSpPr>
          <p:nvPr/>
        </p:nvSpPr>
        <p:spPr bwMode="auto">
          <a:xfrm rot="16200000">
            <a:off x="418994" y="2314933"/>
            <a:ext cx="345360" cy="153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X 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10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5</a:t>
            </a:r>
            <a:endParaRPr lang="en-US" altLang="ja-JP" b="1" baseline="30000" dirty="0">
              <a:latin typeface="Arial" charset="0"/>
              <a:cs typeface="Arial" charset="0"/>
            </a:endParaRPr>
          </a:p>
        </p:txBody>
      </p:sp>
      <p:sp>
        <p:nvSpPr>
          <p:cNvPr id="834" name="Rectangle 4337"/>
          <p:cNvSpPr>
            <a:spLocks noChangeArrowheads="1"/>
          </p:cNvSpPr>
          <p:nvPr/>
        </p:nvSpPr>
        <p:spPr bwMode="auto">
          <a:xfrm rot="16200000">
            <a:off x="56272" y="1599041"/>
            <a:ext cx="10708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(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degcm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2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 dmole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-1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)</a:t>
            </a:r>
            <a:endParaRPr lang="en-US" altLang="ja-JP" b="1" dirty="0">
              <a:latin typeface="Arial" charset="0"/>
              <a:cs typeface="Arial" charset="0"/>
            </a:endParaRPr>
          </a:p>
        </p:txBody>
      </p:sp>
      <p:sp>
        <p:nvSpPr>
          <p:cNvPr id="839" name="テキスト ボックス 88"/>
          <p:cNvSpPr txBox="1">
            <a:spLocks noChangeArrowheads="1"/>
          </p:cNvSpPr>
          <p:nvPr/>
        </p:nvSpPr>
        <p:spPr bwMode="auto">
          <a:xfrm>
            <a:off x="649804" y="669899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0" name="テキスト ボックス 88"/>
          <p:cNvSpPr txBox="1">
            <a:spLocks noChangeArrowheads="1"/>
          </p:cNvSpPr>
          <p:nvPr/>
        </p:nvSpPr>
        <p:spPr bwMode="auto">
          <a:xfrm>
            <a:off x="649804" y="936430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841" name="テキスト ボックス 88"/>
          <p:cNvSpPr txBox="1">
            <a:spLocks noChangeArrowheads="1"/>
          </p:cNvSpPr>
          <p:nvPr/>
        </p:nvSpPr>
        <p:spPr bwMode="auto">
          <a:xfrm>
            <a:off x="649804" y="1213378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2" name="テキスト ボックス 88"/>
          <p:cNvSpPr txBox="1">
            <a:spLocks noChangeArrowheads="1"/>
          </p:cNvSpPr>
          <p:nvPr/>
        </p:nvSpPr>
        <p:spPr bwMode="auto">
          <a:xfrm>
            <a:off x="649804" y="1745106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3" name="テキスト ボックス 88"/>
          <p:cNvSpPr txBox="1">
            <a:spLocks noChangeArrowheads="1"/>
          </p:cNvSpPr>
          <p:nvPr/>
        </p:nvSpPr>
        <p:spPr bwMode="auto">
          <a:xfrm>
            <a:off x="649804" y="2027596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2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4" name="テキスト ボックス 88"/>
          <p:cNvSpPr txBox="1">
            <a:spLocks noChangeArrowheads="1"/>
          </p:cNvSpPr>
          <p:nvPr/>
        </p:nvSpPr>
        <p:spPr bwMode="auto">
          <a:xfrm>
            <a:off x="649804" y="1479242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845" name="テキスト ボックス 88"/>
          <p:cNvSpPr txBox="1">
            <a:spLocks noChangeArrowheads="1"/>
          </p:cNvSpPr>
          <p:nvPr/>
        </p:nvSpPr>
        <p:spPr bwMode="auto">
          <a:xfrm>
            <a:off x="620626" y="2296515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6" name="テキスト ボックス 88"/>
          <p:cNvSpPr txBox="1">
            <a:spLocks noChangeArrowheads="1"/>
          </p:cNvSpPr>
          <p:nvPr/>
        </p:nvSpPr>
        <p:spPr bwMode="auto">
          <a:xfrm>
            <a:off x="781493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7" name="テキスト ボックス 88"/>
          <p:cNvSpPr txBox="1">
            <a:spLocks noChangeArrowheads="1"/>
          </p:cNvSpPr>
          <p:nvPr/>
        </p:nvSpPr>
        <p:spPr bwMode="auto">
          <a:xfrm>
            <a:off x="1375070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8" name="テキスト ボックス 88"/>
          <p:cNvSpPr txBox="1">
            <a:spLocks noChangeArrowheads="1"/>
          </p:cNvSpPr>
          <p:nvPr/>
        </p:nvSpPr>
        <p:spPr bwMode="auto">
          <a:xfrm>
            <a:off x="1942817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4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49" name="テキスト ボックス 88"/>
          <p:cNvSpPr txBox="1">
            <a:spLocks noChangeArrowheads="1"/>
          </p:cNvSpPr>
          <p:nvPr/>
        </p:nvSpPr>
        <p:spPr bwMode="auto">
          <a:xfrm>
            <a:off x="2510564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6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50" name="テキスト ボックス 88"/>
          <p:cNvSpPr txBox="1">
            <a:spLocks noChangeArrowheads="1"/>
          </p:cNvSpPr>
          <p:nvPr/>
        </p:nvSpPr>
        <p:spPr bwMode="auto">
          <a:xfrm>
            <a:off x="3089562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8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51" name="テキスト ボックス 88"/>
          <p:cNvSpPr txBox="1">
            <a:spLocks noChangeArrowheads="1"/>
          </p:cNvSpPr>
          <p:nvPr/>
        </p:nvSpPr>
        <p:spPr bwMode="auto">
          <a:xfrm>
            <a:off x="3660460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3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52" name="テキスト ボックス 88"/>
          <p:cNvSpPr txBox="1">
            <a:spLocks noChangeArrowheads="1"/>
          </p:cNvSpPr>
          <p:nvPr/>
        </p:nvSpPr>
        <p:spPr bwMode="auto">
          <a:xfrm>
            <a:off x="4241690" y="2959023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3</a:t>
            </a:r>
            <a:r>
              <a:rPr lang="en-US" altLang="ja-JP" sz="1000" b="1" dirty="0" smtClean="0">
                <a:latin typeface="Arial" charset="0"/>
                <a:cs typeface="Arial" charset="0"/>
              </a:rPr>
              <a:t>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853" name="テキスト ボックス 88"/>
          <p:cNvSpPr txBox="1">
            <a:spLocks noChangeArrowheads="1"/>
          </p:cNvSpPr>
          <p:nvPr/>
        </p:nvSpPr>
        <p:spPr bwMode="auto">
          <a:xfrm>
            <a:off x="1911604" y="3210784"/>
            <a:ext cx="159967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100" b="1" dirty="0" smtClean="0">
                <a:latin typeface="Arial" charset="0"/>
                <a:cs typeface="Arial" charset="0"/>
              </a:rPr>
              <a:t>Wavelength (nm)</a:t>
            </a:r>
            <a:endParaRPr lang="en-US" altLang="ja-JP" sz="1100" b="1" dirty="0">
              <a:latin typeface="Arial" charset="0"/>
              <a:cs typeface="Arial" charset="0"/>
            </a:endParaRPr>
          </a:p>
        </p:txBody>
      </p:sp>
      <p:sp>
        <p:nvSpPr>
          <p:cNvPr id="854" name="テキスト ボックス 88"/>
          <p:cNvSpPr txBox="1">
            <a:spLocks noChangeArrowheads="1"/>
          </p:cNvSpPr>
          <p:nvPr/>
        </p:nvSpPr>
        <p:spPr bwMode="auto">
          <a:xfrm>
            <a:off x="3716970" y="878552"/>
            <a:ext cx="66087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Arial" charset="0"/>
                <a:cs typeface="Arial" charset="0"/>
              </a:rPr>
              <a:t>42 </a:t>
            </a:r>
            <a:r>
              <a:rPr lang="en-US" altLang="ja-JP" sz="1400" b="1" baseline="30000" dirty="0" err="1" smtClean="0">
                <a:latin typeface="Arial" charset="0"/>
                <a:cs typeface="Arial" charset="0"/>
              </a:rPr>
              <a:t>o</a:t>
            </a:r>
            <a:r>
              <a:rPr lang="en-US" altLang="ja-JP" sz="1400" b="1" dirty="0" err="1" smtClean="0">
                <a:latin typeface="Arial" charset="0"/>
                <a:cs typeface="Arial" charset="0"/>
              </a:rPr>
              <a:t>C</a:t>
            </a:r>
            <a:endParaRPr lang="en-US" altLang="ja-JP" sz="1400" b="1" dirty="0">
              <a:latin typeface="Arial" charset="0"/>
              <a:cs typeface="Arial" charset="0"/>
            </a:endParaRPr>
          </a:p>
        </p:txBody>
      </p:sp>
      <p:sp>
        <p:nvSpPr>
          <p:cNvPr id="855" name="テキスト ボックス 88"/>
          <p:cNvSpPr txBox="1">
            <a:spLocks noChangeArrowheads="1"/>
          </p:cNvSpPr>
          <p:nvPr/>
        </p:nvSpPr>
        <p:spPr bwMode="auto">
          <a:xfrm>
            <a:off x="1179396" y="260648"/>
            <a:ext cx="28787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 smtClean="0">
                <a:latin typeface="Arial" charset="0"/>
                <a:cs typeface="Arial" charset="0"/>
              </a:rPr>
              <a:t>CD spectra of </a:t>
            </a:r>
            <a:r>
              <a:rPr lang="en-US" altLang="ja-JP" sz="1200" b="1" dirty="0" err="1" smtClean="0">
                <a:latin typeface="Arial" charset="0"/>
                <a:cs typeface="Arial" charset="0"/>
              </a:rPr>
              <a:t>OppA</a:t>
            </a:r>
            <a:r>
              <a:rPr lang="en-US" altLang="ja-JP" sz="1200" b="1" dirty="0" smtClean="0">
                <a:latin typeface="Arial" charset="0"/>
                <a:cs typeface="Arial" charset="0"/>
              </a:rPr>
              <a:t> WT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sp>
        <p:nvSpPr>
          <p:cNvPr id="892" name="テキスト ボックス 88"/>
          <p:cNvSpPr txBox="1">
            <a:spLocks noChangeArrowheads="1"/>
          </p:cNvSpPr>
          <p:nvPr/>
        </p:nvSpPr>
        <p:spPr bwMode="auto">
          <a:xfrm>
            <a:off x="5416893" y="260648"/>
            <a:ext cx="287874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200" b="1" dirty="0" smtClean="0">
                <a:latin typeface="Arial" charset="0"/>
                <a:cs typeface="Arial" charset="0"/>
              </a:rPr>
              <a:t>CD spectra of </a:t>
            </a:r>
            <a:r>
              <a:rPr lang="en-US" altLang="ja-JP" sz="1200" b="1" dirty="0" err="1" smtClean="0">
                <a:latin typeface="Arial" charset="0"/>
                <a:cs typeface="Arial" charset="0"/>
              </a:rPr>
              <a:t>OppA</a:t>
            </a:r>
            <a:r>
              <a:rPr lang="en-US" altLang="ja-JP" sz="1200" b="1" dirty="0" smtClean="0">
                <a:latin typeface="Arial" charset="0"/>
                <a:cs typeface="Arial" charset="0"/>
              </a:rPr>
              <a:t> +U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sp>
        <p:nvSpPr>
          <p:cNvPr id="893" name="Text Box 2208"/>
          <p:cNvSpPr txBox="1">
            <a:spLocks noChangeArrowheads="1"/>
          </p:cNvSpPr>
          <p:nvPr/>
        </p:nvSpPr>
        <p:spPr bwMode="auto">
          <a:xfrm>
            <a:off x="819468" y="278192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1" dirty="0" smtClean="0">
                <a:latin typeface="Arial" charset="0"/>
                <a:cs typeface="Arial" charset="0"/>
              </a:rPr>
              <a:t>A</a:t>
            </a:r>
            <a:endParaRPr lang="en-US" altLang="ja-JP" sz="1200" b="1" dirty="0">
              <a:latin typeface="Arial" charset="0"/>
              <a:cs typeface="Arial" charset="0"/>
            </a:endParaRPr>
          </a:p>
        </p:txBody>
      </p:sp>
      <p:sp>
        <p:nvSpPr>
          <p:cNvPr id="894" name="Text Box 2208"/>
          <p:cNvSpPr txBox="1">
            <a:spLocks noChangeArrowheads="1"/>
          </p:cNvSpPr>
          <p:nvPr/>
        </p:nvSpPr>
        <p:spPr bwMode="auto">
          <a:xfrm>
            <a:off x="5074245" y="281048"/>
            <a:ext cx="29527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200" b="1" dirty="0">
                <a:latin typeface="Arial" charset="0"/>
                <a:cs typeface="Arial" charset="0"/>
              </a:rPr>
              <a:t>B</a:t>
            </a:r>
          </a:p>
        </p:txBody>
      </p:sp>
      <p:grpSp>
        <p:nvGrpSpPr>
          <p:cNvPr id="898" name="グループ化 897"/>
          <p:cNvGrpSpPr/>
          <p:nvPr/>
        </p:nvGrpSpPr>
        <p:grpSpPr>
          <a:xfrm>
            <a:off x="1246890" y="783285"/>
            <a:ext cx="1068193" cy="925772"/>
            <a:chOff x="1248701" y="2045350"/>
            <a:chExt cx="1068193" cy="925772"/>
          </a:xfrm>
        </p:grpSpPr>
        <p:grpSp>
          <p:nvGrpSpPr>
            <p:cNvPr id="899" name="グループ化 898"/>
            <p:cNvGrpSpPr/>
            <p:nvPr/>
          </p:nvGrpSpPr>
          <p:grpSpPr>
            <a:xfrm>
              <a:off x="1248701" y="2045350"/>
              <a:ext cx="625904" cy="215444"/>
              <a:chOff x="2558800" y="476672"/>
              <a:chExt cx="690036" cy="215444"/>
            </a:xfrm>
          </p:grpSpPr>
          <p:sp>
            <p:nvSpPr>
              <p:cNvPr id="915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476672"/>
                <a:ext cx="65425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None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916" name="直線コネクタ 915"/>
              <p:cNvCxnSpPr/>
              <p:nvPr/>
            </p:nvCxnSpPr>
            <p:spPr>
              <a:xfrm>
                <a:off x="2558800" y="584394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0" name="グループ化 899"/>
            <p:cNvGrpSpPr/>
            <p:nvPr/>
          </p:nvGrpSpPr>
          <p:grpSpPr>
            <a:xfrm>
              <a:off x="1248701" y="2471548"/>
              <a:ext cx="1065091" cy="215444"/>
              <a:chOff x="2558800" y="675698"/>
              <a:chExt cx="1174223" cy="215444"/>
            </a:xfrm>
          </p:grpSpPr>
          <p:sp>
            <p:nvSpPr>
              <p:cNvPr id="913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H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914" name="直線コネクタ 913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1" name="グループ化 900"/>
            <p:cNvGrpSpPr/>
            <p:nvPr/>
          </p:nvGrpSpPr>
          <p:grpSpPr>
            <a:xfrm>
              <a:off x="1250341" y="2329482"/>
              <a:ext cx="1065091" cy="215444"/>
              <a:chOff x="2558800" y="675698"/>
              <a:chExt cx="1174223" cy="215444"/>
            </a:xfrm>
          </p:grpSpPr>
          <p:sp>
            <p:nvSpPr>
              <p:cNvPr id="911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912" name="直線コネクタ 911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2" name="グループ化 901"/>
            <p:cNvGrpSpPr/>
            <p:nvPr/>
          </p:nvGrpSpPr>
          <p:grpSpPr>
            <a:xfrm>
              <a:off x="1251803" y="2187416"/>
              <a:ext cx="1065091" cy="215444"/>
              <a:chOff x="2558800" y="675698"/>
              <a:chExt cx="1174223" cy="215444"/>
            </a:xfrm>
          </p:grpSpPr>
          <p:sp>
            <p:nvSpPr>
              <p:cNvPr id="909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N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910" name="直線コネクタ 909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3" name="グループ化 902"/>
            <p:cNvGrpSpPr/>
            <p:nvPr/>
          </p:nvGrpSpPr>
          <p:grpSpPr>
            <a:xfrm>
              <a:off x="1248701" y="2613614"/>
              <a:ext cx="1065091" cy="215444"/>
              <a:chOff x="2558800" y="675698"/>
              <a:chExt cx="1174223" cy="215444"/>
            </a:xfrm>
          </p:grpSpPr>
          <p:sp>
            <p:nvSpPr>
              <p:cNvPr id="907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APCA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908" name="直線コネクタ 907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04" name="グループ化 903"/>
            <p:cNvGrpSpPr/>
            <p:nvPr/>
          </p:nvGrpSpPr>
          <p:grpSpPr>
            <a:xfrm>
              <a:off x="1248701" y="2755678"/>
              <a:ext cx="1065091" cy="215444"/>
              <a:chOff x="2558800" y="675698"/>
              <a:chExt cx="1174223" cy="215444"/>
            </a:xfrm>
          </p:grpSpPr>
          <p:sp>
            <p:nvSpPr>
              <p:cNvPr id="905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Mg</a:t>
                </a:r>
                <a:r>
                  <a:rPr lang="en-US" altLang="ja-JP" sz="800" b="1" baseline="30000" dirty="0" smtClean="0">
                    <a:latin typeface="Arial" charset="0"/>
                    <a:cs typeface="Arial" charset="0"/>
                  </a:rPr>
                  <a:t>2+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906" name="直線コネクタ 905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18" name="正方形/長方形 917"/>
          <p:cNvSpPr/>
          <p:nvPr/>
        </p:nvSpPr>
        <p:spPr>
          <a:xfrm>
            <a:off x="980666" y="792709"/>
            <a:ext cx="3456384" cy="21514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56" name="直線コネクタ 255"/>
          <p:cNvCxnSpPr/>
          <p:nvPr/>
        </p:nvCxnSpPr>
        <p:spPr>
          <a:xfrm rot="5400000">
            <a:off x="1016666" y="2379631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7" name="直線コネクタ 256"/>
          <p:cNvCxnSpPr/>
          <p:nvPr/>
        </p:nvCxnSpPr>
        <p:spPr>
          <a:xfrm rot="5400000">
            <a:off x="1016666" y="2114052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8" name="テキスト ボックス 88"/>
          <p:cNvSpPr txBox="1">
            <a:spLocks noChangeArrowheads="1"/>
          </p:cNvSpPr>
          <p:nvPr/>
        </p:nvSpPr>
        <p:spPr bwMode="auto">
          <a:xfrm>
            <a:off x="623139" y="2559362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6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259" name="テキスト ボックス 88"/>
          <p:cNvSpPr txBox="1">
            <a:spLocks noChangeArrowheads="1"/>
          </p:cNvSpPr>
          <p:nvPr/>
        </p:nvSpPr>
        <p:spPr bwMode="auto">
          <a:xfrm>
            <a:off x="625652" y="2822209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262" name="フリーフォーム 261"/>
          <p:cNvSpPr/>
          <p:nvPr/>
        </p:nvSpPr>
        <p:spPr>
          <a:xfrm>
            <a:off x="982684" y="941972"/>
            <a:ext cx="3452552" cy="1369153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03 h 1379936"/>
              <a:gd name="connsiteX1" fmla="*/ 2776451 w 3452552"/>
              <a:gd name="connsiteY1" fmla="*/ 914403 h 1379936"/>
              <a:gd name="connsiteX2" fmla="*/ 1906385 w 3452552"/>
              <a:gd name="connsiteY2" fmla="*/ 3 h 1379936"/>
              <a:gd name="connsiteX3" fmla="*/ 1413163 w 3452552"/>
              <a:gd name="connsiteY3" fmla="*/ 925486 h 1379936"/>
              <a:gd name="connsiteX4" fmla="*/ 908858 w 3452552"/>
              <a:gd name="connsiteY4" fmla="*/ 1014155 h 1379936"/>
              <a:gd name="connsiteX5" fmla="*/ 615142 w 3452552"/>
              <a:gd name="connsiteY5" fmla="*/ 820192 h 1379936"/>
              <a:gd name="connsiteX6" fmla="*/ 271550 w 3452552"/>
              <a:gd name="connsiteY6" fmla="*/ 1379916 h 1379936"/>
              <a:gd name="connsiteX7" fmla="*/ 0 w 3452552"/>
              <a:gd name="connsiteY7" fmla="*/ 798025 h 1379936"/>
              <a:gd name="connsiteX0" fmla="*/ 3452552 w 3452552"/>
              <a:gd name="connsiteY0" fmla="*/ 914403 h 1380323"/>
              <a:gd name="connsiteX1" fmla="*/ 2776451 w 3452552"/>
              <a:gd name="connsiteY1" fmla="*/ 914403 h 1380323"/>
              <a:gd name="connsiteX2" fmla="*/ 1906385 w 3452552"/>
              <a:gd name="connsiteY2" fmla="*/ 3 h 1380323"/>
              <a:gd name="connsiteX3" fmla="*/ 1413163 w 3452552"/>
              <a:gd name="connsiteY3" fmla="*/ 925486 h 1380323"/>
              <a:gd name="connsiteX4" fmla="*/ 908858 w 3452552"/>
              <a:gd name="connsiteY4" fmla="*/ 1014155 h 1380323"/>
              <a:gd name="connsiteX5" fmla="*/ 615142 w 3452552"/>
              <a:gd name="connsiteY5" fmla="*/ 892236 h 1380323"/>
              <a:gd name="connsiteX6" fmla="*/ 271550 w 3452552"/>
              <a:gd name="connsiteY6" fmla="*/ 1379916 h 1380323"/>
              <a:gd name="connsiteX7" fmla="*/ 0 w 3452552"/>
              <a:gd name="connsiteY7" fmla="*/ 798025 h 1380323"/>
              <a:gd name="connsiteX0" fmla="*/ 3452552 w 3452552"/>
              <a:gd name="connsiteY0" fmla="*/ 914403 h 1380318"/>
              <a:gd name="connsiteX1" fmla="*/ 2776451 w 3452552"/>
              <a:gd name="connsiteY1" fmla="*/ 914403 h 1380318"/>
              <a:gd name="connsiteX2" fmla="*/ 1906385 w 3452552"/>
              <a:gd name="connsiteY2" fmla="*/ 3 h 1380318"/>
              <a:gd name="connsiteX3" fmla="*/ 1413163 w 3452552"/>
              <a:gd name="connsiteY3" fmla="*/ 925486 h 1380318"/>
              <a:gd name="connsiteX4" fmla="*/ 908858 w 3452552"/>
              <a:gd name="connsiteY4" fmla="*/ 1052948 h 1380318"/>
              <a:gd name="connsiteX5" fmla="*/ 615142 w 3452552"/>
              <a:gd name="connsiteY5" fmla="*/ 892236 h 1380318"/>
              <a:gd name="connsiteX6" fmla="*/ 271550 w 3452552"/>
              <a:gd name="connsiteY6" fmla="*/ 1379916 h 1380318"/>
              <a:gd name="connsiteX7" fmla="*/ 0 w 3452552"/>
              <a:gd name="connsiteY7" fmla="*/ 798025 h 1380318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74793"/>
              <a:gd name="connsiteX1" fmla="*/ 2776451 w 3452552"/>
              <a:gd name="connsiteY1" fmla="*/ 931029 h 1374793"/>
              <a:gd name="connsiteX2" fmla="*/ 1906385 w 3452552"/>
              <a:gd name="connsiteY2" fmla="*/ 3 h 1374793"/>
              <a:gd name="connsiteX3" fmla="*/ 1413163 w 3452552"/>
              <a:gd name="connsiteY3" fmla="*/ 942112 h 1374793"/>
              <a:gd name="connsiteX4" fmla="*/ 908858 w 3452552"/>
              <a:gd name="connsiteY4" fmla="*/ 1069574 h 1374793"/>
              <a:gd name="connsiteX5" fmla="*/ 615142 w 3452552"/>
              <a:gd name="connsiteY5" fmla="*/ 908862 h 1374793"/>
              <a:gd name="connsiteX6" fmla="*/ 271550 w 3452552"/>
              <a:gd name="connsiteY6" fmla="*/ 1374374 h 1374793"/>
              <a:gd name="connsiteX7" fmla="*/ 0 w 3452552"/>
              <a:gd name="connsiteY7" fmla="*/ 814651 h 1374793"/>
              <a:gd name="connsiteX0" fmla="*/ 3452552 w 3452552"/>
              <a:gd name="connsiteY0" fmla="*/ 931029 h 1374694"/>
              <a:gd name="connsiteX1" fmla="*/ 2776451 w 3452552"/>
              <a:gd name="connsiteY1" fmla="*/ 931029 h 1374694"/>
              <a:gd name="connsiteX2" fmla="*/ 1906385 w 3452552"/>
              <a:gd name="connsiteY2" fmla="*/ 3 h 1374694"/>
              <a:gd name="connsiteX3" fmla="*/ 1413163 w 3452552"/>
              <a:gd name="connsiteY3" fmla="*/ 942112 h 1374694"/>
              <a:gd name="connsiteX4" fmla="*/ 908858 w 3452552"/>
              <a:gd name="connsiteY4" fmla="*/ 1069574 h 1374694"/>
              <a:gd name="connsiteX5" fmla="*/ 615142 w 3452552"/>
              <a:gd name="connsiteY5" fmla="*/ 897779 h 1374694"/>
              <a:gd name="connsiteX6" fmla="*/ 271550 w 3452552"/>
              <a:gd name="connsiteY6" fmla="*/ 1374374 h 1374694"/>
              <a:gd name="connsiteX7" fmla="*/ 0 w 3452552"/>
              <a:gd name="connsiteY7" fmla="*/ 814651 h 1374694"/>
              <a:gd name="connsiteX0" fmla="*/ 3452552 w 3452552"/>
              <a:gd name="connsiteY0" fmla="*/ 931029 h 1374695"/>
              <a:gd name="connsiteX1" fmla="*/ 2776451 w 3452552"/>
              <a:gd name="connsiteY1" fmla="*/ 931029 h 1374695"/>
              <a:gd name="connsiteX2" fmla="*/ 1906385 w 3452552"/>
              <a:gd name="connsiteY2" fmla="*/ 3 h 1374695"/>
              <a:gd name="connsiteX3" fmla="*/ 1413163 w 3452552"/>
              <a:gd name="connsiteY3" fmla="*/ 942112 h 1374695"/>
              <a:gd name="connsiteX4" fmla="*/ 908858 w 3452552"/>
              <a:gd name="connsiteY4" fmla="*/ 1064033 h 1374695"/>
              <a:gd name="connsiteX5" fmla="*/ 615142 w 3452552"/>
              <a:gd name="connsiteY5" fmla="*/ 897779 h 1374695"/>
              <a:gd name="connsiteX6" fmla="*/ 271550 w 3452552"/>
              <a:gd name="connsiteY6" fmla="*/ 1374374 h 1374695"/>
              <a:gd name="connsiteX7" fmla="*/ 0 w 3452552"/>
              <a:gd name="connsiteY7" fmla="*/ 814651 h 1374695"/>
              <a:gd name="connsiteX0" fmla="*/ 3452552 w 3452552"/>
              <a:gd name="connsiteY0" fmla="*/ 925488 h 1369154"/>
              <a:gd name="connsiteX1" fmla="*/ 2776451 w 3452552"/>
              <a:gd name="connsiteY1" fmla="*/ 925488 h 1369154"/>
              <a:gd name="connsiteX2" fmla="*/ 1911926 w 3452552"/>
              <a:gd name="connsiteY2" fmla="*/ 4 h 1369154"/>
              <a:gd name="connsiteX3" fmla="*/ 1413163 w 3452552"/>
              <a:gd name="connsiteY3" fmla="*/ 936571 h 1369154"/>
              <a:gd name="connsiteX4" fmla="*/ 908858 w 3452552"/>
              <a:gd name="connsiteY4" fmla="*/ 1058492 h 1369154"/>
              <a:gd name="connsiteX5" fmla="*/ 615142 w 3452552"/>
              <a:gd name="connsiteY5" fmla="*/ 892238 h 1369154"/>
              <a:gd name="connsiteX6" fmla="*/ 271550 w 3452552"/>
              <a:gd name="connsiteY6" fmla="*/ 1368833 h 1369154"/>
              <a:gd name="connsiteX7" fmla="*/ 0 w 3452552"/>
              <a:gd name="connsiteY7" fmla="*/ 809110 h 1369154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369153">
                <a:moveTo>
                  <a:pt x="3452552" y="925487"/>
                </a:moveTo>
                <a:cubicBezTo>
                  <a:pt x="3223028" y="929644"/>
                  <a:pt x="3044306" y="941188"/>
                  <a:pt x="2776451" y="925487"/>
                </a:cubicBezTo>
                <a:cubicBezTo>
                  <a:pt x="2508596" y="909786"/>
                  <a:pt x="2139141" y="-1844"/>
                  <a:pt x="1911926" y="3"/>
                </a:cubicBezTo>
                <a:cubicBezTo>
                  <a:pt x="1684711" y="1850"/>
                  <a:pt x="1580341" y="760155"/>
                  <a:pt x="1413163" y="936570"/>
                </a:cubicBezTo>
                <a:cubicBezTo>
                  <a:pt x="1245985" y="1112985"/>
                  <a:pt x="1041861" y="1065880"/>
                  <a:pt x="908858" y="1058491"/>
                </a:cubicBezTo>
                <a:cubicBezTo>
                  <a:pt x="775855" y="1051102"/>
                  <a:pt x="721360" y="840514"/>
                  <a:pt x="615142" y="892237"/>
                </a:cubicBezTo>
                <a:cubicBezTo>
                  <a:pt x="508924" y="943960"/>
                  <a:pt x="374074" y="1382687"/>
                  <a:pt x="271550" y="1368832"/>
                </a:cubicBezTo>
                <a:cubicBezTo>
                  <a:pt x="169026" y="1354977"/>
                  <a:pt x="96520" y="1028472"/>
                  <a:pt x="0" y="809109"/>
                </a:cubicBezTo>
              </a:path>
            </a:pathLst>
          </a:custGeom>
          <a:noFill/>
          <a:ln w="127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3" name="フリーフォーム 262"/>
          <p:cNvSpPr/>
          <p:nvPr/>
        </p:nvSpPr>
        <p:spPr>
          <a:xfrm>
            <a:off x="980974" y="946476"/>
            <a:ext cx="3452552" cy="1335792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03 h 1379936"/>
              <a:gd name="connsiteX1" fmla="*/ 2776451 w 3452552"/>
              <a:gd name="connsiteY1" fmla="*/ 914403 h 1379936"/>
              <a:gd name="connsiteX2" fmla="*/ 1906385 w 3452552"/>
              <a:gd name="connsiteY2" fmla="*/ 3 h 1379936"/>
              <a:gd name="connsiteX3" fmla="*/ 1413163 w 3452552"/>
              <a:gd name="connsiteY3" fmla="*/ 925486 h 1379936"/>
              <a:gd name="connsiteX4" fmla="*/ 908858 w 3452552"/>
              <a:gd name="connsiteY4" fmla="*/ 1014155 h 1379936"/>
              <a:gd name="connsiteX5" fmla="*/ 615142 w 3452552"/>
              <a:gd name="connsiteY5" fmla="*/ 820192 h 1379936"/>
              <a:gd name="connsiteX6" fmla="*/ 271550 w 3452552"/>
              <a:gd name="connsiteY6" fmla="*/ 1379916 h 1379936"/>
              <a:gd name="connsiteX7" fmla="*/ 0 w 3452552"/>
              <a:gd name="connsiteY7" fmla="*/ 798025 h 1379936"/>
              <a:gd name="connsiteX0" fmla="*/ 3452552 w 3452552"/>
              <a:gd name="connsiteY0" fmla="*/ 914403 h 1380323"/>
              <a:gd name="connsiteX1" fmla="*/ 2776451 w 3452552"/>
              <a:gd name="connsiteY1" fmla="*/ 914403 h 1380323"/>
              <a:gd name="connsiteX2" fmla="*/ 1906385 w 3452552"/>
              <a:gd name="connsiteY2" fmla="*/ 3 h 1380323"/>
              <a:gd name="connsiteX3" fmla="*/ 1413163 w 3452552"/>
              <a:gd name="connsiteY3" fmla="*/ 925486 h 1380323"/>
              <a:gd name="connsiteX4" fmla="*/ 908858 w 3452552"/>
              <a:gd name="connsiteY4" fmla="*/ 1014155 h 1380323"/>
              <a:gd name="connsiteX5" fmla="*/ 615142 w 3452552"/>
              <a:gd name="connsiteY5" fmla="*/ 892236 h 1380323"/>
              <a:gd name="connsiteX6" fmla="*/ 271550 w 3452552"/>
              <a:gd name="connsiteY6" fmla="*/ 1379916 h 1380323"/>
              <a:gd name="connsiteX7" fmla="*/ 0 w 3452552"/>
              <a:gd name="connsiteY7" fmla="*/ 798025 h 1380323"/>
              <a:gd name="connsiteX0" fmla="*/ 3452552 w 3452552"/>
              <a:gd name="connsiteY0" fmla="*/ 914403 h 1380318"/>
              <a:gd name="connsiteX1" fmla="*/ 2776451 w 3452552"/>
              <a:gd name="connsiteY1" fmla="*/ 914403 h 1380318"/>
              <a:gd name="connsiteX2" fmla="*/ 1906385 w 3452552"/>
              <a:gd name="connsiteY2" fmla="*/ 3 h 1380318"/>
              <a:gd name="connsiteX3" fmla="*/ 1413163 w 3452552"/>
              <a:gd name="connsiteY3" fmla="*/ 925486 h 1380318"/>
              <a:gd name="connsiteX4" fmla="*/ 908858 w 3452552"/>
              <a:gd name="connsiteY4" fmla="*/ 1052948 h 1380318"/>
              <a:gd name="connsiteX5" fmla="*/ 615142 w 3452552"/>
              <a:gd name="connsiteY5" fmla="*/ 892236 h 1380318"/>
              <a:gd name="connsiteX6" fmla="*/ 271550 w 3452552"/>
              <a:gd name="connsiteY6" fmla="*/ 1379916 h 1380318"/>
              <a:gd name="connsiteX7" fmla="*/ 0 w 3452552"/>
              <a:gd name="connsiteY7" fmla="*/ 798025 h 1380318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74793"/>
              <a:gd name="connsiteX1" fmla="*/ 2776451 w 3452552"/>
              <a:gd name="connsiteY1" fmla="*/ 931029 h 1374793"/>
              <a:gd name="connsiteX2" fmla="*/ 1906385 w 3452552"/>
              <a:gd name="connsiteY2" fmla="*/ 3 h 1374793"/>
              <a:gd name="connsiteX3" fmla="*/ 1413163 w 3452552"/>
              <a:gd name="connsiteY3" fmla="*/ 942112 h 1374793"/>
              <a:gd name="connsiteX4" fmla="*/ 908858 w 3452552"/>
              <a:gd name="connsiteY4" fmla="*/ 1069574 h 1374793"/>
              <a:gd name="connsiteX5" fmla="*/ 615142 w 3452552"/>
              <a:gd name="connsiteY5" fmla="*/ 908862 h 1374793"/>
              <a:gd name="connsiteX6" fmla="*/ 271550 w 3452552"/>
              <a:gd name="connsiteY6" fmla="*/ 1374374 h 1374793"/>
              <a:gd name="connsiteX7" fmla="*/ 0 w 3452552"/>
              <a:gd name="connsiteY7" fmla="*/ 814651 h 1374793"/>
              <a:gd name="connsiteX0" fmla="*/ 3452552 w 3452552"/>
              <a:gd name="connsiteY0" fmla="*/ 931029 h 1374694"/>
              <a:gd name="connsiteX1" fmla="*/ 2776451 w 3452552"/>
              <a:gd name="connsiteY1" fmla="*/ 931029 h 1374694"/>
              <a:gd name="connsiteX2" fmla="*/ 1906385 w 3452552"/>
              <a:gd name="connsiteY2" fmla="*/ 3 h 1374694"/>
              <a:gd name="connsiteX3" fmla="*/ 1413163 w 3452552"/>
              <a:gd name="connsiteY3" fmla="*/ 942112 h 1374694"/>
              <a:gd name="connsiteX4" fmla="*/ 908858 w 3452552"/>
              <a:gd name="connsiteY4" fmla="*/ 1069574 h 1374694"/>
              <a:gd name="connsiteX5" fmla="*/ 615142 w 3452552"/>
              <a:gd name="connsiteY5" fmla="*/ 897779 h 1374694"/>
              <a:gd name="connsiteX6" fmla="*/ 271550 w 3452552"/>
              <a:gd name="connsiteY6" fmla="*/ 1374374 h 1374694"/>
              <a:gd name="connsiteX7" fmla="*/ 0 w 3452552"/>
              <a:gd name="connsiteY7" fmla="*/ 814651 h 1374694"/>
              <a:gd name="connsiteX0" fmla="*/ 3452552 w 3452552"/>
              <a:gd name="connsiteY0" fmla="*/ 931029 h 1374695"/>
              <a:gd name="connsiteX1" fmla="*/ 2776451 w 3452552"/>
              <a:gd name="connsiteY1" fmla="*/ 931029 h 1374695"/>
              <a:gd name="connsiteX2" fmla="*/ 1906385 w 3452552"/>
              <a:gd name="connsiteY2" fmla="*/ 3 h 1374695"/>
              <a:gd name="connsiteX3" fmla="*/ 1413163 w 3452552"/>
              <a:gd name="connsiteY3" fmla="*/ 942112 h 1374695"/>
              <a:gd name="connsiteX4" fmla="*/ 908858 w 3452552"/>
              <a:gd name="connsiteY4" fmla="*/ 1064033 h 1374695"/>
              <a:gd name="connsiteX5" fmla="*/ 615142 w 3452552"/>
              <a:gd name="connsiteY5" fmla="*/ 897779 h 1374695"/>
              <a:gd name="connsiteX6" fmla="*/ 271550 w 3452552"/>
              <a:gd name="connsiteY6" fmla="*/ 1374374 h 1374695"/>
              <a:gd name="connsiteX7" fmla="*/ 0 w 3452552"/>
              <a:gd name="connsiteY7" fmla="*/ 814651 h 1374695"/>
              <a:gd name="connsiteX0" fmla="*/ 3452552 w 3452552"/>
              <a:gd name="connsiteY0" fmla="*/ 925488 h 1369154"/>
              <a:gd name="connsiteX1" fmla="*/ 2776451 w 3452552"/>
              <a:gd name="connsiteY1" fmla="*/ 925488 h 1369154"/>
              <a:gd name="connsiteX2" fmla="*/ 1911926 w 3452552"/>
              <a:gd name="connsiteY2" fmla="*/ 4 h 1369154"/>
              <a:gd name="connsiteX3" fmla="*/ 1413163 w 3452552"/>
              <a:gd name="connsiteY3" fmla="*/ 936571 h 1369154"/>
              <a:gd name="connsiteX4" fmla="*/ 908858 w 3452552"/>
              <a:gd name="connsiteY4" fmla="*/ 1058492 h 1369154"/>
              <a:gd name="connsiteX5" fmla="*/ 615142 w 3452552"/>
              <a:gd name="connsiteY5" fmla="*/ 892238 h 1369154"/>
              <a:gd name="connsiteX6" fmla="*/ 271550 w 3452552"/>
              <a:gd name="connsiteY6" fmla="*/ 1368833 h 1369154"/>
              <a:gd name="connsiteX7" fmla="*/ 0 w 3452552"/>
              <a:gd name="connsiteY7" fmla="*/ 809110 h 1369154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52538"/>
              <a:gd name="connsiteX1" fmla="*/ 2776451 w 3452552"/>
              <a:gd name="connsiteY1" fmla="*/ 925487 h 1352538"/>
              <a:gd name="connsiteX2" fmla="*/ 1911926 w 3452552"/>
              <a:gd name="connsiteY2" fmla="*/ 3 h 1352538"/>
              <a:gd name="connsiteX3" fmla="*/ 1413163 w 3452552"/>
              <a:gd name="connsiteY3" fmla="*/ 936570 h 1352538"/>
              <a:gd name="connsiteX4" fmla="*/ 908858 w 3452552"/>
              <a:gd name="connsiteY4" fmla="*/ 1058491 h 1352538"/>
              <a:gd name="connsiteX5" fmla="*/ 615142 w 3452552"/>
              <a:gd name="connsiteY5" fmla="*/ 892237 h 1352538"/>
              <a:gd name="connsiteX6" fmla="*/ 271550 w 3452552"/>
              <a:gd name="connsiteY6" fmla="*/ 1352207 h 1352538"/>
              <a:gd name="connsiteX7" fmla="*/ 0 w 3452552"/>
              <a:gd name="connsiteY7" fmla="*/ 809109 h 1352538"/>
              <a:gd name="connsiteX0" fmla="*/ 3452552 w 3452552"/>
              <a:gd name="connsiteY0" fmla="*/ 925487 h 1341461"/>
              <a:gd name="connsiteX1" fmla="*/ 2776451 w 3452552"/>
              <a:gd name="connsiteY1" fmla="*/ 925487 h 1341461"/>
              <a:gd name="connsiteX2" fmla="*/ 1911926 w 3452552"/>
              <a:gd name="connsiteY2" fmla="*/ 3 h 1341461"/>
              <a:gd name="connsiteX3" fmla="*/ 1413163 w 3452552"/>
              <a:gd name="connsiteY3" fmla="*/ 936570 h 1341461"/>
              <a:gd name="connsiteX4" fmla="*/ 908858 w 3452552"/>
              <a:gd name="connsiteY4" fmla="*/ 1058491 h 1341461"/>
              <a:gd name="connsiteX5" fmla="*/ 615142 w 3452552"/>
              <a:gd name="connsiteY5" fmla="*/ 892237 h 1341461"/>
              <a:gd name="connsiteX6" fmla="*/ 271550 w 3452552"/>
              <a:gd name="connsiteY6" fmla="*/ 1341123 h 1341461"/>
              <a:gd name="connsiteX7" fmla="*/ 0 w 3452552"/>
              <a:gd name="connsiteY7" fmla="*/ 809109 h 1341461"/>
              <a:gd name="connsiteX0" fmla="*/ 3452552 w 3452552"/>
              <a:gd name="connsiteY0" fmla="*/ 925487 h 1341333"/>
              <a:gd name="connsiteX1" fmla="*/ 2776451 w 3452552"/>
              <a:gd name="connsiteY1" fmla="*/ 925487 h 1341333"/>
              <a:gd name="connsiteX2" fmla="*/ 1911926 w 3452552"/>
              <a:gd name="connsiteY2" fmla="*/ 3 h 1341333"/>
              <a:gd name="connsiteX3" fmla="*/ 1413163 w 3452552"/>
              <a:gd name="connsiteY3" fmla="*/ 936570 h 1341333"/>
              <a:gd name="connsiteX4" fmla="*/ 908858 w 3452552"/>
              <a:gd name="connsiteY4" fmla="*/ 1058491 h 1341333"/>
              <a:gd name="connsiteX5" fmla="*/ 615142 w 3452552"/>
              <a:gd name="connsiteY5" fmla="*/ 875612 h 1341333"/>
              <a:gd name="connsiteX6" fmla="*/ 271550 w 3452552"/>
              <a:gd name="connsiteY6" fmla="*/ 1341123 h 1341333"/>
              <a:gd name="connsiteX7" fmla="*/ 0 w 3452552"/>
              <a:gd name="connsiteY7" fmla="*/ 809109 h 1341333"/>
              <a:gd name="connsiteX0" fmla="*/ 3452552 w 3452552"/>
              <a:gd name="connsiteY0" fmla="*/ 925487 h 1341334"/>
              <a:gd name="connsiteX1" fmla="*/ 2776451 w 3452552"/>
              <a:gd name="connsiteY1" fmla="*/ 925487 h 1341334"/>
              <a:gd name="connsiteX2" fmla="*/ 1911926 w 3452552"/>
              <a:gd name="connsiteY2" fmla="*/ 3 h 1341334"/>
              <a:gd name="connsiteX3" fmla="*/ 1413163 w 3452552"/>
              <a:gd name="connsiteY3" fmla="*/ 936570 h 1341334"/>
              <a:gd name="connsiteX4" fmla="*/ 908858 w 3452552"/>
              <a:gd name="connsiteY4" fmla="*/ 1047408 h 1341334"/>
              <a:gd name="connsiteX5" fmla="*/ 615142 w 3452552"/>
              <a:gd name="connsiteY5" fmla="*/ 875612 h 1341334"/>
              <a:gd name="connsiteX6" fmla="*/ 271550 w 3452552"/>
              <a:gd name="connsiteY6" fmla="*/ 1341123 h 1341334"/>
              <a:gd name="connsiteX7" fmla="*/ 0 w 3452552"/>
              <a:gd name="connsiteY7" fmla="*/ 809109 h 1341334"/>
              <a:gd name="connsiteX0" fmla="*/ 3452552 w 3452552"/>
              <a:gd name="connsiteY0" fmla="*/ 919946 h 1335793"/>
              <a:gd name="connsiteX1" fmla="*/ 2776451 w 3452552"/>
              <a:gd name="connsiteY1" fmla="*/ 919946 h 1335793"/>
              <a:gd name="connsiteX2" fmla="*/ 1906384 w 3452552"/>
              <a:gd name="connsiteY2" fmla="*/ 4 h 1335793"/>
              <a:gd name="connsiteX3" fmla="*/ 1413163 w 3452552"/>
              <a:gd name="connsiteY3" fmla="*/ 931029 h 1335793"/>
              <a:gd name="connsiteX4" fmla="*/ 908858 w 3452552"/>
              <a:gd name="connsiteY4" fmla="*/ 1041867 h 1335793"/>
              <a:gd name="connsiteX5" fmla="*/ 615142 w 3452552"/>
              <a:gd name="connsiteY5" fmla="*/ 870071 h 1335793"/>
              <a:gd name="connsiteX6" fmla="*/ 271550 w 3452552"/>
              <a:gd name="connsiteY6" fmla="*/ 1335582 h 1335793"/>
              <a:gd name="connsiteX7" fmla="*/ 0 w 3452552"/>
              <a:gd name="connsiteY7" fmla="*/ 803568 h 1335793"/>
              <a:gd name="connsiteX0" fmla="*/ 3452552 w 3452552"/>
              <a:gd name="connsiteY0" fmla="*/ 919945 h 1335792"/>
              <a:gd name="connsiteX1" fmla="*/ 2776451 w 3452552"/>
              <a:gd name="connsiteY1" fmla="*/ 919945 h 1335792"/>
              <a:gd name="connsiteX2" fmla="*/ 1906384 w 3452552"/>
              <a:gd name="connsiteY2" fmla="*/ 3 h 1335792"/>
              <a:gd name="connsiteX3" fmla="*/ 1413163 w 3452552"/>
              <a:gd name="connsiteY3" fmla="*/ 931028 h 1335792"/>
              <a:gd name="connsiteX4" fmla="*/ 908858 w 3452552"/>
              <a:gd name="connsiteY4" fmla="*/ 1041866 h 1335792"/>
              <a:gd name="connsiteX5" fmla="*/ 615142 w 3452552"/>
              <a:gd name="connsiteY5" fmla="*/ 870070 h 1335792"/>
              <a:gd name="connsiteX6" fmla="*/ 271550 w 3452552"/>
              <a:gd name="connsiteY6" fmla="*/ 1335581 h 1335792"/>
              <a:gd name="connsiteX7" fmla="*/ 0 w 3452552"/>
              <a:gd name="connsiteY7" fmla="*/ 803567 h 133579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335792">
                <a:moveTo>
                  <a:pt x="3452552" y="919945"/>
                </a:moveTo>
                <a:cubicBezTo>
                  <a:pt x="3223028" y="924102"/>
                  <a:pt x="3034146" y="940265"/>
                  <a:pt x="2776451" y="919945"/>
                </a:cubicBezTo>
                <a:cubicBezTo>
                  <a:pt x="2518756" y="899625"/>
                  <a:pt x="2133599" y="-1844"/>
                  <a:pt x="1906384" y="3"/>
                </a:cubicBezTo>
                <a:cubicBezTo>
                  <a:pt x="1679169" y="1850"/>
                  <a:pt x="1579417" y="757384"/>
                  <a:pt x="1413163" y="931028"/>
                </a:cubicBezTo>
                <a:cubicBezTo>
                  <a:pt x="1246909" y="1104672"/>
                  <a:pt x="1041861" y="1052026"/>
                  <a:pt x="908858" y="1041866"/>
                </a:cubicBezTo>
                <a:cubicBezTo>
                  <a:pt x="775855" y="1031706"/>
                  <a:pt x="721360" y="821118"/>
                  <a:pt x="615142" y="870070"/>
                </a:cubicBezTo>
                <a:cubicBezTo>
                  <a:pt x="508924" y="919023"/>
                  <a:pt x="374074" y="1346665"/>
                  <a:pt x="271550" y="1335581"/>
                </a:cubicBezTo>
                <a:cubicBezTo>
                  <a:pt x="169026" y="1324497"/>
                  <a:pt x="96520" y="1022930"/>
                  <a:pt x="0" y="803567"/>
                </a:cubicBezTo>
              </a:path>
            </a:pathLst>
          </a:custGeom>
          <a:noFill/>
          <a:ln w="12700">
            <a:solidFill>
              <a:srgbClr val="00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4" name="フリーフォーム 263"/>
          <p:cNvSpPr/>
          <p:nvPr/>
        </p:nvSpPr>
        <p:spPr>
          <a:xfrm>
            <a:off x="982684" y="953056"/>
            <a:ext cx="3452552" cy="1300011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03 h 1379936"/>
              <a:gd name="connsiteX1" fmla="*/ 2776451 w 3452552"/>
              <a:gd name="connsiteY1" fmla="*/ 914403 h 1379936"/>
              <a:gd name="connsiteX2" fmla="*/ 1906385 w 3452552"/>
              <a:gd name="connsiteY2" fmla="*/ 3 h 1379936"/>
              <a:gd name="connsiteX3" fmla="*/ 1413163 w 3452552"/>
              <a:gd name="connsiteY3" fmla="*/ 925486 h 1379936"/>
              <a:gd name="connsiteX4" fmla="*/ 908858 w 3452552"/>
              <a:gd name="connsiteY4" fmla="*/ 1014155 h 1379936"/>
              <a:gd name="connsiteX5" fmla="*/ 615142 w 3452552"/>
              <a:gd name="connsiteY5" fmla="*/ 820192 h 1379936"/>
              <a:gd name="connsiteX6" fmla="*/ 271550 w 3452552"/>
              <a:gd name="connsiteY6" fmla="*/ 1379916 h 1379936"/>
              <a:gd name="connsiteX7" fmla="*/ 0 w 3452552"/>
              <a:gd name="connsiteY7" fmla="*/ 798025 h 1379936"/>
              <a:gd name="connsiteX0" fmla="*/ 3452552 w 3452552"/>
              <a:gd name="connsiteY0" fmla="*/ 914403 h 1380323"/>
              <a:gd name="connsiteX1" fmla="*/ 2776451 w 3452552"/>
              <a:gd name="connsiteY1" fmla="*/ 914403 h 1380323"/>
              <a:gd name="connsiteX2" fmla="*/ 1906385 w 3452552"/>
              <a:gd name="connsiteY2" fmla="*/ 3 h 1380323"/>
              <a:gd name="connsiteX3" fmla="*/ 1413163 w 3452552"/>
              <a:gd name="connsiteY3" fmla="*/ 925486 h 1380323"/>
              <a:gd name="connsiteX4" fmla="*/ 908858 w 3452552"/>
              <a:gd name="connsiteY4" fmla="*/ 1014155 h 1380323"/>
              <a:gd name="connsiteX5" fmla="*/ 615142 w 3452552"/>
              <a:gd name="connsiteY5" fmla="*/ 892236 h 1380323"/>
              <a:gd name="connsiteX6" fmla="*/ 271550 w 3452552"/>
              <a:gd name="connsiteY6" fmla="*/ 1379916 h 1380323"/>
              <a:gd name="connsiteX7" fmla="*/ 0 w 3452552"/>
              <a:gd name="connsiteY7" fmla="*/ 798025 h 1380323"/>
              <a:gd name="connsiteX0" fmla="*/ 3452552 w 3452552"/>
              <a:gd name="connsiteY0" fmla="*/ 914403 h 1380318"/>
              <a:gd name="connsiteX1" fmla="*/ 2776451 w 3452552"/>
              <a:gd name="connsiteY1" fmla="*/ 914403 h 1380318"/>
              <a:gd name="connsiteX2" fmla="*/ 1906385 w 3452552"/>
              <a:gd name="connsiteY2" fmla="*/ 3 h 1380318"/>
              <a:gd name="connsiteX3" fmla="*/ 1413163 w 3452552"/>
              <a:gd name="connsiteY3" fmla="*/ 925486 h 1380318"/>
              <a:gd name="connsiteX4" fmla="*/ 908858 w 3452552"/>
              <a:gd name="connsiteY4" fmla="*/ 1052948 h 1380318"/>
              <a:gd name="connsiteX5" fmla="*/ 615142 w 3452552"/>
              <a:gd name="connsiteY5" fmla="*/ 892236 h 1380318"/>
              <a:gd name="connsiteX6" fmla="*/ 271550 w 3452552"/>
              <a:gd name="connsiteY6" fmla="*/ 1379916 h 1380318"/>
              <a:gd name="connsiteX7" fmla="*/ 0 w 3452552"/>
              <a:gd name="connsiteY7" fmla="*/ 798025 h 1380318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74793"/>
              <a:gd name="connsiteX1" fmla="*/ 2776451 w 3452552"/>
              <a:gd name="connsiteY1" fmla="*/ 931029 h 1374793"/>
              <a:gd name="connsiteX2" fmla="*/ 1906385 w 3452552"/>
              <a:gd name="connsiteY2" fmla="*/ 3 h 1374793"/>
              <a:gd name="connsiteX3" fmla="*/ 1413163 w 3452552"/>
              <a:gd name="connsiteY3" fmla="*/ 942112 h 1374793"/>
              <a:gd name="connsiteX4" fmla="*/ 908858 w 3452552"/>
              <a:gd name="connsiteY4" fmla="*/ 1069574 h 1374793"/>
              <a:gd name="connsiteX5" fmla="*/ 615142 w 3452552"/>
              <a:gd name="connsiteY5" fmla="*/ 908862 h 1374793"/>
              <a:gd name="connsiteX6" fmla="*/ 271550 w 3452552"/>
              <a:gd name="connsiteY6" fmla="*/ 1374374 h 1374793"/>
              <a:gd name="connsiteX7" fmla="*/ 0 w 3452552"/>
              <a:gd name="connsiteY7" fmla="*/ 814651 h 1374793"/>
              <a:gd name="connsiteX0" fmla="*/ 3452552 w 3452552"/>
              <a:gd name="connsiteY0" fmla="*/ 931029 h 1374694"/>
              <a:gd name="connsiteX1" fmla="*/ 2776451 w 3452552"/>
              <a:gd name="connsiteY1" fmla="*/ 931029 h 1374694"/>
              <a:gd name="connsiteX2" fmla="*/ 1906385 w 3452552"/>
              <a:gd name="connsiteY2" fmla="*/ 3 h 1374694"/>
              <a:gd name="connsiteX3" fmla="*/ 1413163 w 3452552"/>
              <a:gd name="connsiteY3" fmla="*/ 942112 h 1374694"/>
              <a:gd name="connsiteX4" fmla="*/ 908858 w 3452552"/>
              <a:gd name="connsiteY4" fmla="*/ 1069574 h 1374694"/>
              <a:gd name="connsiteX5" fmla="*/ 615142 w 3452552"/>
              <a:gd name="connsiteY5" fmla="*/ 897779 h 1374694"/>
              <a:gd name="connsiteX6" fmla="*/ 271550 w 3452552"/>
              <a:gd name="connsiteY6" fmla="*/ 1374374 h 1374694"/>
              <a:gd name="connsiteX7" fmla="*/ 0 w 3452552"/>
              <a:gd name="connsiteY7" fmla="*/ 814651 h 1374694"/>
              <a:gd name="connsiteX0" fmla="*/ 3452552 w 3452552"/>
              <a:gd name="connsiteY0" fmla="*/ 931029 h 1374695"/>
              <a:gd name="connsiteX1" fmla="*/ 2776451 w 3452552"/>
              <a:gd name="connsiteY1" fmla="*/ 931029 h 1374695"/>
              <a:gd name="connsiteX2" fmla="*/ 1906385 w 3452552"/>
              <a:gd name="connsiteY2" fmla="*/ 3 h 1374695"/>
              <a:gd name="connsiteX3" fmla="*/ 1413163 w 3452552"/>
              <a:gd name="connsiteY3" fmla="*/ 942112 h 1374695"/>
              <a:gd name="connsiteX4" fmla="*/ 908858 w 3452552"/>
              <a:gd name="connsiteY4" fmla="*/ 1064033 h 1374695"/>
              <a:gd name="connsiteX5" fmla="*/ 615142 w 3452552"/>
              <a:gd name="connsiteY5" fmla="*/ 897779 h 1374695"/>
              <a:gd name="connsiteX6" fmla="*/ 271550 w 3452552"/>
              <a:gd name="connsiteY6" fmla="*/ 1374374 h 1374695"/>
              <a:gd name="connsiteX7" fmla="*/ 0 w 3452552"/>
              <a:gd name="connsiteY7" fmla="*/ 814651 h 1374695"/>
              <a:gd name="connsiteX0" fmla="*/ 3452552 w 3452552"/>
              <a:gd name="connsiteY0" fmla="*/ 925488 h 1369154"/>
              <a:gd name="connsiteX1" fmla="*/ 2776451 w 3452552"/>
              <a:gd name="connsiteY1" fmla="*/ 925488 h 1369154"/>
              <a:gd name="connsiteX2" fmla="*/ 1911926 w 3452552"/>
              <a:gd name="connsiteY2" fmla="*/ 4 h 1369154"/>
              <a:gd name="connsiteX3" fmla="*/ 1413163 w 3452552"/>
              <a:gd name="connsiteY3" fmla="*/ 936571 h 1369154"/>
              <a:gd name="connsiteX4" fmla="*/ 908858 w 3452552"/>
              <a:gd name="connsiteY4" fmla="*/ 1058492 h 1369154"/>
              <a:gd name="connsiteX5" fmla="*/ 615142 w 3452552"/>
              <a:gd name="connsiteY5" fmla="*/ 892238 h 1369154"/>
              <a:gd name="connsiteX6" fmla="*/ 271550 w 3452552"/>
              <a:gd name="connsiteY6" fmla="*/ 1368833 h 1369154"/>
              <a:gd name="connsiteX7" fmla="*/ 0 w 3452552"/>
              <a:gd name="connsiteY7" fmla="*/ 809110 h 1369154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52538"/>
              <a:gd name="connsiteX1" fmla="*/ 2776451 w 3452552"/>
              <a:gd name="connsiteY1" fmla="*/ 925487 h 1352538"/>
              <a:gd name="connsiteX2" fmla="*/ 1911926 w 3452552"/>
              <a:gd name="connsiteY2" fmla="*/ 3 h 1352538"/>
              <a:gd name="connsiteX3" fmla="*/ 1413163 w 3452552"/>
              <a:gd name="connsiteY3" fmla="*/ 936570 h 1352538"/>
              <a:gd name="connsiteX4" fmla="*/ 908858 w 3452552"/>
              <a:gd name="connsiteY4" fmla="*/ 1058491 h 1352538"/>
              <a:gd name="connsiteX5" fmla="*/ 615142 w 3452552"/>
              <a:gd name="connsiteY5" fmla="*/ 892237 h 1352538"/>
              <a:gd name="connsiteX6" fmla="*/ 271550 w 3452552"/>
              <a:gd name="connsiteY6" fmla="*/ 1352207 h 1352538"/>
              <a:gd name="connsiteX7" fmla="*/ 0 w 3452552"/>
              <a:gd name="connsiteY7" fmla="*/ 809109 h 1352538"/>
              <a:gd name="connsiteX0" fmla="*/ 3452552 w 3452552"/>
              <a:gd name="connsiteY0" fmla="*/ 925487 h 1341461"/>
              <a:gd name="connsiteX1" fmla="*/ 2776451 w 3452552"/>
              <a:gd name="connsiteY1" fmla="*/ 925487 h 1341461"/>
              <a:gd name="connsiteX2" fmla="*/ 1911926 w 3452552"/>
              <a:gd name="connsiteY2" fmla="*/ 3 h 1341461"/>
              <a:gd name="connsiteX3" fmla="*/ 1413163 w 3452552"/>
              <a:gd name="connsiteY3" fmla="*/ 936570 h 1341461"/>
              <a:gd name="connsiteX4" fmla="*/ 908858 w 3452552"/>
              <a:gd name="connsiteY4" fmla="*/ 1058491 h 1341461"/>
              <a:gd name="connsiteX5" fmla="*/ 615142 w 3452552"/>
              <a:gd name="connsiteY5" fmla="*/ 892237 h 1341461"/>
              <a:gd name="connsiteX6" fmla="*/ 271550 w 3452552"/>
              <a:gd name="connsiteY6" fmla="*/ 1341123 h 1341461"/>
              <a:gd name="connsiteX7" fmla="*/ 0 w 3452552"/>
              <a:gd name="connsiteY7" fmla="*/ 809109 h 1341461"/>
              <a:gd name="connsiteX0" fmla="*/ 3452552 w 3452552"/>
              <a:gd name="connsiteY0" fmla="*/ 925487 h 1341333"/>
              <a:gd name="connsiteX1" fmla="*/ 2776451 w 3452552"/>
              <a:gd name="connsiteY1" fmla="*/ 925487 h 1341333"/>
              <a:gd name="connsiteX2" fmla="*/ 1911926 w 3452552"/>
              <a:gd name="connsiteY2" fmla="*/ 3 h 1341333"/>
              <a:gd name="connsiteX3" fmla="*/ 1413163 w 3452552"/>
              <a:gd name="connsiteY3" fmla="*/ 936570 h 1341333"/>
              <a:gd name="connsiteX4" fmla="*/ 908858 w 3452552"/>
              <a:gd name="connsiteY4" fmla="*/ 1058491 h 1341333"/>
              <a:gd name="connsiteX5" fmla="*/ 615142 w 3452552"/>
              <a:gd name="connsiteY5" fmla="*/ 875612 h 1341333"/>
              <a:gd name="connsiteX6" fmla="*/ 271550 w 3452552"/>
              <a:gd name="connsiteY6" fmla="*/ 1341123 h 1341333"/>
              <a:gd name="connsiteX7" fmla="*/ 0 w 3452552"/>
              <a:gd name="connsiteY7" fmla="*/ 809109 h 1341333"/>
              <a:gd name="connsiteX0" fmla="*/ 3452552 w 3452552"/>
              <a:gd name="connsiteY0" fmla="*/ 925487 h 1341334"/>
              <a:gd name="connsiteX1" fmla="*/ 2776451 w 3452552"/>
              <a:gd name="connsiteY1" fmla="*/ 925487 h 1341334"/>
              <a:gd name="connsiteX2" fmla="*/ 1911926 w 3452552"/>
              <a:gd name="connsiteY2" fmla="*/ 3 h 1341334"/>
              <a:gd name="connsiteX3" fmla="*/ 1413163 w 3452552"/>
              <a:gd name="connsiteY3" fmla="*/ 936570 h 1341334"/>
              <a:gd name="connsiteX4" fmla="*/ 908858 w 3452552"/>
              <a:gd name="connsiteY4" fmla="*/ 1047408 h 1341334"/>
              <a:gd name="connsiteX5" fmla="*/ 615142 w 3452552"/>
              <a:gd name="connsiteY5" fmla="*/ 875612 h 1341334"/>
              <a:gd name="connsiteX6" fmla="*/ 271550 w 3452552"/>
              <a:gd name="connsiteY6" fmla="*/ 1341123 h 1341334"/>
              <a:gd name="connsiteX7" fmla="*/ 0 w 3452552"/>
              <a:gd name="connsiteY7" fmla="*/ 809109 h 1341334"/>
              <a:gd name="connsiteX0" fmla="*/ 3452552 w 3452552"/>
              <a:gd name="connsiteY0" fmla="*/ 919946 h 1335793"/>
              <a:gd name="connsiteX1" fmla="*/ 2776451 w 3452552"/>
              <a:gd name="connsiteY1" fmla="*/ 919946 h 1335793"/>
              <a:gd name="connsiteX2" fmla="*/ 1906384 w 3452552"/>
              <a:gd name="connsiteY2" fmla="*/ 4 h 1335793"/>
              <a:gd name="connsiteX3" fmla="*/ 1413163 w 3452552"/>
              <a:gd name="connsiteY3" fmla="*/ 931029 h 1335793"/>
              <a:gd name="connsiteX4" fmla="*/ 908858 w 3452552"/>
              <a:gd name="connsiteY4" fmla="*/ 1041867 h 1335793"/>
              <a:gd name="connsiteX5" fmla="*/ 615142 w 3452552"/>
              <a:gd name="connsiteY5" fmla="*/ 870071 h 1335793"/>
              <a:gd name="connsiteX6" fmla="*/ 271550 w 3452552"/>
              <a:gd name="connsiteY6" fmla="*/ 1335582 h 1335793"/>
              <a:gd name="connsiteX7" fmla="*/ 0 w 3452552"/>
              <a:gd name="connsiteY7" fmla="*/ 803568 h 1335793"/>
              <a:gd name="connsiteX0" fmla="*/ 3452552 w 3452552"/>
              <a:gd name="connsiteY0" fmla="*/ 919945 h 1335792"/>
              <a:gd name="connsiteX1" fmla="*/ 2776451 w 3452552"/>
              <a:gd name="connsiteY1" fmla="*/ 919945 h 1335792"/>
              <a:gd name="connsiteX2" fmla="*/ 1906384 w 3452552"/>
              <a:gd name="connsiteY2" fmla="*/ 3 h 1335792"/>
              <a:gd name="connsiteX3" fmla="*/ 1413163 w 3452552"/>
              <a:gd name="connsiteY3" fmla="*/ 931028 h 1335792"/>
              <a:gd name="connsiteX4" fmla="*/ 908858 w 3452552"/>
              <a:gd name="connsiteY4" fmla="*/ 1041866 h 1335792"/>
              <a:gd name="connsiteX5" fmla="*/ 615142 w 3452552"/>
              <a:gd name="connsiteY5" fmla="*/ 870070 h 1335792"/>
              <a:gd name="connsiteX6" fmla="*/ 271550 w 3452552"/>
              <a:gd name="connsiteY6" fmla="*/ 1335581 h 1335792"/>
              <a:gd name="connsiteX7" fmla="*/ 0 w 3452552"/>
              <a:gd name="connsiteY7" fmla="*/ 803567 h 1335792"/>
              <a:gd name="connsiteX0" fmla="*/ 3452552 w 3452552"/>
              <a:gd name="connsiteY0" fmla="*/ 919945 h 1302557"/>
              <a:gd name="connsiteX1" fmla="*/ 2776451 w 3452552"/>
              <a:gd name="connsiteY1" fmla="*/ 919945 h 1302557"/>
              <a:gd name="connsiteX2" fmla="*/ 1906384 w 3452552"/>
              <a:gd name="connsiteY2" fmla="*/ 3 h 1302557"/>
              <a:gd name="connsiteX3" fmla="*/ 1413163 w 3452552"/>
              <a:gd name="connsiteY3" fmla="*/ 931028 h 1302557"/>
              <a:gd name="connsiteX4" fmla="*/ 908858 w 3452552"/>
              <a:gd name="connsiteY4" fmla="*/ 1041866 h 1302557"/>
              <a:gd name="connsiteX5" fmla="*/ 615142 w 3452552"/>
              <a:gd name="connsiteY5" fmla="*/ 870070 h 1302557"/>
              <a:gd name="connsiteX6" fmla="*/ 271550 w 3452552"/>
              <a:gd name="connsiteY6" fmla="*/ 1302331 h 1302557"/>
              <a:gd name="connsiteX7" fmla="*/ 0 w 3452552"/>
              <a:gd name="connsiteY7" fmla="*/ 803567 h 1302557"/>
              <a:gd name="connsiteX0" fmla="*/ 3452552 w 3452552"/>
              <a:gd name="connsiteY0" fmla="*/ 919945 h 1302485"/>
              <a:gd name="connsiteX1" fmla="*/ 2776451 w 3452552"/>
              <a:gd name="connsiteY1" fmla="*/ 919945 h 1302485"/>
              <a:gd name="connsiteX2" fmla="*/ 1906384 w 3452552"/>
              <a:gd name="connsiteY2" fmla="*/ 3 h 1302485"/>
              <a:gd name="connsiteX3" fmla="*/ 1413163 w 3452552"/>
              <a:gd name="connsiteY3" fmla="*/ 931028 h 1302485"/>
              <a:gd name="connsiteX4" fmla="*/ 908858 w 3452552"/>
              <a:gd name="connsiteY4" fmla="*/ 1041866 h 1302485"/>
              <a:gd name="connsiteX5" fmla="*/ 615142 w 3452552"/>
              <a:gd name="connsiteY5" fmla="*/ 858986 h 1302485"/>
              <a:gd name="connsiteX6" fmla="*/ 271550 w 3452552"/>
              <a:gd name="connsiteY6" fmla="*/ 1302331 h 1302485"/>
              <a:gd name="connsiteX7" fmla="*/ 0 w 3452552"/>
              <a:gd name="connsiteY7" fmla="*/ 803567 h 1302485"/>
              <a:gd name="connsiteX0" fmla="*/ 3452552 w 3452552"/>
              <a:gd name="connsiteY0" fmla="*/ 919945 h 1302485"/>
              <a:gd name="connsiteX1" fmla="*/ 2776451 w 3452552"/>
              <a:gd name="connsiteY1" fmla="*/ 919945 h 1302485"/>
              <a:gd name="connsiteX2" fmla="*/ 1906384 w 3452552"/>
              <a:gd name="connsiteY2" fmla="*/ 3 h 1302485"/>
              <a:gd name="connsiteX3" fmla="*/ 1413163 w 3452552"/>
              <a:gd name="connsiteY3" fmla="*/ 931028 h 1302485"/>
              <a:gd name="connsiteX4" fmla="*/ 908858 w 3452552"/>
              <a:gd name="connsiteY4" fmla="*/ 1030782 h 1302485"/>
              <a:gd name="connsiteX5" fmla="*/ 615142 w 3452552"/>
              <a:gd name="connsiteY5" fmla="*/ 858986 h 1302485"/>
              <a:gd name="connsiteX6" fmla="*/ 271550 w 3452552"/>
              <a:gd name="connsiteY6" fmla="*/ 1302331 h 1302485"/>
              <a:gd name="connsiteX7" fmla="*/ 0 w 3452552"/>
              <a:gd name="connsiteY7" fmla="*/ 803567 h 1302485"/>
              <a:gd name="connsiteX0" fmla="*/ 3452552 w 3452552"/>
              <a:gd name="connsiteY0" fmla="*/ 914404 h 1296944"/>
              <a:gd name="connsiteX1" fmla="*/ 2776451 w 3452552"/>
              <a:gd name="connsiteY1" fmla="*/ 914404 h 1296944"/>
              <a:gd name="connsiteX2" fmla="*/ 1906384 w 3452552"/>
              <a:gd name="connsiteY2" fmla="*/ 4 h 1296944"/>
              <a:gd name="connsiteX3" fmla="*/ 1413163 w 3452552"/>
              <a:gd name="connsiteY3" fmla="*/ 925487 h 1296944"/>
              <a:gd name="connsiteX4" fmla="*/ 908858 w 3452552"/>
              <a:gd name="connsiteY4" fmla="*/ 1025241 h 1296944"/>
              <a:gd name="connsiteX5" fmla="*/ 615142 w 3452552"/>
              <a:gd name="connsiteY5" fmla="*/ 853445 h 1296944"/>
              <a:gd name="connsiteX6" fmla="*/ 271550 w 3452552"/>
              <a:gd name="connsiteY6" fmla="*/ 1296790 h 1296944"/>
              <a:gd name="connsiteX7" fmla="*/ 0 w 3452552"/>
              <a:gd name="connsiteY7" fmla="*/ 798026 h 1296944"/>
              <a:gd name="connsiteX0" fmla="*/ 3452552 w 3452552"/>
              <a:gd name="connsiteY0" fmla="*/ 914403 h 1296943"/>
              <a:gd name="connsiteX1" fmla="*/ 2776451 w 3452552"/>
              <a:gd name="connsiteY1" fmla="*/ 914403 h 1296943"/>
              <a:gd name="connsiteX2" fmla="*/ 1906384 w 3452552"/>
              <a:gd name="connsiteY2" fmla="*/ 3 h 1296943"/>
              <a:gd name="connsiteX3" fmla="*/ 1413163 w 3452552"/>
              <a:gd name="connsiteY3" fmla="*/ 925486 h 1296943"/>
              <a:gd name="connsiteX4" fmla="*/ 908858 w 3452552"/>
              <a:gd name="connsiteY4" fmla="*/ 1025240 h 1296943"/>
              <a:gd name="connsiteX5" fmla="*/ 615142 w 3452552"/>
              <a:gd name="connsiteY5" fmla="*/ 853444 h 1296943"/>
              <a:gd name="connsiteX6" fmla="*/ 271550 w 3452552"/>
              <a:gd name="connsiteY6" fmla="*/ 1296789 h 1296943"/>
              <a:gd name="connsiteX7" fmla="*/ 0 w 3452552"/>
              <a:gd name="connsiteY7" fmla="*/ 798025 h 1296943"/>
              <a:gd name="connsiteX0" fmla="*/ 3452552 w 3452552"/>
              <a:gd name="connsiteY0" fmla="*/ 914403 h 1300011"/>
              <a:gd name="connsiteX1" fmla="*/ 2776451 w 3452552"/>
              <a:gd name="connsiteY1" fmla="*/ 914403 h 1300011"/>
              <a:gd name="connsiteX2" fmla="*/ 1906384 w 3452552"/>
              <a:gd name="connsiteY2" fmla="*/ 3 h 1300011"/>
              <a:gd name="connsiteX3" fmla="*/ 1413163 w 3452552"/>
              <a:gd name="connsiteY3" fmla="*/ 925486 h 1300011"/>
              <a:gd name="connsiteX4" fmla="*/ 908858 w 3452552"/>
              <a:gd name="connsiteY4" fmla="*/ 1025240 h 1300011"/>
              <a:gd name="connsiteX5" fmla="*/ 615142 w 3452552"/>
              <a:gd name="connsiteY5" fmla="*/ 853444 h 1300011"/>
              <a:gd name="connsiteX6" fmla="*/ 271550 w 3452552"/>
              <a:gd name="connsiteY6" fmla="*/ 1299858 h 1300011"/>
              <a:gd name="connsiteX7" fmla="*/ 0 w 3452552"/>
              <a:gd name="connsiteY7" fmla="*/ 798025 h 130001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300011">
                <a:moveTo>
                  <a:pt x="3452552" y="914403"/>
                </a:moveTo>
                <a:cubicBezTo>
                  <a:pt x="3223028" y="918560"/>
                  <a:pt x="3056313" y="928258"/>
                  <a:pt x="2776451" y="914403"/>
                </a:cubicBezTo>
                <a:cubicBezTo>
                  <a:pt x="2496589" y="900548"/>
                  <a:pt x="2133599" y="-1844"/>
                  <a:pt x="1906384" y="3"/>
                </a:cubicBezTo>
                <a:cubicBezTo>
                  <a:pt x="1679169" y="1850"/>
                  <a:pt x="1579417" y="754613"/>
                  <a:pt x="1413163" y="925486"/>
                </a:cubicBezTo>
                <a:cubicBezTo>
                  <a:pt x="1246909" y="1096359"/>
                  <a:pt x="1041861" y="1037247"/>
                  <a:pt x="908858" y="1025240"/>
                </a:cubicBezTo>
                <a:cubicBezTo>
                  <a:pt x="775855" y="1013233"/>
                  <a:pt x="721360" y="807674"/>
                  <a:pt x="615142" y="853444"/>
                </a:cubicBezTo>
                <a:cubicBezTo>
                  <a:pt x="508924" y="899214"/>
                  <a:pt x="374074" y="1309095"/>
                  <a:pt x="271550" y="1299858"/>
                </a:cubicBezTo>
                <a:cubicBezTo>
                  <a:pt x="169026" y="1290621"/>
                  <a:pt x="96520" y="1017388"/>
                  <a:pt x="0" y="798025"/>
                </a:cubicBezTo>
              </a:path>
            </a:pathLst>
          </a:custGeom>
          <a:noFill/>
          <a:ln w="127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5" name="フリーフォーム 264"/>
          <p:cNvSpPr/>
          <p:nvPr/>
        </p:nvSpPr>
        <p:spPr>
          <a:xfrm>
            <a:off x="982684" y="956088"/>
            <a:ext cx="3452552" cy="1269254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03 h 1379936"/>
              <a:gd name="connsiteX1" fmla="*/ 2776451 w 3452552"/>
              <a:gd name="connsiteY1" fmla="*/ 914403 h 1379936"/>
              <a:gd name="connsiteX2" fmla="*/ 1906385 w 3452552"/>
              <a:gd name="connsiteY2" fmla="*/ 3 h 1379936"/>
              <a:gd name="connsiteX3" fmla="*/ 1413163 w 3452552"/>
              <a:gd name="connsiteY3" fmla="*/ 925486 h 1379936"/>
              <a:gd name="connsiteX4" fmla="*/ 908858 w 3452552"/>
              <a:gd name="connsiteY4" fmla="*/ 1014155 h 1379936"/>
              <a:gd name="connsiteX5" fmla="*/ 615142 w 3452552"/>
              <a:gd name="connsiteY5" fmla="*/ 820192 h 1379936"/>
              <a:gd name="connsiteX6" fmla="*/ 271550 w 3452552"/>
              <a:gd name="connsiteY6" fmla="*/ 1379916 h 1379936"/>
              <a:gd name="connsiteX7" fmla="*/ 0 w 3452552"/>
              <a:gd name="connsiteY7" fmla="*/ 798025 h 1379936"/>
              <a:gd name="connsiteX0" fmla="*/ 3452552 w 3452552"/>
              <a:gd name="connsiteY0" fmla="*/ 914403 h 1380323"/>
              <a:gd name="connsiteX1" fmla="*/ 2776451 w 3452552"/>
              <a:gd name="connsiteY1" fmla="*/ 914403 h 1380323"/>
              <a:gd name="connsiteX2" fmla="*/ 1906385 w 3452552"/>
              <a:gd name="connsiteY2" fmla="*/ 3 h 1380323"/>
              <a:gd name="connsiteX3" fmla="*/ 1413163 w 3452552"/>
              <a:gd name="connsiteY3" fmla="*/ 925486 h 1380323"/>
              <a:gd name="connsiteX4" fmla="*/ 908858 w 3452552"/>
              <a:gd name="connsiteY4" fmla="*/ 1014155 h 1380323"/>
              <a:gd name="connsiteX5" fmla="*/ 615142 w 3452552"/>
              <a:gd name="connsiteY5" fmla="*/ 892236 h 1380323"/>
              <a:gd name="connsiteX6" fmla="*/ 271550 w 3452552"/>
              <a:gd name="connsiteY6" fmla="*/ 1379916 h 1380323"/>
              <a:gd name="connsiteX7" fmla="*/ 0 w 3452552"/>
              <a:gd name="connsiteY7" fmla="*/ 798025 h 1380323"/>
              <a:gd name="connsiteX0" fmla="*/ 3452552 w 3452552"/>
              <a:gd name="connsiteY0" fmla="*/ 914403 h 1380318"/>
              <a:gd name="connsiteX1" fmla="*/ 2776451 w 3452552"/>
              <a:gd name="connsiteY1" fmla="*/ 914403 h 1380318"/>
              <a:gd name="connsiteX2" fmla="*/ 1906385 w 3452552"/>
              <a:gd name="connsiteY2" fmla="*/ 3 h 1380318"/>
              <a:gd name="connsiteX3" fmla="*/ 1413163 w 3452552"/>
              <a:gd name="connsiteY3" fmla="*/ 925486 h 1380318"/>
              <a:gd name="connsiteX4" fmla="*/ 908858 w 3452552"/>
              <a:gd name="connsiteY4" fmla="*/ 1052948 h 1380318"/>
              <a:gd name="connsiteX5" fmla="*/ 615142 w 3452552"/>
              <a:gd name="connsiteY5" fmla="*/ 892236 h 1380318"/>
              <a:gd name="connsiteX6" fmla="*/ 271550 w 3452552"/>
              <a:gd name="connsiteY6" fmla="*/ 1379916 h 1380318"/>
              <a:gd name="connsiteX7" fmla="*/ 0 w 3452552"/>
              <a:gd name="connsiteY7" fmla="*/ 798025 h 1380318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74793"/>
              <a:gd name="connsiteX1" fmla="*/ 2776451 w 3452552"/>
              <a:gd name="connsiteY1" fmla="*/ 931029 h 1374793"/>
              <a:gd name="connsiteX2" fmla="*/ 1906385 w 3452552"/>
              <a:gd name="connsiteY2" fmla="*/ 3 h 1374793"/>
              <a:gd name="connsiteX3" fmla="*/ 1413163 w 3452552"/>
              <a:gd name="connsiteY3" fmla="*/ 942112 h 1374793"/>
              <a:gd name="connsiteX4" fmla="*/ 908858 w 3452552"/>
              <a:gd name="connsiteY4" fmla="*/ 1069574 h 1374793"/>
              <a:gd name="connsiteX5" fmla="*/ 615142 w 3452552"/>
              <a:gd name="connsiteY5" fmla="*/ 908862 h 1374793"/>
              <a:gd name="connsiteX6" fmla="*/ 271550 w 3452552"/>
              <a:gd name="connsiteY6" fmla="*/ 1374374 h 1374793"/>
              <a:gd name="connsiteX7" fmla="*/ 0 w 3452552"/>
              <a:gd name="connsiteY7" fmla="*/ 814651 h 1374793"/>
              <a:gd name="connsiteX0" fmla="*/ 3452552 w 3452552"/>
              <a:gd name="connsiteY0" fmla="*/ 931029 h 1374694"/>
              <a:gd name="connsiteX1" fmla="*/ 2776451 w 3452552"/>
              <a:gd name="connsiteY1" fmla="*/ 931029 h 1374694"/>
              <a:gd name="connsiteX2" fmla="*/ 1906385 w 3452552"/>
              <a:gd name="connsiteY2" fmla="*/ 3 h 1374694"/>
              <a:gd name="connsiteX3" fmla="*/ 1413163 w 3452552"/>
              <a:gd name="connsiteY3" fmla="*/ 942112 h 1374694"/>
              <a:gd name="connsiteX4" fmla="*/ 908858 w 3452552"/>
              <a:gd name="connsiteY4" fmla="*/ 1069574 h 1374694"/>
              <a:gd name="connsiteX5" fmla="*/ 615142 w 3452552"/>
              <a:gd name="connsiteY5" fmla="*/ 897779 h 1374694"/>
              <a:gd name="connsiteX6" fmla="*/ 271550 w 3452552"/>
              <a:gd name="connsiteY6" fmla="*/ 1374374 h 1374694"/>
              <a:gd name="connsiteX7" fmla="*/ 0 w 3452552"/>
              <a:gd name="connsiteY7" fmla="*/ 814651 h 1374694"/>
              <a:gd name="connsiteX0" fmla="*/ 3452552 w 3452552"/>
              <a:gd name="connsiteY0" fmla="*/ 931029 h 1374695"/>
              <a:gd name="connsiteX1" fmla="*/ 2776451 w 3452552"/>
              <a:gd name="connsiteY1" fmla="*/ 931029 h 1374695"/>
              <a:gd name="connsiteX2" fmla="*/ 1906385 w 3452552"/>
              <a:gd name="connsiteY2" fmla="*/ 3 h 1374695"/>
              <a:gd name="connsiteX3" fmla="*/ 1413163 w 3452552"/>
              <a:gd name="connsiteY3" fmla="*/ 942112 h 1374695"/>
              <a:gd name="connsiteX4" fmla="*/ 908858 w 3452552"/>
              <a:gd name="connsiteY4" fmla="*/ 1064033 h 1374695"/>
              <a:gd name="connsiteX5" fmla="*/ 615142 w 3452552"/>
              <a:gd name="connsiteY5" fmla="*/ 897779 h 1374695"/>
              <a:gd name="connsiteX6" fmla="*/ 271550 w 3452552"/>
              <a:gd name="connsiteY6" fmla="*/ 1374374 h 1374695"/>
              <a:gd name="connsiteX7" fmla="*/ 0 w 3452552"/>
              <a:gd name="connsiteY7" fmla="*/ 814651 h 1374695"/>
              <a:gd name="connsiteX0" fmla="*/ 3452552 w 3452552"/>
              <a:gd name="connsiteY0" fmla="*/ 925488 h 1369154"/>
              <a:gd name="connsiteX1" fmla="*/ 2776451 w 3452552"/>
              <a:gd name="connsiteY1" fmla="*/ 925488 h 1369154"/>
              <a:gd name="connsiteX2" fmla="*/ 1911926 w 3452552"/>
              <a:gd name="connsiteY2" fmla="*/ 4 h 1369154"/>
              <a:gd name="connsiteX3" fmla="*/ 1413163 w 3452552"/>
              <a:gd name="connsiteY3" fmla="*/ 936571 h 1369154"/>
              <a:gd name="connsiteX4" fmla="*/ 908858 w 3452552"/>
              <a:gd name="connsiteY4" fmla="*/ 1058492 h 1369154"/>
              <a:gd name="connsiteX5" fmla="*/ 615142 w 3452552"/>
              <a:gd name="connsiteY5" fmla="*/ 892238 h 1369154"/>
              <a:gd name="connsiteX6" fmla="*/ 271550 w 3452552"/>
              <a:gd name="connsiteY6" fmla="*/ 1368833 h 1369154"/>
              <a:gd name="connsiteX7" fmla="*/ 0 w 3452552"/>
              <a:gd name="connsiteY7" fmla="*/ 809110 h 1369154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69153"/>
              <a:gd name="connsiteX1" fmla="*/ 2776451 w 3452552"/>
              <a:gd name="connsiteY1" fmla="*/ 925487 h 1369153"/>
              <a:gd name="connsiteX2" fmla="*/ 1911926 w 3452552"/>
              <a:gd name="connsiteY2" fmla="*/ 3 h 1369153"/>
              <a:gd name="connsiteX3" fmla="*/ 1413163 w 3452552"/>
              <a:gd name="connsiteY3" fmla="*/ 936570 h 1369153"/>
              <a:gd name="connsiteX4" fmla="*/ 908858 w 3452552"/>
              <a:gd name="connsiteY4" fmla="*/ 1058491 h 1369153"/>
              <a:gd name="connsiteX5" fmla="*/ 615142 w 3452552"/>
              <a:gd name="connsiteY5" fmla="*/ 892237 h 1369153"/>
              <a:gd name="connsiteX6" fmla="*/ 271550 w 3452552"/>
              <a:gd name="connsiteY6" fmla="*/ 1368832 h 1369153"/>
              <a:gd name="connsiteX7" fmla="*/ 0 w 3452552"/>
              <a:gd name="connsiteY7" fmla="*/ 809109 h 1369153"/>
              <a:gd name="connsiteX0" fmla="*/ 3452552 w 3452552"/>
              <a:gd name="connsiteY0" fmla="*/ 925487 h 1352538"/>
              <a:gd name="connsiteX1" fmla="*/ 2776451 w 3452552"/>
              <a:gd name="connsiteY1" fmla="*/ 925487 h 1352538"/>
              <a:gd name="connsiteX2" fmla="*/ 1911926 w 3452552"/>
              <a:gd name="connsiteY2" fmla="*/ 3 h 1352538"/>
              <a:gd name="connsiteX3" fmla="*/ 1413163 w 3452552"/>
              <a:gd name="connsiteY3" fmla="*/ 936570 h 1352538"/>
              <a:gd name="connsiteX4" fmla="*/ 908858 w 3452552"/>
              <a:gd name="connsiteY4" fmla="*/ 1058491 h 1352538"/>
              <a:gd name="connsiteX5" fmla="*/ 615142 w 3452552"/>
              <a:gd name="connsiteY5" fmla="*/ 892237 h 1352538"/>
              <a:gd name="connsiteX6" fmla="*/ 271550 w 3452552"/>
              <a:gd name="connsiteY6" fmla="*/ 1352207 h 1352538"/>
              <a:gd name="connsiteX7" fmla="*/ 0 w 3452552"/>
              <a:gd name="connsiteY7" fmla="*/ 809109 h 1352538"/>
              <a:gd name="connsiteX0" fmla="*/ 3452552 w 3452552"/>
              <a:gd name="connsiteY0" fmla="*/ 925487 h 1341461"/>
              <a:gd name="connsiteX1" fmla="*/ 2776451 w 3452552"/>
              <a:gd name="connsiteY1" fmla="*/ 925487 h 1341461"/>
              <a:gd name="connsiteX2" fmla="*/ 1911926 w 3452552"/>
              <a:gd name="connsiteY2" fmla="*/ 3 h 1341461"/>
              <a:gd name="connsiteX3" fmla="*/ 1413163 w 3452552"/>
              <a:gd name="connsiteY3" fmla="*/ 936570 h 1341461"/>
              <a:gd name="connsiteX4" fmla="*/ 908858 w 3452552"/>
              <a:gd name="connsiteY4" fmla="*/ 1058491 h 1341461"/>
              <a:gd name="connsiteX5" fmla="*/ 615142 w 3452552"/>
              <a:gd name="connsiteY5" fmla="*/ 892237 h 1341461"/>
              <a:gd name="connsiteX6" fmla="*/ 271550 w 3452552"/>
              <a:gd name="connsiteY6" fmla="*/ 1341123 h 1341461"/>
              <a:gd name="connsiteX7" fmla="*/ 0 w 3452552"/>
              <a:gd name="connsiteY7" fmla="*/ 809109 h 1341461"/>
              <a:gd name="connsiteX0" fmla="*/ 3452552 w 3452552"/>
              <a:gd name="connsiteY0" fmla="*/ 925487 h 1341333"/>
              <a:gd name="connsiteX1" fmla="*/ 2776451 w 3452552"/>
              <a:gd name="connsiteY1" fmla="*/ 925487 h 1341333"/>
              <a:gd name="connsiteX2" fmla="*/ 1911926 w 3452552"/>
              <a:gd name="connsiteY2" fmla="*/ 3 h 1341333"/>
              <a:gd name="connsiteX3" fmla="*/ 1413163 w 3452552"/>
              <a:gd name="connsiteY3" fmla="*/ 936570 h 1341333"/>
              <a:gd name="connsiteX4" fmla="*/ 908858 w 3452552"/>
              <a:gd name="connsiteY4" fmla="*/ 1058491 h 1341333"/>
              <a:gd name="connsiteX5" fmla="*/ 615142 w 3452552"/>
              <a:gd name="connsiteY5" fmla="*/ 875612 h 1341333"/>
              <a:gd name="connsiteX6" fmla="*/ 271550 w 3452552"/>
              <a:gd name="connsiteY6" fmla="*/ 1341123 h 1341333"/>
              <a:gd name="connsiteX7" fmla="*/ 0 w 3452552"/>
              <a:gd name="connsiteY7" fmla="*/ 809109 h 1341333"/>
              <a:gd name="connsiteX0" fmla="*/ 3452552 w 3452552"/>
              <a:gd name="connsiteY0" fmla="*/ 925487 h 1341334"/>
              <a:gd name="connsiteX1" fmla="*/ 2776451 w 3452552"/>
              <a:gd name="connsiteY1" fmla="*/ 925487 h 1341334"/>
              <a:gd name="connsiteX2" fmla="*/ 1911926 w 3452552"/>
              <a:gd name="connsiteY2" fmla="*/ 3 h 1341334"/>
              <a:gd name="connsiteX3" fmla="*/ 1413163 w 3452552"/>
              <a:gd name="connsiteY3" fmla="*/ 936570 h 1341334"/>
              <a:gd name="connsiteX4" fmla="*/ 908858 w 3452552"/>
              <a:gd name="connsiteY4" fmla="*/ 1047408 h 1341334"/>
              <a:gd name="connsiteX5" fmla="*/ 615142 w 3452552"/>
              <a:gd name="connsiteY5" fmla="*/ 875612 h 1341334"/>
              <a:gd name="connsiteX6" fmla="*/ 271550 w 3452552"/>
              <a:gd name="connsiteY6" fmla="*/ 1341123 h 1341334"/>
              <a:gd name="connsiteX7" fmla="*/ 0 w 3452552"/>
              <a:gd name="connsiteY7" fmla="*/ 809109 h 1341334"/>
              <a:gd name="connsiteX0" fmla="*/ 3452552 w 3452552"/>
              <a:gd name="connsiteY0" fmla="*/ 919946 h 1335793"/>
              <a:gd name="connsiteX1" fmla="*/ 2776451 w 3452552"/>
              <a:gd name="connsiteY1" fmla="*/ 919946 h 1335793"/>
              <a:gd name="connsiteX2" fmla="*/ 1906384 w 3452552"/>
              <a:gd name="connsiteY2" fmla="*/ 4 h 1335793"/>
              <a:gd name="connsiteX3" fmla="*/ 1413163 w 3452552"/>
              <a:gd name="connsiteY3" fmla="*/ 931029 h 1335793"/>
              <a:gd name="connsiteX4" fmla="*/ 908858 w 3452552"/>
              <a:gd name="connsiteY4" fmla="*/ 1041867 h 1335793"/>
              <a:gd name="connsiteX5" fmla="*/ 615142 w 3452552"/>
              <a:gd name="connsiteY5" fmla="*/ 870071 h 1335793"/>
              <a:gd name="connsiteX6" fmla="*/ 271550 w 3452552"/>
              <a:gd name="connsiteY6" fmla="*/ 1335582 h 1335793"/>
              <a:gd name="connsiteX7" fmla="*/ 0 w 3452552"/>
              <a:gd name="connsiteY7" fmla="*/ 803568 h 1335793"/>
              <a:gd name="connsiteX0" fmla="*/ 3452552 w 3452552"/>
              <a:gd name="connsiteY0" fmla="*/ 919945 h 1335792"/>
              <a:gd name="connsiteX1" fmla="*/ 2776451 w 3452552"/>
              <a:gd name="connsiteY1" fmla="*/ 919945 h 1335792"/>
              <a:gd name="connsiteX2" fmla="*/ 1906384 w 3452552"/>
              <a:gd name="connsiteY2" fmla="*/ 3 h 1335792"/>
              <a:gd name="connsiteX3" fmla="*/ 1413163 w 3452552"/>
              <a:gd name="connsiteY3" fmla="*/ 931028 h 1335792"/>
              <a:gd name="connsiteX4" fmla="*/ 908858 w 3452552"/>
              <a:gd name="connsiteY4" fmla="*/ 1041866 h 1335792"/>
              <a:gd name="connsiteX5" fmla="*/ 615142 w 3452552"/>
              <a:gd name="connsiteY5" fmla="*/ 870070 h 1335792"/>
              <a:gd name="connsiteX6" fmla="*/ 271550 w 3452552"/>
              <a:gd name="connsiteY6" fmla="*/ 1335581 h 1335792"/>
              <a:gd name="connsiteX7" fmla="*/ 0 w 3452552"/>
              <a:gd name="connsiteY7" fmla="*/ 803567 h 1335792"/>
              <a:gd name="connsiteX0" fmla="*/ 3452552 w 3452552"/>
              <a:gd name="connsiteY0" fmla="*/ 919945 h 1302557"/>
              <a:gd name="connsiteX1" fmla="*/ 2776451 w 3452552"/>
              <a:gd name="connsiteY1" fmla="*/ 919945 h 1302557"/>
              <a:gd name="connsiteX2" fmla="*/ 1906384 w 3452552"/>
              <a:gd name="connsiteY2" fmla="*/ 3 h 1302557"/>
              <a:gd name="connsiteX3" fmla="*/ 1413163 w 3452552"/>
              <a:gd name="connsiteY3" fmla="*/ 931028 h 1302557"/>
              <a:gd name="connsiteX4" fmla="*/ 908858 w 3452552"/>
              <a:gd name="connsiteY4" fmla="*/ 1041866 h 1302557"/>
              <a:gd name="connsiteX5" fmla="*/ 615142 w 3452552"/>
              <a:gd name="connsiteY5" fmla="*/ 870070 h 1302557"/>
              <a:gd name="connsiteX6" fmla="*/ 271550 w 3452552"/>
              <a:gd name="connsiteY6" fmla="*/ 1302331 h 1302557"/>
              <a:gd name="connsiteX7" fmla="*/ 0 w 3452552"/>
              <a:gd name="connsiteY7" fmla="*/ 803567 h 1302557"/>
              <a:gd name="connsiteX0" fmla="*/ 3452552 w 3452552"/>
              <a:gd name="connsiteY0" fmla="*/ 919945 h 1302485"/>
              <a:gd name="connsiteX1" fmla="*/ 2776451 w 3452552"/>
              <a:gd name="connsiteY1" fmla="*/ 919945 h 1302485"/>
              <a:gd name="connsiteX2" fmla="*/ 1906384 w 3452552"/>
              <a:gd name="connsiteY2" fmla="*/ 3 h 1302485"/>
              <a:gd name="connsiteX3" fmla="*/ 1413163 w 3452552"/>
              <a:gd name="connsiteY3" fmla="*/ 931028 h 1302485"/>
              <a:gd name="connsiteX4" fmla="*/ 908858 w 3452552"/>
              <a:gd name="connsiteY4" fmla="*/ 1041866 h 1302485"/>
              <a:gd name="connsiteX5" fmla="*/ 615142 w 3452552"/>
              <a:gd name="connsiteY5" fmla="*/ 858986 h 1302485"/>
              <a:gd name="connsiteX6" fmla="*/ 271550 w 3452552"/>
              <a:gd name="connsiteY6" fmla="*/ 1302331 h 1302485"/>
              <a:gd name="connsiteX7" fmla="*/ 0 w 3452552"/>
              <a:gd name="connsiteY7" fmla="*/ 803567 h 1302485"/>
              <a:gd name="connsiteX0" fmla="*/ 3452552 w 3452552"/>
              <a:gd name="connsiteY0" fmla="*/ 919945 h 1302485"/>
              <a:gd name="connsiteX1" fmla="*/ 2776451 w 3452552"/>
              <a:gd name="connsiteY1" fmla="*/ 919945 h 1302485"/>
              <a:gd name="connsiteX2" fmla="*/ 1906384 w 3452552"/>
              <a:gd name="connsiteY2" fmla="*/ 3 h 1302485"/>
              <a:gd name="connsiteX3" fmla="*/ 1413163 w 3452552"/>
              <a:gd name="connsiteY3" fmla="*/ 931028 h 1302485"/>
              <a:gd name="connsiteX4" fmla="*/ 908858 w 3452552"/>
              <a:gd name="connsiteY4" fmla="*/ 1030782 h 1302485"/>
              <a:gd name="connsiteX5" fmla="*/ 615142 w 3452552"/>
              <a:gd name="connsiteY5" fmla="*/ 858986 h 1302485"/>
              <a:gd name="connsiteX6" fmla="*/ 271550 w 3452552"/>
              <a:gd name="connsiteY6" fmla="*/ 1302331 h 1302485"/>
              <a:gd name="connsiteX7" fmla="*/ 0 w 3452552"/>
              <a:gd name="connsiteY7" fmla="*/ 803567 h 1302485"/>
              <a:gd name="connsiteX0" fmla="*/ 3452552 w 3452552"/>
              <a:gd name="connsiteY0" fmla="*/ 914404 h 1296944"/>
              <a:gd name="connsiteX1" fmla="*/ 2776451 w 3452552"/>
              <a:gd name="connsiteY1" fmla="*/ 914404 h 1296944"/>
              <a:gd name="connsiteX2" fmla="*/ 1906384 w 3452552"/>
              <a:gd name="connsiteY2" fmla="*/ 4 h 1296944"/>
              <a:gd name="connsiteX3" fmla="*/ 1413163 w 3452552"/>
              <a:gd name="connsiteY3" fmla="*/ 925487 h 1296944"/>
              <a:gd name="connsiteX4" fmla="*/ 908858 w 3452552"/>
              <a:gd name="connsiteY4" fmla="*/ 1025241 h 1296944"/>
              <a:gd name="connsiteX5" fmla="*/ 615142 w 3452552"/>
              <a:gd name="connsiteY5" fmla="*/ 853445 h 1296944"/>
              <a:gd name="connsiteX6" fmla="*/ 271550 w 3452552"/>
              <a:gd name="connsiteY6" fmla="*/ 1296790 h 1296944"/>
              <a:gd name="connsiteX7" fmla="*/ 0 w 3452552"/>
              <a:gd name="connsiteY7" fmla="*/ 798026 h 1296944"/>
              <a:gd name="connsiteX0" fmla="*/ 3452552 w 3452552"/>
              <a:gd name="connsiteY0" fmla="*/ 914403 h 1296943"/>
              <a:gd name="connsiteX1" fmla="*/ 2776451 w 3452552"/>
              <a:gd name="connsiteY1" fmla="*/ 914403 h 1296943"/>
              <a:gd name="connsiteX2" fmla="*/ 1906384 w 3452552"/>
              <a:gd name="connsiteY2" fmla="*/ 3 h 1296943"/>
              <a:gd name="connsiteX3" fmla="*/ 1413163 w 3452552"/>
              <a:gd name="connsiteY3" fmla="*/ 925486 h 1296943"/>
              <a:gd name="connsiteX4" fmla="*/ 908858 w 3452552"/>
              <a:gd name="connsiteY4" fmla="*/ 1025240 h 1296943"/>
              <a:gd name="connsiteX5" fmla="*/ 615142 w 3452552"/>
              <a:gd name="connsiteY5" fmla="*/ 853444 h 1296943"/>
              <a:gd name="connsiteX6" fmla="*/ 271550 w 3452552"/>
              <a:gd name="connsiteY6" fmla="*/ 1296789 h 1296943"/>
              <a:gd name="connsiteX7" fmla="*/ 0 w 3452552"/>
              <a:gd name="connsiteY7" fmla="*/ 798025 h 1296943"/>
              <a:gd name="connsiteX0" fmla="*/ 3452552 w 3452552"/>
              <a:gd name="connsiteY0" fmla="*/ 914403 h 1272403"/>
              <a:gd name="connsiteX1" fmla="*/ 2776451 w 3452552"/>
              <a:gd name="connsiteY1" fmla="*/ 914403 h 1272403"/>
              <a:gd name="connsiteX2" fmla="*/ 1906384 w 3452552"/>
              <a:gd name="connsiteY2" fmla="*/ 3 h 1272403"/>
              <a:gd name="connsiteX3" fmla="*/ 1413163 w 3452552"/>
              <a:gd name="connsiteY3" fmla="*/ 925486 h 1272403"/>
              <a:gd name="connsiteX4" fmla="*/ 908858 w 3452552"/>
              <a:gd name="connsiteY4" fmla="*/ 1025240 h 1272403"/>
              <a:gd name="connsiteX5" fmla="*/ 615142 w 3452552"/>
              <a:gd name="connsiteY5" fmla="*/ 853444 h 1272403"/>
              <a:gd name="connsiteX6" fmla="*/ 274619 w 3452552"/>
              <a:gd name="connsiteY6" fmla="*/ 1272241 h 1272403"/>
              <a:gd name="connsiteX7" fmla="*/ 0 w 3452552"/>
              <a:gd name="connsiteY7" fmla="*/ 798025 h 1272403"/>
              <a:gd name="connsiteX0" fmla="*/ 3452552 w 3452552"/>
              <a:gd name="connsiteY0" fmla="*/ 914403 h 1272403"/>
              <a:gd name="connsiteX1" fmla="*/ 2776451 w 3452552"/>
              <a:gd name="connsiteY1" fmla="*/ 914403 h 1272403"/>
              <a:gd name="connsiteX2" fmla="*/ 1906384 w 3452552"/>
              <a:gd name="connsiteY2" fmla="*/ 3 h 1272403"/>
              <a:gd name="connsiteX3" fmla="*/ 1413163 w 3452552"/>
              <a:gd name="connsiteY3" fmla="*/ 925486 h 1272403"/>
              <a:gd name="connsiteX4" fmla="*/ 908858 w 3452552"/>
              <a:gd name="connsiteY4" fmla="*/ 1025240 h 1272403"/>
              <a:gd name="connsiteX5" fmla="*/ 615142 w 3452552"/>
              <a:gd name="connsiteY5" fmla="*/ 853444 h 1272403"/>
              <a:gd name="connsiteX6" fmla="*/ 274619 w 3452552"/>
              <a:gd name="connsiteY6" fmla="*/ 1272241 h 1272403"/>
              <a:gd name="connsiteX7" fmla="*/ 0 w 3452552"/>
              <a:gd name="connsiteY7" fmla="*/ 798025 h 1272403"/>
              <a:gd name="connsiteX0" fmla="*/ 3452552 w 3452552"/>
              <a:gd name="connsiteY0" fmla="*/ 914403 h 1272323"/>
              <a:gd name="connsiteX1" fmla="*/ 2776451 w 3452552"/>
              <a:gd name="connsiteY1" fmla="*/ 914403 h 1272323"/>
              <a:gd name="connsiteX2" fmla="*/ 1906384 w 3452552"/>
              <a:gd name="connsiteY2" fmla="*/ 3 h 1272323"/>
              <a:gd name="connsiteX3" fmla="*/ 1413163 w 3452552"/>
              <a:gd name="connsiteY3" fmla="*/ 925486 h 1272323"/>
              <a:gd name="connsiteX4" fmla="*/ 908858 w 3452552"/>
              <a:gd name="connsiteY4" fmla="*/ 1025240 h 1272323"/>
              <a:gd name="connsiteX5" fmla="*/ 618210 w 3452552"/>
              <a:gd name="connsiteY5" fmla="*/ 838102 h 1272323"/>
              <a:gd name="connsiteX6" fmla="*/ 274619 w 3452552"/>
              <a:gd name="connsiteY6" fmla="*/ 1272241 h 1272323"/>
              <a:gd name="connsiteX7" fmla="*/ 0 w 3452552"/>
              <a:gd name="connsiteY7" fmla="*/ 798025 h 1272323"/>
              <a:gd name="connsiteX0" fmla="*/ 3452552 w 3452552"/>
              <a:gd name="connsiteY0" fmla="*/ 914403 h 1272323"/>
              <a:gd name="connsiteX1" fmla="*/ 2776451 w 3452552"/>
              <a:gd name="connsiteY1" fmla="*/ 914403 h 1272323"/>
              <a:gd name="connsiteX2" fmla="*/ 1906384 w 3452552"/>
              <a:gd name="connsiteY2" fmla="*/ 3 h 1272323"/>
              <a:gd name="connsiteX3" fmla="*/ 1413163 w 3452552"/>
              <a:gd name="connsiteY3" fmla="*/ 925486 h 1272323"/>
              <a:gd name="connsiteX4" fmla="*/ 911926 w 3452552"/>
              <a:gd name="connsiteY4" fmla="*/ 1022172 h 1272323"/>
              <a:gd name="connsiteX5" fmla="*/ 618210 w 3452552"/>
              <a:gd name="connsiteY5" fmla="*/ 838102 h 1272323"/>
              <a:gd name="connsiteX6" fmla="*/ 274619 w 3452552"/>
              <a:gd name="connsiteY6" fmla="*/ 1272241 h 1272323"/>
              <a:gd name="connsiteX7" fmla="*/ 0 w 3452552"/>
              <a:gd name="connsiteY7" fmla="*/ 798025 h 1272323"/>
              <a:gd name="connsiteX0" fmla="*/ 3452552 w 3452552"/>
              <a:gd name="connsiteY0" fmla="*/ 911335 h 1269255"/>
              <a:gd name="connsiteX1" fmla="*/ 2776451 w 3452552"/>
              <a:gd name="connsiteY1" fmla="*/ 911335 h 1269255"/>
              <a:gd name="connsiteX2" fmla="*/ 1906384 w 3452552"/>
              <a:gd name="connsiteY2" fmla="*/ 4 h 1269255"/>
              <a:gd name="connsiteX3" fmla="*/ 1413163 w 3452552"/>
              <a:gd name="connsiteY3" fmla="*/ 922418 h 1269255"/>
              <a:gd name="connsiteX4" fmla="*/ 911926 w 3452552"/>
              <a:gd name="connsiteY4" fmla="*/ 1019104 h 1269255"/>
              <a:gd name="connsiteX5" fmla="*/ 618210 w 3452552"/>
              <a:gd name="connsiteY5" fmla="*/ 835034 h 1269255"/>
              <a:gd name="connsiteX6" fmla="*/ 274619 w 3452552"/>
              <a:gd name="connsiteY6" fmla="*/ 1269173 h 1269255"/>
              <a:gd name="connsiteX7" fmla="*/ 0 w 3452552"/>
              <a:gd name="connsiteY7" fmla="*/ 794957 h 1269255"/>
              <a:gd name="connsiteX0" fmla="*/ 3452552 w 3452552"/>
              <a:gd name="connsiteY0" fmla="*/ 911334 h 1269254"/>
              <a:gd name="connsiteX1" fmla="*/ 2776451 w 3452552"/>
              <a:gd name="connsiteY1" fmla="*/ 911334 h 1269254"/>
              <a:gd name="connsiteX2" fmla="*/ 1906384 w 3452552"/>
              <a:gd name="connsiteY2" fmla="*/ 3 h 1269254"/>
              <a:gd name="connsiteX3" fmla="*/ 1413163 w 3452552"/>
              <a:gd name="connsiteY3" fmla="*/ 922417 h 1269254"/>
              <a:gd name="connsiteX4" fmla="*/ 911926 w 3452552"/>
              <a:gd name="connsiteY4" fmla="*/ 1019103 h 1269254"/>
              <a:gd name="connsiteX5" fmla="*/ 618210 w 3452552"/>
              <a:gd name="connsiteY5" fmla="*/ 835033 h 1269254"/>
              <a:gd name="connsiteX6" fmla="*/ 274619 w 3452552"/>
              <a:gd name="connsiteY6" fmla="*/ 1269172 h 1269254"/>
              <a:gd name="connsiteX7" fmla="*/ 0 w 3452552"/>
              <a:gd name="connsiteY7" fmla="*/ 794956 h 12692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269254">
                <a:moveTo>
                  <a:pt x="3452552" y="911334"/>
                </a:moveTo>
                <a:cubicBezTo>
                  <a:pt x="3223028" y="915491"/>
                  <a:pt x="3064831" y="925142"/>
                  <a:pt x="2776451" y="911334"/>
                </a:cubicBezTo>
                <a:cubicBezTo>
                  <a:pt x="2488071" y="897526"/>
                  <a:pt x="2133599" y="-1844"/>
                  <a:pt x="1906384" y="3"/>
                </a:cubicBezTo>
                <a:cubicBezTo>
                  <a:pt x="1679169" y="1850"/>
                  <a:pt x="1578906" y="752567"/>
                  <a:pt x="1413163" y="922417"/>
                </a:cubicBezTo>
                <a:cubicBezTo>
                  <a:pt x="1247420" y="1092267"/>
                  <a:pt x="1044418" y="1033667"/>
                  <a:pt x="911926" y="1019103"/>
                </a:cubicBezTo>
                <a:cubicBezTo>
                  <a:pt x="779434" y="1004539"/>
                  <a:pt x="724428" y="793355"/>
                  <a:pt x="618210" y="835033"/>
                </a:cubicBezTo>
                <a:cubicBezTo>
                  <a:pt x="511992" y="876711"/>
                  <a:pt x="377654" y="1275852"/>
                  <a:pt x="274619" y="1269172"/>
                </a:cubicBezTo>
                <a:cubicBezTo>
                  <a:pt x="171584" y="1262493"/>
                  <a:pt x="96520" y="1014319"/>
                  <a:pt x="0" y="794956"/>
                </a:cubicBezTo>
              </a:path>
            </a:pathLst>
          </a:custGeom>
          <a:noFill/>
          <a:ln w="127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フリーフォーム 2"/>
          <p:cNvSpPr/>
          <p:nvPr/>
        </p:nvSpPr>
        <p:spPr>
          <a:xfrm>
            <a:off x="986444" y="953191"/>
            <a:ext cx="3452552" cy="1241396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241396">
                <a:moveTo>
                  <a:pt x="3452552" y="914403"/>
                </a:moveTo>
                <a:cubicBezTo>
                  <a:pt x="3223028" y="918560"/>
                  <a:pt x="3089563" y="933800"/>
                  <a:pt x="2776451" y="914403"/>
                </a:cubicBezTo>
                <a:cubicBezTo>
                  <a:pt x="2463339" y="895006"/>
                  <a:pt x="2133600" y="-1844"/>
                  <a:pt x="1906385" y="3"/>
                </a:cubicBezTo>
                <a:cubicBezTo>
                  <a:pt x="1679170" y="1850"/>
                  <a:pt x="1607126" y="778628"/>
                  <a:pt x="1413163" y="925486"/>
                </a:cubicBezTo>
                <a:cubicBezTo>
                  <a:pt x="1219200" y="1072344"/>
                  <a:pt x="1041862" y="1031704"/>
                  <a:pt x="908858" y="1014155"/>
                </a:cubicBezTo>
                <a:cubicBezTo>
                  <a:pt x="775855" y="996606"/>
                  <a:pt x="718589" y="782323"/>
                  <a:pt x="615142" y="820192"/>
                </a:cubicBezTo>
                <a:cubicBezTo>
                  <a:pt x="511695" y="858061"/>
                  <a:pt x="390699" y="1245064"/>
                  <a:pt x="288175" y="1241370"/>
                </a:cubicBezTo>
                <a:cubicBezTo>
                  <a:pt x="185651" y="1237676"/>
                  <a:pt x="96520" y="1017388"/>
                  <a:pt x="0" y="798025"/>
                </a:cubicBezTo>
              </a:path>
            </a:pathLst>
          </a:cu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1" name="フリーフォーム 260"/>
          <p:cNvSpPr/>
          <p:nvPr/>
        </p:nvSpPr>
        <p:spPr>
          <a:xfrm>
            <a:off x="978425" y="936392"/>
            <a:ext cx="3452552" cy="1396944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03 h 1379936"/>
              <a:gd name="connsiteX1" fmla="*/ 2776451 w 3452552"/>
              <a:gd name="connsiteY1" fmla="*/ 914403 h 1379936"/>
              <a:gd name="connsiteX2" fmla="*/ 1906385 w 3452552"/>
              <a:gd name="connsiteY2" fmla="*/ 3 h 1379936"/>
              <a:gd name="connsiteX3" fmla="*/ 1413163 w 3452552"/>
              <a:gd name="connsiteY3" fmla="*/ 925486 h 1379936"/>
              <a:gd name="connsiteX4" fmla="*/ 908858 w 3452552"/>
              <a:gd name="connsiteY4" fmla="*/ 1014155 h 1379936"/>
              <a:gd name="connsiteX5" fmla="*/ 615142 w 3452552"/>
              <a:gd name="connsiteY5" fmla="*/ 820192 h 1379936"/>
              <a:gd name="connsiteX6" fmla="*/ 271550 w 3452552"/>
              <a:gd name="connsiteY6" fmla="*/ 1379916 h 1379936"/>
              <a:gd name="connsiteX7" fmla="*/ 0 w 3452552"/>
              <a:gd name="connsiteY7" fmla="*/ 798025 h 1379936"/>
              <a:gd name="connsiteX0" fmla="*/ 3452552 w 3452552"/>
              <a:gd name="connsiteY0" fmla="*/ 914403 h 1380323"/>
              <a:gd name="connsiteX1" fmla="*/ 2776451 w 3452552"/>
              <a:gd name="connsiteY1" fmla="*/ 914403 h 1380323"/>
              <a:gd name="connsiteX2" fmla="*/ 1906385 w 3452552"/>
              <a:gd name="connsiteY2" fmla="*/ 3 h 1380323"/>
              <a:gd name="connsiteX3" fmla="*/ 1413163 w 3452552"/>
              <a:gd name="connsiteY3" fmla="*/ 925486 h 1380323"/>
              <a:gd name="connsiteX4" fmla="*/ 908858 w 3452552"/>
              <a:gd name="connsiteY4" fmla="*/ 1014155 h 1380323"/>
              <a:gd name="connsiteX5" fmla="*/ 615142 w 3452552"/>
              <a:gd name="connsiteY5" fmla="*/ 892236 h 1380323"/>
              <a:gd name="connsiteX6" fmla="*/ 271550 w 3452552"/>
              <a:gd name="connsiteY6" fmla="*/ 1379916 h 1380323"/>
              <a:gd name="connsiteX7" fmla="*/ 0 w 3452552"/>
              <a:gd name="connsiteY7" fmla="*/ 798025 h 1380323"/>
              <a:gd name="connsiteX0" fmla="*/ 3452552 w 3452552"/>
              <a:gd name="connsiteY0" fmla="*/ 914403 h 1380318"/>
              <a:gd name="connsiteX1" fmla="*/ 2776451 w 3452552"/>
              <a:gd name="connsiteY1" fmla="*/ 914403 h 1380318"/>
              <a:gd name="connsiteX2" fmla="*/ 1906385 w 3452552"/>
              <a:gd name="connsiteY2" fmla="*/ 3 h 1380318"/>
              <a:gd name="connsiteX3" fmla="*/ 1413163 w 3452552"/>
              <a:gd name="connsiteY3" fmla="*/ 925486 h 1380318"/>
              <a:gd name="connsiteX4" fmla="*/ 908858 w 3452552"/>
              <a:gd name="connsiteY4" fmla="*/ 1052948 h 1380318"/>
              <a:gd name="connsiteX5" fmla="*/ 615142 w 3452552"/>
              <a:gd name="connsiteY5" fmla="*/ 892236 h 1380318"/>
              <a:gd name="connsiteX6" fmla="*/ 271550 w 3452552"/>
              <a:gd name="connsiteY6" fmla="*/ 1379916 h 1380318"/>
              <a:gd name="connsiteX7" fmla="*/ 0 w 3452552"/>
              <a:gd name="connsiteY7" fmla="*/ 798025 h 1380318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  <a:gd name="connsiteX0" fmla="*/ 3452552 w 3452552"/>
              <a:gd name="connsiteY0" fmla="*/ 931029 h 1396944"/>
              <a:gd name="connsiteX1" fmla="*/ 2776451 w 3452552"/>
              <a:gd name="connsiteY1" fmla="*/ 931029 h 1396944"/>
              <a:gd name="connsiteX2" fmla="*/ 1906385 w 3452552"/>
              <a:gd name="connsiteY2" fmla="*/ 3 h 1396944"/>
              <a:gd name="connsiteX3" fmla="*/ 1413163 w 3452552"/>
              <a:gd name="connsiteY3" fmla="*/ 942112 h 1396944"/>
              <a:gd name="connsiteX4" fmla="*/ 908858 w 3452552"/>
              <a:gd name="connsiteY4" fmla="*/ 1069574 h 1396944"/>
              <a:gd name="connsiteX5" fmla="*/ 615142 w 3452552"/>
              <a:gd name="connsiteY5" fmla="*/ 908862 h 1396944"/>
              <a:gd name="connsiteX6" fmla="*/ 271550 w 3452552"/>
              <a:gd name="connsiteY6" fmla="*/ 1396542 h 1396944"/>
              <a:gd name="connsiteX7" fmla="*/ 0 w 3452552"/>
              <a:gd name="connsiteY7" fmla="*/ 814651 h 13969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396944">
                <a:moveTo>
                  <a:pt x="3452552" y="931029"/>
                </a:moveTo>
                <a:cubicBezTo>
                  <a:pt x="3223028" y="935186"/>
                  <a:pt x="3034145" y="947655"/>
                  <a:pt x="2776451" y="931029"/>
                </a:cubicBezTo>
                <a:cubicBezTo>
                  <a:pt x="2518757" y="914403"/>
                  <a:pt x="2133600" y="-1844"/>
                  <a:pt x="1906385" y="3"/>
                </a:cubicBezTo>
                <a:cubicBezTo>
                  <a:pt x="1679170" y="1850"/>
                  <a:pt x="1579418" y="763850"/>
                  <a:pt x="1413163" y="942112"/>
                </a:cubicBezTo>
                <a:cubicBezTo>
                  <a:pt x="1246909" y="1120374"/>
                  <a:pt x="1041862" y="1075116"/>
                  <a:pt x="908858" y="1069574"/>
                </a:cubicBezTo>
                <a:cubicBezTo>
                  <a:pt x="775855" y="1064032"/>
                  <a:pt x="721360" y="854367"/>
                  <a:pt x="615142" y="908862"/>
                </a:cubicBezTo>
                <a:cubicBezTo>
                  <a:pt x="508924" y="963357"/>
                  <a:pt x="374074" y="1412244"/>
                  <a:pt x="271550" y="1396542"/>
                </a:cubicBezTo>
                <a:cubicBezTo>
                  <a:pt x="169026" y="1380840"/>
                  <a:pt x="96520" y="1034014"/>
                  <a:pt x="0" y="814651"/>
                </a:cubicBezTo>
              </a:path>
            </a:pathLst>
          </a:cu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294" name="直線コネクタ 293"/>
          <p:cNvCxnSpPr/>
          <p:nvPr/>
        </p:nvCxnSpPr>
        <p:spPr>
          <a:xfrm>
            <a:off x="5795298" y="2868079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5" name="直線コネクタ 294"/>
          <p:cNvCxnSpPr/>
          <p:nvPr/>
        </p:nvCxnSpPr>
        <p:spPr>
          <a:xfrm>
            <a:off x="6365184" y="2868079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直線コネクタ 295"/>
          <p:cNvCxnSpPr/>
          <p:nvPr/>
        </p:nvCxnSpPr>
        <p:spPr>
          <a:xfrm>
            <a:off x="6935070" y="2868079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7" name="直線コネクタ 296"/>
          <p:cNvCxnSpPr/>
          <p:nvPr/>
        </p:nvCxnSpPr>
        <p:spPr>
          <a:xfrm>
            <a:off x="7511134" y="2868079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8" name="直線コネクタ 297"/>
          <p:cNvCxnSpPr/>
          <p:nvPr/>
        </p:nvCxnSpPr>
        <p:spPr>
          <a:xfrm>
            <a:off x="8087198" y="2868079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直線コネクタ 298"/>
          <p:cNvCxnSpPr/>
          <p:nvPr/>
        </p:nvCxnSpPr>
        <p:spPr>
          <a:xfrm rot="5400000">
            <a:off x="5242878" y="1289587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0" name="直線コネクタ 299"/>
          <p:cNvCxnSpPr/>
          <p:nvPr/>
        </p:nvCxnSpPr>
        <p:spPr>
          <a:xfrm rot="5400000">
            <a:off x="5242878" y="1018181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1" name="直線コネクタ 300"/>
          <p:cNvCxnSpPr/>
          <p:nvPr/>
        </p:nvCxnSpPr>
        <p:spPr>
          <a:xfrm rot="5400000">
            <a:off x="5242878" y="1561031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2" name="直線コネクタ 301"/>
          <p:cNvCxnSpPr/>
          <p:nvPr/>
        </p:nvCxnSpPr>
        <p:spPr>
          <a:xfrm rot="5400000">
            <a:off x="5242878" y="2641113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3" name="直線コネクタ 302"/>
          <p:cNvCxnSpPr/>
          <p:nvPr/>
        </p:nvCxnSpPr>
        <p:spPr>
          <a:xfrm>
            <a:off x="5208522" y="1868437"/>
            <a:ext cx="3454740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3" name="テキスト ボックス 88"/>
          <p:cNvSpPr txBox="1">
            <a:spLocks noChangeArrowheads="1"/>
          </p:cNvSpPr>
          <p:nvPr/>
        </p:nvSpPr>
        <p:spPr bwMode="auto">
          <a:xfrm>
            <a:off x="4876016" y="665802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14" name="テキスト ボックス 88"/>
          <p:cNvSpPr txBox="1">
            <a:spLocks noChangeArrowheads="1"/>
          </p:cNvSpPr>
          <p:nvPr/>
        </p:nvSpPr>
        <p:spPr bwMode="auto">
          <a:xfrm>
            <a:off x="4876016" y="932333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315" name="テキスト ボックス 88"/>
          <p:cNvSpPr txBox="1">
            <a:spLocks noChangeArrowheads="1"/>
          </p:cNvSpPr>
          <p:nvPr/>
        </p:nvSpPr>
        <p:spPr bwMode="auto">
          <a:xfrm>
            <a:off x="4876016" y="1209281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16" name="テキスト ボックス 88"/>
          <p:cNvSpPr txBox="1">
            <a:spLocks noChangeArrowheads="1"/>
          </p:cNvSpPr>
          <p:nvPr/>
        </p:nvSpPr>
        <p:spPr bwMode="auto">
          <a:xfrm>
            <a:off x="4876016" y="1741009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17" name="テキスト ボックス 88"/>
          <p:cNvSpPr txBox="1">
            <a:spLocks noChangeArrowheads="1"/>
          </p:cNvSpPr>
          <p:nvPr/>
        </p:nvSpPr>
        <p:spPr bwMode="auto">
          <a:xfrm>
            <a:off x="4876016" y="2023499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2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18" name="テキスト ボックス 88"/>
          <p:cNvSpPr txBox="1">
            <a:spLocks noChangeArrowheads="1"/>
          </p:cNvSpPr>
          <p:nvPr/>
        </p:nvSpPr>
        <p:spPr bwMode="auto">
          <a:xfrm>
            <a:off x="4876016" y="1475145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319" name="テキスト ボックス 88"/>
          <p:cNvSpPr txBox="1">
            <a:spLocks noChangeArrowheads="1"/>
          </p:cNvSpPr>
          <p:nvPr/>
        </p:nvSpPr>
        <p:spPr bwMode="auto">
          <a:xfrm>
            <a:off x="4846838" y="2292418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0" name="テキスト ボックス 88"/>
          <p:cNvSpPr txBox="1">
            <a:spLocks noChangeArrowheads="1"/>
          </p:cNvSpPr>
          <p:nvPr/>
        </p:nvSpPr>
        <p:spPr bwMode="auto">
          <a:xfrm>
            <a:off x="5007705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1" name="テキスト ボックス 88"/>
          <p:cNvSpPr txBox="1">
            <a:spLocks noChangeArrowheads="1"/>
          </p:cNvSpPr>
          <p:nvPr/>
        </p:nvSpPr>
        <p:spPr bwMode="auto">
          <a:xfrm>
            <a:off x="5601282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2" name="テキスト ボックス 88"/>
          <p:cNvSpPr txBox="1">
            <a:spLocks noChangeArrowheads="1"/>
          </p:cNvSpPr>
          <p:nvPr/>
        </p:nvSpPr>
        <p:spPr bwMode="auto">
          <a:xfrm>
            <a:off x="6169029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4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3" name="テキスト ボックス 88"/>
          <p:cNvSpPr txBox="1">
            <a:spLocks noChangeArrowheads="1"/>
          </p:cNvSpPr>
          <p:nvPr/>
        </p:nvSpPr>
        <p:spPr bwMode="auto">
          <a:xfrm>
            <a:off x="6736776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6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4" name="テキスト ボックス 88"/>
          <p:cNvSpPr txBox="1">
            <a:spLocks noChangeArrowheads="1"/>
          </p:cNvSpPr>
          <p:nvPr/>
        </p:nvSpPr>
        <p:spPr bwMode="auto">
          <a:xfrm>
            <a:off x="7315774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8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5" name="テキスト ボックス 88"/>
          <p:cNvSpPr txBox="1">
            <a:spLocks noChangeArrowheads="1"/>
          </p:cNvSpPr>
          <p:nvPr/>
        </p:nvSpPr>
        <p:spPr bwMode="auto">
          <a:xfrm>
            <a:off x="7886672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3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6" name="テキスト ボックス 88"/>
          <p:cNvSpPr txBox="1">
            <a:spLocks noChangeArrowheads="1"/>
          </p:cNvSpPr>
          <p:nvPr/>
        </p:nvSpPr>
        <p:spPr bwMode="auto">
          <a:xfrm>
            <a:off x="8467902" y="295492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3</a:t>
            </a:r>
            <a:r>
              <a:rPr lang="en-US" altLang="ja-JP" sz="1000" b="1" dirty="0" smtClean="0">
                <a:latin typeface="Arial" charset="0"/>
                <a:cs typeface="Arial" charset="0"/>
              </a:rPr>
              <a:t>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27" name="テキスト ボックス 88"/>
          <p:cNvSpPr txBox="1">
            <a:spLocks noChangeArrowheads="1"/>
          </p:cNvSpPr>
          <p:nvPr/>
        </p:nvSpPr>
        <p:spPr bwMode="auto">
          <a:xfrm>
            <a:off x="6137816" y="3206687"/>
            <a:ext cx="159967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100" b="1" dirty="0" smtClean="0">
                <a:latin typeface="Arial" charset="0"/>
                <a:cs typeface="Arial" charset="0"/>
              </a:rPr>
              <a:t>Wavelength (nm)</a:t>
            </a:r>
            <a:endParaRPr lang="en-US" altLang="ja-JP" sz="1100" b="1" dirty="0">
              <a:latin typeface="Arial" charset="0"/>
              <a:cs typeface="Arial" charset="0"/>
            </a:endParaRPr>
          </a:p>
        </p:txBody>
      </p:sp>
      <p:sp>
        <p:nvSpPr>
          <p:cNvPr id="328" name="テキスト ボックス 88"/>
          <p:cNvSpPr txBox="1">
            <a:spLocks noChangeArrowheads="1"/>
          </p:cNvSpPr>
          <p:nvPr/>
        </p:nvSpPr>
        <p:spPr bwMode="auto">
          <a:xfrm>
            <a:off x="7943182" y="874455"/>
            <a:ext cx="66087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Arial" charset="0"/>
                <a:cs typeface="Arial" charset="0"/>
              </a:rPr>
              <a:t>42 </a:t>
            </a:r>
            <a:r>
              <a:rPr lang="en-US" altLang="ja-JP" sz="1400" b="1" baseline="30000" dirty="0" err="1" smtClean="0">
                <a:latin typeface="Arial" charset="0"/>
                <a:cs typeface="Arial" charset="0"/>
              </a:rPr>
              <a:t>o</a:t>
            </a:r>
            <a:r>
              <a:rPr lang="en-US" altLang="ja-JP" sz="1400" b="1" dirty="0" err="1" smtClean="0">
                <a:latin typeface="Arial" charset="0"/>
                <a:cs typeface="Arial" charset="0"/>
              </a:rPr>
              <a:t>C</a:t>
            </a:r>
            <a:endParaRPr lang="en-US" altLang="ja-JP" sz="1400" b="1" dirty="0">
              <a:latin typeface="Arial" charset="0"/>
              <a:cs typeface="Arial" charset="0"/>
            </a:endParaRPr>
          </a:p>
        </p:txBody>
      </p:sp>
      <p:grpSp>
        <p:nvGrpSpPr>
          <p:cNvPr id="329" name="グループ化 328"/>
          <p:cNvGrpSpPr/>
          <p:nvPr/>
        </p:nvGrpSpPr>
        <p:grpSpPr>
          <a:xfrm>
            <a:off x="5473102" y="779188"/>
            <a:ext cx="1068193" cy="925772"/>
            <a:chOff x="1248701" y="2045350"/>
            <a:chExt cx="1068193" cy="925772"/>
          </a:xfrm>
        </p:grpSpPr>
        <p:grpSp>
          <p:nvGrpSpPr>
            <p:cNvPr id="330" name="グループ化 329"/>
            <p:cNvGrpSpPr/>
            <p:nvPr/>
          </p:nvGrpSpPr>
          <p:grpSpPr>
            <a:xfrm>
              <a:off x="1248701" y="2045350"/>
              <a:ext cx="625904" cy="215444"/>
              <a:chOff x="2558800" y="476672"/>
              <a:chExt cx="690036" cy="215444"/>
            </a:xfrm>
          </p:grpSpPr>
          <p:sp>
            <p:nvSpPr>
              <p:cNvPr id="346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476672"/>
                <a:ext cx="65425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None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47" name="直線コネクタ 346"/>
              <p:cNvCxnSpPr/>
              <p:nvPr/>
            </p:nvCxnSpPr>
            <p:spPr>
              <a:xfrm>
                <a:off x="2558800" y="584394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1" name="グループ化 330"/>
            <p:cNvGrpSpPr/>
            <p:nvPr/>
          </p:nvGrpSpPr>
          <p:grpSpPr>
            <a:xfrm>
              <a:off x="1248701" y="2471548"/>
              <a:ext cx="1065091" cy="215444"/>
              <a:chOff x="2558800" y="675698"/>
              <a:chExt cx="1174223" cy="215444"/>
            </a:xfrm>
          </p:grpSpPr>
          <p:sp>
            <p:nvSpPr>
              <p:cNvPr id="344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H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45" name="直線コネクタ 344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2" name="グループ化 331"/>
            <p:cNvGrpSpPr/>
            <p:nvPr/>
          </p:nvGrpSpPr>
          <p:grpSpPr>
            <a:xfrm>
              <a:off x="1250341" y="2329482"/>
              <a:ext cx="1065091" cy="215444"/>
              <a:chOff x="2558800" y="675698"/>
              <a:chExt cx="1174223" cy="215444"/>
            </a:xfrm>
          </p:grpSpPr>
          <p:sp>
            <p:nvSpPr>
              <p:cNvPr id="342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43" name="直線コネクタ 342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3" name="グループ化 332"/>
            <p:cNvGrpSpPr/>
            <p:nvPr/>
          </p:nvGrpSpPr>
          <p:grpSpPr>
            <a:xfrm>
              <a:off x="1251803" y="2187416"/>
              <a:ext cx="1065091" cy="215444"/>
              <a:chOff x="2558800" y="675698"/>
              <a:chExt cx="1174223" cy="215444"/>
            </a:xfrm>
          </p:grpSpPr>
          <p:sp>
            <p:nvSpPr>
              <p:cNvPr id="340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N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41" name="直線コネクタ 340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4" name="グループ化 333"/>
            <p:cNvGrpSpPr/>
            <p:nvPr/>
          </p:nvGrpSpPr>
          <p:grpSpPr>
            <a:xfrm>
              <a:off x="1248701" y="2613614"/>
              <a:ext cx="1065091" cy="215444"/>
              <a:chOff x="2558800" y="675698"/>
              <a:chExt cx="1174223" cy="215444"/>
            </a:xfrm>
          </p:grpSpPr>
          <p:sp>
            <p:nvSpPr>
              <p:cNvPr id="338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APCA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39" name="直線コネクタ 338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35" name="グループ化 334"/>
            <p:cNvGrpSpPr/>
            <p:nvPr/>
          </p:nvGrpSpPr>
          <p:grpSpPr>
            <a:xfrm>
              <a:off x="1248701" y="2755678"/>
              <a:ext cx="1065091" cy="215444"/>
              <a:chOff x="2558800" y="675698"/>
              <a:chExt cx="1174223" cy="215444"/>
            </a:xfrm>
          </p:grpSpPr>
          <p:sp>
            <p:nvSpPr>
              <p:cNvPr id="336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Mg</a:t>
                </a:r>
                <a:r>
                  <a:rPr lang="en-US" altLang="ja-JP" sz="800" b="1" baseline="30000" dirty="0" smtClean="0">
                    <a:latin typeface="Arial" charset="0"/>
                    <a:cs typeface="Arial" charset="0"/>
                  </a:rPr>
                  <a:t>2+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37" name="直線コネクタ 336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48" name="正方形/長方形 347"/>
          <p:cNvSpPr/>
          <p:nvPr/>
        </p:nvSpPr>
        <p:spPr>
          <a:xfrm>
            <a:off x="5206878" y="788612"/>
            <a:ext cx="3456384" cy="21514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349" name="直線コネクタ 348"/>
          <p:cNvCxnSpPr/>
          <p:nvPr/>
        </p:nvCxnSpPr>
        <p:spPr>
          <a:xfrm rot="5400000">
            <a:off x="5242878" y="2375534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0" name="直線コネクタ 349"/>
          <p:cNvCxnSpPr/>
          <p:nvPr/>
        </p:nvCxnSpPr>
        <p:spPr>
          <a:xfrm rot="5400000">
            <a:off x="5242878" y="2109955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1" name="テキスト ボックス 88"/>
          <p:cNvSpPr txBox="1">
            <a:spLocks noChangeArrowheads="1"/>
          </p:cNvSpPr>
          <p:nvPr/>
        </p:nvSpPr>
        <p:spPr bwMode="auto">
          <a:xfrm>
            <a:off x="4849351" y="2555265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6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52" name="テキスト ボックス 88"/>
          <p:cNvSpPr txBox="1">
            <a:spLocks noChangeArrowheads="1"/>
          </p:cNvSpPr>
          <p:nvPr/>
        </p:nvSpPr>
        <p:spPr bwMode="auto">
          <a:xfrm>
            <a:off x="4851864" y="2818112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385" name="フリーフォーム 384"/>
          <p:cNvSpPr/>
          <p:nvPr/>
        </p:nvSpPr>
        <p:spPr>
          <a:xfrm>
            <a:off x="5215612" y="1048266"/>
            <a:ext cx="3452552" cy="1228599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29 h 1241422"/>
              <a:gd name="connsiteX1" fmla="*/ 2705083 w 3452552"/>
              <a:gd name="connsiteY1" fmla="*/ 959034 h 1241422"/>
              <a:gd name="connsiteX2" fmla="*/ 1906385 w 3452552"/>
              <a:gd name="connsiteY2" fmla="*/ 29 h 1241422"/>
              <a:gd name="connsiteX3" fmla="*/ 1413163 w 3452552"/>
              <a:gd name="connsiteY3" fmla="*/ 925512 h 1241422"/>
              <a:gd name="connsiteX4" fmla="*/ 908858 w 3452552"/>
              <a:gd name="connsiteY4" fmla="*/ 1014181 h 1241422"/>
              <a:gd name="connsiteX5" fmla="*/ 615142 w 3452552"/>
              <a:gd name="connsiteY5" fmla="*/ 820218 h 1241422"/>
              <a:gd name="connsiteX6" fmla="*/ 288175 w 3452552"/>
              <a:gd name="connsiteY6" fmla="*/ 1241396 h 1241422"/>
              <a:gd name="connsiteX7" fmla="*/ 0 w 3452552"/>
              <a:gd name="connsiteY7" fmla="*/ 798051 h 1241422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35017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675 h 1130668"/>
              <a:gd name="connsiteX1" fmla="*/ 2705083 w 3452552"/>
              <a:gd name="connsiteY1" fmla="*/ 848280 h 1130668"/>
              <a:gd name="connsiteX2" fmla="*/ 1835017 w 3452552"/>
              <a:gd name="connsiteY2" fmla="*/ 788 h 1130668"/>
              <a:gd name="connsiteX3" fmla="*/ 1364098 w 3452552"/>
              <a:gd name="connsiteY3" fmla="*/ 694325 h 1130668"/>
              <a:gd name="connsiteX4" fmla="*/ 908858 w 3452552"/>
              <a:gd name="connsiteY4" fmla="*/ 903427 h 1130668"/>
              <a:gd name="connsiteX5" fmla="*/ 615142 w 3452552"/>
              <a:gd name="connsiteY5" fmla="*/ 709464 h 1130668"/>
              <a:gd name="connsiteX6" fmla="*/ 288175 w 3452552"/>
              <a:gd name="connsiteY6" fmla="*/ 1130642 h 1130668"/>
              <a:gd name="connsiteX7" fmla="*/ 0 w 3452552"/>
              <a:gd name="connsiteY7" fmla="*/ 687297 h 1130668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61780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715 h 1130708"/>
              <a:gd name="connsiteX1" fmla="*/ 2705083 w 3452552"/>
              <a:gd name="connsiteY1" fmla="*/ 848320 h 1130708"/>
              <a:gd name="connsiteX2" fmla="*/ 1861780 w 3452552"/>
              <a:gd name="connsiteY2" fmla="*/ 828 h 1130708"/>
              <a:gd name="connsiteX3" fmla="*/ 1364098 w 3452552"/>
              <a:gd name="connsiteY3" fmla="*/ 694365 h 1130708"/>
              <a:gd name="connsiteX4" fmla="*/ 913318 w 3452552"/>
              <a:gd name="connsiteY4" fmla="*/ 845481 h 1130708"/>
              <a:gd name="connsiteX5" fmla="*/ 615142 w 3452552"/>
              <a:gd name="connsiteY5" fmla="*/ 709504 h 1130708"/>
              <a:gd name="connsiteX6" fmla="*/ 288175 w 3452552"/>
              <a:gd name="connsiteY6" fmla="*/ 1130682 h 1130708"/>
              <a:gd name="connsiteX7" fmla="*/ 0 w 3452552"/>
              <a:gd name="connsiteY7" fmla="*/ 687337 h 1130708"/>
              <a:gd name="connsiteX0" fmla="*/ 3452552 w 3452552"/>
              <a:gd name="connsiteY0" fmla="*/ 803715 h 1103947"/>
              <a:gd name="connsiteX1" fmla="*/ 2705083 w 3452552"/>
              <a:gd name="connsiteY1" fmla="*/ 848320 h 1103947"/>
              <a:gd name="connsiteX2" fmla="*/ 1861780 w 3452552"/>
              <a:gd name="connsiteY2" fmla="*/ 828 h 1103947"/>
              <a:gd name="connsiteX3" fmla="*/ 1364098 w 3452552"/>
              <a:gd name="connsiteY3" fmla="*/ 694365 h 1103947"/>
              <a:gd name="connsiteX4" fmla="*/ 913318 w 3452552"/>
              <a:gd name="connsiteY4" fmla="*/ 845481 h 1103947"/>
              <a:gd name="connsiteX5" fmla="*/ 615142 w 3452552"/>
              <a:gd name="connsiteY5" fmla="*/ 709504 h 1103947"/>
              <a:gd name="connsiteX6" fmla="*/ 288175 w 3452552"/>
              <a:gd name="connsiteY6" fmla="*/ 1103919 h 1103947"/>
              <a:gd name="connsiteX7" fmla="*/ 0 w 3452552"/>
              <a:gd name="connsiteY7" fmla="*/ 687337 h 1103947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88543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52 h 1188447"/>
              <a:gd name="connsiteX1" fmla="*/ 2705083 w 3452552"/>
              <a:gd name="connsiteY1" fmla="*/ 861457 h 1188447"/>
              <a:gd name="connsiteX2" fmla="*/ 1888543 w 3452552"/>
              <a:gd name="connsiteY2" fmla="*/ 583 h 1188447"/>
              <a:gd name="connsiteX3" fmla="*/ 1350716 w 3452552"/>
              <a:gd name="connsiteY3" fmla="*/ 729805 h 1188447"/>
              <a:gd name="connsiteX4" fmla="*/ 904397 w 3452552"/>
              <a:gd name="connsiteY4" fmla="*/ 885381 h 1188447"/>
              <a:gd name="connsiteX5" fmla="*/ 615142 w 3452552"/>
              <a:gd name="connsiteY5" fmla="*/ 722641 h 1188447"/>
              <a:gd name="connsiteX6" fmla="*/ 274794 w 3452552"/>
              <a:gd name="connsiteY6" fmla="*/ 1188423 h 1188447"/>
              <a:gd name="connsiteX7" fmla="*/ 0 w 3452552"/>
              <a:gd name="connsiteY7" fmla="*/ 700474 h 1188447"/>
              <a:gd name="connsiteX0" fmla="*/ 3452552 w 3452552"/>
              <a:gd name="connsiteY0" fmla="*/ 816852 h 1188818"/>
              <a:gd name="connsiteX1" fmla="*/ 2705083 w 3452552"/>
              <a:gd name="connsiteY1" fmla="*/ 861457 h 1188818"/>
              <a:gd name="connsiteX2" fmla="*/ 1888543 w 3452552"/>
              <a:gd name="connsiteY2" fmla="*/ 583 h 1188818"/>
              <a:gd name="connsiteX3" fmla="*/ 1350716 w 3452552"/>
              <a:gd name="connsiteY3" fmla="*/ 729805 h 1188818"/>
              <a:gd name="connsiteX4" fmla="*/ 904397 w 3452552"/>
              <a:gd name="connsiteY4" fmla="*/ 885381 h 1188818"/>
              <a:gd name="connsiteX5" fmla="*/ 610681 w 3452552"/>
              <a:gd name="connsiteY5" fmla="*/ 785088 h 1188818"/>
              <a:gd name="connsiteX6" fmla="*/ 274794 w 3452552"/>
              <a:gd name="connsiteY6" fmla="*/ 1188423 h 1188818"/>
              <a:gd name="connsiteX7" fmla="*/ 0 w 3452552"/>
              <a:gd name="connsiteY7" fmla="*/ 700474 h 1188818"/>
              <a:gd name="connsiteX0" fmla="*/ 3452552 w 3452552"/>
              <a:gd name="connsiteY0" fmla="*/ 816852 h 1242303"/>
              <a:gd name="connsiteX1" fmla="*/ 2705083 w 3452552"/>
              <a:gd name="connsiteY1" fmla="*/ 861457 h 1242303"/>
              <a:gd name="connsiteX2" fmla="*/ 1888543 w 3452552"/>
              <a:gd name="connsiteY2" fmla="*/ 583 h 1242303"/>
              <a:gd name="connsiteX3" fmla="*/ 1350716 w 3452552"/>
              <a:gd name="connsiteY3" fmla="*/ 729805 h 1242303"/>
              <a:gd name="connsiteX4" fmla="*/ 904397 w 3452552"/>
              <a:gd name="connsiteY4" fmla="*/ 885381 h 1242303"/>
              <a:gd name="connsiteX5" fmla="*/ 610681 w 3452552"/>
              <a:gd name="connsiteY5" fmla="*/ 785088 h 1242303"/>
              <a:gd name="connsiteX6" fmla="*/ 270334 w 3452552"/>
              <a:gd name="connsiteY6" fmla="*/ 1241949 h 1242303"/>
              <a:gd name="connsiteX7" fmla="*/ 0 w 3452552"/>
              <a:gd name="connsiteY7" fmla="*/ 700474 h 1242303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071 h 1255522"/>
              <a:gd name="connsiteX1" fmla="*/ 2705083 w 3452552"/>
              <a:gd name="connsiteY1" fmla="*/ 874676 h 1255522"/>
              <a:gd name="connsiteX2" fmla="*/ 1884083 w 3452552"/>
              <a:gd name="connsiteY2" fmla="*/ 420 h 1255522"/>
              <a:gd name="connsiteX3" fmla="*/ 1377478 w 3452552"/>
              <a:gd name="connsiteY3" fmla="*/ 760866 h 1255522"/>
              <a:gd name="connsiteX4" fmla="*/ 904397 w 3452552"/>
              <a:gd name="connsiteY4" fmla="*/ 898600 h 1255522"/>
              <a:gd name="connsiteX5" fmla="*/ 610681 w 3452552"/>
              <a:gd name="connsiteY5" fmla="*/ 798307 h 1255522"/>
              <a:gd name="connsiteX6" fmla="*/ 270334 w 3452552"/>
              <a:gd name="connsiteY6" fmla="*/ 1255168 h 1255522"/>
              <a:gd name="connsiteX7" fmla="*/ 0 w 3452552"/>
              <a:gd name="connsiteY7" fmla="*/ 713693 h 1255522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77478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64097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33227"/>
              <a:gd name="connsiteX1" fmla="*/ 2705083 w 3452552"/>
              <a:gd name="connsiteY1" fmla="*/ 874668 h 1233227"/>
              <a:gd name="connsiteX2" fmla="*/ 1884083 w 3452552"/>
              <a:gd name="connsiteY2" fmla="*/ 412 h 1233227"/>
              <a:gd name="connsiteX3" fmla="*/ 1364097 w 3452552"/>
              <a:gd name="connsiteY3" fmla="*/ 760858 h 1233227"/>
              <a:gd name="connsiteX4" fmla="*/ 904397 w 3452552"/>
              <a:gd name="connsiteY4" fmla="*/ 898592 h 1233227"/>
              <a:gd name="connsiteX5" fmla="*/ 610681 w 3452552"/>
              <a:gd name="connsiteY5" fmla="*/ 798299 h 1233227"/>
              <a:gd name="connsiteX6" fmla="*/ 274794 w 3452552"/>
              <a:gd name="connsiteY6" fmla="*/ 1232857 h 1233227"/>
              <a:gd name="connsiteX7" fmla="*/ 0 w 3452552"/>
              <a:gd name="connsiteY7" fmla="*/ 713685 h 1233227"/>
              <a:gd name="connsiteX0" fmla="*/ 3452552 w 3452552"/>
              <a:gd name="connsiteY0" fmla="*/ 830063 h 1233080"/>
              <a:gd name="connsiteX1" fmla="*/ 2705083 w 3452552"/>
              <a:gd name="connsiteY1" fmla="*/ 874668 h 1233080"/>
              <a:gd name="connsiteX2" fmla="*/ 1884083 w 3452552"/>
              <a:gd name="connsiteY2" fmla="*/ 412 h 1233080"/>
              <a:gd name="connsiteX3" fmla="*/ 1364097 w 3452552"/>
              <a:gd name="connsiteY3" fmla="*/ 760858 h 1233080"/>
              <a:gd name="connsiteX4" fmla="*/ 904397 w 3452552"/>
              <a:gd name="connsiteY4" fmla="*/ 898592 h 1233080"/>
              <a:gd name="connsiteX5" fmla="*/ 606221 w 3452552"/>
              <a:gd name="connsiteY5" fmla="*/ 780458 h 1233080"/>
              <a:gd name="connsiteX6" fmla="*/ 274794 w 3452552"/>
              <a:gd name="connsiteY6" fmla="*/ 1232857 h 1233080"/>
              <a:gd name="connsiteX7" fmla="*/ 0 w 3452552"/>
              <a:gd name="connsiteY7" fmla="*/ 713685 h 1233080"/>
              <a:gd name="connsiteX0" fmla="*/ 3452552 w 3452552"/>
              <a:gd name="connsiteY0" fmla="*/ 830069 h 1233087"/>
              <a:gd name="connsiteX1" fmla="*/ 2705083 w 3452552"/>
              <a:gd name="connsiteY1" fmla="*/ 874674 h 1233087"/>
              <a:gd name="connsiteX2" fmla="*/ 1884083 w 3452552"/>
              <a:gd name="connsiteY2" fmla="*/ 418 h 1233087"/>
              <a:gd name="connsiteX3" fmla="*/ 1364097 w 3452552"/>
              <a:gd name="connsiteY3" fmla="*/ 760864 h 1233087"/>
              <a:gd name="connsiteX4" fmla="*/ 904397 w 3452552"/>
              <a:gd name="connsiteY4" fmla="*/ 885217 h 1233087"/>
              <a:gd name="connsiteX5" fmla="*/ 606221 w 3452552"/>
              <a:gd name="connsiteY5" fmla="*/ 780464 h 1233087"/>
              <a:gd name="connsiteX6" fmla="*/ 274794 w 3452552"/>
              <a:gd name="connsiteY6" fmla="*/ 1232863 h 1233087"/>
              <a:gd name="connsiteX7" fmla="*/ 0 w 3452552"/>
              <a:gd name="connsiteY7" fmla="*/ 713691 h 1233087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42"/>
              <a:gd name="connsiteX1" fmla="*/ 2705083 w 3452552"/>
              <a:gd name="connsiteY1" fmla="*/ 865759 h 1224142"/>
              <a:gd name="connsiteX2" fmla="*/ 1884083 w 3452552"/>
              <a:gd name="connsiteY2" fmla="*/ 424 h 1224142"/>
              <a:gd name="connsiteX3" fmla="*/ 1364097 w 3452552"/>
              <a:gd name="connsiteY3" fmla="*/ 751949 h 1224142"/>
              <a:gd name="connsiteX4" fmla="*/ 904397 w 3452552"/>
              <a:gd name="connsiteY4" fmla="*/ 876302 h 1224142"/>
              <a:gd name="connsiteX5" fmla="*/ 606221 w 3452552"/>
              <a:gd name="connsiteY5" fmla="*/ 767089 h 1224142"/>
              <a:gd name="connsiteX6" fmla="*/ 274794 w 3452552"/>
              <a:gd name="connsiteY6" fmla="*/ 1223948 h 1224142"/>
              <a:gd name="connsiteX7" fmla="*/ 0 w 3452552"/>
              <a:gd name="connsiteY7" fmla="*/ 704776 h 1224142"/>
              <a:gd name="connsiteX0" fmla="*/ 3452552 w 3452552"/>
              <a:gd name="connsiteY0" fmla="*/ 821153 h 1224141"/>
              <a:gd name="connsiteX1" fmla="*/ 2705083 w 3452552"/>
              <a:gd name="connsiteY1" fmla="*/ 865758 h 1224141"/>
              <a:gd name="connsiteX2" fmla="*/ 1884083 w 3452552"/>
              <a:gd name="connsiteY2" fmla="*/ 423 h 1224141"/>
              <a:gd name="connsiteX3" fmla="*/ 1364097 w 3452552"/>
              <a:gd name="connsiteY3" fmla="*/ 751948 h 1224141"/>
              <a:gd name="connsiteX4" fmla="*/ 904397 w 3452552"/>
              <a:gd name="connsiteY4" fmla="*/ 871840 h 1224141"/>
              <a:gd name="connsiteX5" fmla="*/ 606221 w 3452552"/>
              <a:gd name="connsiteY5" fmla="*/ 767088 h 1224141"/>
              <a:gd name="connsiteX6" fmla="*/ 274794 w 3452552"/>
              <a:gd name="connsiteY6" fmla="*/ 1223947 h 1224141"/>
              <a:gd name="connsiteX7" fmla="*/ 0 w 3452552"/>
              <a:gd name="connsiteY7" fmla="*/ 704775 h 1224141"/>
              <a:gd name="connsiteX0" fmla="*/ 3452552 w 3452552"/>
              <a:gd name="connsiteY0" fmla="*/ 821153 h 1228599"/>
              <a:gd name="connsiteX1" fmla="*/ 2705083 w 3452552"/>
              <a:gd name="connsiteY1" fmla="*/ 865758 h 1228599"/>
              <a:gd name="connsiteX2" fmla="*/ 1884083 w 3452552"/>
              <a:gd name="connsiteY2" fmla="*/ 423 h 1228599"/>
              <a:gd name="connsiteX3" fmla="*/ 1364097 w 3452552"/>
              <a:gd name="connsiteY3" fmla="*/ 751948 h 1228599"/>
              <a:gd name="connsiteX4" fmla="*/ 904397 w 3452552"/>
              <a:gd name="connsiteY4" fmla="*/ 871840 h 1228599"/>
              <a:gd name="connsiteX5" fmla="*/ 606221 w 3452552"/>
              <a:gd name="connsiteY5" fmla="*/ 767088 h 1228599"/>
              <a:gd name="connsiteX6" fmla="*/ 274794 w 3452552"/>
              <a:gd name="connsiteY6" fmla="*/ 1228407 h 1228599"/>
              <a:gd name="connsiteX7" fmla="*/ 0 w 3452552"/>
              <a:gd name="connsiteY7" fmla="*/ 704775 h 12285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228599">
                <a:moveTo>
                  <a:pt x="3452552" y="821153"/>
                </a:moveTo>
                <a:cubicBezTo>
                  <a:pt x="3223028" y="825310"/>
                  <a:pt x="2966494" y="891034"/>
                  <a:pt x="2705083" y="865758"/>
                </a:cubicBezTo>
                <a:cubicBezTo>
                  <a:pt x="2443672" y="840482"/>
                  <a:pt x="2107581" y="19391"/>
                  <a:pt x="1884083" y="423"/>
                </a:cubicBezTo>
                <a:cubicBezTo>
                  <a:pt x="1660585" y="-18545"/>
                  <a:pt x="1527378" y="606712"/>
                  <a:pt x="1364097" y="751948"/>
                </a:cubicBezTo>
                <a:cubicBezTo>
                  <a:pt x="1200816" y="897184"/>
                  <a:pt x="1030710" y="869317"/>
                  <a:pt x="904397" y="871840"/>
                </a:cubicBezTo>
                <a:cubicBezTo>
                  <a:pt x="778084" y="874363"/>
                  <a:pt x="711155" y="707660"/>
                  <a:pt x="606221" y="767088"/>
                </a:cubicBezTo>
                <a:cubicBezTo>
                  <a:pt x="501287" y="826516"/>
                  <a:pt x="375831" y="1238792"/>
                  <a:pt x="274794" y="1228407"/>
                </a:cubicBezTo>
                <a:cubicBezTo>
                  <a:pt x="173757" y="1218022"/>
                  <a:pt x="96520" y="924138"/>
                  <a:pt x="0" y="704775"/>
                </a:cubicBezTo>
              </a:path>
            </a:pathLst>
          </a:custGeom>
          <a:noFill/>
          <a:ln w="127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6" name="フリーフォーム 385"/>
          <p:cNvSpPr/>
          <p:nvPr/>
        </p:nvSpPr>
        <p:spPr>
          <a:xfrm>
            <a:off x="5215612" y="1052049"/>
            <a:ext cx="3452552" cy="1217117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29 h 1241422"/>
              <a:gd name="connsiteX1" fmla="*/ 2705083 w 3452552"/>
              <a:gd name="connsiteY1" fmla="*/ 959034 h 1241422"/>
              <a:gd name="connsiteX2" fmla="*/ 1906385 w 3452552"/>
              <a:gd name="connsiteY2" fmla="*/ 29 h 1241422"/>
              <a:gd name="connsiteX3" fmla="*/ 1413163 w 3452552"/>
              <a:gd name="connsiteY3" fmla="*/ 925512 h 1241422"/>
              <a:gd name="connsiteX4" fmla="*/ 908858 w 3452552"/>
              <a:gd name="connsiteY4" fmla="*/ 1014181 h 1241422"/>
              <a:gd name="connsiteX5" fmla="*/ 615142 w 3452552"/>
              <a:gd name="connsiteY5" fmla="*/ 820218 h 1241422"/>
              <a:gd name="connsiteX6" fmla="*/ 288175 w 3452552"/>
              <a:gd name="connsiteY6" fmla="*/ 1241396 h 1241422"/>
              <a:gd name="connsiteX7" fmla="*/ 0 w 3452552"/>
              <a:gd name="connsiteY7" fmla="*/ 798051 h 1241422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35017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675 h 1130668"/>
              <a:gd name="connsiteX1" fmla="*/ 2705083 w 3452552"/>
              <a:gd name="connsiteY1" fmla="*/ 848280 h 1130668"/>
              <a:gd name="connsiteX2" fmla="*/ 1835017 w 3452552"/>
              <a:gd name="connsiteY2" fmla="*/ 788 h 1130668"/>
              <a:gd name="connsiteX3" fmla="*/ 1364098 w 3452552"/>
              <a:gd name="connsiteY3" fmla="*/ 694325 h 1130668"/>
              <a:gd name="connsiteX4" fmla="*/ 908858 w 3452552"/>
              <a:gd name="connsiteY4" fmla="*/ 903427 h 1130668"/>
              <a:gd name="connsiteX5" fmla="*/ 615142 w 3452552"/>
              <a:gd name="connsiteY5" fmla="*/ 709464 h 1130668"/>
              <a:gd name="connsiteX6" fmla="*/ 288175 w 3452552"/>
              <a:gd name="connsiteY6" fmla="*/ 1130642 h 1130668"/>
              <a:gd name="connsiteX7" fmla="*/ 0 w 3452552"/>
              <a:gd name="connsiteY7" fmla="*/ 687297 h 1130668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61780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715 h 1130708"/>
              <a:gd name="connsiteX1" fmla="*/ 2705083 w 3452552"/>
              <a:gd name="connsiteY1" fmla="*/ 848320 h 1130708"/>
              <a:gd name="connsiteX2" fmla="*/ 1861780 w 3452552"/>
              <a:gd name="connsiteY2" fmla="*/ 828 h 1130708"/>
              <a:gd name="connsiteX3" fmla="*/ 1364098 w 3452552"/>
              <a:gd name="connsiteY3" fmla="*/ 694365 h 1130708"/>
              <a:gd name="connsiteX4" fmla="*/ 913318 w 3452552"/>
              <a:gd name="connsiteY4" fmla="*/ 845481 h 1130708"/>
              <a:gd name="connsiteX5" fmla="*/ 615142 w 3452552"/>
              <a:gd name="connsiteY5" fmla="*/ 709504 h 1130708"/>
              <a:gd name="connsiteX6" fmla="*/ 288175 w 3452552"/>
              <a:gd name="connsiteY6" fmla="*/ 1130682 h 1130708"/>
              <a:gd name="connsiteX7" fmla="*/ 0 w 3452552"/>
              <a:gd name="connsiteY7" fmla="*/ 687337 h 1130708"/>
              <a:gd name="connsiteX0" fmla="*/ 3452552 w 3452552"/>
              <a:gd name="connsiteY0" fmla="*/ 803715 h 1103947"/>
              <a:gd name="connsiteX1" fmla="*/ 2705083 w 3452552"/>
              <a:gd name="connsiteY1" fmla="*/ 848320 h 1103947"/>
              <a:gd name="connsiteX2" fmla="*/ 1861780 w 3452552"/>
              <a:gd name="connsiteY2" fmla="*/ 828 h 1103947"/>
              <a:gd name="connsiteX3" fmla="*/ 1364098 w 3452552"/>
              <a:gd name="connsiteY3" fmla="*/ 694365 h 1103947"/>
              <a:gd name="connsiteX4" fmla="*/ 913318 w 3452552"/>
              <a:gd name="connsiteY4" fmla="*/ 845481 h 1103947"/>
              <a:gd name="connsiteX5" fmla="*/ 615142 w 3452552"/>
              <a:gd name="connsiteY5" fmla="*/ 709504 h 1103947"/>
              <a:gd name="connsiteX6" fmla="*/ 288175 w 3452552"/>
              <a:gd name="connsiteY6" fmla="*/ 1103919 h 1103947"/>
              <a:gd name="connsiteX7" fmla="*/ 0 w 3452552"/>
              <a:gd name="connsiteY7" fmla="*/ 687337 h 1103947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88543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52 h 1188447"/>
              <a:gd name="connsiteX1" fmla="*/ 2705083 w 3452552"/>
              <a:gd name="connsiteY1" fmla="*/ 861457 h 1188447"/>
              <a:gd name="connsiteX2" fmla="*/ 1888543 w 3452552"/>
              <a:gd name="connsiteY2" fmla="*/ 583 h 1188447"/>
              <a:gd name="connsiteX3" fmla="*/ 1350716 w 3452552"/>
              <a:gd name="connsiteY3" fmla="*/ 729805 h 1188447"/>
              <a:gd name="connsiteX4" fmla="*/ 904397 w 3452552"/>
              <a:gd name="connsiteY4" fmla="*/ 885381 h 1188447"/>
              <a:gd name="connsiteX5" fmla="*/ 615142 w 3452552"/>
              <a:gd name="connsiteY5" fmla="*/ 722641 h 1188447"/>
              <a:gd name="connsiteX6" fmla="*/ 274794 w 3452552"/>
              <a:gd name="connsiteY6" fmla="*/ 1188423 h 1188447"/>
              <a:gd name="connsiteX7" fmla="*/ 0 w 3452552"/>
              <a:gd name="connsiteY7" fmla="*/ 700474 h 1188447"/>
              <a:gd name="connsiteX0" fmla="*/ 3452552 w 3452552"/>
              <a:gd name="connsiteY0" fmla="*/ 816852 h 1188818"/>
              <a:gd name="connsiteX1" fmla="*/ 2705083 w 3452552"/>
              <a:gd name="connsiteY1" fmla="*/ 861457 h 1188818"/>
              <a:gd name="connsiteX2" fmla="*/ 1888543 w 3452552"/>
              <a:gd name="connsiteY2" fmla="*/ 583 h 1188818"/>
              <a:gd name="connsiteX3" fmla="*/ 1350716 w 3452552"/>
              <a:gd name="connsiteY3" fmla="*/ 729805 h 1188818"/>
              <a:gd name="connsiteX4" fmla="*/ 904397 w 3452552"/>
              <a:gd name="connsiteY4" fmla="*/ 885381 h 1188818"/>
              <a:gd name="connsiteX5" fmla="*/ 610681 w 3452552"/>
              <a:gd name="connsiteY5" fmla="*/ 785088 h 1188818"/>
              <a:gd name="connsiteX6" fmla="*/ 274794 w 3452552"/>
              <a:gd name="connsiteY6" fmla="*/ 1188423 h 1188818"/>
              <a:gd name="connsiteX7" fmla="*/ 0 w 3452552"/>
              <a:gd name="connsiteY7" fmla="*/ 700474 h 1188818"/>
              <a:gd name="connsiteX0" fmla="*/ 3452552 w 3452552"/>
              <a:gd name="connsiteY0" fmla="*/ 816852 h 1242303"/>
              <a:gd name="connsiteX1" fmla="*/ 2705083 w 3452552"/>
              <a:gd name="connsiteY1" fmla="*/ 861457 h 1242303"/>
              <a:gd name="connsiteX2" fmla="*/ 1888543 w 3452552"/>
              <a:gd name="connsiteY2" fmla="*/ 583 h 1242303"/>
              <a:gd name="connsiteX3" fmla="*/ 1350716 w 3452552"/>
              <a:gd name="connsiteY3" fmla="*/ 729805 h 1242303"/>
              <a:gd name="connsiteX4" fmla="*/ 904397 w 3452552"/>
              <a:gd name="connsiteY4" fmla="*/ 885381 h 1242303"/>
              <a:gd name="connsiteX5" fmla="*/ 610681 w 3452552"/>
              <a:gd name="connsiteY5" fmla="*/ 785088 h 1242303"/>
              <a:gd name="connsiteX6" fmla="*/ 270334 w 3452552"/>
              <a:gd name="connsiteY6" fmla="*/ 1241949 h 1242303"/>
              <a:gd name="connsiteX7" fmla="*/ 0 w 3452552"/>
              <a:gd name="connsiteY7" fmla="*/ 700474 h 1242303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071 h 1255522"/>
              <a:gd name="connsiteX1" fmla="*/ 2705083 w 3452552"/>
              <a:gd name="connsiteY1" fmla="*/ 874676 h 1255522"/>
              <a:gd name="connsiteX2" fmla="*/ 1884083 w 3452552"/>
              <a:gd name="connsiteY2" fmla="*/ 420 h 1255522"/>
              <a:gd name="connsiteX3" fmla="*/ 1377478 w 3452552"/>
              <a:gd name="connsiteY3" fmla="*/ 760866 h 1255522"/>
              <a:gd name="connsiteX4" fmla="*/ 904397 w 3452552"/>
              <a:gd name="connsiteY4" fmla="*/ 898600 h 1255522"/>
              <a:gd name="connsiteX5" fmla="*/ 610681 w 3452552"/>
              <a:gd name="connsiteY5" fmla="*/ 798307 h 1255522"/>
              <a:gd name="connsiteX6" fmla="*/ 270334 w 3452552"/>
              <a:gd name="connsiteY6" fmla="*/ 1255168 h 1255522"/>
              <a:gd name="connsiteX7" fmla="*/ 0 w 3452552"/>
              <a:gd name="connsiteY7" fmla="*/ 713693 h 1255522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77478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64097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33227"/>
              <a:gd name="connsiteX1" fmla="*/ 2705083 w 3452552"/>
              <a:gd name="connsiteY1" fmla="*/ 874668 h 1233227"/>
              <a:gd name="connsiteX2" fmla="*/ 1884083 w 3452552"/>
              <a:gd name="connsiteY2" fmla="*/ 412 h 1233227"/>
              <a:gd name="connsiteX3" fmla="*/ 1364097 w 3452552"/>
              <a:gd name="connsiteY3" fmla="*/ 760858 h 1233227"/>
              <a:gd name="connsiteX4" fmla="*/ 904397 w 3452552"/>
              <a:gd name="connsiteY4" fmla="*/ 898592 h 1233227"/>
              <a:gd name="connsiteX5" fmla="*/ 610681 w 3452552"/>
              <a:gd name="connsiteY5" fmla="*/ 798299 h 1233227"/>
              <a:gd name="connsiteX6" fmla="*/ 274794 w 3452552"/>
              <a:gd name="connsiteY6" fmla="*/ 1232857 h 1233227"/>
              <a:gd name="connsiteX7" fmla="*/ 0 w 3452552"/>
              <a:gd name="connsiteY7" fmla="*/ 713685 h 1233227"/>
              <a:gd name="connsiteX0" fmla="*/ 3452552 w 3452552"/>
              <a:gd name="connsiteY0" fmla="*/ 830063 h 1233080"/>
              <a:gd name="connsiteX1" fmla="*/ 2705083 w 3452552"/>
              <a:gd name="connsiteY1" fmla="*/ 874668 h 1233080"/>
              <a:gd name="connsiteX2" fmla="*/ 1884083 w 3452552"/>
              <a:gd name="connsiteY2" fmla="*/ 412 h 1233080"/>
              <a:gd name="connsiteX3" fmla="*/ 1364097 w 3452552"/>
              <a:gd name="connsiteY3" fmla="*/ 760858 h 1233080"/>
              <a:gd name="connsiteX4" fmla="*/ 904397 w 3452552"/>
              <a:gd name="connsiteY4" fmla="*/ 898592 h 1233080"/>
              <a:gd name="connsiteX5" fmla="*/ 606221 w 3452552"/>
              <a:gd name="connsiteY5" fmla="*/ 780458 h 1233080"/>
              <a:gd name="connsiteX6" fmla="*/ 274794 w 3452552"/>
              <a:gd name="connsiteY6" fmla="*/ 1232857 h 1233080"/>
              <a:gd name="connsiteX7" fmla="*/ 0 w 3452552"/>
              <a:gd name="connsiteY7" fmla="*/ 713685 h 1233080"/>
              <a:gd name="connsiteX0" fmla="*/ 3452552 w 3452552"/>
              <a:gd name="connsiteY0" fmla="*/ 830069 h 1233087"/>
              <a:gd name="connsiteX1" fmla="*/ 2705083 w 3452552"/>
              <a:gd name="connsiteY1" fmla="*/ 874674 h 1233087"/>
              <a:gd name="connsiteX2" fmla="*/ 1884083 w 3452552"/>
              <a:gd name="connsiteY2" fmla="*/ 418 h 1233087"/>
              <a:gd name="connsiteX3" fmla="*/ 1364097 w 3452552"/>
              <a:gd name="connsiteY3" fmla="*/ 760864 h 1233087"/>
              <a:gd name="connsiteX4" fmla="*/ 904397 w 3452552"/>
              <a:gd name="connsiteY4" fmla="*/ 885217 h 1233087"/>
              <a:gd name="connsiteX5" fmla="*/ 606221 w 3452552"/>
              <a:gd name="connsiteY5" fmla="*/ 780464 h 1233087"/>
              <a:gd name="connsiteX6" fmla="*/ 274794 w 3452552"/>
              <a:gd name="connsiteY6" fmla="*/ 1232863 h 1233087"/>
              <a:gd name="connsiteX7" fmla="*/ 0 w 3452552"/>
              <a:gd name="connsiteY7" fmla="*/ 713691 h 1233087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42"/>
              <a:gd name="connsiteX1" fmla="*/ 2705083 w 3452552"/>
              <a:gd name="connsiteY1" fmla="*/ 865759 h 1224142"/>
              <a:gd name="connsiteX2" fmla="*/ 1884083 w 3452552"/>
              <a:gd name="connsiteY2" fmla="*/ 424 h 1224142"/>
              <a:gd name="connsiteX3" fmla="*/ 1364097 w 3452552"/>
              <a:gd name="connsiteY3" fmla="*/ 751949 h 1224142"/>
              <a:gd name="connsiteX4" fmla="*/ 904397 w 3452552"/>
              <a:gd name="connsiteY4" fmla="*/ 876302 h 1224142"/>
              <a:gd name="connsiteX5" fmla="*/ 606221 w 3452552"/>
              <a:gd name="connsiteY5" fmla="*/ 767089 h 1224142"/>
              <a:gd name="connsiteX6" fmla="*/ 274794 w 3452552"/>
              <a:gd name="connsiteY6" fmla="*/ 1223948 h 1224142"/>
              <a:gd name="connsiteX7" fmla="*/ 0 w 3452552"/>
              <a:gd name="connsiteY7" fmla="*/ 704776 h 1224142"/>
              <a:gd name="connsiteX0" fmla="*/ 3452552 w 3452552"/>
              <a:gd name="connsiteY0" fmla="*/ 821153 h 1224141"/>
              <a:gd name="connsiteX1" fmla="*/ 2705083 w 3452552"/>
              <a:gd name="connsiteY1" fmla="*/ 865758 h 1224141"/>
              <a:gd name="connsiteX2" fmla="*/ 1884083 w 3452552"/>
              <a:gd name="connsiteY2" fmla="*/ 423 h 1224141"/>
              <a:gd name="connsiteX3" fmla="*/ 1364097 w 3452552"/>
              <a:gd name="connsiteY3" fmla="*/ 751948 h 1224141"/>
              <a:gd name="connsiteX4" fmla="*/ 904397 w 3452552"/>
              <a:gd name="connsiteY4" fmla="*/ 871840 h 1224141"/>
              <a:gd name="connsiteX5" fmla="*/ 606221 w 3452552"/>
              <a:gd name="connsiteY5" fmla="*/ 767088 h 1224141"/>
              <a:gd name="connsiteX6" fmla="*/ 274794 w 3452552"/>
              <a:gd name="connsiteY6" fmla="*/ 1223947 h 1224141"/>
              <a:gd name="connsiteX7" fmla="*/ 0 w 3452552"/>
              <a:gd name="connsiteY7" fmla="*/ 704775 h 1224141"/>
              <a:gd name="connsiteX0" fmla="*/ 3452552 w 3452552"/>
              <a:gd name="connsiteY0" fmla="*/ 821153 h 1215224"/>
              <a:gd name="connsiteX1" fmla="*/ 2705083 w 3452552"/>
              <a:gd name="connsiteY1" fmla="*/ 865758 h 1215224"/>
              <a:gd name="connsiteX2" fmla="*/ 1884083 w 3452552"/>
              <a:gd name="connsiteY2" fmla="*/ 423 h 1215224"/>
              <a:gd name="connsiteX3" fmla="*/ 1364097 w 3452552"/>
              <a:gd name="connsiteY3" fmla="*/ 751948 h 1215224"/>
              <a:gd name="connsiteX4" fmla="*/ 904397 w 3452552"/>
              <a:gd name="connsiteY4" fmla="*/ 871840 h 1215224"/>
              <a:gd name="connsiteX5" fmla="*/ 606221 w 3452552"/>
              <a:gd name="connsiteY5" fmla="*/ 767088 h 1215224"/>
              <a:gd name="connsiteX6" fmla="*/ 274794 w 3452552"/>
              <a:gd name="connsiteY6" fmla="*/ 1215026 h 1215224"/>
              <a:gd name="connsiteX7" fmla="*/ 0 w 3452552"/>
              <a:gd name="connsiteY7" fmla="*/ 704775 h 1215224"/>
              <a:gd name="connsiteX0" fmla="*/ 3452552 w 3452552"/>
              <a:gd name="connsiteY0" fmla="*/ 821153 h 1215145"/>
              <a:gd name="connsiteX1" fmla="*/ 2705083 w 3452552"/>
              <a:gd name="connsiteY1" fmla="*/ 865758 h 1215145"/>
              <a:gd name="connsiteX2" fmla="*/ 1884083 w 3452552"/>
              <a:gd name="connsiteY2" fmla="*/ 423 h 1215145"/>
              <a:gd name="connsiteX3" fmla="*/ 1364097 w 3452552"/>
              <a:gd name="connsiteY3" fmla="*/ 751948 h 1215145"/>
              <a:gd name="connsiteX4" fmla="*/ 904397 w 3452552"/>
              <a:gd name="connsiteY4" fmla="*/ 871840 h 1215145"/>
              <a:gd name="connsiteX5" fmla="*/ 606221 w 3452552"/>
              <a:gd name="connsiteY5" fmla="*/ 753706 h 1215145"/>
              <a:gd name="connsiteX6" fmla="*/ 274794 w 3452552"/>
              <a:gd name="connsiteY6" fmla="*/ 1215026 h 1215145"/>
              <a:gd name="connsiteX7" fmla="*/ 0 w 3452552"/>
              <a:gd name="connsiteY7" fmla="*/ 704775 h 1215145"/>
              <a:gd name="connsiteX0" fmla="*/ 3452552 w 3452552"/>
              <a:gd name="connsiteY0" fmla="*/ 821152 h 1215144"/>
              <a:gd name="connsiteX1" fmla="*/ 2705083 w 3452552"/>
              <a:gd name="connsiteY1" fmla="*/ 865757 h 1215144"/>
              <a:gd name="connsiteX2" fmla="*/ 1884083 w 3452552"/>
              <a:gd name="connsiteY2" fmla="*/ 422 h 1215144"/>
              <a:gd name="connsiteX3" fmla="*/ 1364097 w 3452552"/>
              <a:gd name="connsiteY3" fmla="*/ 751947 h 1215144"/>
              <a:gd name="connsiteX4" fmla="*/ 899937 w 3452552"/>
              <a:gd name="connsiteY4" fmla="*/ 862918 h 1215144"/>
              <a:gd name="connsiteX5" fmla="*/ 606221 w 3452552"/>
              <a:gd name="connsiteY5" fmla="*/ 753705 h 1215144"/>
              <a:gd name="connsiteX6" fmla="*/ 274794 w 3452552"/>
              <a:gd name="connsiteY6" fmla="*/ 1215025 h 1215144"/>
              <a:gd name="connsiteX7" fmla="*/ 0 w 3452552"/>
              <a:gd name="connsiteY7" fmla="*/ 704774 h 1215144"/>
              <a:gd name="connsiteX0" fmla="*/ 3452552 w 3452552"/>
              <a:gd name="connsiteY0" fmla="*/ 821187 h 1215179"/>
              <a:gd name="connsiteX1" fmla="*/ 2705083 w 3452552"/>
              <a:gd name="connsiteY1" fmla="*/ 865792 h 1215179"/>
              <a:gd name="connsiteX2" fmla="*/ 1884083 w 3452552"/>
              <a:gd name="connsiteY2" fmla="*/ 457 h 1215179"/>
              <a:gd name="connsiteX3" fmla="*/ 1359636 w 3452552"/>
              <a:gd name="connsiteY3" fmla="*/ 747522 h 1215179"/>
              <a:gd name="connsiteX4" fmla="*/ 899937 w 3452552"/>
              <a:gd name="connsiteY4" fmla="*/ 862953 h 1215179"/>
              <a:gd name="connsiteX5" fmla="*/ 606221 w 3452552"/>
              <a:gd name="connsiteY5" fmla="*/ 753740 h 1215179"/>
              <a:gd name="connsiteX6" fmla="*/ 274794 w 3452552"/>
              <a:gd name="connsiteY6" fmla="*/ 1215060 h 1215179"/>
              <a:gd name="connsiteX7" fmla="*/ 0 w 3452552"/>
              <a:gd name="connsiteY7" fmla="*/ 704809 h 1215179"/>
              <a:gd name="connsiteX0" fmla="*/ 3452552 w 3452552"/>
              <a:gd name="connsiteY0" fmla="*/ 816731 h 1210723"/>
              <a:gd name="connsiteX1" fmla="*/ 2705083 w 3452552"/>
              <a:gd name="connsiteY1" fmla="*/ 861336 h 1210723"/>
              <a:gd name="connsiteX2" fmla="*/ 1884083 w 3452552"/>
              <a:gd name="connsiteY2" fmla="*/ 461 h 1210723"/>
              <a:gd name="connsiteX3" fmla="*/ 1359636 w 3452552"/>
              <a:gd name="connsiteY3" fmla="*/ 743066 h 1210723"/>
              <a:gd name="connsiteX4" fmla="*/ 899937 w 3452552"/>
              <a:gd name="connsiteY4" fmla="*/ 858497 h 1210723"/>
              <a:gd name="connsiteX5" fmla="*/ 606221 w 3452552"/>
              <a:gd name="connsiteY5" fmla="*/ 749284 h 1210723"/>
              <a:gd name="connsiteX6" fmla="*/ 274794 w 3452552"/>
              <a:gd name="connsiteY6" fmla="*/ 1210604 h 1210723"/>
              <a:gd name="connsiteX7" fmla="*/ 0 w 3452552"/>
              <a:gd name="connsiteY7" fmla="*/ 700353 h 1210723"/>
              <a:gd name="connsiteX0" fmla="*/ 3452552 w 3452552"/>
              <a:gd name="connsiteY0" fmla="*/ 816731 h 1210723"/>
              <a:gd name="connsiteX1" fmla="*/ 2705083 w 3452552"/>
              <a:gd name="connsiteY1" fmla="*/ 861336 h 1210723"/>
              <a:gd name="connsiteX2" fmla="*/ 1884083 w 3452552"/>
              <a:gd name="connsiteY2" fmla="*/ 461 h 1210723"/>
              <a:gd name="connsiteX3" fmla="*/ 1359636 w 3452552"/>
              <a:gd name="connsiteY3" fmla="*/ 743066 h 1210723"/>
              <a:gd name="connsiteX4" fmla="*/ 899937 w 3452552"/>
              <a:gd name="connsiteY4" fmla="*/ 858497 h 1210723"/>
              <a:gd name="connsiteX5" fmla="*/ 606221 w 3452552"/>
              <a:gd name="connsiteY5" fmla="*/ 749284 h 1210723"/>
              <a:gd name="connsiteX6" fmla="*/ 274794 w 3452552"/>
              <a:gd name="connsiteY6" fmla="*/ 1210604 h 1210723"/>
              <a:gd name="connsiteX7" fmla="*/ 0 w 3452552"/>
              <a:gd name="connsiteY7" fmla="*/ 700353 h 1210723"/>
              <a:gd name="connsiteX0" fmla="*/ 3452552 w 3452552"/>
              <a:gd name="connsiteY0" fmla="*/ 816731 h 1217117"/>
              <a:gd name="connsiteX1" fmla="*/ 2705083 w 3452552"/>
              <a:gd name="connsiteY1" fmla="*/ 861336 h 1217117"/>
              <a:gd name="connsiteX2" fmla="*/ 1884083 w 3452552"/>
              <a:gd name="connsiteY2" fmla="*/ 461 h 1217117"/>
              <a:gd name="connsiteX3" fmla="*/ 1359636 w 3452552"/>
              <a:gd name="connsiteY3" fmla="*/ 743066 h 1217117"/>
              <a:gd name="connsiteX4" fmla="*/ 899937 w 3452552"/>
              <a:gd name="connsiteY4" fmla="*/ 858497 h 1217117"/>
              <a:gd name="connsiteX5" fmla="*/ 606221 w 3452552"/>
              <a:gd name="connsiteY5" fmla="*/ 749284 h 1217117"/>
              <a:gd name="connsiteX6" fmla="*/ 274794 w 3452552"/>
              <a:gd name="connsiteY6" fmla="*/ 1216999 h 1217117"/>
              <a:gd name="connsiteX7" fmla="*/ 0 w 3452552"/>
              <a:gd name="connsiteY7" fmla="*/ 700353 h 121711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217117">
                <a:moveTo>
                  <a:pt x="3452552" y="816731"/>
                </a:moveTo>
                <a:cubicBezTo>
                  <a:pt x="3223028" y="820888"/>
                  <a:pt x="2957574" y="894790"/>
                  <a:pt x="2705083" y="861336"/>
                </a:cubicBezTo>
                <a:cubicBezTo>
                  <a:pt x="2452592" y="827882"/>
                  <a:pt x="2108324" y="20173"/>
                  <a:pt x="1884083" y="461"/>
                </a:cubicBezTo>
                <a:cubicBezTo>
                  <a:pt x="1659842" y="-19251"/>
                  <a:pt x="1523660" y="600060"/>
                  <a:pt x="1359636" y="743066"/>
                </a:cubicBezTo>
                <a:cubicBezTo>
                  <a:pt x="1195612" y="886072"/>
                  <a:pt x="1025506" y="857461"/>
                  <a:pt x="899937" y="858497"/>
                </a:cubicBezTo>
                <a:cubicBezTo>
                  <a:pt x="774368" y="859533"/>
                  <a:pt x="710411" y="689534"/>
                  <a:pt x="606221" y="749284"/>
                </a:cubicBezTo>
                <a:cubicBezTo>
                  <a:pt x="502031" y="809034"/>
                  <a:pt x="375831" y="1225154"/>
                  <a:pt x="274794" y="1216999"/>
                </a:cubicBezTo>
                <a:cubicBezTo>
                  <a:pt x="173757" y="1208844"/>
                  <a:pt x="96520" y="919716"/>
                  <a:pt x="0" y="700353"/>
                </a:cubicBezTo>
              </a:path>
            </a:pathLst>
          </a:custGeom>
          <a:noFill/>
          <a:ln w="12700">
            <a:solidFill>
              <a:srgbClr val="00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7" name="フリーフォーム 386"/>
          <p:cNvSpPr/>
          <p:nvPr/>
        </p:nvSpPr>
        <p:spPr>
          <a:xfrm>
            <a:off x="5215612" y="1052624"/>
            <a:ext cx="3452552" cy="1210778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29 h 1241422"/>
              <a:gd name="connsiteX1" fmla="*/ 2705083 w 3452552"/>
              <a:gd name="connsiteY1" fmla="*/ 959034 h 1241422"/>
              <a:gd name="connsiteX2" fmla="*/ 1906385 w 3452552"/>
              <a:gd name="connsiteY2" fmla="*/ 29 h 1241422"/>
              <a:gd name="connsiteX3" fmla="*/ 1413163 w 3452552"/>
              <a:gd name="connsiteY3" fmla="*/ 925512 h 1241422"/>
              <a:gd name="connsiteX4" fmla="*/ 908858 w 3452552"/>
              <a:gd name="connsiteY4" fmla="*/ 1014181 h 1241422"/>
              <a:gd name="connsiteX5" fmla="*/ 615142 w 3452552"/>
              <a:gd name="connsiteY5" fmla="*/ 820218 h 1241422"/>
              <a:gd name="connsiteX6" fmla="*/ 288175 w 3452552"/>
              <a:gd name="connsiteY6" fmla="*/ 1241396 h 1241422"/>
              <a:gd name="connsiteX7" fmla="*/ 0 w 3452552"/>
              <a:gd name="connsiteY7" fmla="*/ 798051 h 1241422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35017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675 h 1130668"/>
              <a:gd name="connsiteX1" fmla="*/ 2705083 w 3452552"/>
              <a:gd name="connsiteY1" fmla="*/ 848280 h 1130668"/>
              <a:gd name="connsiteX2" fmla="*/ 1835017 w 3452552"/>
              <a:gd name="connsiteY2" fmla="*/ 788 h 1130668"/>
              <a:gd name="connsiteX3" fmla="*/ 1364098 w 3452552"/>
              <a:gd name="connsiteY3" fmla="*/ 694325 h 1130668"/>
              <a:gd name="connsiteX4" fmla="*/ 908858 w 3452552"/>
              <a:gd name="connsiteY4" fmla="*/ 903427 h 1130668"/>
              <a:gd name="connsiteX5" fmla="*/ 615142 w 3452552"/>
              <a:gd name="connsiteY5" fmla="*/ 709464 h 1130668"/>
              <a:gd name="connsiteX6" fmla="*/ 288175 w 3452552"/>
              <a:gd name="connsiteY6" fmla="*/ 1130642 h 1130668"/>
              <a:gd name="connsiteX7" fmla="*/ 0 w 3452552"/>
              <a:gd name="connsiteY7" fmla="*/ 687297 h 1130668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61780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715 h 1130708"/>
              <a:gd name="connsiteX1" fmla="*/ 2705083 w 3452552"/>
              <a:gd name="connsiteY1" fmla="*/ 848320 h 1130708"/>
              <a:gd name="connsiteX2" fmla="*/ 1861780 w 3452552"/>
              <a:gd name="connsiteY2" fmla="*/ 828 h 1130708"/>
              <a:gd name="connsiteX3" fmla="*/ 1364098 w 3452552"/>
              <a:gd name="connsiteY3" fmla="*/ 694365 h 1130708"/>
              <a:gd name="connsiteX4" fmla="*/ 913318 w 3452552"/>
              <a:gd name="connsiteY4" fmla="*/ 845481 h 1130708"/>
              <a:gd name="connsiteX5" fmla="*/ 615142 w 3452552"/>
              <a:gd name="connsiteY5" fmla="*/ 709504 h 1130708"/>
              <a:gd name="connsiteX6" fmla="*/ 288175 w 3452552"/>
              <a:gd name="connsiteY6" fmla="*/ 1130682 h 1130708"/>
              <a:gd name="connsiteX7" fmla="*/ 0 w 3452552"/>
              <a:gd name="connsiteY7" fmla="*/ 687337 h 1130708"/>
              <a:gd name="connsiteX0" fmla="*/ 3452552 w 3452552"/>
              <a:gd name="connsiteY0" fmla="*/ 803715 h 1103947"/>
              <a:gd name="connsiteX1" fmla="*/ 2705083 w 3452552"/>
              <a:gd name="connsiteY1" fmla="*/ 848320 h 1103947"/>
              <a:gd name="connsiteX2" fmla="*/ 1861780 w 3452552"/>
              <a:gd name="connsiteY2" fmla="*/ 828 h 1103947"/>
              <a:gd name="connsiteX3" fmla="*/ 1364098 w 3452552"/>
              <a:gd name="connsiteY3" fmla="*/ 694365 h 1103947"/>
              <a:gd name="connsiteX4" fmla="*/ 913318 w 3452552"/>
              <a:gd name="connsiteY4" fmla="*/ 845481 h 1103947"/>
              <a:gd name="connsiteX5" fmla="*/ 615142 w 3452552"/>
              <a:gd name="connsiteY5" fmla="*/ 709504 h 1103947"/>
              <a:gd name="connsiteX6" fmla="*/ 288175 w 3452552"/>
              <a:gd name="connsiteY6" fmla="*/ 1103919 h 1103947"/>
              <a:gd name="connsiteX7" fmla="*/ 0 w 3452552"/>
              <a:gd name="connsiteY7" fmla="*/ 687337 h 1103947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88543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52 h 1188447"/>
              <a:gd name="connsiteX1" fmla="*/ 2705083 w 3452552"/>
              <a:gd name="connsiteY1" fmla="*/ 861457 h 1188447"/>
              <a:gd name="connsiteX2" fmla="*/ 1888543 w 3452552"/>
              <a:gd name="connsiteY2" fmla="*/ 583 h 1188447"/>
              <a:gd name="connsiteX3" fmla="*/ 1350716 w 3452552"/>
              <a:gd name="connsiteY3" fmla="*/ 729805 h 1188447"/>
              <a:gd name="connsiteX4" fmla="*/ 904397 w 3452552"/>
              <a:gd name="connsiteY4" fmla="*/ 885381 h 1188447"/>
              <a:gd name="connsiteX5" fmla="*/ 615142 w 3452552"/>
              <a:gd name="connsiteY5" fmla="*/ 722641 h 1188447"/>
              <a:gd name="connsiteX6" fmla="*/ 274794 w 3452552"/>
              <a:gd name="connsiteY6" fmla="*/ 1188423 h 1188447"/>
              <a:gd name="connsiteX7" fmla="*/ 0 w 3452552"/>
              <a:gd name="connsiteY7" fmla="*/ 700474 h 1188447"/>
              <a:gd name="connsiteX0" fmla="*/ 3452552 w 3452552"/>
              <a:gd name="connsiteY0" fmla="*/ 816852 h 1188818"/>
              <a:gd name="connsiteX1" fmla="*/ 2705083 w 3452552"/>
              <a:gd name="connsiteY1" fmla="*/ 861457 h 1188818"/>
              <a:gd name="connsiteX2" fmla="*/ 1888543 w 3452552"/>
              <a:gd name="connsiteY2" fmla="*/ 583 h 1188818"/>
              <a:gd name="connsiteX3" fmla="*/ 1350716 w 3452552"/>
              <a:gd name="connsiteY3" fmla="*/ 729805 h 1188818"/>
              <a:gd name="connsiteX4" fmla="*/ 904397 w 3452552"/>
              <a:gd name="connsiteY4" fmla="*/ 885381 h 1188818"/>
              <a:gd name="connsiteX5" fmla="*/ 610681 w 3452552"/>
              <a:gd name="connsiteY5" fmla="*/ 785088 h 1188818"/>
              <a:gd name="connsiteX6" fmla="*/ 274794 w 3452552"/>
              <a:gd name="connsiteY6" fmla="*/ 1188423 h 1188818"/>
              <a:gd name="connsiteX7" fmla="*/ 0 w 3452552"/>
              <a:gd name="connsiteY7" fmla="*/ 700474 h 1188818"/>
              <a:gd name="connsiteX0" fmla="*/ 3452552 w 3452552"/>
              <a:gd name="connsiteY0" fmla="*/ 816852 h 1242303"/>
              <a:gd name="connsiteX1" fmla="*/ 2705083 w 3452552"/>
              <a:gd name="connsiteY1" fmla="*/ 861457 h 1242303"/>
              <a:gd name="connsiteX2" fmla="*/ 1888543 w 3452552"/>
              <a:gd name="connsiteY2" fmla="*/ 583 h 1242303"/>
              <a:gd name="connsiteX3" fmla="*/ 1350716 w 3452552"/>
              <a:gd name="connsiteY3" fmla="*/ 729805 h 1242303"/>
              <a:gd name="connsiteX4" fmla="*/ 904397 w 3452552"/>
              <a:gd name="connsiteY4" fmla="*/ 885381 h 1242303"/>
              <a:gd name="connsiteX5" fmla="*/ 610681 w 3452552"/>
              <a:gd name="connsiteY5" fmla="*/ 785088 h 1242303"/>
              <a:gd name="connsiteX6" fmla="*/ 270334 w 3452552"/>
              <a:gd name="connsiteY6" fmla="*/ 1241949 h 1242303"/>
              <a:gd name="connsiteX7" fmla="*/ 0 w 3452552"/>
              <a:gd name="connsiteY7" fmla="*/ 700474 h 1242303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071 h 1255522"/>
              <a:gd name="connsiteX1" fmla="*/ 2705083 w 3452552"/>
              <a:gd name="connsiteY1" fmla="*/ 874676 h 1255522"/>
              <a:gd name="connsiteX2" fmla="*/ 1884083 w 3452552"/>
              <a:gd name="connsiteY2" fmla="*/ 420 h 1255522"/>
              <a:gd name="connsiteX3" fmla="*/ 1377478 w 3452552"/>
              <a:gd name="connsiteY3" fmla="*/ 760866 h 1255522"/>
              <a:gd name="connsiteX4" fmla="*/ 904397 w 3452552"/>
              <a:gd name="connsiteY4" fmla="*/ 898600 h 1255522"/>
              <a:gd name="connsiteX5" fmla="*/ 610681 w 3452552"/>
              <a:gd name="connsiteY5" fmla="*/ 798307 h 1255522"/>
              <a:gd name="connsiteX6" fmla="*/ 270334 w 3452552"/>
              <a:gd name="connsiteY6" fmla="*/ 1255168 h 1255522"/>
              <a:gd name="connsiteX7" fmla="*/ 0 w 3452552"/>
              <a:gd name="connsiteY7" fmla="*/ 713693 h 1255522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77478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64097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33227"/>
              <a:gd name="connsiteX1" fmla="*/ 2705083 w 3452552"/>
              <a:gd name="connsiteY1" fmla="*/ 874668 h 1233227"/>
              <a:gd name="connsiteX2" fmla="*/ 1884083 w 3452552"/>
              <a:gd name="connsiteY2" fmla="*/ 412 h 1233227"/>
              <a:gd name="connsiteX3" fmla="*/ 1364097 w 3452552"/>
              <a:gd name="connsiteY3" fmla="*/ 760858 h 1233227"/>
              <a:gd name="connsiteX4" fmla="*/ 904397 w 3452552"/>
              <a:gd name="connsiteY4" fmla="*/ 898592 h 1233227"/>
              <a:gd name="connsiteX5" fmla="*/ 610681 w 3452552"/>
              <a:gd name="connsiteY5" fmla="*/ 798299 h 1233227"/>
              <a:gd name="connsiteX6" fmla="*/ 274794 w 3452552"/>
              <a:gd name="connsiteY6" fmla="*/ 1232857 h 1233227"/>
              <a:gd name="connsiteX7" fmla="*/ 0 w 3452552"/>
              <a:gd name="connsiteY7" fmla="*/ 713685 h 1233227"/>
              <a:gd name="connsiteX0" fmla="*/ 3452552 w 3452552"/>
              <a:gd name="connsiteY0" fmla="*/ 830063 h 1233080"/>
              <a:gd name="connsiteX1" fmla="*/ 2705083 w 3452552"/>
              <a:gd name="connsiteY1" fmla="*/ 874668 h 1233080"/>
              <a:gd name="connsiteX2" fmla="*/ 1884083 w 3452552"/>
              <a:gd name="connsiteY2" fmla="*/ 412 h 1233080"/>
              <a:gd name="connsiteX3" fmla="*/ 1364097 w 3452552"/>
              <a:gd name="connsiteY3" fmla="*/ 760858 h 1233080"/>
              <a:gd name="connsiteX4" fmla="*/ 904397 w 3452552"/>
              <a:gd name="connsiteY4" fmla="*/ 898592 h 1233080"/>
              <a:gd name="connsiteX5" fmla="*/ 606221 w 3452552"/>
              <a:gd name="connsiteY5" fmla="*/ 780458 h 1233080"/>
              <a:gd name="connsiteX6" fmla="*/ 274794 w 3452552"/>
              <a:gd name="connsiteY6" fmla="*/ 1232857 h 1233080"/>
              <a:gd name="connsiteX7" fmla="*/ 0 w 3452552"/>
              <a:gd name="connsiteY7" fmla="*/ 713685 h 1233080"/>
              <a:gd name="connsiteX0" fmla="*/ 3452552 w 3452552"/>
              <a:gd name="connsiteY0" fmla="*/ 830069 h 1233087"/>
              <a:gd name="connsiteX1" fmla="*/ 2705083 w 3452552"/>
              <a:gd name="connsiteY1" fmla="*/ 874674 h 1233087"/>
              <a:gd name="connsiteX2" fmla="*/ 1884083 w 3452552"/>
              <a:gd name="connsiteY2" fmla="*/ 418 h 1233087"/>
              <a:gd name="connsiteX3" fmla="*/ 1364097 w 3452552"/>
              <a:gd name="connsiteY3" fmla="*/ 760864 h 1233087"/>
              <a:gd name="connsiteX4" fmla="*/ 904397 w 3452552"/>
              <a:gd name="connsiteY4" fmla="*/ 885217 h 1233087"/>
              <a:gd name="connsiteX5" fmla="*/ 606221 w 3452552"/>
              <a:gd name="connsiteY5" fmla="*/ 780464 h 1233087"/>
              <a:gd name="connsiteX6" fmla="*/ 274794 w 3452552"/>
              <a:gd name="connsiteY6" fmla="*/ 1232863 h 1233087"/>
              <a:gd name="connsiteX7" fmla="*/ 0 w 3452552"/>
              <a:gd name="connsiteY7" fmla="*/ 713691 h 1233087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42"/>
              <a:gd name="connsiteX1" fmla="*/ 2705083 w 3452552"/>
              <a:gd name="connsiteY1" fmla="*/ 865759 h 1224142"/>
              <a:gd name="connsiteX2" fmla="*/ 1884083 w 3452552"/>
              <a:gd name="connsiteY2" fmla="*/ 424 h 1224142"/>
              <a:gd name="connsiteX3" fmla="*/ 1364097 w 3452552"/>
              <a:gd name="connsiteY3" fmla="*/ 751949 h 1224142"/>
              <a:gd name="connsiteX4" fmla="*/ 904397 w 3452552"/>
              <a:gd name="connsiteY4" fmla="*/ 876302 h 1224142"/>
              <a:gd name="connsiteX5" fmla="*/ 606221 w 3452552"/>
              <a:gd name="connsiteY5" fmla="*/ 767089 h 1224142"/>
              <a:gd name="connsiteX6" fmla="*/ 274794 w 3452552"/>
              <a:gd name="connsiteY6" fmla="*/ 1223948 h 1224142"/>
              <a:gd name="connsiteX7" fmla="*/ 0 w 3452552"/>
              <a:gd name="connsiteY7" fmla="*/ 704776 h 1224142"/>
              <a:gd name="connsiteX0" fmla="*/ 3452552 w 3452552"/>
              <a:gd name="connsiteY0" fmla="*/ 821153 h 1224141"/>
              <a:gd name="connsiteX1" fmla="*/ 2705083 w 3452552"/>
              <a:gd name="connsiteY1" fmla="*/ 865758 h 1224141"/>
              <a:gd name="connsiteX2" fmla="*/ 1884083 w 3452552"/>
              <a:gd name="connsiteY2" fmla="*/ 423 h 1224141"/>
              <a:gd name="connsiteX3" fmla="*/ 1364097 w 3452552"/>
              <a:gd name="connsiteY3" fmla="*/ 751948 h 1224141"/>
              <a:gd name="connsiteX4" fmla="*/ 904397 w 3452552"/>
              <a:gd name="connsiteY4" fmla="*/ 871840 h 1224141"/>
              <a:gd name="connsiteX5" fmla="*/ 606221 w 3452552"/>
              <a:gd name="connsiteY5" fmla="*/ 767088 h 1224141"/>
              <a:gd name="connsiteX6" fmla="*/ 274794 w 3452552"/>
              <a:gd name="connsiteY6" fmla="*/ 1223947 h 1224141"/>
              <a:gd name="connsiteX7" fmla="*/ 0 w 3452552"/>
              <a:gd name="connsiteY7" fmla="*/ 704775 h 1224141"/>
              <a:gd name="connsiteX0" fmla="*/ 3452552 w 3452552"/>
              <a:gd name="connsiteY0" fmla="*/ 821153 h 1215224"/>
              <a:gd name="connsiteX1" fmla="*/ 2705083 w 3452552"/>
              <a:gd name="connsiteY1" fmla="*/ 865758 h 1215224"/>
              <a:gd name="connsiteX2" fmla="*/ 1884083 w 3452552"/>
              <a:gd name="connsiteY2" fmla="*/ 423 h 1215224"/>
              <a:gd name="connsiteX3" fmla="*/ 1364097 w 3452552"/>
              <a:gd name="connsiteY3" fmla="*/ 751948 h 1215224"/>
              <a:gd name="connsiteX4" fmla="*/ 904397 w 3452552"/>
              <a:gd name="connsiteY4" fmla="*/ 871840 h 1215224"/>
              <a:gd name="connsiteX5" fmla="*/ 606221 w 3452552"/>
              <a:gd name="connsiteY5" fmla="*/ 767088 h 1215224"/>
              <a:gd name="connsiteX6" fmla="*/ 274794 w 3452552"/>
              <a:gd name="connsiteY6" fmla="*/ 1215026 h 1215224"/>
              <a:gd name="connsiteX7" fmla="*/ 0 w 3452552"/>
              <a:gd name="connsiteY7" fmla="*/ 704775 h 1215224"/>
              <a:gd name="connsiteX0" fmla="*/ 3452552 w 3452552"/>
              <a:gd name="connsiteY0" fmla="*/ 821153 h 1215145"/>
              <a:gd name="connsiteX1" fmla="*/ 2705083 w 3452552"/>
              <a:gd name="connsiteY1" fmla="*/ 865758 h 1215145"/>
              <a:gd name="connsiteX2" fmla="*/ 1884083 w 3452552"/>
              <a:gd name="connsiteY2" fmla="*/ 423 h 1215145"/>
              <a:gd name="connsiteX3" fmla="*/ 1364097 w 3452552"/>
              <a:gd name="connsiteY3" fmla="*/ 751948 h 1215145"/>
              <a:gd name="connsiteX4" fmla="*/ 904397 w 3452552"/>
              <a:gd name="connsiteY4" fmla="*/ 871840 h 1215145"/>
              <a:gd name="connsiteX5" fmla="*/ 606221 w 3452552"/>
              <a:gd name="connsiteY5" fmla="*/ 753706 h 1215145"/>
              <a:gd name="connsiteX6" fmla="*/ 274794 w 3452552"/>
              <a:gd name="connsiteY6" fmla="*/ 1215026 h 1215145"/>
              <a:gd name="connsiteX7" fmla="*/ 0 w 3452552"/>
              <a:gd name="connsiteY7" fmla="*/ 704775 h 1215145"/>
              <a:gd name="connsiteX0" fmla="*/ 3452552 w 3452552"/>
              <a:gd name="connsiteY0" fmla="*/ 821152 h 1215144"/>
              <a:gd name="connsiteX1" fmla="*/ 2705083 w 3452552"/>
              <a:gd name="connsiteY1" fmla="*/ 865757 h 1215144"/>
              <a:gd name="connsiteX2" fmla="*/ 1884083 w 3452552"/>
              <a:gd name="connsiteY2" fmla="*/ 422 h 1215144"/>
              <a:gd name="connsiteX3" fmla="*/ 1364097 w 3452552"/>
              <a:gd name="connsiteY3" fmla="*/ 751947 h 1215144"/>
              <a:gd name="connsiteX4" fmla="*/ 899937 w 3452552"/>
              <a:gd name="connsiteY4" fmla="*/ 862918 h 1215144"/>
              <a:gd name="connsiteX5" fmla="*/ 606221 w 3452552"/>
              <a:gd name="connsiteY5" fmla="*/ 753705 h 1215144"/>
              <a:gd name="connsiteX6" fmla="*/ 274794 w 3452552"/>
              <a:gd name="connsiteY6" fmla="*/ 1215025 h 1215144"/>
              <a:gd name="connsiteX7" fmla="*/ 0 w 3452552"/>
              <a:gd name="connsiteY7" fmla="*/ 704774 h 1215144"/>
              <a:gd name="connsiteX0" fmla="*/ 3452552 w 3452552"/>
              <a:gd name="connsiteY0" fmla="*/ 821187 h 1215179"/>
              <a:gd name="connsiteX1" fmla="*/ 2705083 w 3452552"/>
              <a:gd name="connsiteY1" fmla="*/ 865792 h 1215179"/>
              <a:gd name="connsiteX2" fmla="*/ 1884083 w 3452552"/>
              <a:gd name="connsiteY2" fmla="*/ 457 h 1215179"/>
              <a:gd name="connsiteX3" fmla="*/ 1359636 w 3452552"/>
              <a:gd name="connsiteY3" fmla="*/ 747522 h 1215179"/>
              <a:gd name="connsiteX4" fmla="*/ 899937 w 3452552"/>
              <a:gd name="connsiteY4" fmla="*/ 862953 h 1215179"/>
              <a:gd name="connsiteX5" fmla="*/ 606221 w 3452552"/>
              <a:gd name="connsiteY5" fmla="*/ 753740 h 1215179"/>
              <a:gd name="connsiteX6" fmla="*/ 274794 w 3452552"/>
              <a:gd name="connsiteY6" fmla="*/ 1215060 h 1215179"/>
              <a:gd name="connsiteX7" fmla="*/ 0 w 3452552"/>
              <a:gd name="connsiteY7" fmla="*/ 704809 h 1215179"/>
              <a:gd name="connsiteX0" fmla="*/ 3452552 w 3452552"/>
              <a:gd name="connsiteY0" fmla="*/ 816731 h 1210723"/>
              <a:gd name="connsiteX1" fmla="*/ 2705083 w 3452552"/>
              <a:gd name="connsiteY1" fmla="*/ 861336 h 1210723"/>
              <a:gd name="connsiteX2" fmla="*/ 1884083 w 3452552"/>
              <a:gd name="connsiteY2" fmla="*/ 461 h 1210723"/>
              <a:gd name="connsiteX3" fmla="*/ 1359636 w 3452552"/>
              <a:gd name="connsiteY3" fmla="*/ 743066 h 1210723"/>
              <a:gd name="connsiteX4" fmla="*/ 899937 w 3452552"/>
              <a:gd name="connsiteY4" fmla="*/ 858497 h 1210723"/>
              <a:gd name="connsiteX5" fmla="*/ 606221 w 3452552"/>
              <a:gd name="connsiteY5" fmla="*/ 749284 h 1210723"/>
              <a:gd name="connsiteX6" fmla="*/ 274794 w 3452552"/>
              <a:gd name="connsiteY6" fmla="*/ 1210604 h 1210723"/>
              <a:gd name="connsiteX7" fmla="*/ 0 w 3452552"/>
              <a:gd name="connsiteY7" fmla="*/ 700353 h 1210723"/>
              <a:gd name="connsiteX0" fmla="*/ 3452552 w 3452552"/>
              <a:gd name="connsiteY0" fmla="*/ 816731 h 1210723"/>
              <a:gd name="connsiteX1" fmla="*/ 2705083 w 3452552"/>
              <a:gd name="connsiteY1" fmla="*/ 861336 h 1210723"/>
              <a:gd name="connsiteX2" fmla="*/ 1884083 w 3452552"/>
              <a:gd name="connsiteY2" fmla="*/ 461 h 1210723"/>
              <a:gd name="connsiteX3" fmla="*/ 1359636 w 3452552"/>
              <a:gd name="connsiteY3" fmla="*/ 743066 h 1210723"/>
              <a:gd name="connsiteX4" fmla="*/ 899937 w 3452552"/>
              <a:gd name="connsiteY4" fmla="*/ 858497 h 1210723"/>
              <a:gd name="connsiteX5" fmla="*/ 606221 w 3452552"/>
              <a:gd name="connsiteY5" fmla="*/ 749284 h 1210723"/>
              <a:gd name="connsiteX6" fmla="*/ 274794 w 3452552"/>
              <a:gd name="connsiteY6" fmla="*/ 1210604 h 1210723"/>
              <a:gd name="connsiteX7" fmla="*/ 0 w 3452552"/>
              <a:gd name="connsiteY7" fmla="*/ 700353 h 1210723"/>
              <a:gd name="connsiteX0" fmla="*/ 3452552 w 3452552"/>
              <a:gd name="connsiteY0" fmla="*/ 816731 h 1201134"/>
              <a:gd name="connsiteX1" fmla="*/ 2705083 w 3452552"/>
              <a:gd name="connsiteY1" fmla="*/ 861336 h 1201134"/>
              <a:gd name="connsiteX2" fmla="*/ 1884083 w 3452552"/>
              <a:gd name="connsiteY2" fmla="*/ 461 h 1201134"/>
              <a:gd name="connsiteX3" fmla="*/ 1359636 w 3452552"/>
              <a:gd name="connsiteY3" fmla="*/ 743066 h 1201134"/>
              <a:gd name="connsiteX4" fmla="*/ 899937 w 3452552"/>
              <a:gd name="connsiteY4" fmla="*/ 858497 h 1201134"/>
              <a:gd name="connsiteX5" fmla="*/ 606221 w 3452552"/>
              <a:gd name="connsiteY5" fmla="*/ 749284 h 1201134"/>
              <a:gd name="connsiteX6" fmla="*/ 274794 w 3452552"/>
              <a:gd name="connsiteY6" fmla="*/ 1201012 h 1201134"/>
              <a:gd name="connsiteX7" fmla="*/ 0 w 3452552"/>
              <a:gd name="connsiteY7" fmla="*/ 700353 h 1201134"/>
              <a:gd name="connsiteX0" fmla="*/ 3452552 w 3452552"/>
              <a:gd name="connsiteY0" fmla="*/ 816731 h 1201077"/>
              <a:gd name="connsiteX1" fmla="*/ 2705083 w 3452552"/>
              <a:gd name="connsiteY1" fmla="*/ 861336 h 1201077"/>
              <a:gd name="connsiteX2" fmla="*/ 1884083 w 3452552"/>
              <a:gd name="connsiteY2" fmla="*/ 461 h 1201077"/>
              <a:gd name="connsiteX3" fmla="*/ 1359636 w 3452552"/>
              <a:gd name="connsiteY3" fmla="*/ 743066 h 1201077"/>
              <a:gd name="connsiteX4" fmla="*/ 899937 w 3452552"/>
              <a:gd name="connsiteY4" fmla="*/ 858497 h 1201077"/>
              <a:gd name="connsiteX5" fmla="*/ 606221 w 3452552"/>
              <a:gd name="connsiteY5" fmla="*/ 736496 h 1201077"/>
              <a:gd name="connsiteX6" fmla="*/ 274794 w 3452552"/>
              <a:gd name="connsiteY6" fmla="*/ 1201012 h 1201077"/>
              <a:gd name="connsiteX7" fmla="*/ 0 w 3452552"/>
              <a:gd name="connsiteY7" fmla="*/ 700353 h 1201077"/>
              <a:gd name="connsiteX0" fmla="*/ 3452552 w 3452552"/>
              <a:gd name="connsiteY0" fmla="*/ 816843 h 1201189"/>
              <a:gd name="connsiteX1" fmla="*/ 2705083 w 3452552"/>
              <a:gd name="connsiteY1" fmla="*/ 861448 h 1201189"/>
              <a:gd name="connsiteX2" fmla="*/ 1884083 w 3452552"/>
              <a:gd name="connsiteY2" fmla="*/ 573 h 1201189"/>
              <a:gd name="connsiteX3" fmla="*/ 1359636 w 3452552"/>
              <a:gd name="connsiteY3" fmla="*/ 730389 h 1201189"/>
              <a:gd name="connsiteX4" fmla="*/ 899937 w 3452552"/>
              <a:gd name="connsiteY4" fmla="*/ 858609 h 1201189"/>
              <a:gd name="connsiteX5" fmla="*/ 606221 w 3452552"/>
              <a:gd name="connsiteY5" fmla="*/ 736608 h 1201189"/>
              <a:gd name="connsiteX6" fmla="*/ 274794 w 3452552"/>
              <a:gd name="connsiteY6" fmla="*/ 1201124 h 1201189"/>
              <a:gd name="connsiteX7" fmla="*/ 0 w 3452552"/>
              <a:gd name="connsiteY7" fmla="*/ 700465 h 1201189"/>
              <a:gd name="connsiteX0" fmla="*/ 3452552 w 3452552"/>
              <a:gd name="connsiteY0" fmla="*/ 816843 h 1207582"/>
              <a:gd name="connsiteX1" fmla="*/ 2705083 w 3452552"/>
              <a:gd name="connsiteY1" fmla="*/ 861448 h 1207582"/>
              <a:gd name="connsiteX2" fmla="*/ 1884083 w 3452552"/>
              <a:gd name="connsiteY2" fmla="*/ 573 h 1207582"/>
              <a:gd name="connsiteX3" fmla="*/ 1359636 w 3452552"/>
              <a:gd name="connsiteY3" fmla="*/ 730389 h 1207582"/>
              <a:gd name="connsiteX4" fmla="*/ 899937 w 3452552"/>
              <a:gd name="connsiteY4" fmla="*/ 858609 h 1207582"/>
              <a:gd name="connsiteX5" fmla="*/ 606221 w 3452552"/>
              <a:gd name="connsiteY5" fmla="*/ 736608 h 1207582"/>
              <a:gd name="connsiteX6" fmla="*/ 274794 w 3452552"/>
              <a:gd name="connsiteY6" fmla="*/ 1207518 h 1207582"/>
              <a:gd name="connsiteX7" fmla="*/ 0 w 3452552"/>
              <a:gd name="connsiteY7" fmla="*/ 700465 h 1207582"/>
              <a:gd name="connsiteX0" fmla="*/ 3452552 w 3452552"/>
              <a:gd name="connsiteY0" fmla="*/ 816843 h 1210778"/>
              <a:gd name="connsiteX1" fmla="*/ 2705083 w 3452552"/>
              <a:gd name="connsiteY1" fmla="*/ 861448 h 1210778"/>
              <a:gd name="connsiteX2" fmla="*/ 1884083 w 3452552"/>
              <a:gd name="connsiteY2" fmla="*/ 573 h 1210778"/>
              <a:gd name="connsiteX3" fmla="*/ 1359636 w 3452552"/>
              <a:gd name="connsiteY3" fmla="*/ 730389 h 1210778"/>
              <a:gd name="connsiteX4" fmla="*/ 899937 w 3452552"/>
              <a:gd name="connsiteY4" fmla="*/ 858609 h 1210778"/>
              <a:gd name="connsiteX5" fmla="*/ 606221 w 3452552"/>
              <a:gd name="connsiteY5" fmla="*/ 736608 h 1210778"/>
              <a:gd name="connsiteX6" fmla="*/ 271597 w 3452552"/>
              <a:gd name="connsiteY6" fmla="*/ 1210715 h 1210778"/>
              <a:gd name="connsiteX7" fmla="*/ 0 w 3452552"/>
              <a:gd name="connsiteY7" fmla="*/ 700465 h 121077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210778">
                <a:moveTo>
                  <a:pt x="3452552" y="816843"/>
                </a:moveTo>
                <a:cubicBezTo>
                  <a:pt x="3223028" y="821000"/>
                  <a:pt x="2957574" y="894902"/>
                  <a:pt x="2705083" y="861448"/>
                </a:cubicBezTo>
                <a:cubicBezTo>
                  <a:pt x="2452592" y="827994"/>
                  <a:pt x="2108324" y="22416"/>
                  <a:pt x="1884083" y="573"/>
                </a:cubicBezTo>
                <a:cubicBezTo>
                  <a:pt x="1659842" y="-21270"/>
                  <a:pt x="1523660" y="587383"/>
                  <a:pt x="1359636" y="730389"/>
                </a:cubicBezTo>
                <a:cubicBezTo>
                  <a:pt x="1195612" y="873395"/>
                  <a:pt x="1025506" y="857573"/>
                  <a:pt x="899937" y="858609"/>
                </a:cubicBezTo>
                <a:cubicBezTo>
                  <a:pt x="774368" y="859645"/>
                  <a:pt x="710944" y="677924"/>
                  <a:pt x="606221" y="736608"/>
                </a:cubicBezTo>
                <a:cubicBezTo>
                  <a:pt x="501498" y="795292"/>
                  <a:pt x="372634" y="1216739"/>
                  <a:pt x="271597" y="1210715"/>
                </a:cubicBezTo>
                <a:cubicBezTo>
                  <a:pt x="170560" y="1204691"/>
                  <a:pt x="96520" y="919828"/>
                  <a:pt x="0" y="700465"/>
                </a:cubicBezTo>
              </a:path>
            </a:pathLst>
          </a:custGeom>
          <a:noFill/>
          <a:ln w="127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8" name="フリーフォーム 387"/>
          <p:cNvSpPr/>
          <p:nvPr/>
        </p:nvSpPr>
        <p:spPr>
          <a:xfrm>
            <a:off x="5214313" y="1052735"/>
            <a:ext cx="3452552" cy="1197961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29 h 1241422"/>
              <a:gd name="connsiteX1" fmla="*/ 2705083 w 3452552"/>
              <a:gd name="connsiteY1" fmla="*/ 959034 h 1241422"/>
              <a:gd name="connsiteX2" fmla="*/ 1906385 w 3452552"/>
              <a:gd name="connsiteY2" fmla="*/ 29 h 1241422"/>
              <a:gd name="connsiteX3" fmla="*/ 1413163 w 3452552"/>
              <a:gd name="connsiteY3" fmla="*/ 925512 h 1241422"/>
              <a:gd name="connsiteX4" fmla="*/ 908858 w 3452552"/>
              <a:gd name="connsiteY4" fmla="*/ 1014181 h 1241422"/>
              <a:gd name="connsiteX5" fmla="*/ 615142 w 3452552"/>
              <a:gd name="connsiteY5" fmla="*/ 820218 h 1241422"/>
              <a:gd name="connsiteX6" fmla="*/ 288175 w 3452552"/>
              <a:gd name="connsiteY6" fmla="*/ 1241396 h 1241422"/>
              <a:gd name="connsiteX7" fmla="*/ 0 w 3452552"/>
              <a:gd name="connsiteY7" fmla="*/ 798051 h 1241422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35017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675 h 1130668"/>
              <a:gd name="connsiteX1" fmla="*/ 2705083 w 3452552"/>
              <a:gd name="connsiteY1" fmla="*/ 848280 h 1130668"/>
              <a:gd name="connsiteX2" fmla="*/ 1835017 w 3452552"/>
              <a:gd name="connsiteY2" fmla="*/ 788 h 1130668"/>
              <a:gd name="connsiteX3" fmla="*/ 1364098 w 3452552"/>
              <a:gd name="connsiteY3" fmla="*/ 694325 h 1130668"/>
              <a:gd name="connsiteX4" fmla="*/ 908858 w 3452552"/>
              <a:gd name="connsiteY4" fmla="*/ 903427 h 1130668"/>
              <a:gd name="connsiteX5" fmla="*/ 615142 w 3452552"/>
              <a:gd name="connsiteY5" fmla="*/ 709464 h 1130668"/>
              <a:gd name="connsiteX6" fmla="*/ 288175 w 3452552"/>
              <a:gd name="connsiteY6" fmla="*/ 1130642 h 1130668"/>
              <a:gd name="connsiteX7" fmla="*/ 0 w 3452552"/>
              <a:gd name="connsiteY7" fmla="*/ 687297 h 1130668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61780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715 h 1130708"/>
              <a:gd name="connsiteX1" fmla="*/ 2705083 w 3452552"/>
              <a:gd name="connsiteY1" fmla="*/ 848320 h 1130708"/>
              <a:gd name="connsiteX2" fmla="*/ 1861780 w 3452552"/>
              <a:gd name="connsiteY2" fmla="*/ 828 h 1130708"/>
              <a:gd name="connsiteX3" fmla="*/ 1364098 w 3452552"/>
              <a:gd name="connsiteY3" fmla="*/ 694365 h 1130708"/>
              <a:gd name="connsiteX4" fmla="*/ 913318 w 3452552"/>
              <a:gd name="connsiteY4" fmla="*/ 845481 h 1130708"/>
              <a:gd name="connsiteX5" fmla="*/ 615142 w 3452552"/>
              <a:gd name="connsiteY5" fmla="*/ 709504 h 1130708"/>
              <a:gd name="connsiteX6" fmla="*/ 288175 w 3452552"/>
              <a:gd name="connsiteY6" fmla="*/ 1130682 h 1130708"/>
              <a:gd name="connsiteX7" fmla="*/ 0 w 3452552"/>
              <a:gd name="connsiteY7" fmla="*/ 687337 h 1130708"/>
              <a:gd name="connsiteX0" fmla="*/ 3452552 w 3452552"/>
              <a:gd name="connsiteY0" fmla="*/ 803715 h 1103947"/>
              <a:gd name="connsiteX1" fmla="*/ 2705083 w 3452552"/>
              <a:gd name="connsiteY1" fmla="*/ 848320 h 1103947"/>
              <a:gd name="connsiteX2" fmla="*/ 1861780 w 3452552"/>
              <a:gd name="connsiteY2" fmla="*/ 828 h 1103947"/>
              <a:gd name="connsiteX3" fmla="*/ 1364098 w 3452552"/>
              <a:gd name="connsiteY3" fmla="*/ 694365 h 1103947"/>
              <a:gd name="connsiteX4" fmla="*/ 913318 w 3452552"/>
              <a:gd name="connsiteY4" fmla="*/ 845481 h 1103947"/>
              <a:gd name="connsiteX5" fmla="*/ 615142 w 3452552"/>
              <a:gd name="connsiteY5" fmla="*/ 709504 h 1103947"/>
              <a:gd name="connsiteX6" fmla="*/ 288175 w 3452552"/>
              <a:gd name="connsiteY6" fmla="*/ 1103919 h 1103947"/>
              <a:gd name="connsiteX7" fmla="*/ 0 w 3452552"/>
              <a:gd name="connsiteY7" fmla="*/ 687337 h 1103947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88543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52 h 1188447"/>
              <a:gd name="connsiteX1" fmla="*/ 2705083 w 3452552"/>
              <a:gd name="connsiteY1" fmla="*/ 861457 h 1188447"/>
              <a:gd name="connsiteX2" fmla="*/ 1888543 w 3452552"/>
              <a:gd name="connsiteY2" fmla="*/ 583 h 1188447"/>
              <a:gd name="connsiteX3" fmla="*/ 1350716 w 3452552"/>
              <a:gd name="connsiteY3" fmla="*/ 729805 h 1188447"/>
              <a:gd name="connsiteX4" fmla="*/ 904397 w 3452552"/>
              <a:gd name="connsiteY4" fmla="*/ 885381 h 1188447"/>
              <a:gd name="connsiteX5" fmla="*/ 615142 w 3452552"/>
              <a:gd name="connsiteY5" fmla="*/ 722641 h 1188447"/>
              <a:gd name="connsiteX6" fmla="*/ 274794 w 3452552"/>
              <a:gd name="connsiteY6" fmla="*/ 1188423 h 1188447"/>
              <a:gd name="connsiteX7" fmla="*/ 0 w 3452552"/>
              <a:gd name="connsiteY7" fmla="*/ 700474 h 1188447"/>
              <a:gd name="connsiteX0" fmla="*/ 3452552 w 3452552"/>
              <a:gd name="connsiteY0" fmla="*/ 816852 h 1188818"/>
              <a:gd name="connsiteX1" fmla="*/ 2705083 w 3452552"/>
              <a:gd name="connsiteY1" fmla="*/ 861457 h 1188818"/>
              <a:gd name="connsiteX2" fmla="*/ 1888543 w 3452552"/>
              <a:gd name="connsiteY2" fmla="*/ 583 h 1188818"/>
              <a:gd name="connsiteX3" fmla="*/ 1350716 w 3452552"/>
              <a:gd name="connsiteY3" fmla="*/ 729805 h 1188818"/>
              <a:gd name="connsiteX4" fmla="*/ 904397 w 3452552"/>
              <a:gd name="connsiteY4" fmla="*/ 885381 h 1188818"/>
              <a:gd name="connsiteX5" fmla="*/ 610681 w 3452552"/>
              <a:gd name="connsiteY5" fmla="*/ 785088 h 1188818"/>
              <a:gd name="connsiteX6" fmla="*/ 274794 w 3452552"/>
              <a:gd name="connsiteY6" fmla="*/ 1188423 h 1188818"/>
              <a:gd name="connsiteX7" fmla="*/ 0 w 3452552"/>
              <a:gd name="connsiteY7" fmla="*/ 700474 h 1188818"/>
              <a:gd name="connsiteX0" fmla="*/ 3452552 w 3452552"/>
              <a:gd name="connsiteY0" fmla="*/ 816852 h 1242303"/>
              <a:gd name="connsiteX1" fmla="*/ 2705083 w 3452552"/>
              <a:gd name="connsiteY1" fmla="*/ 861457 h 1242303"/>
              <a:gd name="connsiteX2" fmla="*/ 1888543 w 3452552"/>
              <a:gd name="connsiteY2" fmla="*/ 583 h 1242303"/>
              <a:gd name="connsiteX3" fmla="*/ 1350716 w 3452552"/>
              <a:gd name="connsiteY3" fmla="*/ 729805 h 1242303"/>
              <a:gd name="connsiteX4" fmla="*/ 904397 w 3452552"/>
              <a:gd name="connsiteY4" fmla="*/ 885381 h 1242303"/>
              <a:gd name="connsiteX5" fmla="*/ 610681 w 3452552"/>
              <a:gd name="connsiteY5" fmla="*/ 785088 h 1242303"/>
              <a:gd name="connsiteX6" fmla="*/ 270334 w 3452552"/>
              <a:gd name="connsiteY6" fmla="*/ 1241949 h 1242303"/>
              <a:gd name="connsiteX7" fmla="*/ 0 w 3452552"/>
              <a:gd name="connsiteY7" fmla="*/ 700474 h 1242303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071 h 1255522"/>
              <a:gd name="connsiteX1" fmla="*/ 2705083 w 3452552"/>
              <a:gd name="connsiteY1" fmla="*/ 874676 h 1255522"/>
              <a:gd name="connsiteX2" fmla="*/ 1884083 w 3452552"/>
              <a:gd name="connsiteY2" fmla="*/ 420 h 1255522"/>
              <a:gd name="connsiteX3" fmla="*/ 1377478 w 3452552"/>
              <a:gd name="connsiteY3" fmla="*/ 760866 h 1255522"/>
              <a:gd name="connsiteX4" fmla="*/ 904397 w 3452552"/>
              <a:gd name="connsiteY4" fmla="*/ 898600 h 1255522"/>
              <a:gd name="connsiteX5" fmla="*/ 610681 w 3452552"/>
              <a:gd name="connsiteY5" fmla="*/ 798307 h 1255522"/>
              <a:gd name="connsiteX6" fmla="*/ 270334 w 3452552"/>
              <a:gd name="connsiteY6" fmla="*/ 1255168 h 1255522"/>
              <a:gd name="connsiteX7" fmla="*/ 0 w 3452552"/>
              <a:gd name="connsiteY7" fmla="*/ 713693 h 1255522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77478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64097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33227"/>
              <a:gd name="connsiteX1" fmla="*/ 2705083 w 3452552"/>
              <a:gd name="connsiteY1" fmla="*/ 874668 h 1233227"/>
              <a:gd name="connsiteX2" fmla="*/ 1884083 w 3452552"/>
              <a:gd name="connsiteY2" fmla="*/ 412 h 1233227"/>
              <a:gd name="connsiteX3" fmla="*/ 1364097 w 3452552"/>
              <a:gd name="connsiteY3" fmla="*/ 760858 h 1233227"/>
              <a:gd name="connsiteX4" fmla="*/ 904397 w 3452552"/>
              <a:gd name="connsiteY4" fmla="*/ 898592 h 1233227"/>
              <a:gd name="connsiteX5" fmla="*/ 610681 w 3452552"/>
              <a:gd name="connsiteY5" fmla="*/ 798299 h 1233227"/>
              <a:gd name="connsiteX6" fmla="*/ 274794 w 3452552"/>
              <a:gd name="connsiteY6" fmla="*/ 1232857 h 1233227"/>
              <a:gd name="connsiteX7" fmla="*/ 0 w 3452552"/>
              <a:gd name="connsiteY7" fmla="*/ 713685 h 1233227"/>
              <a:gd name="connsiteX0" fmla="*/ 3452552 w 3452552"/>
              <a:gd name="connsiteY0" fmla="*/ 830063 h 1233080"/>
              <a:gd name="connsiteX1" fmla="*/ 2705083 w 3452552"/>
              <a:gd name="connsiteY1" fmla="*/ 874668 h 1233080"/>
              <a:gd name="connsiteX2" fmla="*/ 1884083 w 3452552"/>
              <a:gd name="connsiteY2" fmla="*/ 412 h 1233080"/>
              <a:gd name="connsiteX3" fmla="*/ 1364097 w 3452552"/>
              <a:gd name="connsiteY3" fmla="*/ 760858 h 1233080"/>
              <a:gd name="connsiteX4" fmla="*/ 904397 w 3452552"/>
              <a:gd name="connsiteY4" fmla="*/ 898592 h 1233080"/>
              <a:gd name="connsiteX5" fmla="*/ 606221 w 3452552"/>
              <a:gd name="connsiteY5" fmla="*/ 780458 h 1233080"/>
              <a:gd name="connsiteX6" fmla="*/ 274794 w 3452552"/>
              <a:gd name="connsiteY6" fmla="*/ 1232857 h 1233080"/>
              <a:gd name="connsiteX7" fmla="*/ 0 w 3452552"/>
              <a:gd name="connsiteY7" fmla="*/ 713685 h 1233080"/>
              <a:gd name="connsiteX0" fmla="*/ 3452552 w 3452552"/>
              <a:gd name="connsiteY0" fmla="*/ 830069 h 1233087"/>
              <a:gd name="connsiteX1" fmla="*/ 2705083 w 3452552"/>
              <a:gd name="connsiteY1" fmla="*/ 874674 h 1233087"/>
              <a:gd name="connsiteX2" fmla="*/ 1884083 w 3452552"/>
              <a:gd name="connsiteY2" fmla="*/ 418 h 1233087"/>
              <a:gd name="connsiteX3" fmla="*/ 1364097 w 3452552"/>
              <a:gd name="connsiteY3" fmla="*/ 760864 h 1233087"/>
              <a:gd name="connsiteX4" fmla="*/ 904397 w 3452552"/>
              <a:gd name="connsiteY4" fmla="*/ 885217 h 1233087"/>
              <a:gd name="connsiteX5" fmla="*/ 606221 w 3452552"/>
              <a:gd name="connsiteY5" fmla="*/ 780464 h 1233087"/>
              <a:gd name="connsiteX6" fmla="*/ 274794 w 3452552"/>
              <a:gd name="connsiteY6" fmla="*/ 1232863 h 1233087"/>
              <a:gd name="connsiteX7" fmla="*/ 0 w 3452552"/>
              <a:gd name="connsiteY7" fmla="*/ 713691 h 1233087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72"/>
              <a:gd name="connsiteX1" fmla="*/ 2705083 w 3452552"/>
              <a:gd name="connsiteY1" fmla="*/ 865759 h 1224172"/>
              <a:gd name="connsiteX2" fmla="*/ 1884083 w 3452552"/>
              <a:gd name="connsiteY2" fmla="*/ 424 h 1224172"/>
              <a:gd name="connsiteX3" fmla="*/ 1364097 w 3452552"/>
              <a:gd name="connsiteY3" fmla="*/ 751949 h 1224172"/>
              <a:gd name="connsiteX4" fmla="*/ 904397 w 3452552"/>
              <a:gd name="connsiteY4" fmla="*/ 876302 h 1224172"/>
              <a:gd name="connsiteX5" fmla="*/ 606221 w 3452552"/>
              <a:gd name="connsiteY5" fmla="*/ 771549 h 1224172"/>
              <a:gd name="connsiteX6" fmla="*/ 274794 w 3452552"/>
              <a:gd name="connsiteY6" fmla="*/ 1223948 h 1224172"/>
              <a:gd name="connsiteX7" fmla="*/ 0 w 3452552"/>
              <a:gd name="connsiteY7" fmla="*/ 704776 h 1224172"/>
              <a:gd name="connsiteX0" fmla="*/ 3452552 w 3452552"/>
              <a:gd name="connsiteY0" fmla="*/ 821154 h 1224142"/>
              <a:gd name="connsiteX1" fmla="*/ 2705083 w 3452552"/>
              <a:gd name="connsiteY1" fmla="*/ 865759 h 1224142"/>
              <a:gd name="connsiteX2" fmla="*/ 1884083 w 3452552"/>
              <a:gd name="connsiteY2" fmla="*/ 424 h 1224142"/>
              <a:gd name="connsiteX3" fmla="*/ 1364097 w 3452552"/>
              <a:gd name="connsiteY3" fmla="*/ 751949 h 1224142"/>
              <a:gd name="connsiteX4" fmla="*/ 904397 w 3452552"/>
              <a:gd name="connsiteY4" fmla="*/ 876302 h 1224142"/>
              <a:gd name="connsiteX5" fmla="*/ 606221 w 3452552"/>
              <a:gd name="connsiteY5" fmla="*/ 767089 h 1224142"/>
              <a:gd name="connsiteX6" fmla="*/ 274794 w 3452552"/>
              <a:gd name="connsiteY6" fmla="*/ 1223948 h 1224142"/>
              <a:gd name="connsiteX7" fmla="*/ 0 w 3452552"/>
              <a:gd name="connsiteY7" fmla="*/ 704776 h 1224142"/>
              <a:gd name="connsiteX0" fmla="*/ 3452552 w 3452552"/>
              <a:gd name="connsiteY0" fmla="*/ 821153 h 1224141"/>
              <a:gd name="connsiteX1" fmla="*/ 2705083 w 3452552"/>
              <a:gd name="connsiteY1" fmla="*/ 865758 h 1224141"/>
              <a:gd name="connsiteX2" fmla="*/ 1884083 w 3452552"/>
              <a:gd name="connsiteY2" fmla="*/ 423 h 1224141"/>
              <a:gd name="connsiteX3" fmla="*/ 1364097 w 3452552"/>
              <a:gd name="connsiteY3" fmla="*/ 751948 h 1224141"/>
              <a:gd name="connsiteX4" fmla="*/ 904397 w 3452552"/>
              <a:gd name="connsiteY4" fmla="*/ 871840 h 1224141"/>
              <a:gd name="connsiteX5" fmla="*/ 606221 w 3452552"/>
              <a:gd name="connsiteY5" fmla="*/ 767088 h 1224141"/>
              <a:gd name="connsiteX6" fmla="*/ 274794 w 3452552"/>
              <a:gd name="connsiteY6" fmla="*/ 1223947 h 1224141"/>
              <a:gd name="connsiteX7" fmla="*/ 0 w 3452552"/>
              <a:gd name="connsiteY7" fmla="*/ 704775 h 1224141"/>
              <a:gd name="connsiteX0" fmla="*/ 3452552 w 3452552"/>
              <a:gd name="connsiteY0" fmla="*/ 821153 h 1215224"/>
              <a:gd name="connsiteX1" fmla="*/ 2705083 w 3452552"/>
              <a:gd name="connsiteY1" fmla="*/ 865758 h 1215224"/>
              <a:gd name="connsiteX2" fmla="*/ 1884083 w 3452552"/>
              <a:gd name="connsiteY2" fmla="*/ 423 h 1215224"/>
              <a:gd name="connsiteX3" fmla="*/ 1364097 w 3452552"/>
              <a:gd name="connsiteY3" fmla="*/ 751948 h 1215224"/>
              <a:gd name="connsiteX4" fmla="*/ 904397 w 3452552"/>
              <a:gd name="connsiteY4" fmla="*/ 871840 h 1215224"/>
              <a:gd name="connsiteX5" fmla="*/ 606221 w 3452552"/>
              <a:gd name="connsiteY5" fmla="*/ 767088 h 1215224"/>
              <a:gd name="connsiteX6" fmla="*/ 274794 w 3452552"/>
              <a:gd name="connsiteY6" fmla="*/ 1215026 h 1215224"/>
              <a:gd name="connsiteX7" fmla="*/ 0 w 3452552"/>
              <a:gd name="connsiteY7" fmla="*/ 704775 h 1215224"/>
              <a:gd name="connsiteX0" fmla="*/ 3452552 w 3452552"/>
              <a:gd name="connsiteY0" fmla="*/ 821153 h 1215145"/>
              <a:gd name="connsiteX1" fmla="*/ 2705083 w 3452552"/>
              <a:gd name="connsiteY1" fmla="*/ 865758 h 1215145"/>
              <a:gd name="connsiteX2" fmla="*/ 1884083 w 3452552"/>
              <a:gd name="connsiteY2" fmla="*/ 423 h 1215145"/>
              <a:gd name="connsiteX3" fmla="*/ 1364097 w 3452552"/>
              <a:gd name="connsiteY3" fmla="*/ 751948 h 1215145"/>
              <a:gd name="connsiteX4" fmla="*/ 904397 w 3452552"/>
              <a:gd name="connsiteY4" fmla="*/ 871840 h 1215145"/>
              <a:gd name="connsiteX5" fmla="*/ 606221 w 3452552"/>
              <a:gd name="connsiteY5" fmla="*/ 753706 h 1215145"/>
              <a:gd name="connsiteX6" fmla="*/ 274794 w 3452552"/>
              <a:gd name="connsiteY6" fmla="*/ 1215026 h 1215145"/>
              <a:gd name="connsiteX7" fmla="*/ 0 w 3452552"/>
              <a:gd name="connsiteY7" fmla="*/ 704775 h 1215145"/>
              <a:gd name="connsiteX0" fmla="*/ 3452552 w 3452552"/>
              <a:gd name="connsiteY0" fmla="*/ 821152 h 1215144"/>
              <a:gd name="connsiteX1" fmla="*/ 2705083 w 3452552"/>
              <a:gd name="connsiteY1" fmla="*/ 865757 h 1215144"/>
              <a:gd name="connsiteX2" fmla="*/ 1884083 w 3452552"/>
              <a:gd name="connsiteY2" fmla="*/ 422 h 1215144"/>
              <a:gd name="connsiteX3" fmla="*/ 1364097 w 3452552"/>
              <a:gd name="connsiteY3" fmla="*/ 751947 h 1215144"/>
              <a:gd name="connsiteX4" fmla="*/ 899937 w 3452552"/>
              <a:gd name="connsiteY4" fmla="*/ 862918 h 1215144"/>
              <a:gd name="connsiteX5" fmla="*/ 606221 w 3452552"/>
              <a:gd name="connsiteY5" fmla="*/ 753705 h 1215144"/>
              <a:gd name="connsiteX6" fmla="*/ 274794 w 3452552"/>
              <a:gd name="connsiteY6" fmla="*/ 1215025 h 1215144"/>
              <a:gd name="connsiteX7" fmla="*/ 0 w 3452552"/>
              <a:gd name="connsiteY7" fmla="*/ 704774 h 1215144"/>
              <a:gd name="connsiteX0" fmla="*/ 3452552 w 3452552"/>
              <a:gd name="connsiteY0" fmla="*/ 821187 h 1215179"/>
              <a:gd name="connsiteX1" fmla="*/ 2705083 w 3452552"/>
              <a:gd name="connsiteY1" fmla="*/ 865792 h 1215179"/>
              <a:gd name="connsiteX2" fmla="*/ 1884083 w 3452552"/>
              <a:gd name="connsiteY2" fmla="*/ 457 h 1215179"/>
              <a:gd name="connsiteX3" fmla="*/ 1359636 w 3452552"/>
              <a:gd name="connsiteY3" fmla="*/ 747522 h 1215179"/>
              <a:gd name="connsiteX4" fmla="*/ 899937 w 3452552"/>
              <a:gd name="connsiteY4" fmla="*/ 862953 h 1215179"/>
              <a:gd name="connsiteX5" fmla="*/ 606221 w 3452552"/>
              <a:gd name="connsiteY5" fmla="*/ 753740 h 1215179"/>
              <a:gd name="connsiteX6" fmla="*/ 274794 w 3452552"/>
              <a:gd name="connsiteY6" fmla="*/ 1215060 h 1215179"/>
              <a:gd name="connsiteX7" fmla="*/ 0 w 3452552"/>
              <a:gd name="connsiteY7" fmla="*/ 704809 h 1215179"/>
              <a:gd name="connsiteX0" fmla="*/ 3452552 w 3452552"/>
              <a:gd name="connsiteY0" fmla="*/ 816731 h 1210723"/>
              <a:gd name="connsiteX1" fmla="*/ 2705083 w 3452552"/>
              <a:gd name="connsiteY1" fmla="*/ 861336 h 1210723"/>
              <a:gd name="connsiteX2" fmla="*/ 1884083 w 3452552"/>
              <a:gd name="connsiteY2" fmla="*/ 461 h 1210723"/>
              <a:gd name="connsiteX3" fmla="*/ 1359636 w 3452552"/>
              <a:gd name="connsiteY3" fmla="*/ 743066 h 1210723"/>
              <a:gd name="connsiteX4" fmla="*/ 899937 w 3452552"/>
              <a:gd name="connsiteY4" fmla="*/ 858497 h 1210723"/>
              <a:gd name="connsiteX5" fmla="*/ 606221 w 3452552"/>
              <a:gd name="connsiteY5" fmla="*/ 749284 h 1210723"/>
              <a:gd name="connsiteX6" fmla="*/ 274794 w 3452552"/>
              <a:gd name="connsiteY6" fmla="*/ 1210604 h 1210723"/>
              <a:gd name="connsiteX7" fmla="*/ 0 w 3452552"/>
              <a:gd name="connsiteY7" fmla="*/ 700353 h 1210723"/>
              <a:gd name="connsiteX0" fmla="*/ 3452552 w 3452552"/>
              <a:gd name="connsiteY0" fmla="*/ 816731 h 1210723"/>
              <a:gd name="connsiteX1" fmla="*/ 2705083 w 3452552"/>
              <a:gd name="connsiteY1" fmla="*/ 861336 h 1210723"/>
              <a:gd name="connsiteX2" fmla="*/ 1884083 w 3452552"/>
              <a:gd name="connsiteY2" fmla="*/ 461 h 1210723"/>
              <a:gd name="connsiteX3" fmla="*/ 1359636 w 3452552"/>
              <a:gd name="connsiteY3" fmla="*/ 743066 h 1210723"/>
              <a:gd name="connsiteX4" fmla="*/ 899937 w 3452552"/>
              <a:gd name="connsiteY4" fmla="*/ 858497 h 1210723"/>
              <a:gd name="connsiteX5" fmla="*/ 606221 w 3452552"/>
              <a:gd name="connsiteY5" fmla="*/ 749284 h 1210723"/>
              <a:gd name="connsiteX6" fmla="*/ 274794 w 3452552"/>
              <a:gd name="connsiteY6" fmla="*/ 1210604 h 1210723"/>
              <a:gd name="connsiteX7" fmla="*/ 0 w 3452552"/>
              <a:gd name="connsiteY7" fmla="*/ 700353 h 1210723"/>
              <a:gd name="connsiteX0" fmla="*/ 3452552 w 3452552"/>
              <a:gd name="connsiteY0" fmla="*/ 816731 h 1201134"/>
              <a:gd name="connsiteX1" fmla="*/ 2705083 w 3452552"/>
              <a:gd name="connsiteY1" fmla="*/ 861336 h 1201134"/>
              <a:gd name="connsiteX2" fmla="*/ 1884083 w 3452552"/>
              <a:gd name="connsiteY2" fmla="*/ 461 h 1201134"/>
              <a:gd name="connsiteX3" fmla="*/ 1359636 w 3452552"/>
              <a:gd name="connsiteY3" fmla="*/ 743066 h 1201134"/>
              <a:gd name="connsiteX4" fmla="*/ 899937 w 3452552"/>
              <a:gd name="connsiteY4" fmla="*/ 858497 h 1201134"/>
              <a:gd name="connsiteX5" fmla="*/ 606221 w 3452552"/>
              <a:gd name="connsiteY5" fmla="*/ 749284 h 1201134"/>
              <a:gd name="connsiteX6" fmla="*/ 274794 w 3452552"/>
              <a:gd name="connsiteY6" fmla="*/ 1201012 h 1201134"/>
              <a:gd name="connsiteX7" fmla="*/ 0 w 3452552"/>
              <a:gd name="connsiteY7" fmla="*/ 700353 h 1201134"/>
              <a:gd name="connsiteX0" fmla="*/ 3452552 w 3452552"/>
              <a:gd name="connsiteY0" fmla="*/ 816731 h 1201077"/>
              <a:gd name="connsiteX1" fmla="*/ 2705083 w 3452552"/>
              <a:gd name="connsiteY1" fmla="*/ 861336 h 1201077"/>
              <a:gd name="connsiteX2" fmla="*/ 1884083 w 3452552"/>
              <a:gd name="connsiteY2" fmla="*/ 461 h 1201077"/>
              <a:gd name="connsiteX3" fmla="*/ 1359636 w 3452552"/>
              <a:gd name="connsiteY3" fmla="*/ 743066 h 1201077"/>
              <a:gd name="connsiteX4" fmla="*/ 899937 w 3452552"/>
              <a:gd name="connsiteY4" fmla="*/ 858497 h 1201077"/>
              <a:gd name="connsiteX5" fmla="*/ 606221 w 3452552"/>
              <a:gd name="connsiteY5" fmla="*/ 736496 h 1201077"/>
              <a:gd name="connsiteX6" fmla="*/ 274794 w 3452552"/>
              <a:gd name="connsiteY6" fmla="*/ 1201012 h 1201077"/>
              <a:gd name="connsiteX7" fmla="*/ 0 w 3452552"/>
              <a:gd name="connsiteY7" fmla="*/ 700353 h 1201077"/>
              <a:gd name="connsiteX0" fmla="*/ 3452552 w 3452552"/>
              <a:gd name="connsiteY0" fmla="*/ 816843 h 1201189"/>
              <a:gd name="connsiteX1" fmla="*/ 2705083 w 3452552"/>
              <a:gd name="connsiteY1" fmla="*/ 861448 h 1201189"/>
              <a:gd name="connsiteX2" fmla="*/ 1884083 w 3452552"/>
              <a:gd name="connsiteY2" fmla="*/ 573 h 1201189"/>
              <a:gd name="connsiteX3" fmla="*/ 1359636 w 3452552"/>
              <a:gd name="connsiteY3" fmla="*/ 730389 h 1201189"/>
              <a:gd name="connsiteX4" fmla="*/ 899937 w 3452552"/>
              <a:gd name="connsiteY4" fmla="*/ 858609 h 1201189"/>
              <a:gd name="connsiteX5" fmla="*/ 606221 w 3452552"/>
              <a:gd name="connsiteY5" fmla="*/ 736608 h 1201189"/>
              <a:gd name="connsiteX6" fmla="*/ 274794 w 3452552"/>
              <a:gd name="connsiteY6" fmla="*/ 1201124 h 1201189"/>
              <a:gd name="connsiteX7" fmla="*/ 0 w 3452552"/>
              <a:gd name="connsiteY7" fmla="*/ 700465 h 1201189"/>
              <a:gd name="connsiteX0" fmla="*/ 3452552 w 3452552"/>
              <a:gd name="connsiteY0" fmla="*/ 816843 h 1188402"/>
              <a:gd name="connsiteX1" fmla="*/ 2705083 w 3452552"/>
              <a:gd name="connsiteY1" fmla="*/ 861448 h 1188402"/>
              <a:gd name="connsiteX2" fmla="*/ 1884083 w 3452552"/>
              <a:gd name="connsiteY2" fmla="*/ 573 h 1188402"/>
              <a:gd name="connsiteX3" fmla="*/ 1359636 w 3452552"/>
              <a:gd name="connsiteY3" fmla="*/ 730389 h 1188402"/>
              <a:gd name="connsiteX4" fmla="*/ 899937 w 3452552"/>
              <a:gd name="connsiteY4" fmla="*/ 858609 h 1188402"/>
              <a:gd name="connsiteX5" fmla="*/ 606221 w 3452552"/>
              <a:gd name="connsiteY5" fmla="*/ 736608 h 1188402"/>
              <a:gd name="connsiteX6" fmla="*/ 274794 w 3452552"/>
              <a:gd name="connsiteY6" fmla="*/ 1188336 h 1188402"/>
              <a:gd name="connsiteX7" fmla="*/ 0 w 3452552"/>
              <a:gd name="connsiteY7" fmla="*/ 700465 h 1188402"/>
              <a:gd name="connsiteX0" fmla="*/ 3452552 w 3452552"/>
              <a:gd name="connsiteY0" fmla="*/ 816843 h 1188371"/>
              <a:gd name="connsiteX1" fmla="*/ 2705083 w 3452552"/>
              <a:gd name="connsiteY1" fmla="*/ 861448 h 1188371"/>
              <a:gd name="connsiteX2" fmla="*/ 1884083 w 3452552"/>
              <a:gd name="connsiteY2" fmla="*/ 573 h 1188371"/>
              <a:gd name="connsiteX3" fmla="*/ 1359636 w 3452552"/>
              <a:gd name="connsiteY3" fmla="*/ 730389 h 1188371"/>
              <a:gd name="connsiteX4" fmla="*/ 899937 w 3452552"/>
              <a:gd name="connsiteY4" fmla="*/ 858609 h 1188371"/>
              <a:gd name="connsiteX5" fmla="*/ 606221 w 3452552"/>
              <a:gd name="connsiteY5" fmla="*/ 727016 h 1188371"/>
              <a:gd name="connsiteX6" fmla="*/ 274794 w 3452552"/>
              <a:gd name="connsiteY6" fmla="*/ 1188336 h 1188371"/>
              <a:gd name="connsiteX7" fmla="*/ 0 w 3452552"/>
              <a:gd name="connsiteY7" fmla="*/ 700465 h 1188371"/>
              <a:gd name="connsiteX0" fmla="*/ 3452552 w 3452552"/>
              <a:gd name="connsiteY0" fmla="*/ 816843 h 1194765"/>
              <a:gd name="connsiteX1" fmla="*/ 2705083 w 3452552"/>
              <a:gd name="connsiteY1" fmla="*/ 861448 h 1194765"/>
              <a:gd name="connsiteX2" fmla="*/ 1884083 w 3452552"/>
              <a:gd name="connsiteY2" fmla="*/ 573 h 1194765"/>
              <a:gd name="connsiteX3" fmla="*/ 1359636 w 3452552"/>
              <a:gd name="connsiteY3" fmla="*/ 730389 h 1194765"/>
              <a:gd name="connsiteX4" fmla="*/ 899937 w 3452552"/>
              <a:gd name="connsiteY4" fmla="*/ 858609 h 1194765"/>
              <a:gd name="connsiteX5" fmla="*/ 606221 w 3452552"/>
              <a:gd name="connsiteY5" fmla="*/ 727016 h 1194765"/>
              <a:gd name="connsiteX6" fmla="*/ 274794 w 3452552"/>
              <a:gd name="connsiteY6" fmla="*/ 1194730 h 1194765"/>
              <a:gd name="connsiteX7" fmla="*/ 0 w 3452552"/>
              <a:gd name="connsiteY7" fmla="*/ 700465 h 1194765"/>
              <a:gd name="connsiteX0" fmla="*/ 3452552 w 3452552"/>
              <a:gd name="connsiteY0" fmla="*/ 816843 h 1197961"/>
              <a:gd name="connsiteX1" fmla="*/ 2705083 w 3452552"/>
              <a:gd name="connsiteY1" fmla="*/ 861448 h 1197961"/>
              <a:gd name="connsiteX2" fmla="*/ 1884083 w 3452552"/>
              <a:gd name="connsiteY2" fmla="*/ 573 h 1197961"/>
              <a:gd name="connsiteX3" fmla="*/ 1359636 w 3452552"/>
              <a:gd name="connsiteY3" fmla="*/ 730389 h 1197961"/>
              <a:gd name="connsiteX4" fmla="*/ 899937 w 3452552"/>
              <a:gd name="connsiteY4" fmla="*/ 858609 h 1197961"/>
              <a:gd name="connsiteX5" fmla="*/ 606221 w 3452552"/>
              <a:gd name="connsiteY5" fmla="*/ 727016 h 1197961"/>
              <a:gd name="connsiteX6" fmla="*/ 274794 w 3452552"/>
              <a:gd name="connsiteY6" fmla="*/ 1197927 h 1197961"/>
              <a:gd name="connsiteX7" fmla="*/ 0 w 3452552"/>
              <a:gd name="connsiteY7" fmla="*/ 700465 h 119796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197961">
                <a:moveTo>
                  <a:pt x="3452552" y="816843"/>
                </a:moveTo>
                <a:cubicBezTo>
                  <a:pt x="3223028" y="821000"/>
                  <a:pt x="2957574" y="894902"/>
                  <a:pt x="2705083" y="861448"/>
                </a:cubicBezTo>
                <a:cubicBezTo>
                  <a:pt x="2452592" y="827994"/>
                  <a:pt x="2108324" y="22416"/>
                  <a:pt x="1884083" y="573"/>
                </a:cubicBezTo>
                <a:cubicBezTo>
                  <a:pt x="1659842" y="-21270"/>
                  <a:pt x="1523660" y="587383"/>
                  <a:pt x="1359636" y="730389"/>
                </a:cubicBezTo>
                <a:cubicBezTo>
                  <a:pt x="1195612" y="873395"/>
                  <a:pt x="1025506" y="859171"/>
                  <a:pt x="899937" y="858609"/>
                </a:cubicBezTo>
                <a:cubicBezTo>
                  <a:pt x="774368" y="858047"/>
                  <a:pt x="710412" y="670463"/>
                  <a:pt x="606221" y="727016"/>
                </a:cubicBezTo>
                <a:cubicBezTo>
                  <a:pt x="502031" y="783569"/>
                  <a:pt x="375831" y="1202352"/>
                  <a:pt x="274794" y="1197927"/>
                </a:cubicBezTo>
                <a:cubicBezTo>
                  <a:pt x="173757" y="1193502"/>
                  <a:pt x="96520" y="919828"/>
                  <a:pt x="0" y="700465"/>
                </a:cubicBezTo>
              </a:path>
            </a:pathLst>
          </a:custGeom>
          <a:noFill/>
          <a:ln w="127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57" name="フリーフォーム 356"/>
          <p:cNvSpPr/>
          <p:nvPr/>
        </p:nvSpPr>
        <p:spPr>
          <a:xfrm>
            <a:off x="5212656" y="1060021"/>
            <a:ext cx="3452552" cy="1175072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29 h 1241422"/>
              <a:gd name="connsiteX1" fmla="*/ 2705083 w 3452552"/>
              <a:gd name="connsiteY1" fmla="*/ 959034 h 1241422"/>
              <a:gd name="connsiteX2" fmla="*/ 1906385 w 3452552"/>
              <a:gd name="connsiteY2" fmla="*/ 29 h 1241422"/>
              <a:gd name="connsiteX3" fmla="*/ 1413163 w 3452552"/>
              <a:gd name="connsiteY3" fmla="*/ 925512 h 1241422"/>
              <a:gd name="connsiteX4" fmla="*/ 908858 w 3452552"/>
              <a:gd name="connsiteY4" fmla="*/ 1014181 h 1241422"/>
              <a:gd name="connsiteX5" fmla="*/ 615142 w 3452552"/>
              <a:gd name="connsiteY5" fmla="*/ 820218 h 1241422"/>
              <a:gd name="connsiteX6" fmla="*/ 288175 w 3452552"/>
              <a:gd name="connsiteY6" fmla="*/ 1241396 h 1241422"/>
              <a:gd name="connsiteX7" fmla="*/ 0 w 3452552"/>
              <a:gd name="connsiteY7" fmla="*/ 798051 h 1241422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35017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675 h 1130668"/>
              <a:gd name="connsiteX1" fmla="*/ 2705083 w 3452552"/>
              <a:gd name="connsiteY1" fmla="*/ 848280 h 1130668"/>
              <a:gd name="connsiteX2" fmla="*/ 1835017 w 3452552"/>
              <a:gd name="connsiteY2" fmla="*/ 788 h 1130668"/>
              <a:gd name="connsiteX3" fmla="*/ 1364098 w 3452552"/>
              <a:gd name="connsiteY3" fmla="*/ 694325 h 1130668"/>
              <a:gd name="connsiteX4" fmla="*/ 908858 w 3452552"/>
              <a:gd name="connsiteY4" fmla="*/ 903427 h 1130668"/>
              <a:gd name="connsiteX5" fmla="*/ 615142 w 3452552"/>
              <a:gd name="connsiteY5" fmla="*/ 709464 h 1130668"/>
              <a:gd name="connsiteX6" fmla="*/ 288175 w 3452552"/>
              <a:gd name="connsiteY6" fmla="*/ 1130642 h 1130668"/>
              <a:gd name="connsiteX7" fmla="*/ 0 w 3452552"/>
              <a:gd name="connsiteY7" fmla="*/ 687297 h 1130668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61780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715 h 1130708"/>
              <a:gd name="connsiteX1" fmla="*/ 2705083 w 3452552"/>
              <a:gd name="connsiteY1" fmla="*/ 848320 h 1130708"/>
              <a:gd name="connsiteX2" fmla="*/ 1861780 w 3452552"/>
              <a:gd name="connsiteY2" fmla="*/ 828 h 1130708"/>
              <a:gd name="connsiteX3" fmla="*/ 1364098 w 3452552"/>
              <a:gd name="connsiteY3" fmla="*/ 694365 h 1130708"/>
              <a:gd name="connsiteX4" fmla="*/ 913318 w 3452552"/>
              <a:gd name="connsiteY4" fmla="*/ 845481 h 1130708"/>
              <a:gd name="connsiteX5" fmla="*/ 615142 w 3452552"/>
              <a:gd name="connsiteY5" fmla="*/ 709504 h 1130708"/>
              <a:gd name="connsiteX6" fmla="*/ 288175 w 3452552"/>
              <a:gd name="connsiteY6" fmla="*/ 1130682 h 1130708"/>
              <a:gd name="connsiteX7" fmla="*/ 0 w 3452552"/>
              <a:gd name="connsiteY7" fmla="*/ 687337 h 1130708"/>
              <a:gd name="connsiteX0" fmla="*/ 3452552 w 3452552"/>
              <a:gd name="connsiteY0" fmla="*/ 803715 h 1103947"/>
              <a:gd name="connsiteX1" fmla="*/ 2705083 w 3452552"/>
              <a:gd name="connsiteY1" fmla="*/ 848320 h 1103947"/>
              <a:gd name="connsiteX2" fmla="*/ 1861780 w 3452552"/>
              <a:gd name="connsiteY2" fmla="*/ 828 h 1103947"/>
              <a:gd name="connsiteX3" fmla="*/ 1364098 w 3452552"/>
              <a:gd name="connsiteY3" fmla="*/ 694365 h 1103947"/>
              <a:gd name="connsiteX4" fmla="*/ 913318 w 3452552"/>
              <a:gd name="connsiteY4" fmla="*/ 845481 h 1103947"/>
              <a:gd name="connsiteX5" fmla="*/ 615142 w 3452552"/>
              <a:gd name="connsiteY5" fmla="*/ 709504 h 1103947"/>
              <a:gd name="connsiteX6" fmla="*/ 288175 w 3452552"/>
              <a:gd name="connsiteY6" fmla="*/ 1103919 h 1103947"/>
              <a:gd name="connsiteX7" fmla="*/ 0 w 3452552"/>
              <a:gd name="connsiteY7" fmla="*/ 687337 h 1103947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88543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175072">
                <a:moveTo>
                  <a:pt x="3452552" y="803477"/>
                </a:moveTo>
                <a:cubicBezTo>
                  <a:pt x="3223028" y="807634"/>
                  <a:pt x="2961290" y="883766"/>
                  <a:pt x="2705083" y="848082"/>
                </a:cubicBezTo>
                <a:cubicBezTo>
                  <a:pt x="2448876" y="812398"/>
                  <a:pt x="2114271" y="22532"/>
                  <a:pt x="1888543" y="590"/>
                </a:cubicBezTo>
                <a:cubicBezTo>
                  <a:pt x="1662815" y="-21352"/>
                  <a:pt x="1513253" y="575655"/>
                  <a:pt x="1350716" y="716430"/>
                </a:cubicBezTo>
                <a:cubicBezTo>
                  <a:pt x="1188179" y="857205"/>
                  <a:pt x="1035914" y="846437"/>
                  <a:pt x="913318" y="845243"/>
                </a:cubicBezTo>
                <a:cubicBezTo>
                  <a:pt x="790722" y="844049"/>
                  <a:pt x="721563" y="654299"/>
                  <a:pt x="615142" y="709266"/>
                </a:cubicBezTo>
                <a:cubicBezTo>
                  <a:pt x="508721" y="764233"/>
                  <a:pt x="377318" y="1178742"/>
                  <a:pt x="274794" y="1175048"/>
                </a:cubicBezTo>
                <a:cubicBezTo>
                  <a:pt x="172270" y="1171354"/>
                  <a:pt x="96520" y="906462"/>
                  <a:pt x="0" y="687099"/>
                </a:cubicBezTo>
              </a:path>
            </a:pathLst>
          </a:cu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84" name="フリーフォーム 383"/>
          <p:cNvSpPr/>
          <p:nvPr/>
        </p:nvSpPr>
        <p:spPr>
          <a:xfrm>
            <a:off x="5214984" y="1035070"/>
            <a:ext cx="3452552" cy="1255514"/>
          </a:xfrm>
          <a:custGeom>
            <a:avLst/>
            <a:gdLst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50720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1"/>
              <a:gd name="connsiteX1" fmla="*/ 2776451 w 3452552"/>
              <a:gd name="connsiteY1" fmla="*/ 914403 h 1241411"/>
              <a:gd name="connsiteX2" fmla="*/ 1906385 w 3452552"/>
              <a:gd name="connsiteY2" fmla="*/ 3 h 1241411"/>
              <a:gd name="connsiteX3" fmla="*/ 1413163 w 3452552"/>
              <a:gd name="connsiteY3" fmla="*/ 925486 h 1241411"/>
              <a:gd name="connsiteX4" fmla="*/ 870065 w 3452552"/>
              <a:gd name="connsiteY4" fmla="*/ 1014155 h 1241411"/>
              <a:gd name="connsiteX5" fmla="*/ 637309 w 3452552"/>
              <a:gd name="connsiteY5" fmla="*/ 825734 h 1241411"/>
              <a:gd name="connsiteX6" fmla="*/ 299258 w 3452552"/>
              <a:gd name="connsiteY6" fmla="*/ 1241370 h 1241411"/>
              <a:gd name="connsiteX7" fmla="*/ 0 w 3452552"/>
              <a:gd name="connsiteY7" fmla="*/ 798025 h 1241411"/>
              <a:gd name="connsiteX0" fmla="*/ 3452552 w 3452552"/>
              <a:gd name="connsiteY0" fmla="*/ 914403 h 1241412"/>
              <a:gd name="connsiteX1" fmla="*/ 2776451 w 3452552"/>
              <a:gd name="connsiteY1" fmla="*/ 914403 h 1241412"/>
              <a:gd name="connsiteX2" fmla="*/ 1906385 w 3452552"/>
              <a:gd name="connsiteY2" fmla="*/ 3 h 1241412"/>
              <a:gd name="connsiteX3" fmla="*/ 1413163 w 3452552"/>
              <a:gd name="connsiteY3" fmla="*/ 925486 h 1241412"/>
              <a:gd name="connsiteX4" fmla="*/ 886690 w 3452552"/>
              <a:gd name="connsiteY4" fmla="*/ 975362 h 1241412"/>
              <a:gd name="connsiteX5" fmla="*/ 637309 w 3452552"/>
              <a:gd name="connsiteY5" fmla="*/ 825734 h 1241412"/>
              <a:gd name="connsiteX6" fmla="*/ 299258 w 3452552"/>
              <a:gd name="connsiteY6" fmla="*/ 1241370 h 1241412"/>
              <a:gd name="connsiteX7" fmla="*/ 0 w 3452552"/>
              <a:gd name="connsiteY7" fmla="*/ 798025 h 1241412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1409"/>
              <a:gd name="connsiteX1" fmla="*/ 2776451 w 3452552"/>
              <a:gd name="connsiteY1" fmla="*/ 914403 h 1241409"/>
              <a:gd name="connsiteX2" fmla="*/ 1906385 w 3452552"/>
              <a:gd name="connsiteY2" fmla="*/ 3 h 1241409"/>
              <a:gd name="connsiteX3" fmla="*/ 1413163 w 3452552"/>
              <a:gd name="connsiteY3" fmla="*/ 925486 h 1241409"/>
              <a:gd name="connsiteX4" fmla="*/ 886690 w 3452552"/>
              <a:gd name="connsiteY4" fmla="*/ 975362 h 1241409"/>
              <a:gd name="connsiteX5" fmla="*/ 637309 w 3452552"/>
              <a:gd name="connsiteY5" fmla="*/ 825734 h 1241409"/>
              <a:gd name="connsiteX6" fmla="*/ 299258 w 3452552"/>
              <a:gd name="connsiteY6" fmla="*/ 1241370 h 1241409"/>
              <a:gd name="connsiteX7" fmla="*/ 0 w 3452552"/>
              <a:gd name="connsiteY7" fmla="*/ 798025 h 1241409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99258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86690 w 3452552"/>
              <a:gd name="connsiteY4" fmla="*/ 975362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875607 w 3452552"/>
              <a:gd name="connsiteY4" fmla="*/ 991987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2272"/>
              <a:gd name="connsiteX1" fmla="*/ 2776451 w 3452552"/>
              <a:gd name="connsiteY1" fmla="*/ 914403 h 1242272"/>
              <a:gd name="connsiteX2" fmla="*/ 1906385 w 3452552"/>
              <a:gd name="connsiteY2" fmla="*/ 3 h 1242272"/>
              <a:gd name="connsiteX3" fmla="*/ 1413163 w 3452552"/>
              <a:gd name="connsiteY3" fmla="*/ 925486 h 1242272"/>
              <a:gd name="connsiteX4" fmla="*/ 908858 w 3452552"/>
              <a:gd name="connsiteY4" fmla="*/ 1014155 h 1242272"/>
              <a:gd name="connsiteX5" fmla="*/ 637309 w 3452552"/>
              <a:gd name="connsiteY5" fmla="*/ 825734 h 1242272"/>
              <a:gd name="connsiteX6" fmla="*/ 288175 w 3452552"/>
              <a:gd name="connsiteY6" fmla="*/ 1241370 h 1242272"/>
              <a:gd name="connsiteX7" fmla="*/ 0 w 3452552"/>
              <a:gd name="connsiteY7" fmla="*/ 798025 h 1242272"/>
              <a:gd name="connsiteX0" fmla="*/ 3452552 w 3452552"/>
              <a:gd name="connsiteY0" fmla="*/ 914403 h 1241396"/>
              <a:gd name="connsiteX1" fmla="*/ 2776451 w 3452552"/>
              <a:gd name="connsiteY1" fmla="*/ 914403 h 1241396"/>
              <a:gd name="connsiteX2" fmla="*/ 1906385 w 3452552"/>
              <a:gd name="connsiteY2" fmla="*/ 3 h 1241396"/>
              <a:gd name="connsiteX3" fmla="*/ 1413163 w 3452552"/>
              <a:gd name="connsiteY3" fmla="*/ 925486 h 1241396"/>
              <a:gd name="connsiteX4" fmla="*/ 908858 w 3452552"/>
              <a:gd name="connsiteY4" fmla="*/ 1014155 h 1241396"/>
              <a:gd name="connsiteX5" fmla="*/ 615142 w 3452552"/>
              <a:gd name="connsiteY5" fmla="*/ 820192 h 1241396"/>
              <a:gd name="connsiteX6" fmla="*/ 288175 w 3452552"/>
              <a:gd name="connsiteY6" fmla="*/ 1241370 h 1241396"/>
              <a:gd name="connsiteX7" fmla="*/ 0 w 3452552"/>
              <a:gd name="connsiteY7" fmla="*/ 798025 h 1241396"/>
              <a:gd name="connsiteX0" fmla="*/ 3452552 w 3452552"/>
              <a:gd name="connsiteY0" fmla="*/ 914429 h 1241422"/>
              <a:gd name="connsiteX1" fmla="*/ 2705083 w 3452552"/>
              <a:gd name="connsiteY1" fmla="*/ 959034 h 1241422"/>
              <a:gd name="connsiteX2" fmla="*/ 1906385 w 3452552"/>
              <a:gd name="connsiteY2" fmla="*/ 29 h 1241422"/>
              <a:gd name="connsiteX3" fmla="*/ 1413163 w 3452552"/>
              <a:gd name="connsiteY3" fmla="*/ 925512 h 1241422"/>
              <a:gd name="connsiteX4" fmla="*/ 908858 w 3452552"/>
              <a:gd name="connsiteY4" fmla="*/ 1014181 h 1241422"/>
              <a:gd name="connsiteX5" fmla="*/ 615142 w 3452552"/>
              <a:gd name="connsiteY5" fmla="*/ 820218 h 1241422"/>
              <a:gd name="connsiteX6" fmla="*/ 288175 w 3452552"/>
              <a:gd name="connsiteY6" fmla="*/ 1241396 h 1241422"/>
              <a:gd name="connsiteX7" fmla="*/ 0 w 3452552"/>
              <a:gd name="connsiteY7" fmla="*/ 798051 h 1241422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2922 h 1129915"/>
              <a:gd name="connsiteX1" fmla="*/ 2705083 w 3452552"/>
              <a:gd name="connsiteY1" fmla="*/ 847527 h 1129915"/>
              <a:gd name="connsiteX2" fmla="*/ 1835017 w 3452552"/>
              <a:gd name="connsiteY2" fmla="*/ 35 h 1129915"/>
              <a:gd name="connsiteX3" fmla="*/ 1413163 w 3452552"/>
              <a:gd name="connsiteY3" fmla="*/ 814005 h 1129915"/>
              <a:gd name="connsiteX4" fmla="*/ 908858 w 3452552"/>
              <a:gd name="connsiteY4" fmla="*/ 902674 h 1129915"/>
              <a:gd name="connsiteX5" fmla="*/ 615142 w 3452552"/>
              <a:gd name="connsiteY5" fmla="*/ 708711 h 1129915"/>
              <a:gd name="connsiteX6" fmla="*/ 288175 w 3452552"/>
              <a:gd name="connsiteY6" fmla="*/ 1129889 h 1129915"/>
              <a:gd name="connsiteX7" fmla="*/ 0 w 3452552"/>
              <a:gd name="connsiteY7" fmla="*/ 686544 h 1129915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35017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675 h 1130668"/>
              <a:gd name="connsiteX1" fmla="*/ 2705083 w 3452552"/>
              <a:gd name="connsiteY1" fmla="*/ 848280 h 1130668"/>
              <a:gd name="connsiteX2" fmla="*/ 1835017 w 3452552"/>
              <a:gd name="connsiteY2" fmla="*/ 788 h 1130668"/>
              <a:gd name="connsiteX3" fmla="*/ 1364098 w 3452552"/>
              <a:gd name="connsiteY3" fmla="*/ 694325 h 1130668"/>
              <a:gd name="connsiteX4" fmla="*/ 908858 w 3452552"/>
              <a:gd name="connsiteY4" fmla="*/ 903427 h 1130668"/>
              <a:gd name="connsiteX5" fmla="*/ 615142 w 3452552"/>
              <a:gd name="connsiteY5" fmla="*/ 709464 h 1130668"/>
              <a:gd name="connsiteX6" fmla="*/ 288175 w 3452552"/>
              <a:gd name="connsiteY6" fmla="*/ 1130642 h 1130668"/>
              <a:gd name="connsiteX7" fmla="*/ 0 w 3452552"/>
              <a:gd name="connsiteY7" fmla="*/ 687297 h 1130668"/>
              <a:gd name="connsiteX0" fmla="*/ 3452552 w 3452552"/>
              <a:gd name="connsiteY0" fmla="*/ 803728 h 1130721"/>
              <a:gd name="connsiteX1" fmla="*/ 2705083 w 3452552"/>
              <a:gd name="connsiteY1" fmla="*/ 848333 h 1130721"/>
              <a:gd name="connsiteX2" fmla="*/ 1861780 w 3452552"/>
              <a:gd name="connsiteY2" fmla="*/ 841 h 1130721"/>
              <a:gd name="connsiteX3" fmla="*/ 1364098 w 3452552"/>
              <a:gd name="connsiteY3" fmla="*/ 694378 h 1130721"/>
              <a:gd name="connsiteX4" fmla="*/ 908858 w 3452552"/>
              <a:gd name="connsiteY4" fmla="*/ 903480 h 1130721"/>
              <a:gd name="connsiteX5" fmla="*/ 615142 w 3452552"/>
              <a:gd name="connsiteY5" fmla="*/ 709517 h 1130721"/>
              <a:gd name="connsiteX6" fmla="*/ 288175 w 3452552"/>
              <a:gd name="connsiteY6" fmla="*/ 1130695 h 1130721"/>
              <a:gd name="connsiteX7" fmla="*/ 0 w 3452552"/>
              <a:gd name="connsiteY7" fmla="*/ 687350 h 1130721"/>
              <a:gd name="connsiteX0" fmla="*/ 3452552 w 3452552"/>
              <a:gd name="connsiteY0" fmla="*/ 803715 h 1130708"/>
              <a:gd name="connsiteX1" fmla="*/ 2705083 w 3452552"/>
              <a:gd name="connsiteY1" fmla="*/ 848320 h 1130708"/>
              <a:gd name="connsiteX2" fmla="*/ 1861780 w 3452552"/>
              <a:gd name="connsiteY2" fmla="*/ 828 h 1130708"/>
              <a:gd name="connsiteX3" fmla="*/ 1364098 w 3452552"/>
              <a:gd name="connsiteY3" fmla="*/ 694365 h 1130708"/>
              <a:gd name="connsiteX4" fmla="*/ 913318 w 3452552"/>
              <a:gd name="connsiteY4" fmla="*/ 845481 h 1130708"/>
              <a:gd name="connsiteX5" fmla="*/ 615142 w 3452552"/>
              <a:gd name="connsiteY5" fmla="*/ 709504 h 1130708"/>
              <a:gd name="connsiteX6" fmla="*/ 288175 w 3452552"/>
              <a:gd name="connsiteY6" fmla="*/ 1130682 h 1130708"/>
              <a:gd name="connsiteX7" fmla="*/ 0 w 3452552"/>
              <a:gd name="connsiteY7" fmla="*/ 687337 h 1130708"/>
              <a:gd name="connsiteX0" fmla="*/ 3452552 w 3452552"/>
              <a:gd name="connsiteY0" fmla="*/ 803715 h 1103947"/>
              <a:gd name="connsiteX1" fmla="*/ 2705083 w 3452552"/>
              <a:gd name="connsiteY1" fmla="*/ 848320 h 1103947"/>
              <a:gd name="connsiteX2" fmla="*/ 1861780 w 3452552"/>
              <a:gd name="connsiteY2" fmla="*/ 828 h 1103947"/>
              <a:gd name="connsiteX3" fmla="*/ 1364098 w 3452552"/>
              <a:gd name="connsiteY3" fmla="*/ 694365 h 1103947"/>
              <a:gd name="connsiteX4" fmla="*/ 913318 w 3452552"/>
              <a:gd name="connsiteY4" fmla="*/ 845481 h 1103947"/>
              <a:gd name="connsiteX5" fmla="*/ 615142 w 3452552"/>
              <a:gd name="connsiteY5" fmla="*/ 709504 h 1103947"/>
              <a:gd name="connsiteX6" fmla="*/ 288175 w 3452552"/>
              <a:gd name="connsiteY6" fmla="*/ 1103919 h 1103947"/>
              <a:gd name="connsiteX7" fmla="*/ 0 w 3452552"/>
              <a:gd name="connsiteY7" fmla="*/ 687337 h 1103947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61780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715 h 1175310"/>
              <a:gd name="connsiteX1" fmla="*/ 2705083 w 3452552"/>
              <a:gd name="connsiteY1" fmla="*/ 848320 h 1175310"/>
              <a:gd name="connsiteX2" fmla="*/ 1888543 w 3452552"/>
              <a:gd name="connsiteY2" fmla="*/ 828 h 1175310"/>
              <a:gd name="connsiteX3" fmla="*/ 1364098 w 3452552"/>
              <a:gd name="connsiteY3" fmla="*/ 694365 h 1175310"/>
              <a:gd name="connsiteX4" fmla="*/ 913318 w 3452552"/>
              <a:gd name="connsiteY4" fmla="*/ 845481 h 1175310"/>
              <a:gd name="connsiteX5" fmla="*/ 615142 w 3452552"/>
              <a:gd name="connsiteY5" fmla="*/ 709504 h 1175310"/>
              <a:gd name="connsiteX6" fmla="*/ 274794 w 3452552"/>
              <a:gd name="connsiteY6" fmla="*/ 1175286 h 1175310"/>
              <a:gd name="connsiteX7" fmla="*/ 0 w 3452552"/>
              <a:gd name="connsiteY7" fmla="*/ 687337 h 1175310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03477 h 1175072"/>
              <a:gd name="connsiteX1" fmla="*/ 2705083 w 3452552"/>
              <a:gd name="connsiteY1" fmla="*/ 848082 h 1175072"/>
              <a:gd name="connsiteX2" fmla="*/ 1888543 w 3452552"/>
              <a:gd name="connsiteY2" fmla="*/ 590 h 1175072"/>
              <a:gd name="connsiteX3" fmla="*/ 1350716 w 3452552"/>
              <a:gd name="connsiteY3" fmla="*/ 716430 h 1175072"/>
              <a:gd name="connsiteX4" fmla="*/ 913318 w 3452552"/>
              <a:gd name="connsiteY4" fmla="*/ 845243 h 1175072"/>
              <a:gd name="connsiteX5" fmla="*/ 615142 w 3452552"/>
              <a:gd name="connsiteY5" fmla="*/ 709266 h 1175072"/>
              <a:gd name="connsiteX6" fmla="*/ 274794 w 3452552"/>
              <a:gd name="connsiteY6" fmla="*/ 1175048 h 1175072"/>
              <a:gd name="connsiteX7" fmla="*/ 0 w 3452552"/>
              <a:gd name="connsiteY7" fmla="*/ 687099 h 117507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47 h 1188442"/>
              <a:gd name="connsiteX1" fmla="*/ 2705083 w 3452552"/>
              <a:gd name="connsiteY1" fmla="*/ 861452 h 1188442"/>
              <a:gd name="connsiteX2" fmla="*/ 1888543 w 3452552"/>
              <a:gd name="connsiteY2" fmla="*/ 578 h 1188442"/>
              <a:gd name="connsiteX3" fmla="*/ 1350716 w 3452552"/>
              <a:gd name="connsiteY3" fmla="*/ 729800 h 1188442"/>
              <a:gd name="connsiteX4" fmla="*/ 913318 w 3452552"/>
              <a:gd name="connsiteY4" fmla="*/ 858613 h 1188442"/>
              <a:gd name="connsiteX5" fmla="*/ 615142 w 3452552"/>
              <a:gd name="connsiteY5" fmla="*/ 722636 h 1188442"/>
              <a:gd name="connsiteX6" fmla="*/ 274794 w 3452552"/>
              <a:gd name="connsiteY6" fmla="*/ 1188418 h 1188442"/>
              <a:gd name="connsiteX7" fmla="*/ 0 w 3452552"/>
              <a:gd name="connsiteY7" fmla="*/ 700469 h 1188442"/>
              <a:gd name="connsiteX0" fmla="*/ 3452552 w 3452552"/>
              <a:gd name="connsiteY0" fmla="*/ 816852 h 1188447"/>
              <a:gd name="connsiteX1" fmla="*/ 2705083 w 3452552"/>
              <a:gd name="connsiteY1" fmla="*/ 861457 h 1188447"/>
              <a:gd name="connsiteX2" fmla="*/ 1888543 w 3452552"/>
              <a:gd name="connsiteY2" fmla="*/ 583 h 1188447"/>
              <a:gd name="connsiteX3" fmla="*/ 1350716 w 3452552"/>
              <a:gd name="connsiteY3" fmla="*/ 729805 h 1188447"/>
              <a:gd name="connsiteX4" fmla="*/ 904397 w 3452552"/>
              <a:gd name="connsiteY4" fmla="*/ 885381 h 1188447"/>
              <a:gd name="connsiteX5" fmla="*/ 615142 w 3452552"/>
              <a:gd name="connsiteY5" fmla="*/ 722641 h 1188447"/>
              <a:gd name="connsiteX6" fmla="*/ 274794 w 3452552"/>
              <a:gd name="connsiteY6" fmla="*/ 1188423 h 1188447"/>
              <a:gd name="connsiteX7" fmla="*/ 0 w 3452552"/>
              <a:gd name="connsiteY7" fmla="*/ 700474 h 1188447"/>
              <a:gd name="connsiteX0" fmla="*/ 3452552 w 3452552"/>
              <a:gd name="connsiteY0" fmla="*/ 816852 h 1188818"/>
              <a:gd name="connsiteX1" fmla="*/ 2705083 w 3452552"/>
              <a:gd name="connsiteY1" fmla="*/ 861457 h 1188818"/>
              <a:gd name="connsiteX2" fmla="*/ 1888543 w 3452552"/>
              <a:gd name="connsiteY2" fmla="*/ 583 h 1188818"/>
              <a:gd name="connsiteX3" fmla="*/ 1350716 w 3452552"/>
              <a:gd name="connsiteY3" fmla="*/ 729805 h 1188818"/>
              <a:gd name="connsiteX4" fmla="*/ 904397 w 3452552"/>
              <a:gd name="connsiteY4" fmla="*/ 885381 h 1188818"/>
              <a:gd name="connsiteX5" fmla="*/ 610681 w 3452552"/>
              <a:gd name="connsiteY5" fmla="*/ 785088 h 1188818"/>
              <a:gd name="connsiteX6" fmla="*/ 274794 w 3452552"/>
              <a:gd name="connsiteY6" fmla="*/ 1188423 h 1188818"/>
              <a:gd name="connsiteX7" fmla="*/ 0 w 3452552"/>
              <a:gd name="connsiteY7" fmla="*/ 700474 h 1188818"/>
              <a:gd name="connsiteX0" fmla="*/ 3452552 w 3452552"/>
              <a:gd name="connsiteY0" fmla="*/ 816852 h 1242303"/>
              <a:gd name="connsiteX1" fmla="*/ 2705083 w 3452552"/>
              <a:gd name="connsiteY1" fmla="*/ 861457 h 1242303"/>
              <a:gd name="connsiteX2" fmla="*/ 1888543 w 3452552"/>
              <a:gd name="connsiteY2" fmla="*/ 583 h 1242303"/>
              <a:gd name="connsiteX3" fmla="*/ 1350716 w 3452552"/>
              <a:gd name="connsiteY3" fmla="*/ 729805 h 1242303"/>
              <a:gd name="connsiteX4" fmla="*/ 904397 w 3452552"/>
              <a:gd name="connsiteY4" fmla="*/ 885381 h 1242303"/>
              <a:gd name="connsiteX5" fmla="*/ 610681 w 3452552"/>
              <a:gd name="connsiteY5" fmla="*/ 785088 h 1242303"/>
              <a:gd name="connsiteX6" fmla="*/ 270334 w 3452552"/>
              <a:gd name="connsiteY6" fmla="*/ 1241949 h 1242303"/>
              <a:gd name="connsiteX7" fmla="*/ 0 w 3452552"/>
              <a:gd name="connsiteY7" fmla="*/ 700474 h 1242303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223 h 1255674"/>
              <a:gd name="connsiteX1" fmla="*/ 2705083 w 3452552"/>
              <a:gd name="connsiteY1" fmla="*/ 874828 h 1255674"/>
              <a:gd name="connsiteX2" fmla="*/ 1884083 w 3452552"/>
              <a:gd name="connsiteY2" fmla="*/ 572 h 1255674"/>
              <a:gd name="connsiteX3" fmla="*/ 1350716 w 3452552"/>
              <a:gd name="connsiteY3" fmla="*/ 743176 h 1255674"/>
              <a:gd name="connsiteX4" fmla="*/ 904397 w 3452552"/>
              <a:gd name="connsiteY4" fmla="*/ 898752 h 1255674"/>
              <a:gd name="connsiteX5" fmla="*/ 610681 w 3452552"/>
              <a:gd name="connsiteY5" fmla="*/ 798459 h 1255674"/>
              <a:gd name="connsiteX6" fmla="*/ 270334 w 3452552"/>
              <a:gd name="connsiteY6" fmla="*/ 1255320 h 1255674"/>
              <a:gd name="connsiteX7" fmla="*/ 0 w 3452552"/>
              <a:gd name="connsiteY7" fmla="*/ 713845 h 1255674"/>
              <a:gd name="connsiteX0" fmla="*/ 3452552 w 3452552"/>
              <a:gd name="connsiteY0" fmla="*/ 830071 h 1255522"/>
              <a:gd name="connsiteX1" fmla="*/ 2705083 w 3452552"/>
              <a:gd name="connsiteY1" fmla="*/ 874676 h 1255522"/>
              <a:gd name="connsiteX2" fmla="*/ 1884083 w 3452552"/>
              <a:gd name="connsiteY2" fmla="*/ 420 h 1255522"/>
              <a:gd name="connsiteX3" fmla="*/ 1377478 w 3452552"/>
              <a:gd name="connsiteY3" fmla="*/ 760866 h 1255522"/>
              <a:gd name="connsiteX4" fmla="*/ 904397 w 3452552"/>
              <a:gd name="connsiteY4" fmla="*/ 898600 h 1255522"/>
              <a:gd name="connsiteX5" fmla="*/ 610681 w 3452552"/>
              <a:gd name="connsiteY5" fmla="*/ 798307 h 1255522"/>
              <a:gd name="connsiteX6" fmla="*/ 270334 w 3452552"/>
              <a:gd name="connsiteY6" fmla="*/ 1255168 h 1255522"/>
              <a:gd name="connsiteX7" fmla="*/ 0 w 3452552"/>
              <a:gd name="connsiteY7" fmla="*/ 713693 h 1255522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77478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  <a:gd name="connsiteX0" fmla="*/ 3452552 w 3452552"/>
              <a:gd name="connsiteY0" fmla="*/ 830063 h 1255514"/>
              <a:gd name="connsiteX1" fmla="*/ 2705083 w 3452552"/>
              <a:gd name="connsiteY1" fmla="*/ 874668 h 1255514"/>
              <a:gd name="connsiteX2" fmla="*/ 1884083 w 3452552"/>
              <a:gd name="connsiteY2" fmla="*/ 412 h 1255514"/>
              <a:gd name="connsiteX3" fmla="*/ 1364097 w 3452552"/>
              <a:gd name="connsiteY3" fmla="*/ 760858 h 1255514"/>
              <a:gd name="connsiteX4" fmla="*/ 904397 w 3452552"/>
              <a:gd name="connsiteY4" fmla="*/ 898592 h 1255514"/>
              <a:gd name="connsiteX5" fmla="*/ 610681 w 3452552"/>
              <a:gd name="connsiteY5" fmla="*/ 798299 h 1255514"/>
              <a:gd name="connsiteX6" fmla="*/ 270334 w 3452552"/>
              <a:gd name="connsiteY6" fmla="*/ 1255160 h 1255514"/>
              <a:gd name="connsiteX7" fmla="*/ 0 w 3452552"/>
              <a:gd name="connsiteY7" fmla="*/ 713685 h 12555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</a:cxnLst>
            <a:rect l="l" t="t" r="r" b="b"/>
            <a:pathLst>
              <a:path w="3452552" h="1255514">
                <a:moveTo>
                  <a:pt x="3452552" y="830063"/>
                </a:moveTo>
                <a:cubicBezTo>
                  <a:pt x="3223028" y="834220"/>
                  <a:pt x="2975415" y="896970"/>
                  <a:pt x="2705083" y="874668"/>
                </a:cubicBezTo>
                <a:cubicBezTo>
                  <a:pt x="2434751" y="852366"/>
                  <a:pt x="2107581" y="19380"/>
                  <a:pt x="1884083" y="412"/>
                </a:cubicBezTo>
                <a:cubicBezTo>
                  <a:pt x="1660585" y="-18556"/>
                  <a:pt x="1536299" y="624543"/>
                  <a:pt x="1364097" y="760858"/>
                </a:cubicBezTo>
                <a:cubicBezTo>
                  <a:pt x="1191895" y="897173"/>
                  <a:pt x="1029966" y="892352"/>
                  <a:pt x="904397" y="898592"/>
                </a:cubicBezTo>
                <a:cubicBezTo>
                  <a:pt x="778828" y="904832"/>
                  <a:pt x="716358" y="738871"/>
                  <a:pt x="610681" y="798299"/>
                </a:cubicBezTo>
                <a:cubicBezTo>
                  <a:pt x="505004" y="857727"/>
                  <a:pt x="372114" y="1269262"/>
                  <a:pt x="270334" y="1255160"/>
                </a:cubicBezTo>
                <a:cubicBezTo>
                  <a:pt x="168554" y="1241058"/>
                  <a:pt x="96520" y="933048"/>
                  <a:pt x="0" y="713685"/>
                </a:cubicBezTo>
              </a:path>
            </a:pathLst>
          </a:cu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7" name="グループ化 6"/>
          <p:cNvGrpSpPr/>
          <p:nvPr/>
        </p:nvGrpSpPr>
        <p:grpSpPr>
          <a:xfrm>
            <a:off x="2978807" y="5183192"/>
            <a:ext cx="1094389" cy="1054602"/>
            <a:chOff x="2978807" y="5196219"/>
            <a:chExt cx="1094389" cy="1054602"/>
          </a:xfrm>
        </p:grpSpPr>
        <p:cxnSp>
          <p:nvCxnSpPr>
            <p:cNvPr id="389" name="直線コネクタ 388"/>
            <p:cNvCxnSpPr/>
            <p:nvPr/>
          </p:nvCxnSpPr>
          <p:spPr>
            <a:xfrm>
              <a:off x="3657168" y="6013041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0" name="テキスト ボックス 88"/>
            <p:cNvSpPr txBox="1">
              <a:spLocks noChangeArrowheads="1"/>
            </p:cNvSpPr>
            <p:nvPr/>
          </p:nvSpPr>
          <p:spPr bwMode="auto">
            <a:xfrm>
              <a:off x="3457861" y="6035377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1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91" name="テキスト ボックス 88"/>
            <p:cNvSpPr txBox="1">
              <a:spLocks noChangeArrowheads="1"/>
            </p:cNvSpPr>
            <p:nvPr/>
          </p:nvSpPr>
          <p:spPr bwMode="auto">
            <a:xfrm>
              <a:off x="3675512" y="6035377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2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cxnSp>
          <p:nvCxnSpPr>
            <p:cNvPr id="392" name="直線コネクタ 391"/>
            <p:cNvCxnSpPr/>
            <p:nvPr/>
          </p:nvCxnSpPr>
          <p:spPr>
            <a:xfrm rot="5400000">
              <a:off x="3477192" y="5659026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3" name="テキスト ボックス 88"/>
            <p:cNvSpPr txBox="1">
              <a:spLocks noChangeArrowheads="1"/>
            </p:cNvSpPr>
            <p:nvPr/>
          </p:nvSpPr>
          <p:spPr bwMode="auto">
            <a:xfrm>
              <a:off x="3118751" y="5962292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4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94" name="テキスト ボックス 88"/>
            <p:cNvSpPr txBox="1">
              <a:spLocks noChangeArrowheads="1"/>
            </p:cNvSpPr>
            <p:nvPr/>
          </p:nvSpPr>
          <p:spPr bwMode="auto">
            <a:xfrm>
              <a:off x="3118751" y="5580073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3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95" name="テキスト ボックス 88"/>
            <p:cNvSpPr txBox="1">
              <a:spLocks noChangeArrowheads="1"/>
            </p:cNvSpPr>
            <p:nvPr/>
          </p:nvSpPr>
          <p:spPr bwMode="auto">
            <a:xfrm>
              <a:off x="3118751" y="5196219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2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96" name="フリーフォーム 395"/>
            <p:cNvSpPr/>
            <p:nvPr/>
          </p:nvSpPr>
          <p:spPr>
            <a:xfrm>
              <a:off x="3499742" y="5304795"/>
              <a:ext cx="309002" cy="585678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510339"/>
                <a:gd name="connsiteX1" fmla="*/ 112294 w 272716"/>
                <a:gd name="connsiteY1" fmla="*/ 510339 h 510339"/>
                <a:gd name="connsiteX2" fmla="*/ 0 w 272716"/>
                <a:gd name="connsiteY2" fmla="*/ 2517 h 510339"/>
                <a:gd name="connsiteX0" fmla="*/ 287230 w 287230"/>
                <a:gd name="connsiteY0" fmla="*/ 0 h 510339"/>
                <a:gd name="connsiteX1" fmla="*/ 112294 w 287230"/>
                <a:gd name="connsiteY1" fmla="*/ 510339 h 510339"/>
                <a:gd name="connsiteX2" fmla="*/ 0 w 287230"/>
                <a:gd name="connsiteY2" fmla="*/ 2517 h 510339"/>
                <a:gd name="connsiteX0" fmla="*/ 309002 w 309002"/>
                <a:gd name="connsiteY0" fmla="*/ 1112 h 511451"/>
                <a:gd name="connsiteX1" fmla="*/ 134066 w 309002"/>
                <a:gd name="connsiteY1" fmla="*/ 511451 h 511451"/>
                <a:gd name="connsiteX2" fmla="*/ 0 w 309002"/>
                <a:gd name="connsiteY2" fmla="*/ 0 h 511451"/>
                <a:gd name="connsiteX0" fmla="*/ 309002 w 309002"/>
                <a:gd name="connsiteY0" fmla="*/ 1112 h 576766"/>
                <a:gd name="connsiteX1" fmla="*/ 130438 w 309002"/>
                <a:gd name="connsiteY1" fmla="*/ 576766 h 576766"/>
                <a:gd name="connsiteX2" fmla="*/ 0 w 309002"/>
                <a:gd name="connsiteY2" fmla="*/ 0 h 576766"/>
                <a:gd name="connsiteX0" fmla="*/ 309002 w 309002"/>
                <a:gd name="connsiteY0" fmla="*/ 1112 h 536852"/>
                <a:gd name="connsiteX1" fmla="*/ 134066 w 309002"/>
                <a:gd name="connsiteY1" fmla="*/ 536852 h 536852"/>
                <a:gd name="connsiteX2" fmla="*/ 0 w 309002"/>
                <a:gd name="connsiteY2" fmla="*/ 0 h 536852"/>
                <a:gd name="connsiteX0" fmla="*/ 309002 w 309002"/>
                <a:gd name="connsiteY0" fmla="*/ 1112 h 558624"/>
                <a:gd name="connsiteX1" fmla="*/ 134066 w 309002"/>
                <a:gd name="connsiteY1" fmla="*/ 558624 h 558624"/>
                <a:gd name="connsiteX2" fmla="*/ 0 w 309002"/>
                <a:gd name="connsiteY2" fmla="*/ 0 h 558624"/>
                <a:gd name="connsiteX0" fmla="*/ 309002 w 309002"/>
                <a:gd name="connsiteY0" fmla="*/ 1112 h 585678"/>
                <a:gd name="connsiteX1" fmla="*/ 134066 w 309002"/>
                <a:gd name="connsiteY1" fmla="*/ 585678 h 585678"/>
                <a:gd name="connsiteX2" fmla="*/ 0 w 309002"/>
                <a:gd name="connsiteY2" fmla="*/ 0 h 5856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309002" h="585678">
                  <a:moveTo>
                    <a:pt x="309002" y="1112"/>
                  </a:moveTo>
                  <a:cubicBezTo>
                    <a:pt x="289395" y="93800"/>
                    <a:pt x="185566" y="585863"/>
                    <a:pt x="134066" y="585678"/>
                  </a:cubicBezTo>
                  <a:cubicBezTo>
                    <a:pt x="82566" y="585493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7" name="フリーフォーム 396"/>
            <p:cNvSpPr/>
            <p:nvPr/>
          </p:nvSpPr>
          <p:spPr>
            <a:xfrm>
              <a:off x="3614081" y="5304153"/>
              <a:ext cx="94724" cy="60402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90904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7751 w 187751"/>
                <a:gd name="connsiteY0" fmla="*/ 5560 h 208774"/>
                <a:gd name="connsiteX1" fmla="*/ 86151 w 187751"/>
                <a:gd name="connsiteY1" fmla="*/ 208760 h 208774"/>
                <a:gd name="connsiteX2" fmla="*/ 5941 w 187751"/>
                <a:gd name="connsiteY2" fmla="*/ 16255 h 208774"/>
                <a:gd name="connsiteX3" fmla="*/ 5941 w 187751"/>
                <a:gd name="connsiteY3" fmla="*/ 9112 h 20877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0" fmla="*/ 181810 w 181810"/>
                <a:gd name="connsiteY0" fmla="*/ 0 h 203201"/>
                <a:gd name="connsiteX1" fmla="*/ 80210 w 181810"/>
                <a:gd name="connsiteY1" fmla="*/ 203200 h 203201"/>
                <a:gd name="connsiteX2" fmla="*/ 0 w 181810"/>
                <a:gd name="connsiteY2" fmla="*/ 3551 h 203201"/>
                <a:gd name="connsiteX0" fmla="*/ 181810 w 181810"/>
                <a:gd name="connsiteY0" fmla="*/ 0 h 203221"/>
                <a:gd name="connsiteX1" fmla="*/ 80210 w 181810"/>
                <a:gd name="connsiteY1" fmla="*/ 203200 h 203221"/>
                <a:gd name="connsiteX2" fmla="*/ 0 w 181810"/>
                <a:gd name="connsiteY2" fmla="*/ 3551 h 203221"/>
                <a:gd name="connsiteX0" fmla="*/ 181810 w 181810"/>
                <a:gd name="connsiteY0" fmla="*/ 0 h 81161"/>
                <a:gd name="connsiteX1" fmla="*/ 83838 w 181810"/>
                <a:gd name="connsiteY1" fmla="*/ 79829 h 81161"/>
                <a:gd name="connsiteX2" fmla="*/ 0 w 181810"/>
                <a:gd name="connsiteY2" fmla="*/ 3551 h 81161"/>
                <a:gd name="connsiteX0" fmla="*/ 181810 w 181810"/>
                <a:gd name="connsiteY0" fmla="*/ 0 h 80469"/>
                <a:gd name="connsiteX1" fmla="*/ 83838 w 181810"/>
                <a:gd name="connsiteY1" fmla="*/ 79829 h 80469"/>
                <a:gd name="connsiteX2" fmla="*/ 0 w 181810"/>
                <a:gd name="connsiteY2" fmla="*/ 3551 h 80469"/>
                <a:gd name="connsiteX0" fmla="*/ 149153 w 149153"/>
                <a:gd name="connsiteY0" fmla="*/ 0 h 79834"/>
                <a:gd name="connsiteX1" fmla="*/ 83838 w 149153"/>
                <a:gd name="connsiteY1" fmla="*/ 79829 h 79834"/>
                <a:gd name="connsiteX2" fmla="*/ 0 w 149153"/>
                <a:gd name="connsiteY2" fmla="*/ 3551 h 79834"/>
                <a:gd name="connsiteX0" fmla="*/ 109238 w 109238"/>
                <a:gd name="connsiteY0" fmla="*/ 0 h 79834"/>
                <a:gd name="connsiteX1" fmla="*/ 43923 w 109238"/>
                <a:gd name="connsiteY1" fmla="*/ 79829 h 79834"/>
                <a:gd name="connsiteX2" fmla="*/ 0 w 109238"/>
                <a:gd name="connsiteY2" fmla="*/ 3551 h 79834"/>
                <a:gd name="connsiteX0" fmla="*/ 109238 w 109238"/>
                <a:gd name="connsiteY0" fmla="*/ 0 h 61975"/>
                <a:gd name="connsiteX1" fmla="*/ 43923 w 109238"/>
                <a:gd name="connsiteY1" fmla="*/ 58058 h 61975"/>
                <a:gd name="connsiteX2" fmla="*/ 0 w 109238"/>
                <a:gd name="connsiteY2" fmla="*/ 3551 h 61975"/>
                <a:gd name="connsiteX0" fmla="*/ 94724 w 94724"/>
                <a:gd name="connsiteY0" fmla="*/ 0 h 61975"/>
                <a:gd name="connsiteX1" fmla="*/ 43923 w 94724"/>
                <a:gd name="connsiteY1" fmla="*/ 58058 h 61975"/>
                <a:gd name="connsiteX2" fmla="*/ 0 w 94724"/>
                <a:gd name="connsiteY2" fmla="*/ 3551 h 61975"/>
                <a:gd name="connsiteX0" fmla="*/ 94724 w 94724"/>
                <a:gd name="connsiteY0" fmla="*/ 0 h 60402"/>
                <a:gd name="connsiteX1" fmla="*/ 43923 w 94724"/>
                <a:gd name="connsiteY1" fmla="*/ 58058 h 60402"/>
                <a:gd name="connsiteX2" fmla="*/ 0 w 94724"/>
                <a:gd name="connsiteY2" fmla="*/ 3551 h 604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4724" h="60402">
                  <a:moveTo>
                    <a:pt x="94724" y="0"/>
                  </a:moveTo>
                  <a:cubicBezTo>
                    <a:pt x="38832" y="85431"/>
                    <a:pt x="63339" y="53837"/>
                    <a:pt x="43923" y="58058"/>
                  </a:cubicBezTo>
                  <a:cubicBezTo>
                    <a:pt x="24507" y="62279"/>
                    <a:pt x="13368" y="36826"/>
                    <a:pt x="0" y="3551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8" name="フリーフォーム 397"/>
            <p:cNvSpPr/>
            <p:nvPr/>
          </p:nvSpPr>
          <p:spPr>
            <a:xfrm>
              <a:off x="3512440" y="5306936"/>
              <a:ext cx="278255" cy="531801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70082"/>
                <a:gd name="connsiteX1" fmla="*/ 106883 w 256484"/>
                <a:gd name="connsiteY1" fmla="*/ 470082 h 470082"/>
                <a:gd name="connsiteX2" fmla="*/ 0 w 256484"/>
                <a:gd name="connsiteY2" fmla="*/ 2517 h 470082"/>
                <a:gd name="connsiteX0" fmla="*/ 256484 w 256484"/>
                <a:gd name="connsiteY0" fmla="*/ 0 h 481988"/>
                <a:gd name="connsiteX1" fmla="*/ 106883 w 256484"/>
                <a:gd name="connsiteY1" fmla="*/ 481988 h 481988"/>
                <a:gd name="connsiteX2" fmla="*/ 0 w 256484"/>
                <a:gd name="connsiteY2" fmla="*/ 2517 h 481988"/>
                <a:gd name="connsiteX0" fmla="*/ 256484 w 256484"/>
                <a:gd name="connsiteY0" fmla="*/ 0 h 518274"/>
                <a:gd name="connsiteX1" fmla="*/ 103254 w 256484"/>
                <a:gd name="connsiteY1" fmla="*/ 518274 h 518274"/>
                <a:gd name="connsiteX2" fmla="*/ 0 w 256484"/>
                <a:gd name="connsiteY2" fmla="*/ 2517 h 518274"/>
                <a:gd name="connsiteX0" fmla="*/ 274627 w 274627"/>
                <a:gd name="connsiteY0" fmla="*/ 0 h 518274"/>
                <a:gd name="connsiteX1" fmla="*/ 121397 w 274627"/>
                <a:gd name="connsiteY1" fmla="*/ 518274 h 518274"/>
                <a:gd name="connsiteX2" fmla="*/ 0 w 274627"/>
                <a:gd name="connsiteY2" fmla="*/ 2517 h 518274"/>
                <a:gd name="connsiteX0" fmla="*/ 278255 w 278255"/>
                <a:gd name="connsiteY0" fmla="*/ 0 h 518274"/>
                <a:gd name="connsiteX1" fmla="*/ 121397 w 278255"/>
                <a:gd name="connsiteY1" fmla="*/ 518274 h 518274"/>
                <a:gd name="connsiteX2" fmla="*/ 0 w 278255"/>
                <a:gd name="connsiteY2" fmla="*/ 2517 h 518274"/>
                <a:gd name="connsiteX0" fmla="*/ 278255 w 278255"/>
                <a:gd name="connsiteY0" fmla="*/ 0 h 531801"/>
                <a:gd name="connsiteX1" fmla="*/ 121397 w 278255"/>
                <a:gd name="connsiteY1" fmla="*/ 531801 h 531801"/>
                <a:gd name="connsiteX2" fmla="*/ 0 w 278255"/>
                <a:gd name="connsiteY2" fmla="*/ 2517 h 53180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78255" h="531801">
                  <a:moveTo>
                    <a:pt x="278255" y="0"/>
                  </a:moveTo>
                  <a:cubicBezTo>
                    <a:pt x="258648" y="92688"/>
                    <a:pt x="167773" y="531382"/>
                    <a:pt x="121397" y="531801"/>
                  </a:cubicBezTo>
                  <a:cubicBezTo>
                    <a:pt x="75021" y="532220"/>
                    <a:pt x="21389" y="88966"/>
                    <a:pt x="0" y="2517"/>
                  </a:cubicBezTo>
                </a:path>
              </a:pathLst>
            </a:custGeom>
            <a:noFill/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99" name="フリーフォーム 398"/>
            <p:cNvSpPr/>
            <p:nvPr/>
          </p:nvSpPr>
          <p:spPr>
            <a:xfrm>
              <a:off x="3526064" y="5307965"/>
              <a:ext cx="253843" cy="483657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419519"/>
                <a:gd name="connsiteX1" fmla="*/ 101472 w 242957"/>
                <a:gd name="connsiteY1" fmla="*/ 419519 h 419519"/>
                <a:gd name="connsiteX2" fmla="*/ 0 w 242957"/>
                <a:gd name="connsiteY2" fmla="*/ 0 h 419519"/>
                <a:gd name="connsiteX0" fmla="*/ 242957 w 242957"/>
                <a:gd name="connsiteY0" fmla="*/ 189 h 470319"/>
                <a:gd name="connsiteX1" fmla="*/ 97843 w 242957"/>
                <a:gd name="connsiteY1" fmla="*/ 470319 h 470319"/>
                <a:gd name="connsiteX2" fmla="*/ 0 w 242957"/>
                <a:gd name="connsiteY2" fmla="*/ 0 h 470319"/>
                <a:gd name="connsiteX0" fmla="*/ 253843 w 253843"/>
                <a:gd name="connsiteY0" fmla="*/ 0 h 470130"/>
                <a:gd name="connsiteX1" fmla="*/ 108729 w 253843"/>
                <a:gd name="connsiteY1" fmla="*/ 470130 h 470130"/>
                <a:gd name="connsiteX2" fmla="*/ 0 w 253843"/>
                <a:gd name="connsiteY2" fmla="*/ 3439 h 470130"/>
                <a:gd name="connsiteX0" fmla="*/ 253843 w 253843"/>
                <a:gd name="connsiteY0" fmla="*/ 0 h 483657"/>
                <a:gd name="connsiteX1" fmla="*/ 108729 w 253843"/>
                <a:gd name="connsiteY1" fmla="*/ 483657 h 483657"/>
                <a:gd name="connsiteX2" fmla="*/ 0 w 253843"/>
                <a:gd name="connsiteY2" fmla="*/ 3439 h 48365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53843" h="483657">
                  <a:moveTo>
                    <a:pt x="253843" y="0"/>
                  </a:moveTo>
                  <a:cubicBezTo>
                    <a:pt x="234236" y="92688"/>
                    <a:pt x="151036" y="483084"/>
                    <a:pt x="108729" y="483657"/>
                  </a:cubicBezTo>
                  <a:cubicBezTo>
                    <a:pt x="66422" y="484230"/>
                    <a:pt x="21389" y="89888"/>
                    <a:pt x="0" y="3439"/>
                  </a:cubicBezTo>
                </a:path>
              </a:pathLst>
            </a:custGeom>
            <a:noFill/>
            <a:ln w="12700">
              <a:solidFill>
                <a:srgbClr val="00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0" name="フリーフォーム 399"/>
            <p:cNvSpPr/>
            <p:nvPr/>
          </p:nvSpPr>
          <p:spPr>
            <a:xfrm>
              <a:off x="3546023" y="5308616"/>
              <a:ext cx="224020" cy="402748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402748"/>
                <a:gd name="connsiteX1" fmla="*/ 82470 w 224020"/>
                <a:gd name="connsiteY1" fmla="*/ 402748 h 402748"/>
                <a:gd name="connsiteX2" fmla="*/ 0 w 224020"/>
                <a:gd name="connsiteY2" fmla="*/ 0 h 402748"/>
                <a:gd name="connsiteX0" fmla="*/ 224020 w 224020"/>
                <a:gd name="connsiteY0" fmla="*/ 189 h 402748"/>
                <a:gd name="connsiteX1" fmla="*/ 93356 w 224020"/>
                <a:gd name="connsiteY1" fmla="*/ 402748 h 402748"/>
                <a:gd name="connsiteX2" fmla="*/ 0 w 224020"/>
                <a:gd name="connsiteY2" fmla="*/ 0 h 40274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4020" h="402748">
                  <a:moveTo>
                    <a:pt x="224020" y="189"/>
                  </a:moveTo>
                  <a:cubicBezTo>
                    <a:pt x="204413" y="92877"/>
                    <a:pt x="130693" y="402780"/>
                    <a:pt x="93356" y="402748"/>
                  </a:cubicBezTo>
                  <a:cubicBezTo>
                    <a:pt x="56019" y="402717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1" name="フリーフォーム 400"/>
            <p:cNvSpPr/>
            <p:nvPr/>
          </p:nvSpPr>
          <p:spPr>
            <a:xfrm>
              <a:off x="3580222" y="5303634"/>
              <a:ext cx="162624" cy="212219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264455"/>
                <a:gd name="connsiteX1" fmla="*/ 101472 w 224020"/>
                <a:gd name="connsiteY1" fmla="*/ 264455 h 264455"/>
                <a:gd name="connsiteX2" fmla="*/ 0 w 224020"/>
                <a:gd name="connsiteY2" fmla="*/ 0 h 264455"/>
                <a:gd name="connsiteX0" fmla="*/ 207788 w 207788"/>
                <a:gd name="connsiteY0" fmla="*/ 189 h 264455"/>
                <a:gd name="connsiteX1" fmla="*/ 85240 w 207788"/>
                <a:gd name="connsiteY1" fmla="*/ 264455 h 264455"/>
                <a:gd name="connsiteX2" fmla="*/ 0 w 207788"/>
                <a:gd name="connsiteY2" fmla="*/ 0 h 264455"/>
                <a:gd name="connsiteX0" fmla="*/ 194261 w 194261"/>
                <a:gd name="connsiteY0" fmla="*/ 189 h 264455"/>
                <a:gd name="connsiteX1" fmla="*/ 85240 w 194261"/>
                <a:gd name="connsiteY1" fmla="*/ 264455 h 264455"/>
                <a:gd name="connsiteX2" fmla="*/ 0 w 194261"/>
                <a:gd name="connsiteY2" fmla="*/ 0 h 264455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206167 w 206167"/>
                <a:gd name="connsiteY0" fmla="*/ 189 h 266836"/>
                <a:gd name="connsiteX1" fmla="*/ 90002 w 206167"/>
                <a:gd name="connsiteY1" fmla="*/ 266836 h 266836"/>
                <a:gd name="connsiteX2" fmla="*/ 0 w 206167"/>
                <a:gd name="connsiteY2" fmla="*/ 0 h 266836"/>
                <a:gd name="connsiteX0" fmla="*/ 206167 w 206167"/>
                <a:gd name="connsiteY0" fmla="*/ 189 h 208778"/>
                <a:gd name="connsiteX1" fmla="*/ 86373 w 206167"/>
                <a:gd name="connsiteY1" fmla="*/ 208778 h 208778"/>
                <a:gd name="connsiteX2" fmla="*/ 0 w 206167"/>
                <a:gd name="connsiteY2" fmla="*/ 0 h 208778"/>
                <a:gd name="connsiteX0" fmla="*/ 206167 w 206167"/>
                <a:gd name="connsiteY0" fmla="*/ 189 h 208778"/>
                <a:gd name="connsiteX1" fmla="*/ 86373 w 206167"/>
                <a:gd name="connsiteY1" fmla="*/ 208778 h 208778"/>
                <a:gd name="connsiteX2" fmla="*/ 0 w 206167"/>
                <a:gd name="connsiteY2" fmla="*/ 0 h 208778"/>
                <a:gd name="connsiteX0" fmla="*/ 184396 w 184396"/>
                <a:gd name="connsiteY0" fmla="*/ 0 h 212219"/>
                <a:gd name="connsiteX1" fmla="*/ 86373 w 184396"/>
                <a:gd name="connsiteY1" fmla="*/ 212218 h 212219"/>
                <a:gd name="connsiteX2" fmla="*/ 0 w 184396"/>
                <a:gd name="connsiteY2" fmla="*/ 3440 h 212219"/>
                <a:gd name="connsiteX0" fmla="*/ 162624 w 162624"/>
                <a:gd name="connsiteY0" fmla="*/ 0 h 212219"/>
                <a:gd name="connsiteX1" fmla="*/ 64601 w 162624"/>
                <a:gd name="connsiteY1" fmla="*/ 212218 h 212219"/>
                <a:gd name="connsiteX2" fmla="*/ 0 w 162624"/>
                <a:gd name="connsiteY2" fmla="*/ 3440 h 2122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2624" h="212219">
                  <a:moveTo>
                    <a:pt x="162624" y="0"/>
                  </a:moveTo>
                  <a:cubicBezTo>
                    <a:pt x="124874" y="81802"/>
                    <a:pt x="91705" y="211645"/>
                    <a:pt x="64601" y="212218"/>
                  </a:cubicBezTo>
                  <a:cubicBezTo>
                    <a:pt x="37497" y="212791"/>
                    <a:pt x="21389" y="89889"/>
                    <a:pt x="0" y="3440"/>
                  </a:cubicBezTo>
                </a:path>
              </a:pathLst>
            </a:custGeom>
            <a:noFill/>
            <a:ln w="1270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02" name="正方形/長方形 401"/>
            <p:cNvSpPr/>
            <p:nvPr/>
          </p:nvSpPr>
          <p:spPr>
            <a:xfrm>
              <a:off x="3446081" y="5299253"/>
              <a:ext cx="422174" cy="77354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03" name="グループ化 402"/>
            <p:cNvGrpSpPr/>
            <p:nvPr/>
          </p:nvGrpSpPr>
          <p:grpSpPr>
            <a:xfrm>
              <a:off x="2978807" y="5534332"/>
              <a:ext cx="127437" cy="356672"/>
              <a:chOff x="3073698" y="2256656"/>
              <a:chExt cx="127437" cy="356672"/>
            </a:xfrm>
          </p:grpSpPr>
          <p:sp>
            <p:nvSpPr>
              <p:cNvPr id="404" name="Rectangle 4334"/>
              <p:cNvSpPr>
                <a:spLocks noChangeArrowheads="1"/>
              </p:cNvSpPr>
              <p:nvPr/>
            </p:nvSpPr>
            <p:spPr bwMode="auto">
              <a:xfrm rot="16200000">
                <a:off x="3109139" y="2525103"/>
                <a:ext cx="52784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i="1" dirty="0">
                    <a:solidFill>
                      <a:srgbClr val="000000"/>
                    </a:solidFill>
                    <a:latin typeface="Symbol" pitchFamily="18" charset="2"/>
                    <a:cs typeface="Arial" charset="0"/>
                  </a:rPr>
                  <a:t>q</a:t>
                </a:r>
                <a:endParaRPr lang="en-US" altLang="ja-JP" sz="800" b="1" i="1" dirty="0">
                  <a:latin typeface="Symbol" pitchFamily="18" charset="2"/>
                  <a:cs typeface="Arial" charset="0"/>
                </a:endParaRPr>
              </a:p>
            </p:txBody>
          </p:sp>
          <p:sp>
            <p:nvSpPr>
              <p:cNvPr id="405" name="Rectangle 4335"/>
              <p:cNvSpPr>
                <a:spLocks noChangeArrowheads="1"/>
              </p:cNvSpPr>
              <p:nvPr/>
            </p:nvSpPr>
            <p:spPr bwMode="auto">
              <a:xfrm rot="16200000">
                <a:off x="2999046" y="2335079"/>
                <a:ext cx="280512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X 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10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5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</p:grpSp>
        <p:grpSp>
          <p:nvGrpSpPr>
            <p:cNvPr id="406" name="グループ化 405"/>
            <p:cNvGrpSpPr/>
            <p:nvPr/>
          </p:nvGrpSpPr>
          <p:grpSpPr>
            <a:xfrm>
              <a:off x="3115660" y="5284313"/>
              <a:ext cx="123666" cy="856711"/>
              <a:chOff x="3077093" y="1408239"/>
              <a:chExt cx="123666" cy="856711"/>
            </a:xfrm>
          </p:grpSpPr>
          <p:sp>
            <p:nvSpPr>
              <p:cNvPr id="407" name="Rectangle 4337"/>
              <p:cNvSpPr>
                <a:spLocks noChangeArrowheads="1"/>
              </p:cNvSpPr>
              <p:nvPr/>
            </p:nvSpPr>
            <p:spPr bwMode="auto">
              <a:xfrm rot="16200000">
                <a:off x="2922509" y="1986701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(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egcm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2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408" name="Rectangle 4339"/>
              <p:cNvSpPr>
                <a:spLocks noChangeArrowheads="1"/>
              </p:cNvSpPr>
              <p:nvPr/>
            </p:nvSpPr>
            <p:spPr bwMode="auto">
              <a:xfrm rot="16200000">
                <a:off x="2922509" y="1605145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ja-JP" altLang="en-US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　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mole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-1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409" name="Rectangle 4341"/>
              <p:cNvSpPr>
                <a:spLocks noChangeArrowheads="1"/>
              </p:cNvSpPr>
              <p:nvPr/>
            </p:nvSpPr>
            <p:spPr bwMode="auto">
              <a:xfrm rot="16200000">
                <a:off x="3122336" y="1362996"/>
                <a:ext cx="33179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)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410" name="テキスト ボックス 88"/>
            <p:cNvSpPr txBox="1">
              <a:spLocks noChangeArrowheads="1"/>
            </p:cNvSpPr>
            <p:nvPr/>
          </p:nvSpPr>
          <p:spPr bwMode="auto">
            <a:xfrm>
              <a:off x="3455914" y="5826963"/>
              <a:ext cx="4123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(nm)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411" name="テキスト ボックス 88"/>
            <p:cNvSpPr txBox="1">
              <a:spLocks noChangeArrowheads="1"/>
            </p:cNvSpPr>
            <p:nvPr/>
          </p:nvSpPr>
          <p:spPr bwMode="auto">
            <a:xfrm>
              <a:off x="3250077" y="6035256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0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</p:grpSp>
      <p:grpSp>
        <p:nvGrpSpPr>
          <p:cNvPr id="15" name="グループ化 14"/>
          <p:cNvGrpSpPr/>
          <p:nvPr/>
        </p:nvGrpSpPr>
        <p:grpSpPr>
          <a:xfrm>
            <a:off x="7224721" y="5183192"/>
            <a:ext cx="1094389" cy="1054709"/>
            <a:chOff x="7629863" y="5195991"/>
            <a:chExt cx="1094389" cy="1054709"/>
          </a:xfrm>
        </p:grpSpPr>
        <p:cxnSp>
          <p:nvCxnSpPr>
            <p:cNvPr id="412" name="直線コネクタ 411"/>
            <p:cNvCxnSpPr/>
            <p:nvPr/>
          </p:nvCxnSpPr>
          <p:spPr>
            <a:xfrm>
              <a:off x="8308224" y="6012920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3" name="テキスト ボックス 88"/>
            <p:cNvSpPr txBox="1">
              <a:spLocks noChangeArrowheads="1"/>
            </p:cNvSpPr>
            <p:nvPr/>
          </p:nvSpPr>
          <p:spPr bwMode="auto">
            <a:xfrm>
              <a:off x="8108917" y="6035256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1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414" name="テキスト ボックス 88"/>
            <p:cNvSpPr txBox="1">
              <a:spLocks noChangeArrowheads="1"/>
            </p:cNvSpPr>
            <p:nvPr/>
          </p:nvSpPr>
          <p:spPr bwMode="auto">
            <a:xfrm>
              <a:off x="8326568" y="6035256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2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cxnSp>
          <p:nvCxnSpPr>
            <p:cNvPr id="415" name="直線コネクタ 414"/>
            <p:cNvCxnSpPr/>
            <p:nvPr/>
          </p:nvCxnSpPr>
          <p:spPr>
            <a:xfrm rot="5400000">
              <a:off x="8128248" y="5658905"/>
              <a:ext cx="0" cy="54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6" name="テキスト ボックス 88"/>
            <p:cNvSpPr txBox="1">
              <a:spLocks noChangeArrowheads="1"/>
            </p:cNvSpPr>
            <p:nvPr/>
          </p:nvSpPr>
          <p:spPr bwMode="auto">
            <a:xfrm>
              <a:off x="7769807" y="5962171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4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417" name="テキスト ボックス 88"/>
            <p:cNvSpPr txBox="1">
              <a:spLocks noChangeArrowheads="1"/>
            </p:cNvSpPr>
            <p:nvPr/>
          </p:nvSpPr>
          <p:spPr bwMode="auto">
            <a:xfrm>
              <a:off x="7769807" y="5579952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3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418" name="フリーフォーム 417"/>
            <p:cNvSpPr/>
            <p:nvPr/>
          </p:nvSpPr>
          <p:spPr>
            <a:xfrm>
              <a:off x="8162409" y="5304674"/>
              <a:ext cx="282877" cy="391188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510339"/>
                <a:gd name="connsiteX1" fmla="*/ 112294 w 272716"/>
                <a:gd name="connsiteY1" fmla="*/ 510339 h 510339"/>
                <a:gd name="connsiteX2" fmla="*/ 0 w 272716"/>
                <a:gd name="connsiteY2" fmla="*/ 2517 h 510339"/>
                <a:gd name="connsiteX0" fmla="*/ 287230 w 287230"/>
                <a:gd name="connsiteY0" fmla="*/ 0 h 510339"/>
                <a:gd name="connsiteX1" fmla="*/ 112294 w 287230"/>
                <a:gd name="connsiteY1" fmla="*/ 510339 h 510339"/>
                <a:gd name="connsiteX2" fmla="*/ 0 w 287230"/>
                <a:gd name="connsiteY2" fmla="*/ 2517 h 510339"/>
                <a:gd name="connsiteX0" fmla="*/ 309002 w 309002"/>
                <a:gd name="connsiteY0" fmla="*/ 1112 h 511451"/>
                <a:gd name="connsiteX1" fmla="*/ 134066 w 309002"/>
                <a:gd name="connsiteY1" fmla="*/ 511451 h 511451"/>
                <a:gd name="connsiteX2" fmla="*/ 0 w 309002"/>
                <a:gd name="connsiteY2" fmla="*/ 0 h 511451"/>
                <a:gd name="connsiteX0" fmla="*/ 309002 w 309002"/>
                <a:gd name="connsiteY0" fmla="*/ 1112 h 576766"/>
                <a:gd name="connsiteX1" fmla="*/ 130438 w 309002"/>
                <a:gd name="connsiteY1" fmla="*/ 576766 h 576766"/>
                <a:gd name="connsiteX2" fmla="*/ 0 w 309002"/>
                <a:gd name="connsiteY2" fmla="*/ 0 h 576766"/>
                <a:gd name="connsiteX0" fmla="*/ 309002 w 309002"/>
                <a:gd name="connsiteY0" fmla="*/ 1112 h 536852"/>
                <a:gd name="connsiteX1" fmla="*/ 134066 w 309002"/>
                <a:gd name="connsiteY1" fmla="*/ 536852 h 536852"/>
                <a:gd name="connsiteX2" fmla="*/ 0 w 309002"/>
                <a:gd name="connsiteY2" fmla="*/ 0 h 536852"/>
                <a:gd name="connsiteX0" fmla="*/ 309002 w 309002"/>
                <a:gd name="connsiteY0" fmla="*/ 1112 h 558624"/>
                <a:gd name="connsiteX1" fmla="*/ 134066 w 309002"/>
                <a:gd name="connsiteY1" fmla="*/ 558624 h 558624"/>
                <a:gd name="connsiteX2" fmla="*/ 0 w 309002"/>
                <a:gd name="connsiteY2" fmla="*/ 0 h 558624"/>
                <a:gd name="connsiteX0" fmla="*/ 309002 w 309002"/>
                <a:gd name="connsiteY0" fmla="*/ 1112 h 585678"/>
                <a:gd name="connsiteX1" fmla="*/ 134066 w 309002"/>
                <a:gd name="connsiteY1" fmla="*/ 585678 h 585678"/>
                <a:gd name="connsiteX2" fmla="*/ 0 w 309002"/>
                <a:gd name="connsiteY2" fmla="*/ 0 h 585678"/>
                <a:gd name="connsiteX0" fmla="*/ 297391 w 297391"/>
                <a:gd name="connsiteY0" fmla="*/ 1112 h 585678"/>
                <a:gd name="connsiteX1" fmla="*/ 122455 w 297391"/>
                <a:gd name="connsiteY1" fmla="*/ 585678 h 585678"/>
                <a:gd name="connsiteX2" fmla="*/ 0 w 297391"/>
                <a:gd name="connsiteY2" fmla="*/ 0 h 585678"/>
                <a:gd name="connsiteX0" fmla="*/ 282877 w 282877"/>
                <a:gd name="connsiteY0" fmla="*/ 1112 h 585678"/>
                <a:gd name="connsiteX1" fmla="*/ 122455 w 282877"/>
                <a:gd name="connsiteY1" fmla="*/ 585678 h 585678"/>
                <a:gd name="connsiteX2" fmla="*/ 0 w 282877"/>
                <a:gd name="connsiteY2" fmla="*/ 0 h 585678"/>
                <a:gd name="connsiteX0" fmla="*/ 282877 w 282877"/>
                <a:gd name="connsiteY0" fmla="*/ 1112 h 356353"/>
                <a:gd name="connsiteX1" fmla="*/ 119552 w 282877"/>
                <a:gd name="connsiteY1" fmla="*/ 356353 h 356353"/>
                <a:gd name="connsiteX2" fmla="*/ 0 w 282877"/>
                <a:gd name="connsiteY2" fmla="*/ 0 h 356353"/>
                <a:gd name="connsiteX0" fmla="*/ 282877 w 282877"/>
                <a:gd name="connsiteY0" fmla="*/ 1112 h 391188"/>
                <a:gd name="connsiteX1" fmla="*/ 116649 w 282877"/>
                <a:gd name="connsiteY1" fmla="*/ 391188 h 391188"/>
                <a:gd name="connsiteX2" fmla="*/ 0 w 282877"/>
                <a:gd name="connsiteY2" fmla="*/ 0 h 39118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82877" h="391188">
                  <a:moveTo>
                    <a:pt x="282877" y="1112"/>
                  </a:moveTo>
                  <a:cubicBezTo>
                    <a:pt x="263270" y="93800"/>
                    <a:pt x="163795" y="391373"/>
                    <a:pt x="116649" y="391188"/>
                  </a:cubicBezTo>
                  <a:cubicBezTo>
                    <a:pt x="69503" y="391003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19" name="フリーフォーム 418"/>
            <p:cNvSpPr/>
            <p:nvPr/>
          </p:nvSpPr>
          <p:spPr>
            <a:xfrm>
              <a:off x="8265137" y="5304032"/>
              <a:ext cx="94724" cy="60402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90904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7751 w 187751"/>
                <a:gd name="connsiteY0" fmla="*/ 5560 h 208774"/>
                <a:gd name="connsiteX1" fmla="*/ 86151 w 187751"/>
                <a:gd name="connsiteY1" fmla="*/ 208760 h 208774"/>
                <a:gd name="connsiteX2" fmla="*/ 5941 w 187751"/>
                <a:gd name="connsiteY2" fmla="*/ 16255 h 208774"/>
                <a:gd name="connsiteX3" fmla="*/ 5941 w 187751"/>
                <a:gd name="connsiteY3" fmla="*/ 9112 h 208774"/>
                <a:gd name="connsiteX0" fmla="*/ 181810 w 181810"/>
                <a:gd name="connsiteY0" fmla="*/ 0 h 203214"/>
                <a:gd name="connsiteX1" fmla="*/ 80210 w 181810"/>
                <a:gd name="connsiteY1" fmla="*/ 203200 h 203214"/>
                <a:gd name="connsiteX2" fmla="*/ 0 w 181810"/>
                <a:gd name="connsiteY2" fmla="*/ 10695 h 203214"/>
                <a:gd name="connsiteX0" fmla="*/ 181810 w 181810"/>
                <a:gd name="connsiteY0" fmla="*/ 0 h 203201"/>
                <a:gd name="connsiteX1" fmla="*/ 80210 w 181810"/>
                <a:gd name="connsiteY1" fmla="*/ 203200 h 203201"/>
                <a:gd name="connsiteX2" fmla="*/ 0 w 181810"/>
                <a:gd name="connsiteY2" fmla="*/ 3551 h 203201"/>
                <a:gd name="connsiteX0" fmla="*/ 181810 w 181810"/>
                <a:gd name="connsiteY0" fmla="*/ 0 h 203221"/>
                <a:gd name="connsiteX1" fmla="*/ 80210 w 181810"/>
                <a:gd name="connsiteY1" fmla="*/ 203200 h 203221"/>
                <a:gd name="connsiteX2" fmla="*/ 0 w 181810"/>
                <a:gd name="connsiteY2" fmla="*/ 3551 h 203221"/>
                <a:gd name="connsiteX0" fmla="*/ 181810 w 181810"/>
                <a:gd name="connsiteY0" fmla="*/ 0 h 81161"/>
                <a:gd name="connsiteX1" fmla="*/ 83838 w 181810"/>
                <a:gd name="connsiteY1" fmla="*/ 79829 h 81161"/>
                <a:gd name="connsiteX2" fmla="*/ 0 w 181810"/>
                <a:gd name="connsiteY2" fmla="*/ 3551 h 81161"/>
                <a:gd name="connsiteX0" fmla="*/ 181810 w 181810"/>
                <a:gd name="connsiteY0" fmla="*/ 0 h 80469"/>
                <a:gd name="connsiteX1" fmla="*/ 83838 w 181810"/>
                <a:gd name="connsiteY1" fmla="*/ 79829 h 80469"/>
                <a:gd name="connsiteX2" fmla="*/ 0 w 181810"/>
                <a:gd name="connsiteY2" fmla="*/ 3551 h 80469"/>
                <a:gd name="connsiteX0" fmla="*/ 149153 w 149153"/>
                <a:gd name="connsiteY0" fmla="*/ 0 h 79834"/>
                <a:gd name="connsiteX1" fmla="*/ 83838 w 149153"/>
                <a:gd name="connsiteY1" fmla="*/ 79829 h 79834"/>
                <a:gd name="connsiteX2" fmla="*/ 0 w 149153"/>
                <a:gd name="connsiteY2" fmla="*/ 3551 h 79834"/>
                <a:gd name="connsiteX0" fmla="*/ 109238 w 109238"/>
                <a:gd name="connsiteY0" fmla="*/ 0 h 79834"/>
                <a:gd name="connsiteX1" fmla="*/ 43923 w 109238"/>
                <a:gd name="connsiteY1" fmla="*/ 79829 h 79834"/>
                <a:gd name="connsiteX2" fmla="*/ 0 w 109238"/>
                <a:gd name="connsiteY2" fmla="*/ 3551 h 79834"/>
                <a:gd name="connsiteX0" fmla="*/ 109238 w 109238"/>
                <a:gd name="connsiteY0" fmla="*/ 0 h 61975"/>
                <a:gd name="connsiteX1" fmla="*/ 43923 w 109238"/>
                <a:gd name="connsiteY1" fmla="*/ 58058 h 61975"/>
                <a:gd name="connsiteX2" fmla="*/ 0 w 109238"/>
                <a:gd name="connsiteY2" fmla="*/ 3551 h 61975"/>
                <a:gd name="connsiteX0" fmla="*/ 94724 w 94724"/>
                <a:gd name="connsiteY0" fmla="*/ 0 h 61975"/>
                <a:gd name="connsiteX1" fmla="*/ 43923 w 94724"/>
                <a:gd name="connsiteY1" fmla="*/ 58058 h 61975"/>
                <a:gd name="connsiteX2" fmla="*/ 0 w 94724"/>
                <a:gd name="connsiteY2" fmla="*/ 3551 h 61975"/>
                <a:gd name="connsiteX0" fmla="*/ 94724 w 94724"/>
                <a:gd name="connsiteY0" fmla="*/ 0 h 60402"/>
                <a:gd name="connsiteX1" fmla="*/ 43923 w 94724"/>
                <a:gd name="connsiteY1" fmla="*/ 58058 h 60402"/>
                <a:gd name="connsiteX2" fmla="*/ 0 w 94724"/>
                <a:gd name="connsiteY2" fmla="*/ 3551 h 6040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94724" h="60402">
                  <a:moveTo>
                    <a:pt x="94724" y="0"/>
                  </a:moveTo>
                  <a:cubicBezTo>
                    <a:pt x="38832" y="85431"/>
                    <a:pt x="63339" y="53837"/>
                    <a:pt x="43923" y="58058"/>
                  </a:cubicBezTo>
                  <a:cubicBezTo>
                    <a:pt x="24507" y="62279"/>
                    <a:pt x="13368" y="36826"/>
                    <a:pt x="0" y="3551"/>
                  </a:cubicBezTo>
                </a:path>
              </a:pathLst>
            </a:cu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0" name="フリーフォーム 419"/>
            <p:cNvSpPr/>
            <p:nvPr/>
          </p:nvSpPr>
          <p:spPr>
            <a:xfrm>
              <a:off x="8180914" y="5306815"/>
              <a:ext cx="249226" cy="354727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70082"/>
                <a:gd name="connsiteX1" fmla="*/ 106883 w 256484"/>
                <a:gd name="connsiteY1" fmla="*/ 470082 h 470082"/>
                <a:gd name="connsiteX2" fmla="*/ 0 w 256484"/>
                <a:gd name="connsiteY2" fmla="*/ 2517 h 470082"/>
                <a:gd name="connsiteX0" fmla="*/ 256484 w 256484"/>
                <a:gd name="connsiteY0" fmla="*/ 0 h 481988"/>
                <a:gd name="connsiteX1" fmla="*/ 106883 w 256484"/>
                <a:gd name="connsiteY1" fmla="*/ 481988 h 481988"/>
                <a:gd name="connsiteX2" fmla="*/ 0 w 256484"/>
                <a:gd name="connsiteY2" fmla="*/ 2517 h 481988"/>
                <a:gd name="connsiteX0" fmla="*/ 256484 w 256484"/>
                <a:gd name="connsiteY0" fmla="*/ 0 h 518274"/>
                <a:gd name="connsiteX1" fmla="*/ 103254 w 256484"/>
                <a:gd name="connsiteY1" fmla="*/ 518274 h 518274"/>
                <a:gd name="connsiteX2" fmla="*/ 0 w 256484"/>
                <a:gd name="connsiteY2" fmla="*/ 2517 h 518274"/>
                <a:gd name="connsiteX0" fmla="*/ 274627 w 274627"/>
                <a:gd name="connsiteY0" fmla="*/ 0 h 518274"/>
                <a:gd name="connsiteX1" fmla="*/ 121397 w 274627"/>
                <a:gd name="connsiteY1" fmla="*/ 518274 h 518274"/>
                <a:gd name="connsiteX2" fmla="*/ 0 w 274627"/>
                <a:gd name="connsiteY2" fmla="*/ 2517 h 518274"/>
                <a:gd name="connsiteX0" fmla="*/ 278255 w 278255"/>
                <a:gd name="connsiteY0" fmla="*/ 0 h 518274"/>
                <a:gd name="connsiteX1" fmla="*/ 121397 w 278255"/>
                <a:gd name="connsiteY1" fmla="*/ 518274 h 518274"/>
                <a:gd name="connsiteX2" fmla="*/ 0 w 278255"/>
                <a:gd name="connsiteY2" fmla="*/ 2517 h 518274"/>
                <a:gd name="connsiteX0" fmla="*/ 278255 w 278255"/>
                <a:gd name="connsiteY0" fmla="*/ 0 h 531801"/>
                <a:gd name="connsiteX1" fmla="*/ 121397 w 278255"/>
                <a:gd name="connsiteY1" fmla="*/ 531801 h 531801"/>
                <a:gd name="connsiteX2" fmla="*/ 0 w 278255"/>
                <a:gd name="connsiteY2" fmla="*/ 2517 h 531801"/>
                <a:gd name="connsiteX0" fmla="*/ 260837 w 260837"/>
                <a:gd name="connsiteY0" fmla="*/ 0 h 531801"/>
                <a:gd name="connsiteX1" fmla="*/ 103979 w 260837"/>
                <a:gd name="connsiteY1" fmla="*/ 531801 h 531801"/>
                <a:gd name="connsiteX2" fmla="*/ 0 w 260837"/>
                <a:gd name="connsiteY2" fmla="*/ 2517 h 531801"/>
                <a:gd name="connsiteX0" fmla="*/ 249226 w 249226"/>
                <a:gd name="connsiteY0" fmla="*/ 0 h 531801"/>
                <a:gd name="connsiteX1" fmla="*/ 103979 w 249226"/>
                <a:gd name="connsiteY1" fmla="*/ 531801 h 531801"/>
                <a:gd name="connsiteX2" fmla="*/ 0 w 249226"/>
                <a:gd name="connsiteY2" fmla="*/ 2517 h 531801"/>
                <a:gd name="connsiteX0" fmla="*/ 249226 w 249226"/>
                <a:gd name="connsiteY0" fmla="*/ 0 h 308281"/>
                <a:gd name="connsiteX1" fmla="*/ 112688 w 249226"/>
                <a:gd name="connsiteY1" fmla="*/ 308281 h 308281"/>
                <a:gd name="connsiteX2" fmla="*/ 0 w 249226"/>
                <a:gd name="connsiteY2" fmla="*/ 2517 h 308281"/>
                <a:gd name="connsiteX0" fmla="*/ 249226 w 249226"/>
                <a:gd name="connsiteY0" fmla="*/ 0 h 354727"/>
                <a:gd name="connsiteX1" fmla="*/ 101076 w 249226"/>
                <a:gd name="connsiteY1" fmla="*/ 354727 h 354727"/>
                <a:gd name="connsiteX2" fmla="*/ 0 w 249226"/>
                <a:gd name="connsiteY2" fmla="*/ 2517 h 35472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49226" h="354727">
                  <a:moveTo>
                    <a:pt x="249226" y="0"/>
                  </a:moveTo>
                  <a:cubicBezTo>
                    <a:pt x="229619" y="92688"/>
                    <a:pt x="142614" y="354308"/>
                    <a:pt x="101076" y="354727"/>
                  </a:cubicBezTo>
                  <a:cubicBezTo>
                    <a:pt x="59538" y="355147"/>
                    <a:pt x="21389" y="88966"/>
                    <a:pt x="0" y="2517"/>
                  </a:cubicBezTo>
                </a:path>
              </a:pathLst>
            </a:custGeom>
            <a:noFill/>
            <a:ln w="12700">
              <a:solidFill>
                <a:srgbClr val="0000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1" name="フリーフォーム 420"/>
            <p:cNvSpPr/>
            <p:nvPr/>
          </p:nvSpPr>
          <p:spPr>
            <a:xfrm>
              <a:off x="8194538" y="5307844"/>
              <a:ext cx="224814" cy="312390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419519"/>
                <a:gd name="connsiteX1" fmla="*/ 101472 w 242957"/>
                <a:gd name="connsiteY1" fmla="*/ 419519 h 419519"/>
                <a:gd name="connsiteX2" fmla="*/ 0 w 242957"/>
                <a:gd name="connsiteY2" fmla="*/ 0 h 419519"/>
                <a:gd name="connsiteX0" fmla="*/ 242957 w 242957"/>
                <a:gd name="connsiteY0" fmla="*/ 189 h 470319"/>
                <a:gd name="connsiteX1" fmla="*/ 97843 w 242957"/>
                <a:gd name="connsiteY1" fmla="*/ 470319 h 470319"/>
                <a:gd name="connsiteX2" fmla="*/ 0 w 242957"/>
                <a:gd name="connsiteY2" fmla="*/ 0 h 470319"/>
                <a:gd name="connsiteX0" fmla="*/ 253843 w 253843"/>
                <a:gd name="connsiteY0" fmla="*/ 0 h 470130"/>
                <a:gd name="connsiteX1" fmla="*/ 108729 w 253843"/>
                <a:gd name="connsiteY1" fmla="*/ 470130 h 470130"/>
                <a:gd name="connsiteX2" fmla="*/ 0 w 253843"/>
                <a:gd name="connsiteY2" fmla="*/ 3439 h 470130"/>
                <a:gd name="connsiteX0" fmla="*/ 253843 w 253843"/>
                <a:gd name="connsiteY0" fmla="*/ 0 h 483657"/>
                <a:gd name="connsiteX1" fmla="*/ 108729 w 253843"/>
                <a:gd name="connsiteY1" fmla="*/ 483657 h 483657"/>
                <a:gd name="connsiteX2" fmla="*/ 0 w 253843"/>
                <a:gd name="connsiteY2" fmla="*/ 3439 h 483657"/>
                <a:gd name="connsiteX0" fmla="*/ 236426 w 236426"/>
                <a:gd name="connsiteY0" fmla="*/ 0 h 483657"/>
                <a:gd name="connsiteX1" fmla="*/ 91312 w 236426"/>
                <a:gd name="connsiteY1" fmla="*/ 483657 h 483657"/>
                <a:gd name="connsiteX2" fmla="*/ 0 w 236426"/>
                <a:gd name="connsiteY2" fmla="*/ 3439 h 483657"/>
                <a:gd name="connsiteX0" fmla="*/ 224814 w 224814"/>
                <a:gd name="connsiteY0" fmla="*/ 0 h 483657"/>
                <a:gd name="connsiteX1" fmla="*/ 91312 w 224814"/>
                <a:gd name="connsiteY1" fmla="*/ 483657 h 483657"/>
                <a:gd name="connsiteX2" fmla="*/ 0 w 224814"/>
                <a:gd name="connsiteY2" fmla="*/ 3439 h 483657"/>
                <a:gd name="connsiteX0" fmla="*/ 224814 w 224814"/>
                <a:gd name="connsiteY0" fmla="*/ 0 h 271750"/>
                <a:gd name="connsiteX1" fmla="*/ 97118 w 224814"/>
                <a:gd name="connsiteY1" fmla="*/ 271749 h 271750"/>
                <a:gd name="connsiteX2" fmla="*/ 0 w 224814"/>
                <a:gd name="connsiteY2" fmla="*/ 3439 h 271750"/>
                <a:gd name="connsiteX0" fmla="*/ 224814 w 224814"/>
                <a:gd name="connsiteY0" fmla="*/ 0 h 312390"/>
                <a:gd name="connsiteX1" fmla="*/ 85507 w 224814"/>
                <a:gd name="connsiteY1" fmla="*/ 312389 h 312390"/>
                <a:gd name="connsiteX2" fmla="*/ 0 w 224814"/>
                <a:gd name="connsiteY2" fmla="*/ 3439 h 3123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224814" h="312390">
                  <a:moveTo>
                    <a:pt x="224814" y="0"/>
                  </a:moveTo>
                  <a:cubicBezTo>
                    <a:pt x="205207" y="92688"/>
                    <a:pt x="122976" y="311816"/>
                    <a:pt x="85507" y="312389"/>
                  </a:cubicBezTo>
                  <a:cubicBezTo>
                    <a:pt x="48038" y="312962"/>
                    <a:pt x="21389" y="89888"/>
                    <a:pt x="0" y="3439"/>
                  </a:cubicBezTo>
                </a:path>
              </a:pathLst>
            </a:custGeom>
            <a:noFill/>
            <a:ln w="12700">
              <a:solidFill>
                <a:srgbClr val="00CC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2" name="フリーフォーム 421"/>
            <p:cNvSpPr/>
            <p:nvPr/>
          </p:nvSpPr>
          <p:spPr>
            <a:xfrm>
              <a:off x="8214496" y="5308494"/>
              <a:ext cx="189185" cy="272119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402748"/>
                <a:gd name="connsiteX1" fmla="*/ 82470 w 224020"/>
                <a:gd name="connsiteY1" fmla="*/ 402748 h 402748"/>
                <a:gd name="connsiteX2" fmla="*/ 0 w 224020"/>
                <a:gd name="connsiteY2" fmla="*/ 0 h 402748"/>
                <a:gd name="connsiteX0" fmla="*/ 224020 w 224020"/>
                <a:gd name="connsiteY0" fmla="*/ 189 h 402748"/>
                <a:gd name="connsiteX1" fmla="*/ 93356 w 224020"/>
                <a:gd name="connsiteY1" fmla="*/ 402748 h 402748"/>
                <a:gd name="connsiteX2" fmla="*/ 0 w 224020"/>
                <a:gd name="connsiteY2" fmla="*/ 0 h 402748"/>
                <a:gd name="connsiteX0" fmla="*/ 224020 w 224020"/>
                <a:gd name="connsiteY0" fmla="*/ 189 h 240188"/>
                <a:gd name="connsiteX1" fmla="*/ 90453 w 224020"/>
                <a:gd name="connsiteY1" fmla="*/ 240188 h 240188"/>
                <a:gd name="connsiteX2" fmla="*/ 0 w 224020"/>
                <a:gd name="connsiteY2" fmla="*/ 0 h 240188"/>
                <a:gd name="connsiteX0" fmla="*/ 206602 w 206602"/>
                <a:gd name="connsiteY0" fmla="*/ 189 h 240188"/>
                <a:gd name="connsiteX1" fmla="*/ 73035 w 206602"/>
                <a:gd name="connsiteY1" fmla="*/ 240188 h 240188"/>
                <a:gd name="connsiteX2" fmla="*/ 0 w 206602"/>
                <a:gd name="connsiteY2" fmla="*/ 0 h 240188"/>
                <a:gd name="connsiteX0" fmla="*/ 189185 w 189185"/>
                <a:gd name="connsiteY0" fmla="*/ 189 h 240188"/>
                <a:gd name="connsiteX1" fmla="*/ 73035 w 189185"/>
                <a:gd name="connsiteY1" fmla="*/ 240188 h 240188"/>
                <a:gd name="connsiteX2" fmla="*/ 0 w 189185"/>
                <a:gd name="connsiteY2" fmla="*/ 0 h 240188"/>
                <a:gd name="connsiteX0" fmla="*/ 189185 w 189185"/>
                <a:gd name="connsiteY0" fmla="*/ 189 h 237285"/>
                <a:gd name="connsiteX1" fmla="*/ 78841 w 189185"/>
                <a:gd name="connsiteY1" fmla="*/ 237285 h 237285"/>
                <a:gd name="connsiteX2" fmla="*/ 0 w 189185"/>
                <a:gd name="connsiteY2" fmla="*/ 0 h 237285"/>
                <a:gd name="connsiteX0" fmla="*/ 189185 w 189185"/>
                <a:gd name="connsiteY0" fmla="*/ 189 h 272119"/>
                <a:gd name="connsiteX1" fmla="*/ 73035 w 189185"/>
                <a:gd name="connsiteY1" fmla="*/ 272119 h 272119"/>
                <a:gd name="connsiteX2" fmla="*/ 0 w 189185"/>
                <a:gd name="connsiteY2" fmla="*/ 0 h 27211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89185" h="272119">
                  <a:moveTo>
                    <a:pt x="189185" y="189"/>
                  </a:moveTo>
                  <a:cubicBezTo>
                    <a:pt x="169578" y="92877"/>
                    <a:pt x="104566" y="272150"/>
                    <a:pt x="73035" y="272119"/>
                  </a:cubicBezTo>
                  <a:cubicBezTo>
                    <a:pt x="41504" y="272088"/>
                    <a:pt x="21389" y="86449"/>
                    <a:pt x="0" y="0"/>
                  </a:cubicBezTo>
                </a:path>
              </a:pathLst>
            </a:custGeom>
            <a:noFill/>
            <a:ln w="12700"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3" name="フリーフォーム 422"/>
            <p:cNvSpPr/>
            <p:nvPr/>
          </p:nvSpPr>
          <p:spPr>
            <a:xfrm>
              <a:off x="8231278" y="5303513"/>
              <a:ext cx="162624" cy="203512"/>
            </a:xfrm>
            <a:custGeom>
              <a:avLst/>
              <a:gdLst>
                <a:gd name="connsiteX0" fmla="*/ 181810 w 181810"/>
                <a:gd name="connsiteY0" fmla="*/ 0 h 187171"/>
                <a:gd name="connsiteX1" fmla="*/ 112294 w 181810"/>
                <a:gd name="connsiteY1" fmla="*/ 187158 h 187171"/>
                <a:gd name="connsiteX2" fmla="*/ 0 w 181810"/>
                <a:gd name="connsiteY2" fmla="*/ 10695 h 187171"/>
                <a:gd name="connsiteX3" fmla="*/ 0 w 181810"/>
                <a:gd name="connsiteY3" fmla="*/ 10695 h 187171"/>
                <a:gd name="connsiteX0" fmla="*/ 181810 w 181810"/>
                <a:gd name="connsiteY0" fmla="*/ 0 h 203214"/>
                <a:gd name="connsiteX1" fmla="*/ 74862 w 181810"/>
                <a:gd name="connsiteY1" fmla="*/ 203200 h 203214"/>
                <a:gd name="connsiteX2" fmla="*/ 0 w 181810"/>
                <a:gd name="connsiteY2" fmla="*/ 10695 h 203214"/>
                <a:gd name="connsiteX3" fmla="*/ 0 w 181810"/>
                <a:gd name="connsiteY3" fmla="*/ 10695 h 20321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181810 w 181810"/>
                <a:gd name="connsiteY0" fmla="*/ 0 h 529394"/>
                <a:gd name="connsiteX1" fmla="*/ 58820 w 181810"/>
                <a:gd name="connsiteY1" fmla="*/ 529389 h 529394"/>
                <a:gd name="connsiteX2" fmla="*/ 0 w 181810"/>
                <a:gd name="connsiteY2" fmla="*/ 10695 h 529394"/>
                <a:gd name="connsiteX3" fmla="*/ 0 w 181810"/>
                <a:gd name="connsiteY3" fmla="*/ 10695 h 529394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3" fmla="*/ 0 w 219242"/>
                <a:gd name="connsiteY3" fmla="*/ 10695 h 529394"/>
                <a:gd name="connsiteX0" fmla="*/ 288758 w 288758"/>
                <a:gd name="connsiteY0" fmla="*/ 27726 h 557120"/>
                <a:gd name="connsiteX1" fmla="*/ 128336 w 288758"/>
                <a:gd name="connsiteY1" fmla="*/ 557115 h 557120"/>
                <a:gd name="connsiteX2" fmla="*/ 69516 w 288758"/>
                <a:gd name="connsiteY2" fmla="*/ 38421 h 557120"/>
                <a:gd name="connsiteX3" fmla="*/ 0 w 288758"/>
                <a:gd name="connsiteY3" fmla="*/ 38421 h 557120"/>
                <a:gd name="connsiteX0" fmla="*/ 219242 w 219242"/>
                <a:gd name="connsiteY0" fmla="*/ 0 h 529394"/>
                <a:gd name="connsiteX1" fmla="*/ 58820 w 219242"/>
                <a:gd name="connsiteY1" fmla="*/ 529389 h 529394"/>
                <a:gd name="connsiteX2" fmla="*/ 0 w 219242"/>
                <a:gd name="connsiteY2" fmla="*/ 10695 h 529394"/>
                <a:gd name="connsiteX0" fmla="*/ 272716 w 272716"/>
                <a:gd name="connsiteY0" fmla="*/ 0 h 529401"/>
                <a:gd name="connsiteX1" fmla="*/ 112294 w 272716"/>
                <a:gd name="connsiteY1" fmla="*/ 529389 h 529401"/>
                <a:gd name="connsiteX2" fmla="*/ 0 w 272716"/>
                <a:gd name="connsiteY2" fmla="*/ 16043 h 529401"/>
                <a:gd name="connsiteX0" fmla="*/ 272716 w 272716"/>
                <a:gd name="connsiteY0" fmla="*/ 0 h 529389"/>
                <a:gd name="connsiteX1" fmla="*/ 112294 w 272716"/>
                <a:gd name="connsiteY1" fmla="*/ 529389 h 529389"/>
                <a:gd name="connsiteX2" fmla="*/ 0 w 272716"/>
                <a:gd name="connsiteY2" fmla="*/ 2517 h 529389"/>
                <a:gd name="connsiteX0" fmla="*/ 272716 w 272716"/>
                <a:gd name="connsiteY0" fmla="*/ 0 h 491514"/>
                <a:gd name="connsiteX1" fmla="*/ 114999 w 272716"/>
                <a:gd name="connsiteY1" fmla="*/ 491514 h 491514"/>
                <a:gd name="connsiteX2" fmla="*/ 0 w 272716"/>
                <a:gd name="connsiteY2" fmla="*/ 2517 h 491514"/>
                <a:gd name="connsiteX0" fmla="*/ 264600 w 264600"/>
                <a:gd name="connsiteY0" fmla="*/ 0 h 491514"/>
                <a:gd name="connsiteX1" fmla="*/ 106883 w 264600"/>
                <a:gd name="connsiteY1" fmla="*/ 491514 h 491514"/>
                <a:gd name="connsiteX2" fmla="*/ 0 w 264600"/>
                <a:gd name="connsiteY2" fmla="*/ 2517 h 491514"/>
                <a:gd name="connsiteX0" fmla="*/ 256484 w 256484"/>
                <a:gd name="connsiteY0" fmla="*/ 0 h 491514"/>
                <a:gd name="connsiteX1" fmla="*/ 106883 w 256484"/>
                <a:gd name="connsiteY1" fmla="*/ 491514 h 491514"/>
                <a:gd name="connsiteX2" fmla="*/ 0 w 256484"/>
                <a:gd name="connsiteY2" fmla="*/ 2517 h 491514"/>
                <a:gd name="connsiteX0" fmla="*/ 256484 w 256484"/>
                <a:gd name="connsiteY0" fmla="*/ 0 h 445523"/>
                <a:gd name="connsiteX1" fmla="*/ 106883 w 256484"/>
                <a:gd name="connsiteY1" fmla="*/ 445523 h 445523"/>
                <a:gd name="connsiteX2" fmla="*/ 0 w 256484"/>
                <a:gd name="connsiteY2" fmla="*/ 2517 h 445523"/>
                <a:gd name="connsiteX0" fmla="*/ 251073 w 251073"/>
                <a:gd name="connsiteY0" fmla="*/ 189 h 445712"/>
                <a:gd name="connsiteX1" fmla="*/ 101472 w 251073"/>
                <a:gd name="connsiteY1" fmla="*/ 445712 h 445712"/>
                <a:gd name="connsiteX2" fmla="*/ 0 w 251073"/>
                <a:gd name="connsiteY2" fmla="*/ 0 h 445712"/>
                <a:gd name="connsiteX0" fmla="*/ 242957 w 242957"/>
                <a:gd name="connsiteY0" fmla="*/ 189 h 445712"/>
                <a:gd name="connsiteX1" fmla="*/ 101472 w 242957"/>
                <a:gd name="connsiteY1" fmla="*/ 445712 h 445712"/>
                <a:gd name="connsiteX2" fmla="*/ 0 w 242957"/>
                <a:gd name="connsiteY2" fmla="*/ 0 h 445712"/>
                <a:gd name="connsiteX0" fmla="*/ 242957 w 242957"/>
                <a:gd name="connsiteY0" fmla="*/ 189 h 348320"/>
                <a:gd name="connsiteX1" fmla="*/ 104177 w 242957"/>
                <a:gd name="connsiteY1" fmla="*/ 348320 h 348320"/>
                <a:gd name="connsiteX2" fmla="*/ 0 w 242957"/>
                <a:gd name="connsiteY2" fmla="*/ 0 h 348320"/>
                <a:gd name="connsiteX0" fmla="*/ 232136 w 232136"/>
                <a:gd name="connsiteY0" fmla="*/ 189 h 348320"/>
                <a:gd name="connsiteX1" fmla="*/ 93356 w 232136"/>
                <a:gd name="connsiteY1" fmla="*/ 348320 h 348320"/>
                <a:gd name="connsiteX2" fmla="*/ 0 w 232136"/>
                <a:gd name="connsiteY2" fmla="*/ 0 h 348320"/>
                <a:gd name="connsiteX0" fmla="*/ 224020 w 224020"/>
                <a:gd name="connsiteY0" fmla="*/ 189 h 348320"/>
                <a:gd name="connsiteX1" fmla="*/ 93356 w 224020"/>
                <a:gd name="connsiteY1" fmla="*/ 348320 h 348320"/>
                <a:gd name="connsiteX2" fmla="*/ 0 w 224020"/>
                <a:gd name="connsiteY2" fmla="*/ 0 h 348320"/>
                <a:gd name="connsiteX0" fmla="*/ 224020 w 224020"/>
                <a:gd name="connsiteY0" fmla="*/ 189 h 264455"/>
                <a:gd name="connsiteX1" fmla="*/ 101472 w 224020"/>
                <a:gd name="connsiteY1" fmla="*/ 264455 h 264455"/>
                <a:gd name="connsiteX2" fmla="*/ 0 w 224020"/>
                <a:gd name="connsiteY2" fmla="*/ 0 h 264455"/>
                <a:gd name="connsiteX0" fmla="*/ 207788 w 207788"/>
                <a:gd name="connsiteY0" fmla="*/ 189 h 264455"/>
                <a:gd name="connsiteX1" fmla="*/ 85240 w 207788"/>
                <a:gd name="connsiteY1" fmla="*/ 264455 h 264455"/>
                <a:gd name="connsiteX2" fmla="*/ 0 w 207788"/>
                <a:gd name="connsiteY2" fmla="*/ 0 h 264455"/>
                <a:gd name="connsiteX0" fmla="*/ 194261 w 194261"/>
                <a:gd name="connsiteY0" fmla="*/ 189 h 264455"/>
                <a:gd name="connsiteX1" fmla="*/ 85240 w 194261"/>
                <a:gd name="connsiteY1" fmla="*/ 264455 h 264455"/>
                <a:gd name="connsiteX2" fmla="*/ 0 w 194261"/>
                <a:gd name="connsiteY2" fmla="*/ 0 h 264455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199023 w 199023"/>
                <a:gd name="connsiteY0" fmla="*/ 2570 h 266836"/>
                <a:gd name="connsiteX1" fmla="*/ 90002 w 199023"/>
                <a:gd name="connsiteY1" fmla="*/ 266836 h 266836"/>
                <a:gd name="connsiteX2" fmla="*/ 0 w 199023"/>
                <a:gd name="connsiteY2" fmla="*/ 0 h 266836"/>
                <a:gd name="connsiteX0" fmla="*/ 206167 w 206167"/>
                <a:gd name="connsiteY0" fmla="*/ 189 h 266836"/>
                <a:gd name="connsiteX1" fmla="*/ 90002 w 206167"/>
                <a:gd name="connsiteY1" fmla="*/ 266836 h 266836"/>
                <a:gd name="connsiteX2" fmla="*/ 0 w 206167"/>
                <a:gd name="connsiteY2" fmla="*/ 0 h 266836"/>
                <a:gd name="connsiteX0" fmla="*/ 206167 w 206167"/>
                <a:gd name="connsiteY0" fmla="*/ 189 h 208778"/>
                <a:gd name="connsiteX1" fmla="*/ 86373 w 206167"/>
                <a:gd name="connsiteY1" fmla="*/ 208778 h 208778"/>
                <a:gd name="connsiteX2" fmla="*/ 0 w 206167"/>
                <a:gd name="connsiteY2" fmla="*/ 0 h 208778"/>
                <a:gd name="connsiteX0" fmla="*/ 206167 w 206167"/>
                <a:gd name="connsiteY0" fmla="*/ 189 h 208778"/>
                <a:gd name="connsiteX1" fmla="*/ 86373 w 206167"/>
                <a:gd name="connsiteY1" fmla="*/ 208778 h 208778"/>
                <a:gd name="connsiteX2" fmla="*/ 0 w 206167"/>
                <a:gd name="connsiteY2" fmla="*/ 0 h 208778"/>
                <a:gd name="connsiteX0" fmla="*/ 184396 w 184396"/>
                <a:gd name="connsiteY0" fmla="*/ 0 h 212219"/>
                <a:gd name="connsiteX1" fmla="*/ 86373 w 184396"/>
                <a:gd name="connsiteY1" fmla="*/ 212218 h 212219"/>
                <a:gd name="connsiteX2" fmla="*/ 0 w 184396"/>
                <a:gd name="connsiteY2" fmla="*/ 3440 h 212219"/>
                <a:gd name="connsiteX0" fmla="*/ 162624 w 162624"/>
                <a:gd name="connsiteY0" fmla="*/ 0 h 212219"/>
                <a:gd name="connsiteX1" fmla="*/ 64601 w 162624"/>
                <a:gd name="connsiteY1" fmla="*/ 212218 h 212219"/>
                <a:gd name="connsiteX2" fmla="*/ 0 w 162624"/>
                <a:gd name="connsiteY2" fmla="*/ 3440 h 212219"/>
                <a:gd name="connsiteX0" fmla="*/ 162624 w 162624"/>
                <a:gd name="connsiteY0" fmla="*/ 0 h 203512"/>
                <a:gd name="connsiteX1" fmla="*/ 64601 w 162624"/>
                <a:gd name="connsiteY1" fmla="*/ 203510 h 203512"/>
                <a:gd name="connsiteX2" fmla="*/ 0 w 162624"/>
                <a:gd name="connsiteY2" fmla="*/ 3440 h 20351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</a:cxnLst>
              <a:rect l="l" t="t" r="r" b="b"/>
              <a:pathLst>
                <a:path w="162624" h="203512">
                  <a:moveTo>
                    <a:pt x="162624" y="0"/>
                  </a:moveTo>
                  <a:cubicBezTo>
                    <a:pt x="124874" y="81802"/>
                    <a:pt x="91705" y="202937"/>
                    <a:pt x="64601" y="203510"/>
                  </a:cubicBezTo>
                  <a:cubicBezTo>
                    <a:pt x="37497" y="204083"/>
                    <a:pt x="21389" y="89889"/>
                    <a:pt x="0" y="3440"/>
                  </a:cubicBezTo>
                </a:path>
              </a:pathLst>
            </a:custGeom>
            <a:noFill/>
            <a:ln w="12700">
              <a:solidFill>
                <a:srgbClr val="FFC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24" name="正方形/長方形 423"/>
            <p:cNvSpPr/>
            <p:nvPr/>
          </p:nvSpPr>
          <p:spPr>
            <a:xfrm>
              <a:off x="8097137" y="5299132"/>
              <a:ext cx="422174" cy="77354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425" name="グループ化 424"/>
            <p:cNvGrpSpPr/>
            <p:nvPr/>
          </p:nvGrpSpPr>
          <p:grpSpPr>
            <a:xfrm>
              <a:off x="7629863" y="5534211"/>
              <a:ext cx="127437" cy="356672"/>
              <a:chOff x="3073698" y="2256656"/>
              <a:chExt cx="127437" cy="356672"/>
            </a:xfrm>
          </p:grpSpPr>
          <p:sp>
            <p:nvSpPr>
              <p:cNvPr id="426" name="Rectangle 4334"/>
              <p:cNvSpPr>
                <a:spLocks noChangeArrowheads="1"/>
              </p:cNvSpPr>
              <p:nvPr/>
            </p:nvSpPr>
            <p:spPr bwMode="auto">
              <a:xfrm rot="16200000">
                <a:off x="3109139" y="2525103"/>
                <a:ext cx="52784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i="1" dirty="0">
                    <a:solidFill>
                      <a:srgbClr val="000000"/>
                    </a:solidFill>
                    <a:latin typeface="Symbol" pitchFamily="18" charset="2"/>
                    <a:cs typeface="Arial" charset="0"/>
                  </a:rPr>
                  <a:t>q</a:t>
                </a:r>
                <a:endParaRPr lang="en-US" altLang="ja-JP" sz="800" b="1" i="1" dirty="0">
                  <a:latin typeface="Symbol" pitchFamily="18" charset="2"/>
                  <a:cs typeface="Arial" charset="0"/>
                </a:endParaRPr>
              </a:p>
            </p:txBody>
          </p:sp>
          <p:sp>
            <p:nvSpPr>
              <p:cNvPr id="427" name="Rectangle 4335"/>
              <p:cNvSpPr>
                <a:spLocks noChangeArrowheads="1"/>
              </p:cNvSpPr>
              <p:nvPr/>
            </p:nvSpPr>
            <p:spPr bwMode="auto">
              <a:xfrm rot="16200000">
                <a:off x="2999046" y="2335079"/>
                <a:ext cx="280512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X 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10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5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</p:grpSp>
        <p:grpSp>
          <p:nvGrpSpPr>
            <p:cNvPr id="428" name="グループ化 427"/>
            <p:cNvGrpSpPr/>
            <p:nvPr/>
          </p:nvGrpSpPr>
          <p:grpSpPr>
            <a:xfrm>
              <a:off x="7766716" y="5284192"/>
              <a:ext cx="123666" cy="856711"/>
              <a:chOff x="3077093" y="1408239"/>
              <a:chExt cx="123666" cy="856711"/>
            </a:xfrm>
          </p:grpSpPr>
          <p:sp>
            <p:nvSpPr>
              <p:cNvPr id="429" name="Rectangle 4337"/>
              <p:cNvSpPr>
                <a:spLocks noChangeArrowheads="1"/>
              </p:cNvSpPr>
              <p:nvPr/>
            </p:nvSpPr>
            <p:spPr bwMode="auto">
              <a:xfrm rot="16200000">
                <a:off x="2922509" y="1986701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 (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egcm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2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430" name="Rectangle 4339"/>
              <p:cNvSpPr>
                <a:spLocks noChangeArrowheads="1"/>
              </p:cNvSpPr>
              <p:nvPr/>
            </p:nvSpPr>
            <p:spPr bwMode="auto">
              <a:xfrm rot="16200000">
                <a:off x="2922509" y="1605145"/>
                <a:ext cx="432833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ja-JP" altLang="en-US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　</a:t>
                </a:r>
                <a:r>
                  <a:rPr lang="en-US" altLang="ja-JP" sz="800" b="1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dmole</a:t>
                </a:r>
                <a:r>
                  <a:rPr lang="en-US" altLang="ja-JP" sz="800" b="1" baseline="30000" dirty="0" smtClean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-1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431" name="Rectangle 4341"/>
              <p:cNvSpPr>
                <a:spLocks noChangeArrowheads="1"/>
              </p:cNvSpPr>
              <p:nvPr/>
            </p:nvSpPr>
            <p:spPr bwMode="auto">
              <a:xfrm rot="16200000">
                <a:off x="3122336" y="1362996"/>
                <a:ext cx="33179" cy="123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en-US" altLang="ja-JP" sz="800" b="1" dirty="0">
                    <a:solidFill>
                      <a:srgbClr val="000000"/>
                    </a:solidFill>
                    <a:latin typeface="Arial" charset="0"/>
                    <a:cs typeface="Arial" charset="0"/>
                  </a:rPr>
                  <a:t>)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</p:grpSp>
        <p:sp>
          <p:nvSpPr>
            <p:cNvPr id="432" name="テキスト ボックス 88"/>
            <p:cNvSpPr txBox="1">
              <a:spLocks noChangeArrowheads="1"/>
            </p:cNvSpPr>
            <p:nvPr/>
          </p:nvSpPr>
          <p:spPr bwMode="auto">
            <a:xfrm>
              <a:off x="8106970" y="5826842"/>
              <a:ext cx="41234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(nm)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433" name="テキスト ボックス 88"/>
            <p:cNvSpPr txBox="1">
              <a:spLocks noChangeArrowheads="1"/>
            </p:cNvSpPr>
            <p:nvPr/>
          </p:nvSpPr>
          <p:spPr bwMode="auto">
            <a:xfrm>
              <a:off x="7901133" y="6035135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200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  <p:sp>
          <p:nvSpPr>
            <p:cNvPr id="353" name="テキスト ボックス 88"/>
            <p:cNvSpPr txBox="1">
              <a:spLocks noChangeArrowheads="1"/>
            </p:cNvSpPr>
            <p:nvPr/>
          </p:nvSpPr>
          <p:spPr bwMode="auto">
            <a:xfrm>
              <a:off x="7768201" y="5195991"/>
              <a:ext cx="39768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Calibri" pitchFamily="34" charset="0"/>
                  <a:ea typeface="ＭＳ Ｐゴシック" pitchFamily="50" charset="-128"/>
                </a:defRPr>
              </a:lvl9pPr>
            </a:lstStyle>
            <a:p>
              <a:pPr algn="ctr" eaLnBrk="1" hangingPunct="1"/>
              <a:r>
                <a:rPr lang="en-US" altLang="ja-JP" sz="800" b="1" dirty="0" smtClean="0">
                  <a:latin typeface="Arial" charset="0"/>
                  <a:cs typeface="Arial" charset="0"/>
                </a:rPr>
                <a:t>-2</a:t>
              </a:r>
              <a:endParaRPr lang="en-US" altLang="ja-JP" sz="800" b="1" dirty="0">
                <a:latin typeface="Arial" charset="0"/>
                <a:cs typeface="Arial" charset="0"/>
              </a:endParaRPr>
            </a:p>
          </p:txBody>
        </p:sp>
      </p:grpSp>
      <p:sp>
        <p:nvSpPr>
          <p:cNvPr id="453" name="Rectangle 4334"/>
          <p:cNvSpPr>
            <a:spLocks noChangeArrowheads="1"/>
          </p:cNvSpPr>
          <p:nvPr/>
        </p:nvSpPr>
        <p:spPr bwMode="auto">
          <a:xfrm rot="16200000">
            <a:off x="4806807" y="2556822"/>
            <a:ext cx="63341" cy="146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i="1" dirty="0">
                <a:solidFill>
                  <a:srgbClr val="000000"/>
                </a:solidFill>
                <a:latin typeface="Symbol" pitchFamily="18" charset="2"/>
                <a:cs typeface="Arial" charset="0"/>
              </a:rPr>
              <a:t>q</a:t>
            </a:r>
            <a:endParaRPr lang="en-US" altLang="ja-JP" b="1" i="1" dirty="0">
              <a:latin typeface="Symbol" pitchFamily="18" charset="2"/>
              <a:cs typeface="Arial" charset="0"/>
            </a:endParaRPr>
          </a:p>
        </p:txBody>
      </p:sp>
      <p:sp>
        <p:nvSpPr>
          <p:cNvPr id="454" name="Rectangle 4335"/>
          <p:cNvSpPr>
            <a:spLocks noChangeArrowheads="1"/>
          </p:cNvSpPr>
          <p:nvPr/>
        </p:nvSpPr>
        <p:spPr bwMode="auto">
          <a:xfrm rot="16200000">
            <a:off x="4665797" y="2321675"/>
            <a:ext cx="345360" cy="153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X 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10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5</a:t>
            </a:r>
            <a:endParaRPr lang="en-US" altLang="ja-JP" b="1" baseline="30000" dirty="0">
              <a:latin typeface="Arial" charset="0"/>
              <a:cs typeface="Arial" charset="0"/>
            </a:endParaRPr>
          </a:p>
        </p:txBody>
      </p:sp>
      <p:sp>
        <p:nvSpPr>
          <p:cNvPr id="455" name="Rectangle 4337"/>
          <p:cNvSpPr>
            <a:spLocks noChangeArrowheads="1"/>
          </p:cNvSpPr>
          <p:nvPr/>
        </p:nvSpPr>
        <p:spPr bwMode="auto">
          <a:xfrm rot="16200000">
            <a:off x="4303075" y="1605783"/>
            <a:ext cx="10708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(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degcm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2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 dmole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-1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)</a:t>
            </a:r>
            <a:endParaRPr lang="en-US" altLang="ja-JP" b="1" dirty="0">
              <a:latin typeface="Arial" charset="0"/>
              <a:cs typeface="Arial" charset="0"/>
            </a:endParaRPr>
          </a:p>
        </p:txBody>
      </p:sp>
      <p:cxnSp>
        <p:nvCxnSpPr>
          <p:cNvPr id="466" name="直線コネクタ 465"/>
          <p:cNvCxnSpPr/>
          <p:nvPr/>
        </p:nvCxnSpPr>
        <p:spPr>
          <a:xfrm>
            <a:off x="1565790" y="620859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7" name="直線コネクタ 466"/>
          <p:cNvCxnSpPr/>
          <p:nvPr/>
        </p:nvCxnSpPr>
        <p:spPr>
          <a:xfrm>
            <a:off x="2135676" y="620859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8" name="直線コネクタ 467"/>
          <p:cNvCxnSpPr/>
          <p:nvPr/>
        </p:nvCxnSpPr>
        <p:spPr>
          <a:xfrm>
            <a:off x="2705562" y="620859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9" name="直線コネクタ 468"/>
          <p:cNvCxnSpPr/>
          <p:nvPr/>
        </p:nvCxnSpPr>
        <p:spPr>
          <a:xfrm>
            <a:off x="3281626" y="620859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0" name="直線コネクタ 469"/>
          <p:cNvCxnSpPr/>
          <p:nvPr/>
        </p:nvCxnSpPr>
        <p:spPr>
          <a:xfrm>
            <a:off x="3857690" y="6208596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1" name="直線コネクタ 470"/>
          <p:cNvCxnSpPr/>
          <p:nvPr/>
        </p:nvCxnSpPr>
        <p:spPr>
          <a:xfrm rot="5400000">
            <a:off x="1015014" y="4626441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2" name="直線コネクタ 471"/>
          <p:cNvCxnSpPr/>
          <p:nvPr/>
        </p:nvCxnSpPr>
        <p:spPr>
          <a:xfrm rot="5400000">
            <a:off x="1015014" y="4355035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3" name="直線コネクタ 472"/>
          <p:cNvCxnSpPr/>
          <p:nvPr/>
        </p:nvCxnSpPr>
        <p:spPr>
          <a:xfrm rot="5400000">
            <a:off x="1015014" y="4897885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4" name="直線コネクタ 473"/>
          <p:cNvCxnSpPr/>
          <p:nvPr/>
        </p:nvCxnSpPr>
        <p:spPr>
          <a:xfrm rot="5400000">
            <a:off x="1015014" y="5977967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7" name="直線コネクタ 476"/>
          <p:cNvCxnSpPr/>
          <p:nvPr/>
        </p:nvCxnSpPr>
        <p:spPr>
          <a:xfrm>
            <a:off x="979014" y="5205291"/>
            <a:ext cx="3454740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9" name="Rectangle 4334"/>
          <p:cNvSpPr>
            <a:spLocks noChangeArrowheads="1"/>
          </p:cNvSpPr>
          <p:nvPr/>
        </p:nvSpPr>
        <p:spPr bwMode="auto">
          <a:xfrm rot="16200000">
            <a:off x="556708" y="5882837"/>
            <a:ext cx="63341" cy="146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i="1" dirty="0">
                <a:solidFill>
                  <a:srgbClr val="000000"/>
                </a:solidFill>
                <a:latin typeface="Symbol" pitchFamily="18" charset="2"/>
                <a:cs typeface="Arial" charset="0"/>
              </a:rPr>
              <a:t>q</a:t>
            </a:r>
            <a:endParaRPr lang="en-US" altLang="ja-JP" b="1" i="1" dirty="0">
              <a:latin typeface="Symbol" pitchFamily="18" charset="2"/>
              <a:cs typeface="Arial" charset="0"/>
            </a:endParaRPr>
          </a:p>
        </p:txBody>
      </p:sp>
      <p:sp>
        <p:nvSpPr>
          <p:cNvPr id="480" name="Rectangle 4335"/>
          <p:cNvSpPr>
            <a:spLocks noChangeArrowheads="1"/>
          </p:cNvSpPr>
          <p:nvPr/>
        </p:nvSpPr>
        <p:spPr bwMode="auto">
          <a:xfrm rot="16200000">
            <a:off x="415698" y="5647690"/>
            <a:ext cx="345360" cy="153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X 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10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5</a:t>
            </a:r>
            <a:endParaRPr lang="en-US" altLang="ja-JP" b="1" baseline="30000" dirty="0">
              <a:latin typeface="Arial" charset="0"/>
              <a:cs typeface="Arial" charset="0"/>
            </a:endParaRPr>
          </a:p>
        </p:txBody>
      </p:sp>
      <p:sp>
        <p:nvSpPr>
          <p:cNvPr id="483" name="Rectangle 4337"/>
          <p:cNvSpPr>
            <a:spLocks noChangeArrowheads="1"/>
          </p:cNvSpPr>
          <p:nvPr/>
        </p:nvSpPr>
        <p:spPr bwMode="auto">
          <a:xfrm rot="16200000">
            <a:off x="52976" y="4931798"/>
            <a:ext cx="10708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(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degcm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2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 dmole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-1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)</a:t>
            </a:r>
            <a:endParaRPr lang="en-US" altLang="ja-JP" b="1" dirty="0">
              <a:latin typeface="Arial" charset="0"/>
              <a:cs typeface="Arial" charset="0"/>
            </a:endParaRPr>
          </a:p>
        </p:txBody>
      </p:sp>
      <p:sp>
        <p:nvSpPr>
          <p:cNvPr id="484" name="テキスト ボックス 88"/>
          <p:cNvSpPr txBox="1">
            <a:spLocks noChangeArrowheads="1"/>
          </p:cNvSpPr>
          <p:nvPr/>
        </p:nvSpPr>
        <p:spPr bwMode="auto">
          <a:xfrm>
            <a:off x="646508" y="4002656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85" name="テキスト ボックス 88"/>
          <p:cNvSpPr txBox="1">
            <a:spLocks noChangeArrowheads="1"/>
          </p:cNvSpPr>
          <p:nvPr/>
        </p:nvSpPr>
        <p:spPr bwMode="auto">
          <a:xfrm>
            <a:off x="646508" y="4269187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486" name="テキスト ボックス 88"/>
          <p:cNvSpPr txBox="1">
            <a:spLocks noChangeArrowheads="1"/>
          </p:cNvSpPr>
          <p:nvPr/>
        </p:nvSpPr>
        <p:spPr bwMode="auto">
          <a:xfrm>
            <a:off x="646508" y="4546135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87" name="テキスト ボックス 88"/>
          <p:cNvSpPr txBox="1">
            <a:spLocks noChangeArrowheads="1"/>
          </p:cNvSpPr>
          <p:nvPr/>
        </p:nvSpPr>
        <p:spPr bwMode="auto">
          <a:xfrm>
            <a:off x="646508" y="5077863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88" name="テキスト ボックス 88"/>
          <p:cNvSpPr txBox="1">
            <a:spLocks noChangeArrowheads="1"/>
          </p:cNvSpPr>
          <p:nvPr/>
        </p:nvSpPr>
        <p:spPr bwMode="auto">
          <a:xfrm>
            <a:off x="646508" y="5360353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2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89" name="テキスト ボックス 88"/>
          <p:cNvSpPr txBox="1">
            <a:spLocks noChangeArrowheads="1"/>
          </p:cNvSpPr>
          <p:nvPr/>
        </p:nvSpPr>
        <p:spPr bwMode="auto">
          <a:xfrm>
            <a:off x="646508" y="4811999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490" name="テキスト ボックス 88"/>
          <p:cNvSpPr txBox="1">
            <a:spLocks noChangeArrowheads="1"/>
          </p:cNvSpPr>
          <p:nvPr/>
        </p:nvSpPr>
        <p:spPr bwMode="auto">
          <a:xfrm>
            <a:off x="617330" y="5629272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91" name="テキスト ボックス 88"/>
          <p:cNvSpPr txBox="1">
            <a:spLocks noChangeArrowheads="1"/>
          </p:cNvSpPr>
          <p:nvPr/>
        </p:nvSpPr>
        <p:spPr bwMode="auto">
          <a:xfrm>
            <a:off x="778197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92" name="テキスト ボックス 88"/>
          <p:cNvSpPr txBox="1">
            <a:spLocks noChangeArrowheads="1"/>
          </p:cNvSpPr>
          <p:nvPr/>
        </p:nvSpPr>
        <p:spPr bwMode="auto">
          <a:xfrm>
            <a:off x="1371774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93" name="テキスト ボックス 88"/>
          <p:cNvSpPr txBox="1">
            <a:spLocks noChangeArrowheads="1"/>
          </p:cNvSpPr>
          <p:nvPr/>
        </p:nvSpPr>
        <p:spPr bwMode="auto">
          <a:xfrm>
            <a:off x="1939521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4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94" name="テキスト ボックス 88"/>
          <p:cNvSpPr txBox="1">
            <a:spLocks noChangeArrowheads="1"/>
          </p:cNvSpPr>
          <p:nvPr/>
        </p:nvSpPr>
        <p:spPr bwMode="auto">
          <a:xfrm>
            <a:off x="2507268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6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95" name="テキスト ボックス 88"/>
          <p:cNvSpPr txBox="1">
            <a:spLocks noChangeArrowheads="1"/>
          </p:cNvSpPr>
          <p:nvPr/>
        </p:nvSpPr>
        <p:spPr bwMode="auto">
          <a:xfrm>
            <a:off x="3086266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8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496" name="テキスト ボックス 88"/>
          <p:cNvSpPr txBox="1">
            <a:spLocks noChangeArrowheads="1"/>
          </p:cNvSpPr>
          <p:nvPr/>
        </p:nvSpPr>
        <p:spPr bwMode="auto">
          <a:xfrm>
            <a:off x="3657164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3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00" name="テキスト ボックス 88"/>
          <p:cNvSpPr txBox="1">
            <a:spLocks noChangeArrowheads="1"/>
          </p:cNvSpPr>
          <p:nvPr/>
        </p:nvSpPr>
        <p:spPr bwMode="auto">
          <a:xfrm>
            <a:off x="4238394" y="6291780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3</a:t>
            </a:r>
            <a:r>
              <a:rPr lang="en-US" altLang="ja-JP" sz="1000" b="1" dirty="0" smtClean="0">
                <a:latin typeface="Arial" charset="0"/>
                <a:cs typeface="Arial" charset="0"/>
              </a:rPr>
              <a:t>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01" name="テキスト ボックス 88"/>
          <p:cNvSpPr txBox="1">
            <a:spLocks noChangeArrowheads="1"/>
          </p:cNvSpPr>
          <p:nvPr/>
        </p:nvSpPr>
        <p:spPr bwMode="auto">
          <a:xfrm>
            <a:off x="1908308" y="6543541"/>
            <a:ext cx="159967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100" b="1" dirty="0" smtClean="0">
                <a:latin typeface="Arial" charset="0"/>
                <a:cs typeface="Arial" charset="0"/>
              </a:rPr>
              <a:t>Wavelength (nm)</a:t>
            </a:r>
            <a:endParaRPr lang="en-US" altLang="ja-JP" sz="1100" b="1" dirty="0">
              <a:latin typeface="Arial" charset="0"/>
              <a:cs typeface="Arial" charset="0"/>
            </a:endParaRPr>
          </a:p>
        </p:txBody>
      </p:sp>
      <p:sp>
        <p:nvSpPr>
          <p:cNvPr id="502" name="テキスト ボックス 88"/>
          <p:cNvSpPr txBox="1">
            <a:spLocks noChangeArrowheads="1"/>
          </p:cNvSpPr>
          <p:nvPr/>
        </p:nvSpPr>
        <p:spPr bwMode="auto">
          <a:xfrm>
            <a:off x="3713674" y="4211309"/>
            <a:ext cx="66087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Arial" charset="0"/>
                <a:cs typeface="Arial" charset="0"/>
              </a:rPr>
              <a:t>42 </a:t>
            </a:r>
            <a:r>
              <a:rPr lang="en-US" altLang="ja-JP" sz="1400" b="1" baseline="30000" dirty="0" err="1" smtClean="0">
                <a:latin typeface="Arial" charset="0"/>
                <a:cs typeface="Arial" charset="0"/>
              </a:rPr>
              <a:t>o</a:t>
            </a:r>
            <a:r>
              <a:rPr lang="en-US" altLang="ja-JP" sz="1400" b="1" dirty="0" err="1" smtClean="0">
                <a:latin typeface="Arial" charset="0"/>
                <a:cs typeface="Arial" charset="0"/>
              </a:rPr>
              <a:t>C</a:t>
            </a:r>
            <a:endParaRPr lang="en-US" altLang="ja-JP" sz="1400" b="1" dirty="0">
              <a:latin typeface="Arial" charset="0"/>
              <a:cs typeface="Arial" charset="0"/>
            </a:endParaRPr>
          </a:p>
        </p:txBody>
      </p:sp>
      <p:grpSp>
        <p:nvGrpSpPr>
          <p:cNvPr id="503" name="グループ化 502"/>
          <p:cNvGrpSpPr/>
          <p:nvPr/>
        </p:nvGrpSpPr>
        <p:grpSpPr>
          <a:xfrm>
            <a:off x="1243594" y="4116042"/>
            <a:ext cx="1068193" cy="925772"/>
            <a:chOff x="1248701" y="2045350"/>
            <a:chExt cx="1068193" cy="925772"/>
          </a:xfrm>
        </p:grpSpPr>
        <p:grpSp>
          <p:nvGrpSpPr>
            <p:cNvPr id="504" name="グループ化 503"/>
            <p:cNvGrpSpPr/>
            <p:nvPr/>
          </p:nvGrpSpPr>
          <p:grpSpPr>
            <a:xfrm>
              <a:off x="1248701" y="2045350"/>
              <a:ext cx="625904" cy="215444"/>
              <a:chOff x="2558800" y="476672"/>
              <a:chExt cx="690036" cy="215444"/>
            </a:xfrm>
          </p:grpSpPr>
          <p:sp>
            <p:nvSpPr>
              <p:cNvPr id="524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476672"/>
                <a:ext cx="65425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None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526" name="直線コネクタ 525"/>
              <p:cNvCxnSpPr/>
              <p:nvPr/>
            </p:nvCxnSpPr>
            <p:spPr>
              <a:xfrm>
                <a:off x="2558800" y="584394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5" name="グループ化 504"/>
            <p:cNvGrpSpPr/>
            <p:nvPr/>
          </p:nvGrpSpPr>
          <p:grpSpPr>
            <a:xfrm>
              <a:off x="1248701" y="2471548"/>
              <a:ext cx="1065091" cy="215444"/>
              <a:chOff x="2558800" y="675698"/>
              <a:chExt cx="1174223" cy="215444"/>
            </a:xfrm>
          </p:grpSpPr>
          <p:sp>
            <p:nvSpPr>
              <p:cNvPr id="522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H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523" name="直線コネクタ 522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06" name="グループ化 505"/>
            <p:cNvGrpSpPr/>
            <p:nvPr/>
          </p:nvGrpSpPr>
          <p:grpSpPr>
            <a:xfrm>
              <a:off x="1250341" y="2329482"/>
              <a:ext cx="1065091" cy="215444"/>
              <a:chOff x="2558800" y="675698"/>
              <a:chExt cx="1174223" cy="215444"/>
            </a:xfrm>
          </p:grpSpPr>
          <p:sp>
            <p:nvSpPr>
              <p:cNvPr id="520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521" name="直線コネクタ 520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0" name="グループ化 509"/>
            <p:cNvGrpSpPr/>
            <p:nvPr/>
          </p:nvGrpSpPr>
          <p:grpSpPr>
            <a:xfrm>
              <a:off x="1251803" y="2187416"/>
              <a:ext cx="1065091" cy="215444"/>
              <a:chOff x="2558800" y="675698"/>
              <a:chExt cx="1174223" cy="215444"/>
            </a:xfrm>
          </p:grpSpPr>
          <p:sp>
            <p:nvSpPr>
              <p:cNvPr id="518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N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519" name="直線コネクタ 518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1" name="グループ化 510"/>
            <p:cNvGrpSpPr/>
            <p:nvPr/>
          </p:nvGrpSpPr>
          <p:grpSpPr>
            <a:xfrm>
              <a:off x="1248701" y="2613614"/>
              <a:ext cx="1065091" cy="215444"/>
              <a:chOff x="2558800" y="675698"/>
              <a:chExt cx="1174223" cy="215444"/>
            </a:xfrm>
          </p:grpSpPr>
          <p:sp>
            <p:nvSpPr>
              <p:cNvPr id="516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APCA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517" name="直線コネクタ 516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2" name="グループ化 511"/>
            <p:cNvGrpSpPr/>
            <p:nvPr/>
          </p:nvGrpSpPr>
          <p:grpSpPr>
            <a:xfrm>
              <a:off x="1248701" y="2755678"/>
              <a:ext cx="1065091" cy="215444"/>
              <a:chOff x="2558800" y="675698"/>
              <a:chExt cx="1174223" cy="215444"/>
            </a:xfrm>
          </p:grpSpPr>
          <p:sp>
            <p:nvSpPr>
              <p:cNvPr id="513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Mg</a:t>
                </a:r>
                <a:r>
                  <a:rPr lang="en-US" altLang="ja-JP" sz="800" b="1" baseline="30000" dirty="0" smtClean="0">
                    <a:latin typeface="Arial" charset="0"/>
                    <a:cs typeface="Arial" charset="0"/>
                  </a:rPr>
                  <a:t>2+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514" name="直線コネクタ 513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528" name="正方形/長方形 527"/>
          <p:cNvSpPr/>
          <p:nvPr/>
        </p:nvSpPr>
        <p:spPr>
          <a:xfrm>
            <a:off x="977370" y="4125466"/>
            <a:ext cx="3456384" cy="21514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29" name="直線コネクタ 528"/>
          <p:cNvCxnSpPr/>
          <p:nvPr/>
        </p:nvCxnSpPr>
        <p:spPr>
          <a:xfrm rot="5400000">
            <a:off x="1009472" y="5712388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0" name="直線コネクタ 529"/>
          <p:cNvCxnSpPr/>
          <p:nvPr/>
        </p:nvCxnSpPr>
        <p:spPr>
          <a:xfrm rot="5400000">
            <a:off x="1003930" y="5446809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1" name="テキスト ボックス 88"/>
          <p:cNvSpPr txBox="1">
            <a:spLocks noChangeArrowheads="1"/>
          </p:cNvSpPr>
          <p:nvPr/>
        </p:nvSpPr>
        <p:spPr bwMode="auto">
          <a:xfrm>
            <a:off x="619843" y="5892119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6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32" name="テキスト ボックス 88"/>
          <p:cNvSpPr txBox="1">
            <a:spLocks noChangeArrowheads="1"/>
          </p:cNvSpPr>
          <p:nvPr/>
        </p:nvSpPr>
        <p:spPr bwMode="auto">
          <a:xfrm>
            <a:off x="622356" y="6154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43" name="フリーフォーム 542"/>
          <p:cNvSpPr/>
          <p:nvPr/>
        </p:nvSpPr>
        <p:spPr>
          <a:xfrm>
            <a:off x="982031" y="4694663"/>
            <a:ext cx="3452469" cy="935340"/>
          </a:xfrm>
          <a:custGeom>
            <a:avLst/>
            <a:gdLst>
              <a:gd name="connsiteX0" fmla="*/ 3452469 w 3452469"/>
              <a:gd name="connsiteY0" fmla="*/ 485132 h 791733"/>
              <a:gd name="connsiteX1" fmla="*/ 2816213 w 3452469"/>
              <a:gd name="connsiteY1" fmla="*/ 481655 h 791733"/>
              <a:gd name="connsiteX2" fmla="*/ 1992210 w 3452469"/>
              <a:gd name="connsiteY2" fmla="*/ 1856 h 791733"/>
              <a:gd name="connsiteX3" fmla="*/ 1157777 w 3452469"/>
              <a:gd name="connsiteY3" fmla="*/ 683310 h 791733"/>
              <a:gd name="connsiteX4" fmla="*/ 594534 w 3452469"/>
              <a:gd name="connsiteY4" fmla="*/ 471225 h 791733"/>
              <a:gd name="connsiteX5" fmla="*/ 267714 w 3452469"/>
              <a:gd name="connsiteY5" fmla="*/ 791091 h 791733"/>
              <a:gd name="connsiteX6" fmla="*/ 0 w 3452469"/>
              <a:gd name="connsiteY6" fmla="*/ 537284 h 791733"/>
              <a:gd name="connsiteX0" fmla="*/ 3452469 w 3452469"/>
              <a:gd name="connsiteY0" fmla="*/ 484859 h 791460"/>
              <a:gd name="connsiteX1" fmla="*/ 2816213 w 3452469"/>
              <a:gd name="connsiteY1" fmla="*/ 481382 h 791460"/>
              <a:gd name="connsiteX2" fmla="*/ 1992210 w 3452469"/>
              <a:gd name="connsiteY2" fmla="*/ 1583 h 791460"/>
              <a:gd name="connsiteX3" fmla="*/ 1157777 w 3452469"/>
              <a:gd name="connsiteY3" fmla="*/ 683037 h 791460"/>
              <a:gd name="connsiteX4" fmla="*/ 594534 w 3452469"/>
              <a:gd name="connsiteY4" fmla="*/ 470952 h 791460"/>
              <a:gd name="connsiteX5" fmla="*/ 267714 w 3452469"/>
              <a:gd name="connsiteY5" fmla="*/ 790818 h 791460"/>
              <a:gd name="connsiteX6" fmla="*/ 0 w 3452469"/>
              <a:gd name="connsiteY6" fmla="*/ 537011 h 791460"/>
              <a:gd name="connsiteX0" fmla="*/ 3452469 w 3452469"/>
              <a:gd name="connsiteY0" fmla="*/ 488597 h 795198"/>
              <a:gd name="connsiteX1" fmla="*/ 2816213 w 3452469"/>
              <a:gd name="connsiteY1" fmla="*/ 485120 h 795198"/>
              <a:gd name="connsiteX2" fmla="*/ 1940058 w 3452469"/>
              <a:gd name="connsiteY2" fmla="*/ 1844 h 795198"/>
              <a:gd name="connsiteX3" fmla="*/ 1157777 w 3452469"/>
              <a:gd name="connsiteY3" fmla="*/ 686775 h 795198"/>
              <a:gd name="connsiteX4" fmla="*/ 594534 w 3452469"/>
              <a:gd name="connsiteY4" fmla="*/ 474690 h 795198"/>
              <a:gd name="connsiteX5" fmla="*/ 267714 w 3452469"/>
              <a:gd name="connsiteY5" fmla="*/ 794556 h 795198"/>
              <a:gd name="connsiteX6" fmla="*/ 0 w 3452469"/>
              <a:gd name="connsiteY6" fmla="*/ 540749 h 795198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32946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6753 h 793354"/>
              <a:gd name="connsiteX1" fmla="*/ 2816213 w 3452469"/>
              <a:gd name="connsiteY1" fmla="*/ 483276 h 793354"/>
              <a:gd name="connsiteX2" fmla="*/ 1940058 w 3452469"/>
              <a:gd name="connsiteY2" fmla="*/ 0 h 793354"/>
              <a:gd name="connsiteX3" fmla="*/ 1157777 w 3452469"/>
              <a:gd name="connsiteY3" fmla="*/ 671024 h 793354"/>
              <a:gd name="connsiteX4" fmla="*/ 594534 w 3452469"/>
              <a:gd name="connsiteY4" fmla="*/ 472846 h 793354"/>
              <a:gd name="connsiteX5" fmla="*/ 232946 w 3452469"/>
              <a:gd name="connsiteY5" fmla="*/ 792712 h 793354"/>
              <a:gd name="connsiteX6" fmla="*/ 0 w 3452469"/>
              <a:gd name="connsiteY6" fmla="*/ 538905 h 793354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71024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119"/>
              <a:gd name="connsiteX1" fmla="*/ 2816213 w 3452469"/>
              <a:gd name="connsiteY1" fmla="*/ 507613 h 817119"/>
              <a:gd name="connsiteX2" fmla="*/ 1940058 w 3452469"/>
              <a:gd name="connsiteY2" fmla="*/ 0 h 817119"/>
              <a:gd name="connsiteX3" fmla="*/ 1157777 w 3452469"/>
              <a:gd name="connsiteY3" fmla="*/ 671024 h 817119"/>
              <a:gd name="connsiteX4" fmla="*/ 598011 w 3452469"/>
              <a:gd name="connsiteY4" fmla="*/ 542381 h 817119"/>
              <a:gd name="connsiteX5" fmla="*/ 232946 w 3452469"/>
              <a:gd name="connsiteY5" fmla="*/ 817049 h 817119"/>
              <a:gd name="connsiteX6" fmla="*/ 0 w 3452469"/>
              <a:gd name="connsiteY6" fmla="*/ 563242 h 817119"/>
              <a:gd name="connsiteX0" fmla="*/ 3452469 w 3452469"/>
              <a:gd name="connsiteY0" fmla="*/ 511090 h 956155"/>
              <a:gd name="connsiteX1" fmla="*/ 2816213 w 3452469"/>
              <a:gd name="connsiteY1" fmla="*/ 507613 h 956155"/>
              <a:gd name="connsiteX2" fmla="*/ 1940058 w 3452469"/>
              <a:gd name="connsiteY2" fmla="*/ 0 h 956155"/>
              <a:gd name="connsiteX3" fmla="*/ 1157777 w 3452469"/>
              <a:gd name="connsiteY3" fmla="*/ 671024 h 956155"/>
              <a:gd name="connsiteX4" fmla="*/ 598011 w 3452469"/>
              <a:gd name="connsiteY4" fmla="*/ 542381 h 956155"/>
              <a:gd name="connsiteX5" fmla="*/ 232946 w 3452469"/>
              <a:gd name="connsiteY5" fmla="*/ 956121 h 956155"/>
              <a:gd name="connsiteX6" fmla="*/ 0 w 3452469"/>
              <a:gd name="connsiteY6" fmla="*/ 563242 h 956155"/>
              <a:gd name="connsiteX0" fmla="*/ 3452469 w 3452469"/>
              <a:gd name="connsiteY0" fmla="*/ 511090 h 966584"/>
              <a:gd name="connsiteX1" fmla="*/ 2816213 w 3452469"/>
              <a:gd name="connsiteY1" fmla="*/ 507613 h 966584"/>
              <a:gd name="connsiteX2" fmla="*/ 1940058 w 3452469"/>
              <a:gd name="connsiteY2" fmla="*/ 0 h 966584"/>
              <a:gd name="connsiteX3" fmla="*/ 1157777 w 3452469"/>
              <a:gd name="connsiteY3" fmla="*/ 671024 h 966584"/>
              <a:gd name="connsiteX4" fmla="*/ 598011 w 3452469"/>
              <a:gd name="connsiteY4" fmla="*/ 542381 h 966584"/>
              <a:gd name="connsiteX5" fmla="*/ 232946 w 3452469"/>
              <a:gd name="connsiteY5" fmla="*/ 966552 h 966584"/>
              <a:gd name="connsiteX6" fmla="*/ 0 w 3452469"/>
              <a:gd name="connsiteY6" fmla="*/ 563242 h 966584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74501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70"/>
              <a:gd name="connsiteX1" fmla="*/ 2816213 w 3452469"/>
              <a:gd name="connsiteY1" fmla="*/ 500659 h 959670"/>
              <a:gd name="connsiteX2" fmla="*/ 1940058 w 3452469"/>
              <a:gd name="connsiteY2" fmla="*/ 0 h 959670"/>
              <a:gd name="connsiteX3" fmla="*/ 1157777 w 3452469"/>
              <a:gd name="connsiteY3" fmla="*/ 674501 h 959670"/>
              <a:gd name="connsiteX4" fmla="*/ 598011 w 3452469"/>
              <a:gd name="connsiteY4" fmla="*/ 524997 h 959670"/>
              <a:gd name="connsiteX5" fmla="*/ 232946 w 3452469"/>
              <a:gd name="connsiteY5" fmla="*/ 959598 h 959670"/>
              <a:gd name="connsiteX6" fmla="*/ 0 w 3452469"/>
              <a:gd name="connsiteY6" fmla="*/ 556288 h 959670"/>
              <a:gd name="connsiteX0" fmla="*/ 3452469 w 3452469"/>
              <a:gd name="connsiteY0" fmla="*/ 504136 h 942291"/>
              <a:gd name="connsiteX1" fmla="*/ 2816213 w 3452469"/>
              <a:gd name="connsiteY1" fmla="*/ 500659 h 942291"/>
              <a:gd name="connsiteX2" fmla="*/ 1940058 w 3452469"/>
              <a:gd name="connsiteY2" fmla="*/ 0 h 942291"/>
              <a:gd name="connsiteX3" fmla="*/ 1157777 w 3452469"/>
              <a:gd name="connsiteY3" fmla="*/ 674501 h 942291"/>
              <a:gd name="connsiteX4" fmla="*/ 598011 w 3452469"/>
              <a:gd name="connsiteY4" fmla="*/ 524997 h 942291"/>
              <a:gd name="connsiteX5" fmla="*/ 232946 w 3452469"/>
              <a:gd name="connsiteY5" fmla="*/ 942214 h 942291"/>
              <a:gd name="connsiteX6" fmla="*/ 0 w 3452469"/>
              <a:gd name="connsiteY6" fmla="*/ 556288 h 942291"/>
              <a:gd name="connsiteX0" fmla="*/ 3452469 w 3452469"/>
              <a:gd name="connsiteY0" fmla="*/ 504136 h 935340"/>
              <a:gd name="connsiteX1" fmla="*/ 2816213 w 3452469"/>
              <a:gd name="connsiteY1" fmla="*/ 500659 h 935340"/>
              <a:gd name="connsiteX2" fmla="*/ 1940058 w 3452469"/>
              <a:gd name="connsiteY2" fmla="*/ 0 h 935340"/>
              <a:gd name="connsiteX3" fmla="*/ 1157777 w 3452469"/>
              <a:gd name="connsiteY3" fmla="*/ 674501 h 935340"/>
              <a:gd name="connsiteX4" fmla="*/ 598011 w 3452469"/>
              <a:gd name="connsiteY4" fmla="*/ 524997 h 935340"/>
              <a:gd name="connsiteX5" fmla="*/ 232946 w 3452469"/>
              <a:gd name="connsiteY5" fmla="*/ 935261 h 935340"/>
              <a:gd name="connsiteX6" fmla="*/ 0 w 3452469"/>
              <a:gd name="connsiteY6" fmla="*/ 556288 h 93534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2469" h="935340">
                <a:moveTo>
                  <a:pt x="3452469" y="504136"/>
                </a:moveTo>
                <a:cubicBezTo>
                  <a:pt x="3252552" y="507902"/>
                  <a:pt x="3071759" y="515146"/>
                  <a:pt x="2816213" y="500659"/>
                </a:cubicBezTo>
                <a:cubicBezTo>
                  <a:pt x="2560667" y="486172"/>
                  <a:pt x="2199080" y="24338"/>
                  <a:pt x="1940058" y="0"/>
                </a:cubicBezTo>
                <a:cubicBezTo>
                  <a:pt x="1687990" y="24337"/>
                  <a:pt x="1381451" y="587002"/>
                  <a:pt x="1157777" y="674501"/>
                </a:cubicBezTo>
                <a:cubicBezTo>
                  <a:pt x="934103" y="762000"/>
                  <a:pt x="752150" y="481537"/>
                  <a:pt x="598011" y="524997"/>
                </a:cubicBezTo>
                <a:cubicBezTo>
                  <a:pt x="443873" y="568457"/>
                  <a:pt x="332614" y="930046"/>
                  <a:pt x="232946" y="935261"/>
                </a:cubicBezTo>
                <a:cubicBezTo>
                  <a:pt x="133278" y="940476"/>
                  <a:pt x="84312" y="688696"/>
                  <a:pt x="0" y="556288"/>
                </a:cubicBezTo>
              </a:path>
            </a:pathLst>
          </a:custGeom>
          <a:noFill/>
          <a:ln w="127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5" name="フリーフォーム 544"/>
          <p:cNvSpPr/>
          <p:nvPr/>
        </p:nvSpPr>
        <p:spPr>
          <a:xfrm>
            <a:off x="982031" y="4698337"/>
            <a:ext cx="3452469" cy="914525"/>
          </a:xfrm>
          <a:custGeom>
            <a:avLst/>
            <a:gdLst>
              <a:gd name="connsiteX0" fmla="*/ 3452469 w 3452469"/>
              <a:gd name="connsiteY0" fmla="*/ 485132 h 791733"/>
              <a:gd name="connsiteX1" fmla="*/ 2816213 w 3452469"/>
              <a:gd name="connsiteY1" fmla="*/ 481655 h 791733"/>
              <a:gd name="connsiteX2" fmla="*/ 1992210 w 3452469"/>
              <a:gd name="connsiteY2" fmla="*/ 1856 h 791733"/>
              <a:gd name="connsiteX3" fmla="*/ 1157777 w 3452469"/>
              <a:gd name="connsiteY3" fmla="*/ 683310 h 791733"/>
              <a:gd name="connsiteX4" fmla="*/ 594534 w 3452469"/>
              <a:gd name="connsiteY4" fmla="*/ 471225 h 791733"/>
              <a:gd name="connsiteX5" fmla="*/ 267714 w 3452469"/>
              <a:gd name="connsiteY5" fmla="*/ 791091 h 791733"/>
              <a:gd name="connsiteX6" fmla="*/ 0 w 3452469"/>
              <a:gd name="connsiteY6" fmla="*/ 537284 h 791733"/>
              <a:gd name="connsiteX0" fmla="*/ 3452469 w 3452469"/>
              <a:gd name="connsiteY0" fmla="*/ 484859 h 791460"/>
              <a:gd name="connsiteX1" fmla="*/ 2816213 w 3452469"/>
              <a:gd name="connsiteY1" fmla="*/ 481382 h 791460"/>
              <a:gd name="connsiteX2" fmla="*/ 1992210 w 3452469"/>
              <a:gd name="connsiteY2" fmla="*/ 1583 h 791460"/>
              <a:gd name="connsiteX3" fmla="*/ 1157777 w 3452469"/>
              <a:gd name="connsiteY3" fmla="*/ 683037 h 791460"/>
              <a:gd name="connsiteX4" fmla="*/ 594534 w 3452469"/>
              <a:gd name="connsiteY4" fmla="*/ 470952 h 791460"/>
              <a:gd name="connsiteX5" fmla="*/ 267714 w 3452469"/>
              <a:gd name="connsiteY5" fmla="*/ 790818 h 791460"/>
              <a:gd name="connsiteX6" fmla="*/ 0 w 3452469"/>
              <a:gd name="connsiteY6" fmla="*/ 537011 h 791460"/>
              <a:gd name="connsiteX0" fmla="*/ 3452469 w 3452469"/>
              <a:gd name="connsiteY0" fmla="*/ 488597 h 795198"/>
              <a:gd name="connsiteX1" fmla="*/ 2816213 w 3452469"/>
              <a:gd name="connsiteY1" fmla="*/ 485120 h 795198"/>
              <a:gd name="connsiteX2" fmla="*/ 1940058 w 3452469"/>
              <a:gd name="connsiteY2" fmla="*/ 1844 h 795198"/>
              <a:gd name="connsiteX3" fmla="*/ 1157777 w 3452469"/>
              <a:gd name="connsiteY3" fmla="*/ 686775 h 795198"/>
              <a:gd name="connsiteX4" fmla="*/ 594534 w 3452469"/>
              <a:gd name="connsiteY4" fmla="*/ 474690 h 795198"/>
              <a:gd name="connsiteX5" fmla="*/ 267714 w 3452469"/>
              <a:gd name="connsiteY5" fmla="*/ 794556 h 795198"/>
              <a:gd name="connsiteX6" fmla="*/ 0 w 3452469"/>
              <a:gd name="connsiteY6" fmla="*/ 540749 h 795198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32946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6753 h 793354"/>
              <a:gd name="connsiteX1" fmla="*/ 2816213 w 3452469"/>
              <a:gd name="connsiteY1" fmla="*/ 483276 h 793354"/>
              <a:gd name="connsiteX2" fmla="*/ 1940058 w 3452469"/>
              <a:gd name="connsiteY2" fmla="*/ 0 h 793354"/>
              <a:gd name="connsiteX3" fmla="*/ 1157777 w 3452469"/>
              <a:gd name="connsiteY3" fmla="*/ 671024 h 793354"/>
              <a:gd name="connsiteX4" fmla="*/ 594534 w 3452469"/>
              <a:gd name="connsiteY4" fmla="*/ 472846 h 793354"/>
              <a:gd name="connsiteX5" fmla="*/ 232946 w 3452469"/>
              <a:gd name="connsiteY5" fmla="*/ 792712 h 793354"/>
              <a:gd name="connsiteX6" fmla="*/ 0 w 3452469"/>
              <a:gd name="connsiteY6" fmla="*/ 538905 h 793354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71024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119"/>
              <a:gd name="connsiteX1" fmla="*/ 2816213 w 3452469"/>
              <a:gd name="connsiteY1" fmla="*/ 507613 h 817119"/>
              <a:gd name="connsiteX2" fmla="*/ 1940058 w 3452469"/>
              <a:gd name="connsiteY2" fmla="*/ 0 h 817119"/>
              <a:gd name="connsiteX3" fmla="*/ 1157777 w 3452469"/>
              <a:gd name="connsiteY3" fmla="*/ 671024 h 817119"/>
              <a:gd name="connsiteX4" fmla="*/ 598011 w 3452469"/>
              <a:gd name="connsiteY4" fmla="*/ 542381 h 817119"/>
              <a:gd name="connsiteX5" fmla="*/ 232946 w 3452469"/>
              <a:gd name="connsiteY5" fmla="*/ 817049 h 817119"/>
              <a:gd name="connsiteX6" fmla="*/ 0 w 3452469"/>
              <a:gd name="connsiteY6" fmla="*/ 563242 h 817119"/>
              <a:gd name="connsiteX0" fmla="*/ 3452469 w 3452469"/>
              <a:gd name="connsiteY0" fmla="*/ 511090 h 956155"/>
              <a:gd name="connsiteX1" fmla="*/ 2816213 w 3452469"/>
              <a:gd name="connsiteY1" fmla="*/ 507613 h 956155"/>
              <a:gd name="connsiteX2" fmla="*/ 1940058 w 3452469"/>
              <a:gd name="connsiteY2" fmla="*/ 0 h 956155"/>
              <a:gd name="connsiteX3" fmla="*/ 1157777 w 3452469"/>
              <a:gd name="connsiteY3" fmla="*/ 671024 h 956155"/>
              <a:gd name="connsiteX4" fmla="*/ 598011 w 3452469"/>
              <a:gd name="connsiteY4" fmla="*/ 542381 h 956155"/>
              <a:gd name="connsiteX5" fmla="*/ 232946 w 3452469"/>
              <a:gd name="connsiteY5" fmla="*/ 956121 h 956155"/>
              <a:gd name="connsiteX6" fmla="*/ 0 w 3452469"/>
              <a:gd name="connsiteY6" fmla="*/ 563242 h 956155"/>
              <a:gd name="connsiteX0" fmla="*/ 3452469 w 3452469"/>
              <a:gd name="connsiteY0" fmla="*/ 511090 h 966584"/>
              <a:gd name="connsiteX1" fmla="*/ 2816213 w 3452469"/>
              <a:gd name="connsiteY1" fmla="*/ 507613 h 966584"/>
              <a:gd name="connsiteX2" fmla="*/ 1940058 w 3452469"/>
              <a:gd name="connsiteY2" fmla="*/ 0 h 966584"/>
              <a:gd name="connsiteX3" fmla="*/ 1157777 w 3452469"/>
              <a:gd name="connsiteY3" fmla="*/ 671024 h 966584"/>
              <a:gd name="connsiteX4" fmla="*/ 598011 w 3452469"/>
              <a:gd name="connsiteY4" fmla="*/ 542381 h 966584"/>
              <a:gd name="connsiteX5" fmla="*/ 232946 w 3452469"/>
              <a:gd name="connsiteY5" fmla="*/ 966552 h 966584"/>
              <a:gd name="connsiteX6" fmla="*/ 0 w 3452469"/>
              <a:gd name="connsiteY6" fmla="*/ 563242 h 966584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74501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70"/>
              <a:gd name="connsiteX1" fmla="*/ 2816213 w 3452469"/>
              <a:gd name="connsiteY1" fmla="*/ 500659 h 959670"/>
              <a:gd name="connsiteX2" fmla="*/ 1940058 w 3452469"/>
              <a:gd name="connsiteY2" fmla="*/ 0 h 959670"/>
              <a:gd name="connsiteX3" fmla="*/ 1157777 w 3452469"/>
              <a:gd name="connsiteY3" fmla="*/ 674501 h 959670"/>
              <a:gd name="connsiteX4" fmla="*/ 598011 w 3452469"/>
              <a:gd name="connsiteY4" fmla="*/ 524997 h 959670"/>
              <a:gd name="connsiteX5" fmla="*/ 232946 w 3452469"/>
              <a:gd name="connsiteY5" fmla="*/ 959598 h 959670"/>
              <a:gd name="connsiteX6" fmla="*/ 0 w 3452469"/>
              <a:gd name="connsiteY6" fmla="*/ 556288 h 959670"/>
              <a:gd name="connsiteX0" fmla="*/ 3452469 w 3452469"/>
              <a:gd name="connsiteY0" fmla="*/ 504136 h 942291"/>
              <a:gd name="connsiteX1" fmla="*/ 2816213 w 3452469"/>
              <a:gd name="connsiteY1" fmla="*/ 500659 h 942291"/>
              <a:gd name="connsiteX2" fmla="*/ 1940058 w 3452469"/>
              <a:gd name="connsiteY2" fmla="*/ 0 h 942291"/>
              <a:gd name="connsiteX3" fmla="*/ 1157777 w 3452469"/>
              <a:gd name="connsiteY3" fmla="*/ 674501 h 942291"/>
              <a:gd name="connsiteX4" fmla="*/ 598011 w 3452469"/>
              <a:gd name="connsiteY4" fmla="*/ 524997 h 942291"/>
              <a:gd name="connsiteX5" fmla="*/ 232946 w 3452469"/>
              <a:gd name="connsiteY5" fmla="*/ 942214 h 942291"/>
              <a:gd name="connsiteX6" fmla="*/ 0 w 3452469"/>
              <a:gd name="connsiteY6" fmla="*/ 556288 h 942291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57777 w 3452469"/>
              <a:gd name="connsiteY3" fmla="*/ 671024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57777 w 3452469"/>
              <a:gd name="connsiteY3" fmla="*/ 671024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64731 w 3452469"/>
              <a:gd name="connsiteY3" fmla="*/ 674501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52"/>
              <a:gd name="connsiteX1" fmla="*/ 2816213 w 3452469"/>
              <a:gd name="connsiteY1" fmla="*/ 497182 h 938852"/>
              <a:gd name="connsiteX2" fmla="*/ 1943535 w 3452469"/>
              <a:gd name="connsiteY2" fmla="*/ 0 h 938852"/>
              <a:gd name="connsiteX3" fmla="*/ 1164731 w 3452469"/>
              <a:gd name="connsiteY3" fmla="*/ 674501 h 938852"/>
              <a:gd name="connsiteX4" fmla="*/ 594534 w 3452469"/>
              <a:gd name="connsiteY4" fmla="*/ 514566 h 938852"/>
              <a:gd name="connsiteX5" fmla="*/ 232946 w 3452469"/>
              <a:gd name="connsiteY5" fmla="*/ 938737 h 938852"/>
              <a:gd name="connsiteX6" fmla="*/ 0 w 3452469"/>
              <a:gd name="connsiteY6" fmla="*/ 552811 h 938852"/>
              <a:gd name="connsiteX0" fmla="*/ 3452469 w 3452469"/>
              <a:gd name="connsiteY0" fmla="*/ 500659 h 914525"/>
              <a:gd name="connsiteX1" fmla="*/ 2816213 w 3452469"/>
              <a:gd name="connsiteY1" fmla="*/ 497182 h 914525"/>
              <a:gd name="connsiteX2" fmla="*/ 1943535 w 3452469"/>
              <a:gd name="connsiteY2" fmla="*/ 0 h 914525"/>
              <a:gd name="connsiteX3" fmla="*/ 1164731 w 3452469"/>
              <a:gd name="connsiteY3" fmla="*/ 674501 h 914525"/>
              <a:gd name="connsiteX4" fmla="*/ 594534 w 3452469"/>
              <a:gd name="connsiteY4" fmla="*/ 514566 h 914525"/>
              <a:gd name="connsiteX5" fmla="*/ 236422 w 3452469"/>
              <a:gd name="connsiteY5" fmla="*/ 914399 h 914525"/>
              <a:gd name="connsiteX6" fmla="*/ 0 w 3452469"/>
              <a:gd name="connsiteY6" fmla="*/ 552811 h 914525"/>
              <a:gd name="connsiteX0" fmla="*/ 3452469 w 3452469"/>
              <a:gd name="connsiteY0" fmla="*/ 500659 h 914525"/>
              <a:gd name="connsiteX1" fmla="*/ 2816213 w 3452469"/>
              <a:gd name="connsiteY1" fmla="*/ 497182 h 914525"/>
              <a:gd name="connsiteX2" fmla="*/ 1943535 w 3452469"/>
              <a:gd name="connsiteY2" fmla="*/ 0 h 914525"/>
              <a:gd name="connsiteX3" fmla="*/ 1164731 w 3452469"/>
              <a:gd name="connsiteY3" fmla="*/ 674501 h 914525"/>
              <a:gd name="connsiteX4" fmla="*/ 594534 w 3452469"/>
              <a:gd name="connsiteY4" fmla="*/ 514566 h 914525"/>
              <a:gd name="connsiteX5" fmla="*/ 229468 w 3452469"/>
              <a:gd name="connsiteY5" fmla="*/ 914399 h 914525"/>
              <a:gd name="connsiteX6" fmla="*/ 0 w 3452469"/>
              <a:gd name="connsiteY6" fmla="*/ 552811 h 9145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2469" h="914525">
                <a:moveTo>
                  <a:pt x="3452469" y="500659"/>
                </a:moveTo>
                <a:cubicBezTo>
                  <a:pt x="3252552" y="504425"/>
                  <a:pt x="3078132" y="511089"/>
                  <a:pt x="2816213" y="497182"/>
                </a:cubicBezTo>
                <a:cubicBezTo>
                  <a:pt x="2554294" y="483275"/>
                  <a:pt x="2202557" y="24338"/>
                  <a:pt x="1943535" y="0"/>
                </a:cubicBezTo>
                <a:cubicBezTo>
                  <a:pt x="1691467" y="24337"/>
                  <a:pt x="1389564" y="588740"/>
                  <a:pt x="1164731" y="674501"/>
                </a:cubicBezTo>
                <a:cubicBezTo>
                  <a:pt x="939898" y="760262"/>
                  <a:pt x="750411" y="474583"/>
                  <a:pt x="594534" y="514566"/>
                </a:cubicBezTo>
                <a:cubicBezTo>
                  <a:pt x="438657" y="554549"/>
                  <a:pt x="328557" y="908025"/>
                  <a:pt x="229468" y="914399"/>
                </a:cubicBezTo>
                <a:cubicBezTo>
                  <a:pt x="130379" y="920773"/>
                  <a:pt x="84312" y="685219"/>
                  <a:pt x="0" y="552811"/>
                </a:cubicBezTo>
              </a:path>
            </a:pathLst>
          </a:custGeom>
          <a:noFill/>
          <a:ln w="12700">
            <a:solidFill>
              <a:srgbClr val="00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7" name="フリーフォーム 546"/>
          <p:cNvSpPr/>
          <p:nvPr/>
        </p:nvSpPr>
        <p:spPr>
          <a:xfrm>
            <a:off x="978554" y="4700805"/>
            <a:ext cx="3452469" cy="883277"/>
          </a:xfrm>
          <a:custGeom>
            <a:avLst/>
            <a:gdLst>
              <a:gd name="connsiteX0" fmla="*/ 3452469 w 3452469"/>
              <a:gd name="connsiteY0" fmla="*/ 485132 h 791733"/>
              <a:gd name="connsiteX1" fmla="*/ 2816213 w 3452469"/>
              <a:gd name="connsiteY1" fmla="*/ 481655 h 791733"/>
              <a:gd name="connsiteX2" fmla="*/ 1992210 w 3452469"/>
              <a:gd name="connsiteY2" fmla="*/ 1856 h 791733"/>
              <a:gd name="connsiteX3" fmla="*/ 1157777 w 3452469"/>
              <a:gd name="connsiteY3" fmla="*/ 683310 h 791733"/>
              <a:gd name="connsiteX4" fmla="*/ 594534 w 3452469"/>
              <a:gd name="connsiteY4" fmla="*/ 471225 h 791733"/>
              <a:gd name="connsiteX5" fmla="*/ 267714 w 3452469"/>
              <a:gd name="connsiteY5" fmla="*/ 791091 h 791733"/>
              <a:gd name="connsiteX6" fmla="*/ 0 w 3452469"/>
              <a:gd name="connsiteY6" fmla="*/ 537284 h 791733"/>
              <a:gd name="connsiteX0" fmla="*/ 3452469 w 3452469"/>
              <a:gd name="connsiteY0" fmla="*/ 484859 h 791460"/>
              <a:gd name="connsiteX1" fmla="*/ 2816213 w 3452469"/>
              <a:gd name="connsiteY1" fmla="*/ 481382 h 791460"/>
              <a:gd name="connsiteX2" fmla="*/ 1992210 w 3452469"/>
              <a:gd name="connsiteY2" fmla="*/ 1583 h 791460"/>
              <a:gd name="connsiteX3" fmla="*/ 1157777 w 3452469"/>
              <a:gd name="connsiteY3" fmla="*/ 683037 h 791460"/>
              <a:gd name="connsiteX4" fmla="*/ 594534 w 3452469"/>
              <a:gd name="connsiteY4" fmla="*/ 470952 h 791460"/>
              <a:gd name="connsiteX5" fmla="*/ 267714 w 3452469"/>
              <a:gd name="connsiteY5" fmla="*/ 790818 h 791460"/>
              <a:gd name="connsiteX6" fmla="*/ 0 w 3452469"/>
              <a:gd name="connsiteY6" fmla="*/ 537011 h 791460"/>
              <a:gd name="connsiteX0" fmla="*/ 3452469 w 3452469"/>
              <a:gd name="connsiteY0" fmla="*/ 488597 h 795198"/>
              <a:gd name="connsiteX1" fmla="*/ 2816213 w 3452469"/>
              <a:gd name="connsiteY1" fmla="*/ 485120 h 795198"/>
              <a:gd name="connsiteX2" fmla="*/ 1940058 w 3452469"/>
              <a:gd name="connsiteY2" fmla="*/ 1844 h 795198"/>
              <a:gd name="connsiteX3" fmla="*/ 1157777 w 3452469"/>
              <a:gd name="connsiteY3" fmla="*/ 686775 h 795198"/>
              <a:gd name="connsiteX4" fmla="*/ 594534 w 3452469"/>
              <a:gd name="connsiteY4" fmla="*/ 474690 h 795198"/>
              <a:gd name="connsiteX5" fmla="*/ 267714 w 3452469"/>
              <a:gd name="connsiteY5" fmla="*/ 794556 h 795198"/>
              <a:gd name="connsiteX6" fmla="*/ 0 w 3452469"/>
              <a:gd name="connsiteY6" fmla="*/ 540749 h 795198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32946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6753 h 793354"/>
              <a:gd name="connsiteX1" fmla="*/ 2816213 w 3452469"/>
              <a:gd name="connsiteY1" fmla="*/ 483276 h 793354"/>
              <a:gd name="connsiteX2" fmla="*/ 1940058 w 3452469"/>
              <a:gd name="connsiteY2" fmla="*/ 0 h 793354"/>
              <a:gd name="connsiteX3" fmla="*/ 1157777 w 3452469"/>
              <a:gd name="connsiteY3" fmla="*/ 671024 h 793354"/>
              <a:gd name="connsiteX4" fmla="*/ 594534 w 3452469"/>
              <a:gd name="connsiteY4" fmla="*/ 472846 h 793354"/>
              <a:gd name="connsiteX5" fmla="*/ 232946 w 3452469"/>
              <a:gd name="connsiteY5" fmla="*/ 792712 h 793354"/>
              <a:gd name="connsiteX6" fmla="*/ 0 w 3452469"/>
              <a:gd name="connsiteY6" fmla="*/ 538905 h 793354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71024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119"/>
              <a:gd name="connsiteX1" fmla="*/ 2816213 w 3452469"/>
              <a:gd name="connsiteY1" fmla="*/ 507613 h 817119"/>
              <a:gd name="connsiteX2" fmla="*/ 1940058 w 3452469"/>
              <a:gd name="connsiteY2" fmla="*/ 0 h 817119"/>
              <a:gd name="connsiteX3" fmla="*/ 1157777 w 3452469"/>
              <a:gd name="connsiteY3" fmla="*/ 671024 h 817119"/>
              <a:gd name="connsiteX4" fmla="*/ 598011 w 3452469"/>
              <a:gd name="connsiteY4" fmla="*/ 542381 h 817119"/>
              <a:gd name="connsiteX5" fmla="*/ 232946 w 3452469"/>
              <a:gd name="connsiteY5" fmla="*/ 817049 h 817119"/>
              <a:gd name="connsiteX6" fmla="*/ 0 w 3452469"/>
              <a:gd name="connsiteY6" fmla="*/ 563242 h 817119"/>
              <a:gd name="connsiteX0" fmla="*/ 3452469 w 3452469"/>
              <a:gd name="connsiteY0" fmla="*/ 511090 h 956155"/>
              <a:gd name="connsiteX1" fmla="*/ 2816213 w 3452469"/>
              <a:gd name="connsiteY1" fmla="*/ 507613 h 956155"/>
              <a:gd name="connsiteX2" fmla="*/ 1940058 w 3452469"/>
              <a:gd name="connsiteY2" fmla="*/ 0 h 956155"/>
              <a:gd name="connsiteX3" fmla="*/ 1157777 w 3452469"/>
              <a:gd name="connsiteY3" fmla="*/ 671024 h 956155"/>
              <a:gd name="connsiteX4" fmla="*/ 598011 w 3452469"/>
              <a:gd name="connsiteY4" fmla="*/ 542381 h 956155"/>
              <a:gd name="connsiteX5" fmla="*/ 232946 w 3452469"/>
              <a:gd name="connsiteY5" fmla="*/ 956121 h 956155"/>
              <a:gd name="connsiteX6" fmla="*/ 0 w 3452469"/>
              <a:gd name="connsiteY6" fmla="*/ 563242 h 956155"/>
              <a:gd name="connsiteX0" fmla="*/ 3452469 w 3452469"/>
              <a:gd name="connsiteY0" fmla="*/ 511090 h 966584"/>
              <a:gd name="connsiteX1" fmla="*/ 2816213 w 3452469"/>
              <a:gd name="connsiteY1" fmla="*/ 507613 h 966584"/>
              <a:gd name="connsiteX2" fmla="*/ 1940058 w 3452469"/>
              <a:gd name="connsiteY2" fmla="*/ 0 h 966584"/>
              <a:gd name="connsiteX3" fmla="*/ 1157777 w 3452469"/>
              <a:gd name="connsiteY3" fmla="*/ 671024 h 966584"/>
              <a:gd name="connsiteX4" fmla="*/ 598011 w 3452469"/>
              <a:gd name="connsiteY4" fmla="*/ 542381 h 966584"/>
              <a:gd name="connsiteX5" fmla="*/ 232946 w 3452469"/>
              <a:gd name="connsiteY5" fmla="*/ 966552 h 966584"/>
              <a:gd name="connsiteX6" fmla="*/ 0 w 3452469"/>
              <a:gd name="connsiteY6" fmla="*/ 563242 h 966584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74501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70"/>
              <a:gd name="connsiteX1" fmla="*/ 2816213 w 3452469"/>
              <a:gd name="connsiteY1" fmla="*/ 500659 h 959670"/>
              <a:gd name="connsiteX2" fmla="*/ 1940058 w 3452469"/>
              <a:gd name="connsiteY2" fmla="*/ 0 h 959670"/>
              <a:gd name="connsiteX3" fmla="*/ 1157777 w 3452469"/>
              <a:gd name="connsiteY3" fmla="*/ 674501 h 959670"/>
              <a:gd name="connsiteX4" fmla="*/ 598011 w 3452469"/>
              <a:gd name="connsiteY4" fmla="*/ 524997 h 959670"/>
              <a:gd name="connsiteX5" fmla="*/ 232946 w 3452469"/>
              <a:gd name="connsiteY5" fmla="*/ 959598 h 959670"/>
              <a:gd name="connsiteX6" fmla="*/ 0 w 3452469"/>
              <a:gd name="connsiteY6" fmla="*/ 556288 h 959670"/>
              <a:gd name="connsiteX0" fmla="*/ 3452469 w 3452469"/>
              <a:gd name="connsiteY0" fmla="*/ 504136 h 942291"/>
              <a:gd name="connsiteX1" fmla="*/ 2816213 w 3452469"/>
              <a:gd name="connsiteY1" fmla="*/ 500659 h 942291"/>
              <a:gd name="connsiteX2" fmla="*/ 1940058 w 3452469"/>
              <a:gd name="connsiteY2" fmla="*/ 0 h 942291"/>
              <a:gd name="connsiteX3" fmla="*/ 1157777 w 3452469"/>
              <a:gd name="connsiteY3" fmla="*/ 674501 h 942291"/>
              <a:gd name="connsiteX4" fmla="*/ 598011 w 3452469"/>
              <a:gd name="connsiteY4" fmla="*/ 524997 h 942291"/>
              <a:gd name="connsiteX5" fmla="*/ 232946 w 3452469"/>
              <a:gd name="connsiteY5" fmla="*/ 942214 h 942291"/>
              <a:gd name="connsiteX6" fmla="*/ 0 w 3452469"/>
              <a:gd name="connsiteY6" fmla="*/ 556288 h 942291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57777 w 3452469"/>
              <a:gd name="connsiteY3" fmla="*/ 671024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57777 w 3452469"/>
              <a:gd name="connsiteY3" fmla="*/ 671024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64731 w 3452469"/>
              <a:gd name="connsiteY3" fmla="*/ 674501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52"/>
              <a:gd name="connsiteX1" fmla="*/ 2816213 w 3452469"/>
              <a:gd name="connsiteY1" fmla="*/ 497182 h 938852"/>
              <a:gd name="connsiteX2" fmla="*/ 1943535 w 3452469"/>
              <a:gd name="connsiteY2" fmla="*/ 0 h 938852"/>
              <a:gd name="connsiteX3" fmla="*/ 1164731 w 3452469"/>
              <a:gd name="connsiteY3" fmla="*/ 674501 h 938852"/>
              <a:gd name="connsiteX4" fmla="*/ 594534 w 3452469"/>
              <a:gd name="connsiteY4" fmla="*/ 514566 h 938852"/>
              <a:gd name="connsiteX5" fmla="*/ 232946 w 3452469"/>
              <a:gd name="connsiteY5" fmla="*/ 938737 h 938852"/>
              <a:gd name="connsiteX6" fmla="*/ 0 w 3452469"/>
              <a:gd name="connsiteY6" fmla="*/ 552811 h 938852"/>
              <a:gd name="connsiteX0" fmla="*/ 3452469 w 3452469"/>
              <a:gd name="connsiteY0" fmla="*/ 500659 h 914525"/>
              <a:gd name="connsiteX1" fmla="*/ 2816213 w 3452469"/>
              <a:gd name="connsiteY1" fmla="*/ 497182 h 914525"/>
              <a:gd name="connsiteX2" fmla="*/ 1943535 w 3452469"/>
              <a:gd name="connsiteY2" fmla="*/ 0 h 914525"/>
              <a:gd name="connsiteX3" fmla="*/ 1164731 w 3452469"/>
              <a:gd name="connsiteY3" fmla="*/ 674501 h 914525"/>
              <a:gd name="connsiteX4" fmla="*/ 594534 w 3452469"/>
              <a:gd name="connsiteY4" fmla="*/ 514566 h 914525"/>
              <a:gd name="connsiteX5" fmla="*/ 236422 w 3452469"/>
              <a:gd name="connsiteY5" fmla="*/ 914399 h 914525"/>
              <a:gd name="connsiteX6" fmla="*/ 0 w 3452469"/>
              <a:gd name="connsiteY6" fmla="*/ 552811 h 914525"/>
              <a:gd name="connsiteX0" fmla="*/ 3452469 w 3452469"/>
              <a:gd name="connsiteY0" fmla="*/ 500659 h 914525"/>
              <a:gd name="connsiteX1" fmla="*/ 2816213 w 3452469"/>
              <a:gd name="connsiteY1" fmla="*/ 497182 h 914525"/>
              <a:gd name="connsiteX2" fmla="*/ 1943535 w 3452469"/>
              <a:gd name="connsiteY2" fmla="*/ 0 h 914525"/>
              <a:gd name="connsiteX3" fmla="*/ 1164731 w 3452469"/>
              <a:gd name="connsiteY3" fmla="*/ 674501 h 914525"/>
              <a:gd name="connsiteX4" fmla="*/ 594534 w 3452469"/>
              <a:gd name="connsiteY4" fmla="*/ 514566 h 914525"/>
              <a:gd name="connsiteX5" fmla="*/ 229468 w 3452469"/>
              <a:gd name="connsiteY5" fmla="*/ 914399 h 914525"/>
              <a:gd name="connsiteX6" fmla="*/ 0 w 3452469"/>
              <a:gd name="connsiteY6" fmla="*/ 552811 h 914525"/>
              <a:gd name="connsiteX0" fmla="*/ 3452469 w 3452469"/>
              <a:gd name="connsiteY0" fmla="*/ 500659 h 886728"/>
              <a:gd name="connsiteX1" fmla="*/ 2816213 w 3452469"/>
              <a:gd name="connsiteY1" fmla="*/ 497182 h 886728"/>
              <a:gd name="connsiteX2" fmla="*/ 1943535 w 3452469"/>
              <a:gd name="connsiteY2" fmla="*/ 0 h 886728"/>
              <a:gd name="connsiteX3" fmla="*/ 1164731 w 3452469"/>
              <a:gd name="connsiteY3" fmla="*/ 674501 h 886728"/>
              <a:gd name="connsiteX4" fmla="*/ 594534 w 3452469"/>
              <a:gd name="connsiteY4" fmla="*/ 514566 h 886728"/>
              <a:gd name="connsiteX5" fmla="*/ 232945 w 3452469"/>
              <a:gd name="connsiteY5" fmla="*/ 886585 h 886728"/>
              <a:gd name="connsiteX6" fmla="*/ 0 w 3452469"/>
              <a:gd name="connsiteY6" fmla="*/ 552811 h 886728"/>
              <a:gd name="connsiteX0" fmla="*/ 3452469 w 3452469"/>
              <a:gd name="connsiteY0" fmla="*/ 500659 h 886754"/>
              <a:gd name="connsiteX1" fmla="*/ 2816213 w 3452469"/>
              <a:gd name="connsiteY1" fmla="*/ 497182 h 886754"/>
              <a:gd name="connsiteX2" fmla="*/ 1943535 w 3452469"/>
              <a:gd name="connsiteY2" fmla="*/ 0 h 886754"/>
              <a:gd name="connsiteX3" fmla="*/ 1164731 w 3452469"/>
              <a:gd name="connsiteY3" fmla="*/ 674501 h 886754"/>
              <a:gd name="connsiteX4" fmla="*/ 594534 w 3452469"/>
              <a:gd name="connsiteY4" fmla="*/ 511090 h 886754"/>
              <a:gd name="connsiteX5" fmla="*/ 232945 w 3452469"/>
              <a:gd name="connsiteY5" fmla="*/ 886585 h 886754"/>
              <a:gd name="connsiteX6" fmla="*/ 0 w 3452469"/>
              <a:gd name="connsiteY6" fmla="*/ 552811 h 886754"/>
              <a:gd name="connsiteX0" fmla="*/ 3452469 w 3452469"/>
              <a:gd name="connsiteY0" fmla="*/ 497182 h 883277"/>
              <a:gd name="connsiteX1" fmla="*/ 2816213 w 3452469"/>
              <a:gd name="connsiteY1" fmla="*/ 493705 h 883277"/>
              <a:gd name="connsiteX2" fmla="*/ 1943535 w 3452469"/>
              <a:gd name="connsiteY2" fmla="*/ 0 h 883277"/>
              <a:gd name="connsiteX3" fmla="*/ 1164731 w 3452469"/>
              <a:gd name="connsiteY3" fmla="*/ 671024 h 883277"/>
              <a:gd name="connsiteX4" fmla="*/ 594534 w 3452469"/>
              <a:gd name="connsiteY4" fmla="*/ 507613 h 883277"/>
              <a:gd name="connsiteX5" fmla="*/ 232945 w 3452469"/>
              <a:gd name="connsiteY5" fmla="*/ 883108 h 883277"/>
              <a:gd name="connsiteX6" fmla="*/ 0 w 3452469"/>
              <a:gd name="connsiteY6" fmla="*/ 549334 h 883277"/>
              <a:gd name="connsiteX0" fmla="*/ 3452469 w 3452469"/>
              <a:gd name="connsiteY0" fmla="*/ 497182 h 883277"/>
              <a:gd name="connsiteX1" fmla="*/ 2816213 w 3452469"/>
              <a:gd name="connsiteY1" fmla="*/ 493705 h 883277"/>
              <a:gd name="connsiteX2" fmla="*/ 1943535 w 3452469"/>
              <a:gd name="connsiteY2" fmla="*/ 0 h 883277"/>
              <a:gd name="connsiteX3" fmla="*/ 1164731 w 3452469"/>
              <a:gd name="connsiteY3" fmla="*/ 671024 h 883277"/>
              <a:gd name="connsiteX4" fmla="*/ 594534 w 3452469"/>
              <a:gd name="connsiteY4" fmla="*/ 507613 h 883277"/>
              <a:gd name="connsiteX5" fmla="*/ 232945 w 3452469"/>
              <a:gd name="connsiteY5" fmla="*/ 883108 h 883277"/>
              <a:gd name="connsiteX6" fmla="*/ 0 w 3452469"/>
              <a:gd name="connsiteY6" fmla="*/ 549334 h 88327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2469" h="883277">
                <a:moveTo>
                  <a:pt x="3452469" y="497182"/>
                </a:moveTo>
                <a:cubicBezTo>
                  <a:pt x="3252552" y="500948"/>
                  <a:pt x="3098993" y="510510"/>
                  <a:pt x="2816213" y="493705"/>
                </a:cubicBezTo>
                <a:cubicBezTo>
                  <a:pt x="2533433" y="476900"/>
                  <a:pt x="2202557" y="24338"/>
                  <a:pt x="1943535" y="0"/>
                </a:cubicBezTo>
                <a:cubicBezTo>
                  <a:pt x="1691467" y="24337"/>
                  <a:pt x="1389565" y="586422"/>
                  <a:pt x="1164731" y="671024"/>
                </a:cubicBezTo>
                <a:cubicBezTo>
                  <a:pt x="939898" y="755626"/>
                  <a:pt x="749832" y="472266"/>
                  <a:pt x="594534" y="507613"/>
                </a:cubicBezTo>
                <a:cubicBezTo>
                  <a:pt x="439236" y="542960"/>
                  <a:pt x="332034" y="876154"/>
                  <a:pt x="232945" y="883108"/>
                </a:cubicBezTo>
                <a:cubicBezTo>
                  <a:pt x="133856" y="890062"/>
                  <a:pt x="84312" y="681742"/>
                  <a:pt x="0" y="549334"/>
                </a:cubicBezTo>
              </a:path>
            </a:pathLst>
          </a:custGeom>
          <a:noFill/>
          <a:ln w="127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8" name="フリーフォーム 547"/>
          <p:cNvSpPr/>
          <p:nvPr/>
        </p:nvSpPr>
        <p:spPr>
          <a:xfrm>
            <a:off x="975077" y="4703273"/>
            <a:ext cx="3452469" cy="841751"/>
          </a:xfrm>
          <a:custGeom>
            <a:avLst/>
            <a:gdLst>
              <a:gd name="connsiteX0" fmla="*/ 3452469 w 3452469"/>
              <a:gd name="connsiteY0" fmla="*/ 485132 h 791733"/>
              <a:gd name="connsiteX1" fmla="*/ 2816213 w 3452469"/>
              <a:gd name="connsiteY1" fmla="*/ 481655 h 791733"/>
              <a:gd name="connsiteX2" fmla="*/ 1992210 w 3452469"/>
              <a:gd name="connsiteY2" fmla="*/ 1856 h 791733"/>
              <a:gd name="connsiteX3" fmla="*/ 1157777 w 3452469"/>
              <a:gd name="connsiteY3" fmla="*/ 683310 h 791733"/>
              <a:gd name="connsiteX4" fmla="*/ 594534 w 3452469"/>
              <a:gd name="connsiteY4" fmla="*/ 471225 h 791733"/>
              <a:gd name="connsiteX5" fmla="*/ 267714 w 3452469"/>
              <a:gd name="connsiteY5" fmla="*/ 791091 h 791733"/>
              <a:gd name="connsiteX6" fmla="*/ 0 w 3452469"/>
              <a:gd name="connsiteY6" fmla="*/ 537284 h 791733"/>
              <a:gd name="connsiteX0" fmla="*/ 3452469 w 3452469"/>
              <a:gd name="connsiteY0" fmla="*/ 484859 h 791460"/>
              <a:gd name="connsiteX1" fmla="*/ 2816213 w 3452469"/>
              <a:gd name="connsiteY1" fmla="*/ 481382 h 791460"/>
              <a:gd name="connsiteX2" fmla="*/ 1992210 w 3452469"/>
              <a:gd name="connsiteY2" fmla="*/ 1583 h 791460"/>
              <a:gd name="connsiteX3" fmla="*/ 1157777 w 3452469"/>
              <a:gd name="connsiteY3" fmla="*/ 683037 h 791460"/>
              <a:gd name="connsiteX4" fmla="*/ 594534 w 3452469"/>
              <a:gd name="connsiteY4" fmla="*/ 470952 h 791460"/>
              <a:gd name="connsiteX5" fmla="*/ 267714 w 3452469"/>
              <a:gd name="connsiteY5" fmla="*/ 790818 h 791460"/>
              <a:gd name="connsiteX6" fmla="*/ 0 w 3452469"/>
              <a:gd name="connsiteY6" fmla="*/ 537011 h 791460"/>
              <a:gd name="connsiteX0" fmla="*/ 3452469 w 3452469"/>
              <a:gd name="connsiteY0" fmla="*/ 488597 h 795198"/>
              <a:gd name="connsiteX1" fmla="*/ 2816213 w 3452469"/>
              <a:gd name="connsiteY1" fmla="*/ 485120 h 795198"/>
              <a:gd name="connsiteX2" fmla="*/ 1940058 w 3452469"/>
              <a:gd name="connsiteY2" fmla="*/ 1844 h 795198"/>
              <a:gd name="connsiteX3" fmla="*/ 1157777 w 3452469"/>
              <a:gd name="connsiteY3" fmla="*/ 686775 h 795198"/>
              <a:gd name="connsiteX4" fmla="*/ 594534 w 3452469"/>
              <a:gd name="connsiteY4" fmla="*/ 474690 h 795198"/>
              <a:gd name="connsiteX5" fmla="*/ 267714 w 3452469"/>
              <a:gd name="connsiteY5" fmla="*/ 794556 h 795198"/>
              <a:gd name="connsiteX6" fmla="*/ 0 w 3452469"/>
              <a:gd name="connsiteY6" fmla="*/ 540749 h 795198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32946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6753 h 793354"/>
              <a:gd name="connsiteX1" fmla="*/ 2816213 w 3452469"/>
              <a:gd name="connsiteY1" fmla="*/ 483276 h 793354"/>
              <a:gd name="connsiteX2" fmla="*/ 1940058 w 3452469"/>
              <a:gd name="connsiteY2" fmla="*/ 0 h 793354"/>
              <a:gd name="connsiteX3" fmla="*/ 1157777 w 3452469"/>
              <a:gd name="connsiteY3" fmla="*/ 671024 h 793354"/>
              <a:gd name="connsiteX4" fmla="*/ 594534 w 3452469"/>
              <a:gd name="connsiteY4" fmla="*/ 472846 h 793354"/>
              <a:gd name="connsiteX5" fmla="*/ 232946 w 3452469"/>
              <a:gd name="connsiteY5" fmla="*/ 792712 h 793354"/>
              <a:gd name="connsiteX6" fmla="*/ 0 w 3452469"/>
              <a:gd name="connsiteY6" fmla="*/ 538905 h 793354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71024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119"/>
              <a:gd name="connsiteX1" fmla="*/ 2816213 w 3452469"/>
              <a:gd name="connsiteY1" fmla="*/ 507613 h 817119"/>
              <a:gd name="connsiteX2" fmla="*/ 1940058 w 3452469"/>
              <a:gd name="connsiteY2" fmla="*/ 0 h 817119"/>
              <a:gd name="connsiteX3" fmla="*/ 1157777 w 3452469"/>
              <a:gd name="connsiteY3" fmla="*/ 671024 h 817119"/>
              <a:gd name="connsiteX4" fmla="*/ 598011 w 3452469"/>
              <a:gd name="connsiteY4" fmla="*/ 542381 h 817119"/>
              <a:gd name="connsiteX5" fmla="*/ 232946 w 3452469"/>
              <a:gd name="connsiteY5" fmla="*/ 817049 h 817119"/>
              <a:gd name="connsiteX6" fmla="*/ 0 w 3452469"/>
              <a:gd name="connsiteY6" fmla="*/ 563242 h 817119"/>
              <a:gd name="connsiteX0" fmla="*/ 3452469 w 3452469"/>
              <a:gd name="connsiteY0" fmla="*/ 511090 h 956155"/>
              <a:gd name="connsiteX1" fmla="*/ 2816213 w 3452469"/>
              <a:gd name="connsiteY1" fmla="*/ 507613 h 956155"/>
              <a:gd name="connsiteX2" fmla="*/ 1940058 w 3452469"/>
              <a:gd name="connsiteY2" fmla="*/ 0 h 956155"/>
              <a:gd name="connsiteX3" fmla="*/ 1157777 w 3452469"/>
              <a:gd name="connsiteY3" fmla="*/ 671024 h 956155"/>
              <a:gd name="connsiteX4" fmla="*/ 598011 w 3452469"/>
              <a:gd name="connsiteY4" fmla="*/ 542381 h 956155"/>
              <a:gd name="connsiteX5" fmla="*/ 232946 w 3452469"/>
              <a:gd name="connsiteY5" fmla="*/ 956121 h 956155"/>
              <a:gd name="connsiteX6" fmla="*/ 0 w 3452469"/>
              <a:gd name="connsiteY6" fmla="*/ 563242 h 956155"/>
              <a:gd name="connsiteX0" fmla="*/ 3452469 w 3452469"/>
              <a:gd name="connsiteY0" fmla="*/ 511090 h 966584"/>
              <a:gd name="connsiteX1" fmla="*/ 2816213 w 3452469"/>
              <a:gd name="connsiteY1" fmla="*/ 507613 h 966584"/>
              <a:gd name="connsiteX2" fmla="*/ 1940058 w 3452469"/>
              <a:gd name="connsiteY2" fmla="*/ 0 h 966584"/>
              <a:gd name="connsiteX3" fmla="*/ 1157777 w 3452469"/>
              <a:gd name="connsiteY3" fmla="*/ 671024 h 966584"/>
              <a:gd name="connsiteX4" fmla="*/ 598011 w 3452469"/>
              <a:gd name="connsiteY4" fmla="*/ 542381 h 966584"/>
              <a:gd name="connsiteX5" fmla="*/ 232946 w 3452469"/>
              <a:gd name="connsiteY5" fmla="*/ 966552 h 966584"/>
              <a:gd name="connsiteX6" fmla="*/ 0 w 3452469"/>
              <a:gd name="connsiteY6" fmla="*/ 563242 h 966584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64070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30"/>
              <a:gd name="connsiteX1" fmla="*/ 2816213 w 3452469"/>
              <a:gd name="connsiteY1" fmla="*/ 500659 h 959630"/>
              <a:gd name="connsiteX2" fmla="*/ 1940058 w 3452469"/>
              <a:gd name="connsiteY2" fmla="*/ 0 h 959630"/>
              <a:gd name="connsiteX3" fmla="*/ 1157777 w 3452469"/>
              <a:gd name="connsiteY3" fmla="*/ 674501 h 959630"/>
              <a:gd name="connsiteX4" fmla="*/ 598011 w 3452469"/>
              <a:gd name="connsiteY4" fmla="*/ 535427 h 959630"/>
              <a:gd name="connsiteX5" fmla="*/ 232946 w 3452469"/>
              <a:gd name="connsiteY5" fmla="*/ 959598 h 959630"/>
              <a:gd name="connsiteX6" fmla="*/ 0 w 3452469"/>
              <a:gd name="connsiteY6" fmla="*/ 556288 h 959630"/>
              <a:gd name="connsiteX0" fmla="*/ 3452469 w 3452469"/>
              <a:gd name="connsiteY0" fmla="*/ 504136 h 959670"/>
              <a:gd name="connsiteX1" fmla="*/ 2816213 w 3452469"/>
              <a:gd name="connsiteY1" fmla="*/ 500659 h 959670"/>
              <a:gd name="connsiteX2" fmla="*/ 1940058 w 3452469"/>
              <a:gd name="connsiteY2" fmla="*/ 0 h 959670"/>
              <a:gd name="connsiteX3" fmla="*/ 1157777 w 3452469"/>
              <a:gd name="connsiteY3" fmla="*/ 674501 h 959670"/>
              <a:gd name="connsiteX4" fmla="*/ 598011 w 3452469"/>
              <a:gd name="connsiteY4" fmla="*/ 524997 h 959670"/>
              <a:gd name="connsiteX5" fmla="*/ 232946 w 3452469"/>
              <a:gd name="connsiteY5" fmla="*/ 959598 h 959670"/>
              <a:gd name="connsiteX6" fmla="*/ 0 w 3452469"/>
              <a:gd name="connsiteY6" fmla="*/ 556288 h 959670"/>
              <a:gd name="connsiteX0" fmla="*/ 3452469 w 3452469"/>
              <a:gd name="connsiteY0" fmla="*/ 504136 h 942291"/>
              <a:gd name="connsiteX1" fmla="*/ 2816213 w 3452469"/>
              <a:gd name="connsiteY1" fmla="*/ 500659 h 942291"/>
              <a:gd name="connsiteX2" fmla="*/ 1940058 w 3452469"/>
              <a:gd name="connsiteY2" fmla="*/ 0 h 942291"/>
              <a:gd name="connsiteX3" fmla="*/ 1157777 w 3452469"/>
              <a:gd name="connsiteY3" fmla="*/ 674501 h 942291"/>
              <a:gd name="connsiteX4" fmla="*/ 598011 w 3452469"/>
              <a:gd name="connsiteY4" fmla="*/ 524997 h 942291"/>
              <a:gd name="connsiteX5" fmla="*/ 232946 w 3452469"/>
              <a:gd name="connsiteY5" fmla="*/ 942214 h 942291"/>
              <a:gd name="connsiteX6" fmla="*/ 0 w 3452469"/>
              <a:gd name="connsiteY6" fmla="*/ 556288 h 942291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57777 w 3452469"/>
              <a:gd name="connsiteY3" fmla="*/ 671024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57777 w 3452469"/>
              <a:gd name="connsiteY3" fmla="*/ 671024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14"/>
              <a:gd name="connsiteX1" fmla="*/ 2816213 w 3452469"/>
              <a:gd name="connsiteY1" fmla="*/ 497182 h 938814"/>
              <a:gd name="connsiteX2" fmla="*/ 1943535 w 3452469"/>
              <a:gd name="connsiteY2" fmla="*/ 0 h 938814"/>
              <a:gd name="connsiteX3" fmla="*/ 1164731 w 3452469"/>
              <a:gd name="connsiteY3" fmla="*/ 674501 h 938814"/>
              <a:gd name="connsiteX4" fmla="*/ 598011 w 3452469"/>
              <a:gd name="connsiteY4" fmla="*/ 521520 h 938814"/>
              <a:gd name="connsiteX5" fmla="*/ 232946 w 3452469"/>
              <a:gd name="connsiteY5" fmla="*/ 938737 h 938814"/>
              <a:gd name="connsiteX6" fmla="*/ 0 w 3452469"/>
              <a:gd name="connsiteY6" fmla="*/ 552811 h 938814"/>
              <a:gd name="connsiteX0" fmla="*/ 3452469 w 3452469"/>
              <a:gd name="connsiteY0" fmla="*/ 500659 h 938852"/>
              <a:gd name="connsiteX1" fmla="*/ 2816213 w 3452469"/>
              <a:gd name="connsiteY1" fmla="*/ 497182 h 938852"/>
              <a:gd name="connsiteX2" fmla="*/ 1943535 w 3452469"/>
              <a:gd name="connsiteY2" fmla="*/ 0 h 938852"/>
              <a:gd name="connsiteX3" fmla="*/ 1164731 w 3452469"/>
              <a:gd name="connsiteY3" fmla="*/ 674501 h 938852"/>
              <a:gd name="connsiteX4" fmla="*/ 594534 w 3452469"/>
              <a:gd name="connsiteY4" fmla="*/ 514566 h 938852"/>
              <a:gd name="connsiteX5" fmla="*/ 232946 w 3452469"/>
              <a:gd name="connsiteY5" fmla="*/ 938737 h 938852"/>
              <a:gd name="connsiteX6" fmla="*/ 0 w 3452469"/>
              <a:gd name="connsiteY6" fmla="*/ 552811 h 938852"/>
              <a:gd name="connsiteX0" fmla="*/ 3452469 w 3452469"/>
              <a:gd name="connsiteY0" fmla="*/ 500659 h 914525"/>
              <a:gd name="connsiteX1" fmla="*/ 2816213 w 3452469"/>
              <a:gd name="connsiteY1" fmla="*/ 497182 h 914525"/>
              <a:gd name="connsiteX2" fmla="*/ 1943535 w 3452469"/>
              <a:gd name="connsiteY2" fmla="*/ 0 h 914525"/>
              <a:gd name="connsiteX3" fmla="*/ 1164731 w 3452469"/>
              <a:gd name="connsiteY3" fmla="*/ 674501 h 914525"/>
              <a:gd name="connsiteX4" fmla="*/ 594534 w 3452469"/>
              <a:gd name="connsiteY4" fmla="*/ 514566 h 914525"/>
              <a:gd name="connsiteX5" fmla="*/ 236422 w 3452469"/>
              <a:gd name="connsiteY5" fmla="*/ 914399 h 914525"/>
              <a:gd name="connsiteX6" fmla="*/ 0 w 3452469"/>
              <a:gd name="connsiteY6" fmla="*/ 552811 h 914525"/>
              <a:gd name="connsiteX0" fmla="*/ 3452469 w 3452469"/>
              <a:gd name="connsiteY0" fmla="*/ 500659 h 914525"/>
              <a:gd name="connsiteX1" fmla="*/ 2816213 w 3452469"/>
              <a:gd name="connsiteY1" fmla="*/ 497182 h 914525"/>
              <a:gd name="connsiteX2" fmla="*/ 1943535 w 3452469"/>
              <a:gd name="connsiteY2" fmla="*/ 0 h 914525"/>
              <a:gd name="connsiteX3" fmla="*/ 1164731 w 3452469"/>
              <a:gd name="connsiteY3" fmla="*/ 674501 h 914525"/>
              <a:gd name="connsiteX4" fmla="*/ 594534 w 3452469"/>
              <a:gd name="connsiteY4" fmla="*/ 514566 h 914525"/>
              <a:gd name="connsiteX5" fmla="*/ 229468 w 3452469"/>
              <a:gd name="connsiteY5" fmla="*/ 914399 h 914525"/>
              <a:gd name="connsiteX6" fmla="*/ 0 w 3452469"/>
              <a:gd name="connsiteY6" fmla="*/ 552811 h 914525"/>
              <a:gd name="connsiteX0" fmla="*/ 3452469 w 3452469"/>
              <a:gd name="connsiteY0" fmla="*/ 500659 h 886728"/>
              <a:gd name="connsiteX1" fmla="*/ 2816213 w 3452469"/>
              <a:gd name="connsiteY1" fmla="*/ 497182 h 886728"/>
              <a:gd name="connsiteX2" fmla="*/ 1943535 w 3452469"/>
              <a:gd name="connsiteY2" fmla="*/ 0 h 886728"/>
              <a:gd name="connsiteX3" fmla="*/ 1164731 w 3452469"/>
              <a:gd name="connsiteY3" fmla="*/ 674501 h 886728"/>
              <a:gd name="connsiteX4" fmla="*/ 594534 w 3452469"/>
              <a:gd name="connsiteY4" fmla="*/ 514566 h 886728"/>
              <a:gd name="connsiteX5" fmla="*/ 232945 w 3452469"/>
              <a:gd name="connsiteY5" fmla="*/ 886585 h 886728"/>
              <a:gd name="connsiteX6" fmla="*/ 0 w 3452469"/>
              <a:gd name="connsiteY6" fmla="*/ 552811 h 886728"/>
              <a:gd name="connsiteX0" fmla="*/ 3452469 w 3452469"/>
              <a:gd name="connsiteY0" fmla="*/ 500659 h 886754"/>
              <a:gd name="connsiteX1" fmla="*/ 2816213 w 3452469"/>
              <a:gd name="connsiteY1" fmla="*/ 497182 h 886754"/>
              <a:gd name="connsiteX2" fmla="*/ 1943535 w 3452469"/>
              <a:gd name="connsiteY2" fmla="*/ 0 h 886754"/>
              <a:gd name="connsiteX3" fmla="*/ 1164731 w 3452469"/>
              <a:gd name="connsiteY3" fmla="*/ 674501 h 886754"/>
              <a:gd name="connsiteX4" fmla="*/ 594534 w 3452469"/>
              <a:gd name="connsiteY4" fmla="*/ 511090 h 886754"/>
              <a:gd name="connsiteX5" fmla="*/ 232945 w 3452469"/>
              <a:gd name="connsiteY5" fmla="*/ 886585 h 886754"/>
              <a:gd name="connsiteX6" fmla="*/ 0 w 3452469"/>
              <a:gd name="connsiteY6" fmla="*/ 552811 h 886754"/>
              <a:gd name="connsiteX0" fmla="*/ 3452469 w 3452469"/>
              <a:gd name="connsiteY0" fmla="*/ 497182 h 883277"/>
              <a:gd name="connsiteX1" fmla="*/ 2816213 w 3452469"/>
              <a:gd name="connsiteY1" fmla="*/ 493705 h 883277"/>
              <a:gd name="connsiteX2" fmla="*/ 1943535 w 3452469"/>
              <a:gd name="connsiteY2" fmla="*/ 0 h 883277"/>
              <a:gd name="connsiteX3" fmla="*/ 1164731 w 3452469"/>
              <a:gd name="connsiteY3" fmla="*/ 671024 h 883277"/>
              <a:gd name="connsiteX4" fmla="*/ 594534 w 3452469"/>
              <a:gd name="connsiteY4" fmla="*/ 507613 h 883277"/>
              <a:gd name="connsiteX5" fmla="*/ 232945 w 3452469"/>
              <a:gd name="connsiteY5" fmla="*/ 883108 h 883277"/>
              <a:gd name="connsiteX6" fmla="*/ 0 w 3452469"/>
              <a:gd name="connsiteY6" fmla="*/ 549334 h 883277"/>
              <a:gd name="connsiteX0" fmla="*/ 3452469 w 3452469"/>
              <a:gd name="connsiteY0" fmla="*/ 497182 h 883277"/>
              <a:gd name="connsiteX1" fmla="*/ 2816213 w 3452469"/>
              <a:gd name="connsiteY1" fmla="*/ 493705 h 883277"/>
              <a:gd name="connsiteX2" fmla="*/ 1943535 w 3452469"/>
              <a:gd name="connsiteY2" fmla="*/ 0 h 883277"/>
              <a:gd name="connsiteX3" fmla="*/ 1164731 w 3452469"/>
              <a:gd name="connsiteY3" fmla="*/ 671024 h 883277"/>
              <a:gd name="connsiteX4" fmla="*/ 594534 w 3452469"/>
              <a:gd name="connsiteY4" fmla="*/ 507613 h 883277"/>
              <a:gd name="connsiteX5" fmla="*/ 232945 w 3452469"/>
              <a:gd name="connsiteY5" fmla="*/ 883108 h 883277"/>
              <a:gd name="connsiteX6" fmla="*/ 0 w 3452469"/>
              <a:gd name="connsiteY6" fmla="*/ 549334 h 883277"/>
              <a:gd name="connsiteX0" fmla="*/ 3452469 w 3452469"/>
              <a:gd name="connsiteY0" fmla="*/ 497182 h 841596"/>
              <a:gd name="connsiteX1" fmla="*/ 2816213 w 3452469"/>
              <a:gd name="connsiteY1" fmla="*/ 493705 h 841596"/>
              <a:gd name="connsiteX2" fmla="*/ 1943535 w 3452469"/>
              <a:gd name="connsiteY2" fmla="*/ 0 h 841596"/>
              <a:gd name="connsiteX3" fmla="*/ 1164731 w 3452469"/>
              <a:gd name="connsiteY3" fmla="*/ 671024 h 841596"/>
              <a:gd name="connsiteX4" fmla="*/ 594534 w 3452469"/>
              <a:gd name="connsiteY4" fmla="*/ 507613 h 841596"/>
              <a:gd name="connsiteX5" fmla="*/ 236422 w 3452469"/>
              <a:gd name="connsiteY5" fmla="*/ 841386 h 841596"/>
              <a:gd name="connsiteX6" fmla="*/ 0 w 3452469"/>
              <a:gd name="connsiteY6" fmla="*/ 549334 h 841596"/>
              <a:gd name="connsiteX0" fmla="*/ 3452469 w 3452469"/>
              <a:gd name="connsiteY0" fmla="*/ 497182 h 841709"/>
              <a:gd name="connsiteX1" fmla="*/ 2816213 w 3452469"/>
              <a:gd name="connsiteY1" fmla="*/ 493705 h 841709"/>
              <a:gd name="connsiteX2" fmla="*/ 1943535 w 3452469"/>
              <a:gd name="connsiteY2" fmla="*/ 0 h 841709"/>
              <a:gd name="connsiteX3" fmla="*/ 1164731 w 3452469"/>
              <a:gd name="connsiteY3" fmla="*/ 671024 h 841709"/>
              <a:gd name="connsiteX4" fmla="*/ 591057 w 3452469"/>
              <a:gd name="connsiteY4" fmla="*/ 497183 h 841709"/>
              <a:gd name="connsiteX5" fmla="*/ 236422 w 3452469"/>
              <a:gd name="connsiteY5" fmla="*/ 841386 h 841709"/>
              <a:gd name="connsiteX6" fmla="*/ 0 w 3452469"/>
              <a:gd name="connsiteY6" fmla="*/ 549334 h 841709"/>
              <a:gd name="connsiteX0" fmla="*/ 3452469 w 3452469"/>
              <a:gd name="connsiteY0" fmla="*/ 497182 h 841751"/>
              <a:gd name="connsiteX1" fmla="*/ 2816213 w 3452469"/>
              <a:gd name="connsiteY1" fmla="*/ 493705 h 841751"/>
              <a:gd name="connsiteX2" fmla="*/ 1943535 w 3452469"/>
              <a:gd name="connsiteY2" fmla="*/ 0 h 841751"/>
              <a:gd name="connsiteX3" fmla="*/ 1164731 w 3452469"/>
              <a:gd name="connsiteY3" fmla="*/ 671024 h 841751"/>
              <a:gd name="connsiteX4" fmla="*/ 594534 w 3452469"/>
              <a:gd name="connsiteY4" fmla="*/ 493706 h 841751"/>
              <a:gd name="connsiteX5" fmla="*/ 236422 w 3452469"/>
              <a:gd name="connsiteY5" fmla="*/ 841386 h 841751"/>
              <a:gd name="connsiteX6" fmla="*/ 0 w 3452469"/>
              <a:gd name="connsiteY6" fmla="*/ 549334 h 841751"/>
              <a:gd name="connsiteX0" fmla="*/ 3452469 w 3452469"/>
              <a:gd name="connsiteY0" fmla="*/ 497182 h 841751"/>
              <a:gd name="connsiteX1" fmla="*/ 2816213 w 3452469"/>
              <a:gd name="connsiteY1" fmla="*/ 493705 h 841751"/>
              <a:gd name="connsiteX2" fmla="*/ 1943535 w 3452469"/>
              <a:gd name="connsiteY2" fmla="*/ 0 h 841751"/>
              <a:gd name="connsiteX3" fmla="*/ 1168207 w 3452469"/>
              <a:gd name="connsiteY3" fmla="*/ 671024 h 841751"/>
              <a:gd name="connsiteX4" fmla="*/ 594534 w 3452469"/>
              <a:gd name="connsiteY4" fmla="*/ 493706 h 841751"/>
              <a:gd name="connsiteX5" fmla="*/ 236422 w 3452469"/>
              <a:gd name="connsiteY5" fmla="*/ 841386 h 841751"/>
              <a:gd name="connsiteX6" fmla="*/ 0 w 3452469"/>
              <a:gd name="connsiteY6" fmla="*/ 549334 h 841751"/>
              <a:gd name="connsiteX0" fmla="*/ 3452469 w 3452469"/>
              <a:gd name="connsiteY0" fmla="*/ 497182 h 841751"/>
              <a:gd name="connsiteX1" fmla="*/ 2816213 w 3452469"/>
              <a:gd name="connsiteY1" fmla="*/ 493705 h 841751"/>
              <a:gd name="connsiteX2" fmla="*/ 1947012 w 3452469"/>
              <a:gd name="connsiteY2" fmla="*/ 0 h 841751"/>
              <a:gd name="connsiteX3" fmla="*/ 1168207 w 3452469"/>
              <a:gd name="connsiteY3" fmla="*/ 671024 h 841751"/>
              <a:gd name="connsiteX4" fmla="*/ 594534 w 3452469"/>
              <a:gd name="connsiteY4" fmla="*/ 493706 h 841751"/>
              <a:gd name="connsiteX5" fmla="*/ 236422 w 3452469"/>
              <a:gd name="connsiteY5" fmla="*/ 841386 h 841751"/>
              <a:gd name="connsiteX6" fmla="*/ 0 w 3452469"/>
              <a:gd name="connsiteY6" fmla="*/ 549334 h 841751"/>
              <a:gd name="connsiteX0" fmla="*/ 3452469 w 3452469"/>
              <a:gd name="connsiteY0" fmla="*/ 497182 h 841751"/>
              <a:gd name="connsiteX1" fmla="*/ 2816213 w 3452469"/>
              <a:gd name="connsiteY1" fmla="*/ 493705 h 841751"/>
              <a:gd name="connsiteX2" fmla="*/ 1947012 w 3452469"/>
              <a:gd name="connsiteY2" fmla="*/ 0 h 841751"/>
              <a:gd name="connsiteX3" fmla="*/ 1168207 w 3452469"/>
              <a:gd name="connsiteY3" fmla="*/ 671024 h 841751"/>
              <a:gd name="connsiteX4" fmla="*/ 594534 w 3452469"/>
              <a:gd name="connsiteY4" fmla="*/ 493706 h 841751"/>
              <a:gd name="connsiteX5" fmla="*/ 236422 w 3452469"/>
              <a:gd name="connsiteY5" fmla="*/ 841386 h 841751"/>
              <a:gd name="connsiteX6" fmla="*/ 0 w 3452469"/>
              <a:gd name="connsiteY6" fmla="*/ 549334 h 84175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2469" h="841751">
                <a:moveTo>
                  <a:pt x="3452469" y="497182"/>
                </a:moveTo>
                <a:cubicBezTo>
                  <a:pt x="3252552" y="500948"/>
                  <a:pt x="3087983" y="500079"/>
                  <a:pt x="2816213" y="493705"/>
                </a:cubicBezTo>
                <a:cubicBezTo>
                  <a:pt x="2544443" y="487331"/>
                  <a:pt x="2206034" y="24338"/>
                  <a:pt x="1947012" y="0"/>
                </a:cubicBezTo>
                <a:cubicBezTo>
                  <a:pt x="1694944" y="24337"/>
                  <a:pt x="1393620" y="588740"/>
                  <a:pt x="1168207" y="671024"/>
                </a:cubicBezTo>
                <a:cubicBezTo>
                  <a:pt x="942794" y="753308"/>
                  <a:pt x="749832" y="465312"/>
                  <a:pt x="594534" y="493706"/>
                </a:cubicBezTo>
                <a:cubicBezTo>
                  <a:pt x="439237" y="522100"/>
                  <a:pt x="335511" y="832115"/>
                  <a:pt x="236422" y="841386"/>
                </a:cubicBezTo>
                <a:cubicBezTo>
                  <a:pt x="137333" y="850657"/>
                  <a:pt x="84312" y="681742"/>
                  <a:pt x="0" y="549334"/>
                </a:cubicBezTo>
              </a:path>
            </a:pathLst>
          </a:custGeom>
          <a:noFill/>
          <a:ln w="127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フリーフォーム 7"/>
          <p:cNvSpPr/>
          <p:nvPr/>
        </p:nvSpPr>
        <p:spPr>
          <a:xfrm>
            <a:off x="980459" y="4711074"/>
            <a:ext cx="3452469" cy="793354"/>
          </a:xfrm>
          <a:custGeom>
            <a:avLst/>
            <a:gdLst>
              <a:gd name="connsiteX0" fmla="*/ 3452469 w 3452469"/>
              <a:gd name="connsiteY0" fmla="*/ 485132 h 791733"/>
              <a:gd name="connsiteX1" fmla="*/ 2816213 w 3452469"/>
              <a:gd name="connsiteY1" fmla="*/ 481655 h 791733"/>
              <a:gd name="connsiteX2" fmla="*/ 1992210 w 3452469"/>
              <a:gd name="connsiteY2" fmla="*/ 1856 h 791733"/>
              <a:gd name="connsiteX3" fmla="*/ 1157777 w 3452469"/>
              <a:gd name="connsiteY3" fmla="*/ 683310 h 791733"/>
              <a:gd name="connsiteX4" fmla="*/ 594534 w 3452469"/>
              <a:gd name="connsiteY4" fmla="*/ 471225 h 791733"/>
              <a:gd name="connsiteX5" fmla="*/ 267714 w 3452469"/>
              <a:gd name="connsiteY5" fmla="*/ 791091 h 791733"/>
              <a:gd name="connsiteX6" fmla="*/ 0 w 3452469"/>
              <a:gd name="connsiteY6" fmla="*/ 537284 h 791733"/>
              <a:gd name="connsiteX0" fmla="*/ 3452469 w 3452469"/>
              <a:gd name="connsiteY0" fmla="*/ 484859 h 791460"/>
              <a:gd name="connsiteX1" fmla="*/ 2816213 w 3452469"/>
              <a:gd name="connsiteY1" fmla="*/ 481382 h 791460"/>
              <a:gd name="connsiteX2" fmla="*/ 1992210 w 3452469"/>
              <a:gd name="connsiteY2" fmla="*/ 1583 h 791460"/>
              <a:gd name="connsiteX3" fmla="*/ 1157777 w 3452469"/>
              <a:gd name="connsiteY3" fmla="*/ 683037 h 791460"/>
              <a:gd name="connsiteX4" fmla="*/ 594534 w 3452469"/>
              <a:gd name="connsiteY4" fmla="*/ 470952 h 791460"/>
              <a:gd name="connsiteX5" fmla="*/ 267714 w 3452469"/>
              <a:gd name="connsiteY5" fmla="*/ 790818 h 791460"/>
              <a:gd name="connsiteX6" fmla="*/ 0 w 3452469"/>
              <a:gd name="connsiteY6" fmla="*/ 537011 h 791460"/>
              <a:gd name="connsiteX0" fmla="*/ 3452469 w 3452469"/>
              <a:gd name="connsiteY0" fmla="*/ 488597 h 795198"/>
              <a:gd name="connsiteX1" fmla="*/ 2816213 w 3452469"/>
              <a:gd name="connsiteY1" fmla="*/ 485120 h 795198"/>
              <a:gd name="connsiteX2" fmla="*/ 1940058 w 3452469"/>
              <a:gd name="connsiteY2" fmla="*/ 1844 h 795198"/>
              <a:gd name="connsiteX3" fmla="*/ 1157777 w 3452469"/>
              <a:gd name="connsiteY3" fmla="*/ 686775 h 795198"/>
              <a:gd name="connsiteX4" fmla="*/ 594534 w 3452469"/>
              <a:gd name="connsiteY4" fmla="*/ 474690 h 795198"/>
              <a:gd name="connsiteX5" fmla="*/ 267714 w 3452469"/>
              <a:gd name="connsiteY5" fmla="*/ 794556 h 795198"/>
              <a:gd name="connsiteX6" fmla="*/ 0 w 3452469"/>
              <a:gd name="connsiteY6" fmla="*/ 540749 h 795198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32946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6753 h 793354"/>
              <a:gd name="connsiteX1" fmla="*/ 2816213 w 3452469"/>
              <a:gd name="connsiteY1" fmla="*/ 483276 h 793354"/>
              <a:gd name="connsiteX2" fmla="*/ 1940058 w 3452469"/>
              <a:gd name="connsiteY2" fmla="*/ 0 h 793354"/>
              <a:gd name="connsiteX3" fmla="*/ 1157777 w 3452469"/>
              <a:gd name="connsiteY3" fmla="*/ 671024 h 793354"/>
              <a:gd name="connsiteX4" fmla="*/ 594534 w 3452469"/>
              <a:gd name="connsiteY4" fmla="*/ 472846 h 793354"/>
              <a:gd name="connsiteX5" fmla="*/ 232946 w 3452469"/>
              <a:gd name="connsiteY5" fmla="*/ 792712 h 793354"/>
              <a:gd name="connsiteX6" fmla="*/ 0 w 3452469"/>
              <a:gd name="connsiteY6" fmla="*/ 538905 h 79335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2469" h="793354">
                <a:moveTo>
                  <a:pt x="3452469" y="486753"/>
                </a:moveTo>
                <a:cubicBezTo>
                  <a:pt x="3252552" y="490519"/>
                  <a:pt x="3057851" y="477480"/>
                  <a:pt x="2816213" y="483276"/>
                </a:cubicBezTo>
                <a:cubicBezTo>
                  <a:pt x="2574575" y="489072"/>
                  <a:pt x="2199080" y="24338"/>
                  <a:pt x="1940058" y="0"/>
                </a:cubicBezTo>
                <a:cubicBezTo>
                  <a:pt x="1687990" y="24337"/>
                  <a:pt x="1399415" y="616554"/>
                  <a:pt x="1157777" y="671024"/>
                </a:cubicBezTo>
                <a:cubicBezTo>
                  <a:pt x="916139" y="725494"/>
                  <a:pt x="748673" y="452565"/>
                  <a:pt x="594534" y="472846"/>
                </a:cubicBezTo>
                <a:cubicBezTo>
                  <a:pt x="440396" y="493127"/>
                  <a:pt x="332035" y="781702"/>
                  <a:pt x="232946" y="792712"/>
                </a:cubicBezTo>
                <a:cubicBezTo>
                  <a:pt x="133857" y="803722"/>
                  <a:pt x="84312" y="671313"/>
                  <a:pt x="0" y="538905"/>
                </a:cubicBezTo>
              </a:path>
            </a:pathLst>
          </a:cu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0" name="フリーフォーム 539"/>
          <p:cNvSpPr/>
          <p:nvPr/>
        </p:nvSpPr>
        <p:spPr>
          <a:xfrm>
            <a:off x="982031" y="4685633"/>
            <a:ext cx="3452469" cy="966584"/>
          </a:xfrm>
          <a:custGeom>
            <a:avLst/>
            <a:gdLst>
              <a:gd name="connsiteX0" fmla="*/ 3452469 w 3452469"/>
              <a:gd name="connsiteY0" fmla="*/ 485132 h 791733"/>
              <a:gd name="connsiteX1" fmla="*/ 2816213 w 3452469"/>
              <a:gd name="connsiteY1" fmla="*/ 481655 h 791733"/>
              <a:gd name="connsiteX2" fmla="*/ 1992210 w 3452469"/>
              <a:gd name="connsiteY2" fmla="*/ 1856 h 791733"/>
              <a:gd name="connsiteX3" fmla="*/ 1157777 w 3452469"/>
              <a:gd name="connsiteY3" fmla="*/ 683310 h 791733"/>
              <a:gd name="connsiteX4" fmla="*/ 594534 w 3452469"/>
              <a:gd name="connsiteY4" fmla="*/ 471225 h 791733"/>
              <a:gd name="connsiteX5" fmla="*/ 267714 w 3452469"/>
              <a:gd name="connsiteY5" fmla="*/ 791091 h 791733"/>
              <a:gd name="connsiteX6" fmla="*/ 0 w 3452469"/>
              <a:gd name="connsiteY6" fmla="*/ 537284 h 791733"/>
              <a:gd name="connsiteX0" fmla="*/ 3452469 w 3452469"/>
              <a:gd name="connsiteY0" fmla="*/ 484859 h 791460"/>
              <a:gd name="connsiteX1" fmla="*/ 2816213 w 3452469"/>
              <a:gd name="connsiteY1" fmla="*/ 481382 h 791460"/>
              <a:gd name="connsiteX2" fmla="*/ 1992210 w 3452469"/>
              <a:gd name="connsiteY2" fmla="*/ 1583 h 791460"/>
              <a:gd name="connsiteX3" fmla="*/ 1157777 w 3452469"/>
              <a:gd name="connsiteY3" fmla="*/ 683037 h 791460"/>
              <a:gd name="connsiteX4" fmla="*/ 594534 w 3452469"/>
              <a:gd name="connsiteY4" fmla="*/ 470952 h 791460"/>
              <a:gd name="connsiteX5" fmla="*/ 267714 w 3452469"/>
              <a:gd name="connsiteY5" fmla="*/ 790818 h 791460"/>
              <a:gd name="connsiteX6" fmla="*/ 0 w 3452469"/>
              <a:gd name="connsiteY6" fmla="*/ 537011 h 791460"/>
              <a:gd name="connsiteX0" fmla="*/ 3452469 w 3452469"/>
              <a:gd name="connsiteY0" fmla="*/ 488597 h 795198"/>
              <a:gd name="connsiteX1" fmla="*/ 2816213 w 3452469"/>
              <a:gd name="connsiteY1" fmla="*/ 485120 h 795198"/>
              <a:gd name="connsiteX2" fmla="*/ 1940058 w 3452469"/>
              <a:gd name="connsiteY2" fmla="*/ 1844 h 795198"/>
              <a:gd name="connsiteX3" fmla="*/ 1157777 w 3452469"/>
              <a:gd name="connsiteY3" fmla="*/ 686775 h 795198"/>
              <a:gd name="connsiteX4" fmla="*/ 594534 w 3452469"/>
              <a:gd name="connsiteY4" fmla="*/ 474690 h 795198"/>
              <a:gd name="connsiteX5" fmla="*/ 267714 w 3452469"/>
              <a:gd name="connsiteY5" fmla="*/ 794556 h 795198"/>
              <a:gd name="connsiteX6" fmla="*/ 0 w 3452469"/>
              <a:gd name="connsiteY6" fmla="*/ 540749 h 795198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308 h 794909"/>
              <a:gd name="connsiteX1" fmla="*/ 2816213 w 3452469"/>
              <a:gd name="connsiteY1" fmla="*/ 484831 h 794909"/>
              <a:gd name="connsiteX2" fmla="*/ 1940058 w 3452469"/>
              <a:gd name="connsiteY2" fmla="*/ 1555 h 794909"/>
              <a:gd name="connsiteX3" fmla="*/ 1157777 w 3452469"/>
              <a:gd name="connsiteY3" fmla="*/ 686486 h 794909"/>
              <a:gd name="connsiteX4" fmla="*/ 594534 w 3452469"/>
              <a:gd name="connsiteY4" fmla="*/ 474401 h 794909"/>
              <a:gd name="connsiteX5" fmla="*/ 267714 w 3452469"/>
              <a:gd name="connsiteY5" fmla="*/ 794267 h 794909"/>
              <a:gd name="connsiteX6" fmla="*/ 0 w 3452469"/>
              <a:gd name="connsiteY6" fmla="*/ 540460 h 794909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67714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8110 h 794711"/>
              <a:gd name="connsiteX1" fmla="*/ 2816213 w 3452469"/>
              <a:gd name="connsiteY1" fmla="*/ 484633 h 794711"/>
              <a:gd name="connsiteX2" fmla="*/ 1940058 w 3452469"/>
              <a:gd name="connsiteY2" fmla="*/ 1357 h 794711"/>
              <a:gd name="connsiteX3" fmla="*/ 1157777 w 3452469"/>
              <a:gd name="connsiteY3" fmla="*/ 672381 h 794711"/>
              <a:gd name="connsiteX4" fmla="*/ 594534 w 3452469"/>
              <a:gd name="connsiteY4" fmla="*/ 474203 h 794711"/>
              <a:gd name="connsiteX5" fmla="*/ 232946 w 3452469"/>
              <a:gd name="connsiteY5" fmla="*/ 794069 h 794711"/>
              <a:gd name="connsiteX6" fmla="*/ 0 w 3452469"/>
              <a:gd name="connsiteY6" fmla="*/ 540262 h 794711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7429 h 794030"/>
              <a:gd name="connsiteX1" fmla="*/ 2816213 w 3452469"/>
              <a:gd name="connsiteY1" fmla="*/ 483952 h 794030"/>
              <a:gd name="connsiteX2" fmla="*/ 1940058 w 3452469"/>
              <a:gd name="connsiteY2" fmla="*/ 676 h 794030"/>
              <a:gd name="connsiteX3" fmla="*/ 1157777 w 3452469"/>
              <a:gd name="connsiteY3" fmla="*/ 671700 h 794030"/>
              <a:gd name="connsiteX4" fmla="*/ 594534 w 3452469"/>
              <a:gd name="connsiteY4" fmla="*/ 473522 h 794030"/>
              <a:gd name="connsiteX5" fmla="*/ 232946 w 3452469"/>
              <a:gd name="connsiteY5" fmla="*/ 793388 h 794030"/>
              <a:gd name="connsiteX6" fmla="*/ 0 w 3452469"/>
              <a:gd name="connsiteY6" fmla="*/ 539581 h 794030"/>
              <a:gd name="connsiteX0" fmla="*/ 3452469 w 3452469"/>
              <a:gd name="connsiteY0" fmla="*/ 486753 h 793354"/>
              <a:gd name="connsiteX1" fmla="*/ 2816213 w 3452469"/>
              <a:gd name="connsiteY1" fmla="*/ 483276 h 793354"/>
              <a:gd name="connsiteX2" fmla="*/ 1940058 w 3452469"/>
              <a:gd name="connsiteY2" fmla="*/ 0 h 793354"/>
              <a:gd name="connsiteX3" fmla="*/ 1157777 w 3452469"/>
              <a:gd name="connsiteY3" fmla="*/ 671024 h 793354"/>
              <a:gd name="connsiteX4" fmla="*/ 594534 w 3452469"/>
              <a:gd name="connsiteY4" fmla="*/ 472846 h 793354"/>
              <a:gd name="connsiteX5" fmla="*/ 232946 w 3452469"/>
              <a:gd name="connsiteY5" fmla="*/ 792712 h 793354"/>
              <a:gd name="connsiteX6" fmla="*/ 0 w 3452469"/>
              <a:gd name="connsiteY6" fmla="*/ 538905 h 793354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95361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691"/>
              <a:gd name="connsiteX1" fmla="*/ 2816213 w 3452469"/>
              <a:gd name="connsiteY1" fmla="*/ 507613 h 817691"/>
              <a:gd name="connsiteX2" fmla="*/ 1940058 w 3452469"/>
              <a:gd name="connsiteY2" fmla="*/ 0 h 817691"/>
              <a:gd name="connsiteX3" fmla="*/ 1157777 w 3452469"/>
              <a:gd name="connsiteY3" fmla="*/ 671024 h 817691"/>
              <a:gd name="connsiteX4" fmla="*/ 594534 w 3452469"/>
              <a:gd name="connsiteY4" fmla="*/ 497183 h 817691"/>
              <a:gd name="connsiteX5" fmla="*/ 232946 w 3452469"/>
              <a:gd name="connsiteY5" fmla="*/ 817049 h 817691"/>
              <a:gd name="connsiteX6" fmla="*/ 0 w 3452469"/>
              <a:gd name="connsiteY6" fmla="*/ 563242 h 817691"/>
              <a:gd name="connsiteX0" fmla="*/ 3452469 w 3452469"/>
              <a:gd name="connsiteY0" fmla="*/ 511090 h 817119"/>
              <a:gd name="connsiteX1" fmla="*/ 2816213 w 3452469"/>
              <a:gd name="connsiteY1" fmla="*/ 507613 h 817119"/>
              <a:gd name="connsiteX2" fmla="*/ 1940058 w 3452469"/>
              <a:gd name="connsiteY2" fmla="*/ 0 h 817119"/>
              <a:gd name="connsiteX3" fmla="*/ 1157777 w 3452469"/>
              <a:gd name="connsiteY3" fmla="*/ 671024 h 817119"/>
              <a:gd name="connsiteX4" fmla="*/ 598011 w 3452469"/>
              <a:gd name="connsiteY4" fmla="*/ 542381 h 817119"/>
              <a:gd name="connsiteX5" fmla="*/ 232946 w 3452469"/>
              <a:gd name="connsiteY5" fmla="*/ 817049 h 817119"/>
              <a:gd name="connsiteX6" fmla="*/ 0 w 3452469"/>
              <a:gd name="connsiteY6" fmla="*/ 563242 h 817119"/>
              <a:gd name="connsiteX0" fmla="*/ 3452469 w 3452469"/>
              <a:gd name="connsiteY0" fmla="*/ 511090 h 956155"/>
              <a:gd name="connsiteX1" fmla="*/ 2816213 w 3452469"/>
              <a:gd name="connsiteY1" fmla="*/ 507613 h 956155"/>
              <a:gd name="connsiteX2" fmla="*/ 1940058 w 3452469"/>
              <a:gd name="connsiteY2" fmla="*/ 0 h 956155"/>
              <a:gd name="connsiteX3" fmla="*/ 1157777 w 3452469"/>
              <a:gd name="connsiteY3" fmla="*/ 671024 h 956155"/>
              <a:gd name="connsiteX4" fmla="*/ 598011 w 3452469"/>
              <a:gd name="connsiteY4" fmla="*/ 542381 h 956155"/>
              <a:gd name="connsiteX5" fmla="*/ 232946 w 3452469"/>
              <a:gd name="connsiteY5" fmla="*/ 956121 h 956155"/>
              <a:gd name="connsiteX6" fmla="*/ 0 w 3452469"/>
              <a:gd name="connsiteY6" fmla="*/ 563242 h 956155"/>
              <a:gd name="connsiteX0" fmla="*/ 3452469 w 3452469"/>
              <a:gd name="connsiteY0" fmla="*/ 511090 h 966584"/>
              <a:gd name="connsiteX1" fmla="*/ 2816213 w 3452469"/>
              <a:gd name="connsiteY1" fmla="*/ 507613 h 966584"/>
              <a:gd name="connsiteX2" fmla="*/ 1940058 w 3452469"/>
              <a:gd name="connsiteY2" fmla="*/ 0 h 966584"/>
              <a:gd name="connsiteX3" fmla="*/ 1157777 w 3452469"/>
              <a:gd name="connsiteY3" fmla="*/ 671024 h 966584"/>
              <a:gd name="connsiteX4" fmla="*/ 598011 w 3452469"/>
              <a:gd name="connsiteY4" fmla="*/ 542381 h 966584"/>
              <a:gd name="connsiteX5" fmla="*/ 232946 w 3452469"/>
              <a:gd name="connsiteY5" fmla="*/ 966552 h 966584"/>
              <a:gd name="connsiteX6" fmla="*/ 0 w 3452469"/>
              <a:gd name="connsiteY6" fmla="*/ 563242 h 9665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2469" h="966584">
                <a:moveTo>
                  <a:pt x="3452469" y="511090"/>
                </a:moveTo>
                <a:cubicBezTo>
                  <a:pt x="3252552" y="514856"/>
                  <a:pt x="3064805" y="530212"/>
                  <a:pt x="2816213" y="507613"/>
                </a:cubicBezTo>
                <a:cubicBezTo>
                  <a:pt x="2567621" y="485014"/>
                  <a:pt x="2199080" y="24338"/>
                  <a:pt x="1940058" y="0"/>
                </a:cubicBezTo>
                <a:cubicBezTo>
                  <a:pt x="1687990" y="24337"/>
                  <a:pt x="1381451" y="580627"/>
                  <a:pt x="1157777" y="671024"/>
                </a:cubicBezTo>
                <a:cubicBezTo>
                  <a:pt x="934103" y="761421"/>
                  <a:pt x="752149" y="493126"/>
                  <a:pt x="598011" y="542381"/>
                </a:cubicBezTo>
                <a:cubicBezTo>
                  <a:pt x="443873" y="591636"/>
                  <a:pt x="332615" y="963075"/>
                  <a:pt x="232946" y="966552"/>
                </a:cubicBezTo>
                <a:cubicBezTo>
                  <a:pt x="133278" y="970029"/>
                  <a:pt x="84312" y="695650"/>
                  <a:pt x="0" y="563242"/>
                </a:cubicBezTo>
              </a:path>
            </a:pathLst>
          </a:cu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575" name="直線コネクタ 574"/>
          <p:cNvCxnSpPr/>
          <p:nvPr/>
        </p:nvCxnSpPr>
        <p:spPr>
          <a:xfrm>
            <a:off x="5795298" y="6203782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6" name="直線コネクタ 575"/>
          <p:cNvCxnSpPr/>
          <p:nvPr/>
        </p:nvCxnSpPr>
        <p:spPr>
          <a:xfrm>
            <a:off x="6365184" y="6203782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7" name="直線コネクタ 576"/>
          <p:cNvCxnSpPr/>
          <p:nvPr/>
        </p:nvCxnSpPr>
        <p:spPr>
          <a:xfrm>
            <a:off x="6935070" y="6203782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8" name="直線コネクタ 577"/>
          <p:cNvCxnSpPr/>
          <p:nvPr/>
        </p:nvCxnSpPr>
        <p:spPr>
          <a:xfrm>
            <a:off x="7511134" y="6203782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9" name="直線コネクタ 578"/>
          <p:cNvCxnSpPr/>
          <p:nvPr/>
        </p:nvCxnSpPr>
        <p:spPr>
          <a:xfrm>
            <a:off x="8087198" y="6203782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3" name="直線コネクタ 582"/>
          <p:cNvCxnSpPr/>
          <p:nvPr/>
        </p:nvCxnSpPr>
        <p:spPr>
          <a:xfrm rot="5400000">
            <a:off x="5244522" y="4621627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4" name="直線コネクタ 583"/>
          <p:cNvCxnSpPr/>
          <p:nvPr/>
        </p:nvCxnSpPr>
        <p:spPr>
          <a:xfrm rot="5400000">
            <a:off x="5244522" y="4350221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5" name="直線コネクタ 584"/>
          <p:cNvCxnSpPr/>
          <p:nvPr/>
        </p:nvCxnSpPr>
        <p:spPr>
          <a:xfrm rot="5400000">
            <a:off x="5244522" y="4893071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6" name="直線コネクタ 585"/>
          <p:cNvCxnSpPr/>
          <p:nvPr/>
        </p:nvCxnSpPr>
        <p:spPr>
          <a:xfrm rot="5400000">
            <a:off x="5244522" y="5973153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7" name="直線コネクタ 586"/>
          <p:cNvCxnSpPr/>
          <p:nvPr/>
        </p:nvCxnSpPr>
        <p:spPr>
          <a:xfrm>
            <a:off x="5208522" y="5200477"/>
            <a:ext cx="3454740" cy="1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8" name="テキスト ボックス 88"/>
          <p:cNvSpPr txBox="1">
            <a:spLocks noChangeArrowheads="1"/>
          </p:cNvSpPr>
          <p:nvPr/>
        </p:nvSpPr>
        <p:spPr bwMode="auto">
          <a:xfrm>
            <a:off x="4876016" y="3997842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89" name="テキスト ボックス 88"/>
          <p:cNvSpPr txBox="1">
            <a:spLocks noChangeArrowheads="1"/>
          </p:cNvSpPr>
          <p:nvPr/>
        </p:nvSpPr>
        <p:spPr bwMode="auto">
          <a:xfrm>
            <a:off x="4876016" y="4264373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6</a:t>
            </a:r>
          </a:p>
        </p:txBody>
      </p:sp>
      <p:sp>
        <p:nvSpPr>
          <p:cNvPr id="590" name="テキスト ボックス 88"/>
          <p:cNvSpPr txBox="1">
            <a:spLocks noChangeArrowheads="1"/>
          </p:cNvSpPr>
          <p:nvPr/>
        </p:nvSpPr>
        <p:spPr bwMode="auto">
          <a:xfrm>
            <a:off x="4876016" y="4541321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91" name="テキスト ボックス 88"/>
          <p:cNvSpPr txBox="1">
            <a:spLocks noChangeArrowheads="1"/>
          </p:cNvSpPr>
          <p:nvPr/>
        </p:nvSpPr>
        <p:spPr bwMode="auto">
          <a:xfrm>
            <a:off x="4876016" y="5073049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92" name="テキスト ボックス 88"/>
          <p:cNvSpPr txBox="1">
            <a:spLocks noChangeArrowheads="1"/>
          </p:cNvSpPr>
          <p:nvPr/>
        </p:nvSpPr>
        <p:spPr bwMode="auto">
          <a:xfrm>
            <a:off x="4876016" y="5355539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2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93" name="テキスト ボックス 88"/>
          <p:cNvSpPr txBox="1">
            <a:spLocks noChangeArrowheads="1"/>
          </p:cNvSpPr>
          <p:nvPr/>
        </p:nvSpPr>
        <p:spPr bwMode="auto">
          <a:xfrm>
            <a:off x="4876016" y="4807185"/>
            <a:ext cx="33932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2</a:t>
            </a:r>
          </a:p>
        </p:txBody>
      </p:sp>
      <p:sp>
        <p:nvSpPr>
          <p:cNvPr id="594" name="テキスト ボックス 88"/>
          <p:cNvSpPr txBox="1">
            <a:spLocks noChangeArrowheads="1"/>
          </p:cNvSpPr>
          <p:nvPr/>
        </p:nvSpPr>
        <p:spPr bwMode="auto">
          <a:xfrm>
            <a:off x="4846838" y="5624458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4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95" name="テキスト ボックス 88"/>
          <p:cNvSpPr txBox="1">
            <a:spLocks noChangeArrowheads="1"/>
          </p:cNvSpPr>
          <p:nvPr/>
        </p:nvSpPr>
        <p:spPr bwMode="auto">
          <a:xfrm>
            <a:off x="5007705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599" name="テキスト ボックス 88"/>
          <p:cNvSpPr txBox="1">
            <a:spLocks noChangeArrowheads="1"/>
          </p:cNvSpPr>
          <p:nvPr/>
        </p:nvSpPr>
        <p:spPr bwMode="auto">
          <a:xfrm>
            <a:off x="5601282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03" name="テキスト ボックス 88"/>
          <p:cNvSpPr txBox="1">
            <a:spLocks noChangeArrowheads="1"/>
          </p:cNvSpPr>
          <p:nvPr/>
        </p:nvSpPr>
        <p:spPr bwMode="auto">
          <a:xfrm>
            <a:off x="6169029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4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04" name="テキスト ボックス 88"/>
          <p:cNvSpPr txBox="1">
            <a:spLocks noChangeArrowheads="1"/>
          </p:cNvSpPr>
          <p:nvPr/>
        </p:nvSpPr>
        <p:spPr bwMode="auto">
          <a:xfrm>
            <a:off x="6736776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6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07" name="テキスト ボックス 88"/>
          <p:cNvSpPr txBox="1">
            <a:spLocks noChangeArrowheads="1"/>
          </p:cNvSpPr>
          <p:nvPr/>
        </p:nvSpPr>
        <p:spPr bwMode="auto">
          <a:xfrm>
            <a:off x="7315774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28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08" name="テキスト ボックス 88"/>
          <p:cNvSpPr txBox="1">
            <a:spLocks noChangeArrowheads="1"/>
          </p:cNvSpPr>
          <p:nvPr/>
        </p:nvSpPr>
        <p:spPr bwMode="auto">
          <a:xfrm>
            <a:off x="7886672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30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09" name="テキスト ボックス 88"/>
          <p:cNvSpPr txBox="1">
            <a:spLocks noChangeArrowheads="1"/>
          </p:cNvSpPr>
          <p:nvPr/>
        </p:nvSpPr>
        <p:spPr bwMode="auto">
          <a:xfrm>
            <a:off x="8467902" y="6286966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>
                <a:latin typeface="Arial" charset="0"/>
                <a:cs typeface="Arial" charset="0"/>
              </a:rPr>
              <a:t>3</a:t>
            </a:r>
            <a:r>
              <a:rPr lang="en-US" altLang="ja-JP" sz="1000" b="1" dirty="0" smtClean="0">
                <a:latin typeface="Arial" charset="0"/>
                <a:cs typeface="Arial" charset="0"/>
              </a:rPr>
              <a:t>20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10" name="テキスト ボックス 88"/>
          <p:cNvSpPr txBox="1">
            <a:spLocks noChangeArrowheads="1"/>
          </p:cNvSpPr>
          <p:nvPr/>
        </p:nvSpPr>
        <p:spPr bwMode="auto">
          <a:xfrm>
            <a:off x="6137816" y="6538727"/>
            <a:ext cx="1599674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100" b="1" dirty="0" smtClean="0">
                <a:latin typeface="Arial" charset="0"/>
                <a:cs typeface="Arial" charset="0"/>
              </a:rPr>
              <a:t>Wavelength (nm)</a:t>
            </a:r>
            <a:endParaRPr lang="en-US" altLang="ja-JP" sz="1100" b="1" dirty="0">
              <a:latin typeface="Arial" charset="0"/>
              <a:cs typeface="Arial" charset="0"/>
            </a:endParaRPr>
          </a:p>
        </p:txBody>
      </p:sp>
      <p:sp>
        <p:nvSpPr>
          <p:cNvPr id="611" name="テキスト ボックス 88"/>
          <p:cNvSpPr txBox="1">
            <a:spLocks noChangeArrowheads="1"/>
          </p:cNvSpPr>
          <p:nvPr/>
        </p:nvSpPr>
        <p:spPr bwMode="auto">
          <a:xfrm>
            <a:off x="7943182" y="4206495"/>
            <a:ext cx="660879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/>
            <a:r>
              <a:rPr lang="en-US" altLang="ja-JP" sz="1400" b="1" dirty="0" smtClean="0">
                <a:latin typeface="Arial" charset="0"/>
                <a:cs typeface="Arial" charset="0"/>
              </a:rPr>
              <a:t>42 </a:t>
            </a:r>
            <a:r>
              <a:rPr lang="en-US" altLang="ja-JP" sz="1400" b="1" baseline="30000" dirty="0" err="1" smtClean="0">
                <a:latin typeface="Arial" charset="0"/>
                <a:cs typeface="Arial" charset="0"/>
              </a:rPr>
              <a:t>o</a:t>
            </a:r>
            <a:r>
              <a:rPr lang="en-US" altLang="ja-JP" sz="1400" b="1" dirty="0" err="1" smtClean="0">
                <a:latin typeface="Arial" charset="0"/>
                <a:cs typeface="Arial" charset="0"/>
              </a:rPr>
              <a:t>C</a:t>
            </a:r>
            <a:endParaRPr lang="en-US" altLang="ja-JP" sz="1400" b="1" dirty="0">
              <a:latin typeface="Arial" charset="0"/>
              <a:cs typeface="Arial" charset="0"/>
            </a:endParaRPr>
          </a:p>
        </p:txBody>
      </p:sp>
      <p:grpSp>
        <p:nvGrpSpPr>
          <p:cNvPr id="612" name="グループ化 611"/>
          <p:cNvGrpSpPr/>
          <p:nvPr/>
        </p:nvGrpSpPr>
        <p:grpSpPr>
          <a:xfrm>
            <a:off x="5473102" y="4111228"/>
            <a:ext cx="1068193" cy="925772"/>
            <a:chOff x="1248701" y="2045350"/>
            <a:chExt cx="1068193" cy="925772"/>
          </a:xfrm>
        </p:grpSpPr>
        <p:grpSp>
          <p:nvGrpSpPr>
            <p:cNvPr id="613" name="グループ化 612"/>
            <p:cNvGrpSpPr/>
            <p:nvPr/>
          </p:nvGrpSpPr>
          <p:grpSpPr>
            <a:xfrm>
              <a:off x="1248701" y="2045350"/>
              <a:ext cx="625904" cy="215444"/>
              <a:chOff x="2558800" y="476672"/>
              <a:chExt cx="690036" cy="215444"/>
            </a:xfrm>
          </p:grpSpPr>
          <p:sp>
            <p:nvSpPr>
              <p:cNvPr id="629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476672"/>
                <a:ext cx="654250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None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30" name="直線コネクタ 629"/>
              <p:cNvCxnSpPr/>
              <p:nvPr/>
            </p:nvCxnSpPr>
            <p:spPr>
              <a:xfrm>
                <a:off x="2558800" y="584394"/>
                <a:ext cx="10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4" name="グループ化 613"/>
            <p:cNvGrpSpPr/>
            <p:nvPr/>
          </p:nvGrpSpPr>
          <p:grpSpPr>
            <a:xfrm>
              <a:off x="1248701" y="2471548"/>
              <a:ext cx="1065091" cy="215444"/>
              <a:chOff x="2558800" y="675698"/>
              <a:chExt cx="1174223" cy="215444"/>
            </a:xfrm>
          </p:grpSpPr>
          <p:sp>
            <p:nvSpPr>
              <p:cNvPr id="627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H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28" name="直線コネクタ 627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5" name="グループ化 614"/>
            <p:cNvGrpSpPr/>
            <p:nvPr/>
          </p:nvGrpSpPr>
          <p:grpSpPr>
            <a:xfrm>
              <a:off x="1250341" y="2329482"/>
              <a:ext cx="1065091" cy="215444"/>
              <a:chOff x="2558800" y="675698"/>
              <a:chExt cx="1174223" cy="215444"/>
            </a:xfrm>
          </p:grpSpPr>
          <p:sp>
            <p:nvSpPr>
              <p:cNvPr id="625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26" name="直線コネクタ 625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6" name="グループ化 615"/>
            <p:cNvGrpSpPr/>
            <p:nvPr/>
          </p:nvGrpSpPr>
          <p:grpSpPr>
            <a:xfrm>
              <a:off x="1251803" y="2187416"/>
              <a:ext cx="1065091" cy="215444"/>
              <a:chOff x="2558800" y="675698"/>
              <a:chExt cx="1174223" cy="215444"/>
            </a:xfrm>
          </p:grpSpPr>
          <p:sp>
            <p:nvSpPr>
              <p:cNvPr id="623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NSP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24" name="直線コネクタ 623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00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7" name="グループ化 616"/>
            <p:cNvGrpSpPr/>
            <p:nvPr/>
          </p:nvGrpSpPr>
          <p:grpSpPr>
            <a:xfrm>
              <a:off x="1248701" y="2613614"/>
              <a:ext cx="1065091" cy="215444"/>
              <a:chOff x="2558800" y="675698"/>
              <a:chExt cx="1174223" cy="215444"/>
            </a:xfrm>
          </p:grpSpPr>
          <p:sp>
            <p:nvSpPr>
              <p:cNvPr id="621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APCAD</a:t>
                </a:r>
                <a:endParaRPr lang="en-US" altLang="ja-JP" sz="8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22" name="直線コネクタ 621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18" name="グループ化 617"/>
            <p:cNvGrpSpPr/>
            <p:nvPr/>
          </p:nvGrpSpPr>
          <p:grpSpPr>
            <a:xfrm>
              <a:off x="1248701" y="2755678"/>
              <a:ext cx="1065091" cy="215444"/>
              <a:chOff x="2558800" y="675698"/>
              <a:chExt cx="1174223" cy="215444"/>
            </a:xfrm>
          </p:grpSpPr>
          <p:sp>
            <p:nvSpPr>
              <p:cNvPr id="619" name="テキスト ボックス 88"/>
              <p:cNvSpPr txBox="1">
                <a:spLocks noChangeArrowheads="1"/>
              </p:cNvSpPr>
              <p:nvPr/>
            </p:nvSpPr>
            <p:spPr bwMode="auto">
              <a:xfrm>
                <a:off x="2594586" y="675698"/>
                <a:ext cx="113843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Calibri" pitchFamily="34" charset="0"/>
                    <a:ea typeface="ＭＳ Ｐゴシック" pitchFamily="50" charset="-128"/>
                  </a:defRPr>
                </a:lvl9pPr>
              </a:lstStyle>
              <a:p>
                <a:pPr eaLnBrk="1" hangingPunct="1"/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+ 0.8 </a:t>
                </a:r>
                <a:r>
                  <a:rPr lang="en-US" altLang="ja-JP" sz="800" b="1" dirty="0" err="1" smtClean="0">
                    <a:latin typeface="Arial" charset="0"/>
                    <a:cs typeface="Arial" charset="0"/>
                  </a:rPr>
                  <a:t>mM</a:t>
                </a:r>
                <a:r>
                  <a:rPr lang="en-US" altLang="ja-JP" sz="800" b="1" dirty="0" smtClean="0">
                    <a:latin typeface="Arial" charset="0"/>
                    <a:cs typeface="Arial" charset="0"/>
                  </a:rPr>
                  <a:t> Mg</a:t>
                </a:r>
                <a:r>
                  <a:rPr lang="en-US" altLang="ja-JP" sz="800" b="1" baseline="30000" dirty="0" smtClean="0">
                    <a:latin typeface="Arial" charset="0"/>
                    <a:cs typeface="Arial" charset="0"/>
                  </a:rPr>
                  <a:t>2+</a:t>
                </a:r>
                <a:endParaRPr lang="en-US" altLang="ja-JP" sz="800" b="1" baseline="30000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620" name="直線コネクタ 619"/>
              <p:cNvCxnSpPr/>
              <p:nvPr/>
            </p:nvCxnSpPr>
            <p:spPr>
              <a:xfrm>
                <a:off x="2558800" y="783420"/>
                <a:ext cx="108000" cy="0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632" name="直線コネクタ 631"/>
          <p:cNvCxnSpPr/>
          <p:nvPr/>
        </p:nvCxnSpPr>
        <p:spPr>
          <a:xfrm rot="5400000">
            <a:off x="5238980" y="5707574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3" name="直線コネクタ 632"/>
          <p:cNvCxnSpPr/>
          <p:nvPr/>
        </p:nvCxnSpPr>
        <p:spPr>
          <a:xfrm rot="5400000">
            <a:off x="5233438" y="5441995"/>
            <a:ext cx="0" cy="7200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4" name="テキスト ボックス 88"/>
          <p:cNvSpPr txBox="1">
            <a:spLocks noChangeArrowheads="1"/>
          </p:cNvSpPr>
          <p:nvPr/>
        </p:nvSpPr>
        <p:spPr bwMode="auto">
          <a:xfrm>
            <a:off x="4849351" y="5887305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6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35" name="テキスト ボックス 88"/>
          <p:cNvSpPr txBox="1">
            <a:spLocks noChangeArrowheads="1"/>
          </p:cNvSpPr>
          <p:nvPr/>
        </p:nvSpPr>
        <p:spPr bwMode="auto">
          <a:xfrm>
            <a:off x="4851864" y="6150152"/>
            <a:ext cx="3976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algn="ctr" eaLnBrk="1" hangingPunct="1"/>
            <a:r>
              <a:rPr lang="en-US" altLang="ja-JP" sz="1000" b="1" dirty="0" smtClean="0">
                <a:latin typeface="Arial" charset="0"/>
                <a:cs typeface="Arial" charset="0"/>
              </a:rPr>
              <a:t>-8</a:t>
            </a:r>
            <a:endParaRPr lang="en-US" altLang="ja-JP" sz="1000" b="1" dirty="0">
              <a:latin typeface="Arial" charset="0"/>
              <a:cs typeface="Arial" charset="0"/>
            </a:endParaRPr>
          </a:p>
        </p:txBody>
      </p:sp>
      <p:sp>
        <p:nvSpPr>
          <p:cNvPr id="646" name="Rectangle 4334"/>
          <p:cNvSpPr>
            <a:spLocks noChangeArrowheads="1"/>
          </p:cNvSpPr>
          <p:nvPr/>
        </p:nvSpPr>
        <p:spPr bwMode="auto">
          <a:xfrm rot="16200000">
            <a:off x="4806807" y="5888862"/>
            <a:ext cx="63341" cy="1462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i="1" dirty="0">
                <a:solidFill>
                  <a:srgbClr val="000000"/>
                </a:solidFill>
                <a:latin typeface="Symbol" pitchFamily="18" charset="2"/>
                <a:cs typeface="Arial" charset="0"/>
              </a:rPr>
              <a:t>q</a:t>
            </a:r>
            <a:endParaRPr lang="en-US" altLang="ja-JP" b="1" i="1" dirty="0">
              <a:latin typeface="Symbol" pitchFamily="18" charset="2"/>
              <a:cs typeface="Arial" charset="0"/>
            </a:endParaRPr>
          </a:p>
        </p:txBody>
      </p:sp>
      <p:sp>
        <p:nvSpPr>
          <p:cNvPr id="647" name="Rectangle 4335"/>
          <p:cNvSpPr>
            <a:spLocks noChangeArrowheads="1"/>
          </p:cNvSpPr>
          <p:nvPr/>
        </p:nvSpPr>
        <p:spPr bwMode="auto">
          <a:xfrm rot="16200000">
            <a:off x="4665797" y="5653715"/>
            <a:ext cx="345360" cy="153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X 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10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5</a:t>
            </a:r>
            <a:endParaRPr lang="en-US" altLang="ja-JP" b="1" baseline="30000" dirty="0">
              <a:latin typeface="Arial" charset="0"/>
              <a:cs typeface="Arial" charset="0"/>
            </a:endParaRPr>
          </a:p>
        </p:txBody>
      </p:sp>
      <p:sp>
        <p:nvSpPr>
          <p:cNvPr id="648" name="Rectangle 4337"/>
          <p:cNvSpPr>
            <a:spLocks noChangeArrowheads="1"/>
          </p:cNvSpPr>
          <p:nvPr/>
        </p:nvSpPr>
        <p:spPr bwMode="auto">
          <a:xfrm rot="16200000">
            <a:off x="4303075" y="4937823"/>
            <a:ext cx="107080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pPr algn="ctr"/>
            <a:r>
              <a:rPr lang="en-US" altLang="ja-JP" sz="1000" b="1" dirty="0">
                <a:solidFill>
                  <a:srgbClr val="000000"/>
                </a:solidFill>
                <a:latin typeface="Arial" charset="0"/>
                <a:cs typeface="Arial" charset="0"/>
              </a:rPr>
              <a:t> (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degcm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2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 dmole</a:t>
            </a:r>
            <a:r>
              <a:rPr lang="en-US" altLang="ja-JP" sz="1000" b="1" baseline="30000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-1</a:t>
            </a:r>
            <a:r>
              <a:rPr lang="en-US" altLang="ja-JP" sz="1000" b="1" dirty="0" smtClean="0">
                <a:solidFill>
                  <a:srgbClr val="000000"/>
                </a:solidFill>
                <a:latin typeface="Arial" charset="0"/>
                <a:cs typeface="Arial" charset="0"/>
              </a:rPr>
              <a:t>)</a:t>
            </a:r>
            <a:endParaRPr lang="en-US" altLang="ja-JP" b="1" dirty="0">
              <a:latin typeface="Arial" charset="0"/>
              <a:cs typeface="Arial" charset="0"/>
            </a:endParaRPr>
          </a:p>
        </p:txBody>
      </p:sp>
      <p:sp>
        <p:nvSpPr>
          <p:cNvPr id="649" name="フリーフォーム 648"/>
          <p:cNvSpPr/>
          <p:nvPr/>
        </p:nvSpPr>
        <p:spPr>
          <a:xfrm>
            <a:off x="5210546" y="4690230"/>
            <a:ext cx="3451225" cy="895712"/>
          </a:xfrm>
          <a:custGeom>
            <a:avLst/>
            <a:gdLst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20002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19621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5635"/>
              <a:gd name="connsiteX1" fmla="*/ 2813050 w 3441700"/>
              <a:gd name="connsiteY1" fmla="*/ 486067 h 795635"/>
              <a:gd name="connsiteX2" fmla="*/ 1962150 w 3441700"/>
              <a:gd name="connsiteY2" fmla="*/ 292 h 795635"/>
              <a:gd name="connsiteX3" fmla="*/ 1168400 w 3441700"/>
              <a:gd name="connsiteY3" fmla="*/ 660692 h 795635"/>
              <a:gd name="connsiteX4" fmla="*/ 612775 w 3441700"/>
              <a:gd name="connsiteY4" fmla="*/ 479717 h 795635"/>
              <a:gd name="connsiteX5" fmla="*/ 241300 w 3441700"/>
              <a:gd name="connsiteY5" fmla="*/ 794042 h 795635"/>
              <a:gd name="connsiteX6" fmla="*/ 0 w 3441700"/>
              <a:gd name="connsiteY6" fmla="*/ 562267 h 795635"/>
              <a:gd name="connsiteX0" fmla="*/ 3441700 w 3441700"/>
              <a:gd name="connsiteY0" fmla="*/ 486067 h 864797"/>
              <a:gd name="connsiteX1" fmla="*/ 2813050 w 3441700"/>
              <a:gd name="connsiteY1" fmla="*/ 486067 h 864797"/>
              <a:gd name="connsiteX2" fmla="*/ 1962150 w 3441700"/>
              <a:gd name="connsiteY2" fmla="*/ 292 h 864797"/>
              <a:gd name="connsiteX3" fmla="*/ 1168400 w 3441700"/>
              <a:gd name="connsiteY3" fmla="*/ 660692 h 864797"/>
              <a:gd name="connsiteX4" fmla="*/ 612775 w 3441700"/>
              <a:gd name="connsiteY4" fmla="*/ 479717 h 864797"/>
              <a:gd name="connsiteX5" fmla="*/ 234950 w 3441700"/>
              <a:gd name="connsiteY5" fmla="*/ 863892 h 864797"/>
              <a:gd name="connsiteX6" fmla="*/ 0 w 3441700"/>
              <a:gd name="connsiteY6" fmla="*/ 562267 h 864797"/>
              <a:gd name="connsiteX0" fmla="*/ 3444875 w 3444875"/>
              <a:gd name="connsiteY0" fmla="*/ 486067 h 863894"/>
              <a:gd name="connsiteX1" fmla="*/ 2816225 w 3444875"/>
              <a:gd name="connsiteY1" fmla="*/ 486067 h 863894"/>
              <a:gd name="connsiteX2" fmla="*/ 1965325 w 3444875"/>
              <a:gd name="connsiteY2" fmla="*/ 292 h 863894"/>
              <a:gd name="connsiteX3" fmla="*/ 1171575 w 3444875"/>
              <a:gd name="connsiteY3" fmla="*/ 660692 h 863894"/>
              <a:gd name="connsiteX4" fmla="*/ 615950 w 3444875"/>
              <a:gd name="connsiteY4" fmla="*/ 479717 h 863894"/>
              <a:gd name="connsiteX5" fmla="*/ 238125 w 3444875"/>
              <a:gd name="connsiteY5" fmla="*/ 863892 h 863894"/>
              <a:gd name="connsiteX6" fmla="*/ 0 w 3444875"/>
              <a:gd name="connsiteY6" fmla="*/ 473367 h 863894"/>
              <a:gd name="connsiteX0" fmla="*/ 3444875 w 3444875"/>
              <a:gd name="connsiteY0" fmla="*/ 486070 h 864136"/>
              <a:gd name="connsiteX1" fmla="*/ 2816225 w 3444875"/>
              <a:gd name="connsiteY1" fmla="*/ 486070 h 864136"/>
              <a:gd name="connsiteX2" fmla="*/ 1965325 w 3444875"/>
              <a:gd name="connsiteY2" fmla="*/ 295 h 864136"/>
              <a:gd name="connsiteX3" fmla="*/ 1171575 w 3444875"/>
              <a:gd name="connsiteY3" fmla="*/ 660695 h 864136"/>
              <a:gd name="connsiteX4" fmla="*/ 631825 w 3444875"/>
              <a:gd name="connsiteY4" fmla="*/ 533695 h 864136"/>
              <a:gd name="connsiteX5" fmla="*/ 238125 w 3444875"/>
              <a:gd name="connsiteY5" fmla="*/ 863895 h 864136"/>
              <a:gd name="connsiteX6" fmla="*/ 0 w 3444875"/>
              <a:gd name="connsiteY6" fmla="*/ 473370 h 864136"/>
              <a:gd name="connsiteX0" fmla="*/ 3444875 w 3444875"/>
              <a:gd name="connsiteY0" fmla="*/ 486075 h 864143"/>
              <a:gd name="connsiteX1" fmla="*/ 2816225 w 3444875"/>
              <a:gd name="connsiteY1" fmla="*/ 486075 h 864143"/>
              <a:gd name="connsiteX2" fmla="*/ 1965325 w 3444875"/>
              <a:gd name="connsiteY2" fmla="*/ 300 h 864143"/>
              <a:gd name="connsiteX3" fmla="*/ 1171575 w 3444875"/>
              <a:gd name="connsiteY3" fmla="*/ 651175 h 864143"/>
              <a:gd name="connsiteX4" fmla="*/ 631825 w 3444875"/>
              <a:gd name="connsiteY4" fmla="*/ 533700 h 864143"/>
              <a:gd name="connsiteX5" fmla="*/ 238125 w 3444875"/>
              <a:gd name="connsiteY5" fmla="*/ 863900 h 864143"/>
              <a:gd name="connsiteX6" fmla="*/ 0 w 3444875"/>
              <a:gd name="connsiteY6" fmla="*/ 473375 h 864143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132"/>
              <a:gd name="connsiteX1" fmla="*/ 2816225 w 3444875"/>
              <a:gd name="connsiteY1" fmla="*/ 546376 h 902132"/>
              <a:gd name="connsiteX2" fmla="*/ 1984375 w 3444875"/>
              <a:gd name="connsiteY2" fmla="*/ 276 h 902132"/>
              <a:gd name="connsiteX3" fmla="*/ 1171575 w 3444875"/>
              <a:gd name="connsiteY3" fmla="*/ 711476 h 902132"/>
              <a:gd name="connsiteX4" fmla="*/ 635000 w 3444875"/>
              <a:gd name="connsiteY4" fmla="*/ 581301 h 902132"/>
              <a:gd name="connsiteX5" fmla="*/ 238125 w 3444875"/>
              <a:gd name="connsiteY5" fmla="*/ 901976 h 902132"/>
              <a:gd name="connsiteX6" fmla="*/ 0 w 3444875"/>
              <a:gd name="connsiteY6" fmla="*/ 533676 h 902132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4 h 892569"/>
              <a:gd name="connsiteX1" fmla="*/ 2816225 w 3444875"/>
              <a:gd name="connsiteY1" fmla="*/ 536854 h 892569"/>
              <a:gd name="connsiteX2" fmla="*/ 1984375 w 3444875"/>
              <a:gd name="connsiteY2" fmla="*/ 279 h 892569"/>
              <a:gd name="connsiteX3" fmla="*/ 1171575 w 3444875"/>
              <a:gd name="connsiteY3" fmla="*/ 701954 h 892569"/>
              <a:gd name="connsiteX4" fmla="*/ 635000 w 3444875"/>
              <a:gd name="connsiteY4" fmla="*/ 565429 h 892569"/>
              <a:gd name="connsiteX5" fmla="*/ 238125 w 3444875"/>
              <a:gd name="connsiteY5" fmla="*/ 892454 h 892569"/>
              <a:gd name="connsiteX6" fmla="*/ 0 w 3444875"/>
              <a:gd name="connsiteY6" fmla="*/ 524154 h 892569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95743"/>
              <a:gd name="connsiteX1" fmla="*/ 2816225 w 3444875"/>
              <a:gd name="connsiteY1" fmla="*/ 533680 h 895743"/>
              <a:gd name="connsiteX2" fmla="*/ 1984375 w 3444875"/>
              <a:gd name="connsiteY2" fmla="*/ 280 h 895743"/>
              <a:gd name="connsiteX3" fmla="*/ 1171575 w 3444875"/>
              <a:gd name="connsiteY3" fmla="*/ 698780 h 895743"/>
              <a:gd name="connsiteX4" fmla="*/ 635000 w 3444875"/>
              <a:gd name="connsiteY4" fmla="*/ 562255 h 895743"/>
              <a:gd name="connsiteX5" fmla="*/ 238125 w 3444875"/>
              <a:gd name="connsiteY5" fmla="*/ 895630 h 895743"/>
              <a:gd name="connsiteX6" fmla="*/ 0 w 3444875"/>
              <a:gd name="connsiteY6" fmla="*/ 520980 h 895743"/>
              <a:gd name="connsiteX0" fmla="*/ 3444875 w 3444875"/>
              <a:gd name="connsiteY0" fmla="*/ 533680 h 895783"/>
              <a:gd name="connsiteX1" fmla="*/ 2816225 w 3444875"/>
              <a:gd name="connsiteY1" fmla="*/ 533680 h 895783"/>
              <a:gd name="connsiteX2" fmla="*/ 1984375 w 3444875"/>
              <a:gd name="connsiteY2" fmla="*/ 280 h 895783"/>
              <a:gd name="connsiteX3" fmla="*/ 1171575 w 3444875"/>
              <a:gd name="connsiteY3" fmla="*/ 698780 h 895783"/>
              <a:gd name="connsiteX4" fmla="*/ 635000 w 3444875"/>
              <a:gd name="connsiteY4" fmla="*/ 568605 h 895783"/>
              <a:gd name="connsiteX5" fmla="*/ 238125 w 3444875"/>
              <a:gd name="connsiteY5" fmla="*/ 895630 h 895783"/>
              <a:gd name="connsiteX6" fmla="*/ 0 w 3444875"/>
              <a:gd name="connsiteY6" fmla="*/ 520980 h 895783"/>
              <a:gd name="connsiteX0" fmla="*/ 3444875 w 3444875"/>
              <a:gd name="connsiteY0" fmla="*/ 533680 h 895762"/>
              <a:gd name="connsiteX1" fmla="*/ 2816225 w 3444875"/>
              <a:gd name="connsiteY1" fmla="*/ 533680 h 895762"/>
              <a:gd name="connsiteX2" fmla="*/ 1984375 w 3444875"/>
              <a:gd name="connsiteY2" fmla="*/ 280 h 895762"/>
              <a:gd name="connsiteX3" fmla="*/ 1171575 w 3444875"/>
              <a:gd name="connsiteY3" fmla="*/ 698780 h 895762"/>
              <a:gd name="connsiteX4" fmla="*/ 635000 w 3444875"/>
              <a:gd name="connsiteY4" fmla="*/ 565430 h 895762"/>
              <a:gd name="connsiteX5" fmla="*/ 238125 w 3444875"/>
              <a:gd name="connsiteY5" fmla="*/ 895630 h 895762"/>
              <a:gd name="connsiteX6" fmla="*/ 0 w 3444875"/>
              <a:gd name="connsiteY6" fmla="*/ 520980 h 895762"/>
              <a:gd name="connsiteX0" fmla="*/ 3451225 w 3451225"/>
              <a:gd name="connsiteY0" fmla="*/ 533680 h 895712"/>
              <a:gd name="connsiteX1" fmla="*/ 2822575 w 3451225"/>
              <a:gd name="connsiteY1" fmla="*/ 533680 h 895712"/>
              <a:gd name="connsiteX2" fmla="*/ 1990725 w 3451225"/>
              <a:gd name="connsiteY2" fmla="*/ 280 h 895712"/>
              <a:gd name="connsiteX3" fmla="*/ 1177925 w 3451225"/>
              <a:gd name="connsiteY3" fmla="*/ 698780 h 895712"/>
              <a:gd name="connsiteX4" fmla="*/ 641350 w 3451225"/>
              <a:gd name="connsiteY4" fmla="*/ 565430 h 895712"/>
              <a:gd name="connsiteX5" fmla="*/ 244475 w 3451225"/>
              <a:gd name="connsiteY5" fmla="*/ 895630 h 895712"/>
              <a:gd name="connsiteX6" fmla="*/ 0 w 3451225"/>
              <a:gd name="connsiteY6" fmla="*/ 530505 h 89571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51225" h="895712">
                <a:moveTo>
                  <a:pt x="3451225" y="533680"/>
                </a:moveTo>
                <a:cubicBezTo>
                  <a:pt x="3250671" y="536061"/>
                  <a:pt x="3046942" y="527330"/>
                  <a:pt x="2822575" y="533680"/>
                </a:cubicBezTo>
                <a:cubicBezTo>
                  <a:pt x="2598208" y="540030"/>
                  <a:pt x="2261658" y="75951"/>
                  <a:pt x="1990725" y="280"/>
                </a:cubicBezTo>
                <a:cubicBezTo>
                  <a:pt x="1713442" y="-15066"/>
                  <a:pt x="1402821" y="604588"/>
                  <a:pt x="1177925" y="698780"/>
                </a:cubicBezTo>
                <a:cubicBezTo>
                  <a:pt x="953029" y="792972"/>
                  <a:pt x="796925" y="532622"/>
                  <a:pt x="641350" y="565430"/>
                </a:cubicBezTo>
                <a:cubicBezTo>
                  <a:pt x="485775" y="598238"/>
                  <a:pt x="351367" y="901451"/>
                  <a:pt x="244475" y="895630"/>
                </a:cubicBezTo>
                <a:cubicBezTo>
                  <a:pt x="137583" y="889809"/>
                  <a:pt x="69585" y="700896"/>
                  <a:pt x="0" y="530505"/>
                </a:cubicBezTo>
              </a:path>
            </a:pathLst>
          </a:custGeom>
          <a:noFill/>
          <a:ln w="12700">
            <a:solidFill>
              <a:srgbClr val="0000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1" name="フリーフォーム 650"/>
          <p:cNvSpPr/>
          <p:nvPr/>
        </p:nvSpPr>
        <p:spPr>
          <a:xfrm>
            <a:off x="5216897" y="4703018"/>
            <a:ext cx="3444875" cy="867142"/>
          </a:xfrm>
          <a:custGeom>
            <a:avLst/>
            <a:gdLst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20002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19621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5635"/>
              <a:gd name="connsiteX1" fmla="*/ 2813050 w 3441700"/>
              <a:gd name="connsiteY1" fmla="*/ 486067 h 795635"/>
              <a:gd name="connsiteX2" fmla="*/ 1962150 w 3441700"/>
              <a:gd name="connsiteY2" fmla="*/ 292 h 795635"/>
              <a:gd name="connsiteX3" fmla="*/ 1168400 w 3441700"/>
              <a:gd name="connsiteY3" fmla="*/ 660692 h 795635"/>
              <a:gd name="connsiteX4" fmla="*/ 612775 w 3441700"/>
              <a:gd name="connsiteY4" fmla="*/ 479717 h 795635"/>
              <a:gd name="connsiteX5" fmla="*/ 241300 w 3441700"/>
              <a:gd name="connsiteY5" fmla="*/ 794042 h 795635"/>
              <a:gd name="connsiteX6" fmla="*/ 0 w 3441700"/>
              <a:gd name="connsiteY6" fmla="*/ 562267 h 795635"/>
              <a:gd name="connsiteX0" fmla="*/ 3441700 w 3441700"/>
              <a:gd name="connsiteY0" fmla="*/ 486067 h 864797"/>
              <a:gd name="connsiteX1" fmla="*/ 2813050 w 3441700"/>
              <a:gd name="connsiteY1" fmla="*/ 486067 h 864797"/>
              <a:gd name="connsiteX2" fmla="*/ 1962150 w 3441700"/>
              <a:gd name="connsiteY2" fmla="*/ 292 h 864797"/>
              <a:gd name="connsiteX3" fmla="*/ 1168400 w 3441700"/>
              <a:gd name="connsiteY3" fmla="*/ 660692 h 864797"/>
              <a:gd name="connsiteX4" fmla="*/ 612775 w 3441700"/>
              <a:gd name="connsiteY4" fmla="*/ 479717 h 864797"/>
              <a:gd name="connsiteX5" fmla="*/ 234950 w 3441700"/>
              <a:gd name="connsiteY5" fmla="*/ 863892 h 864797"/>
              <a:gd name="connsiteX6" fmla="*/ 0 w 3441700"/>
              <a:gd name="connsiteY6" fmla="*/ 562267 h 864797"/>
              <a:gd name="connsiteX0" fmla="*/ 3444875 w 3444875"/>
              <a:gd name="connsiteY0" fmla="*/ 486067 h 863894"/>
              <a:gd name="connsiteX1" fmla="*/ 2816225 w 3444875"/>
              <a:gd name="connsiteY1" fmla="*/ 486067 h 863894"/>
              <a:gd name="connsiteX2" fmla="*/ 1965325 w 3444875"/>
              <a:gd name="connsiteY2" fmla="*/ 292 h 863894"/>
              <a:gd name="connsiteX3" fmla="*/ 1171575 w 3444875"/>
              <a:gd name="connsiteY3" fmla="*/ 660692 h 863894"/>
              <a:gd name="connsiteX4" fmla="*/ 615950 w 3444875"/>
              <a:gd name="connsiteY4" fmla="*/ 479717 h 863894"/>
              <a:gd name="connsiteX5" fmla="*/ 238125 w 3444875"/>
              <a:gd name="connsiteY5" fmla="*/ 863892 h 863894"/>
              <a:gd name="connsiteX6" fmla="*/ 0 w 3444875"/>
              <a:gd name="connsiteY6" fmla="*/ 473367 h 863894"/>
              <a:gd name="connsiteX0" fmla="*/ 3444875 w 3444875"/>
              <a:gd name="connsiteY0" fmla="*/ 486070 h 864136"/>
              <a:gd name="connsiteX1" fmla="*/ 2816225 w 3444875"/>
              <a:gd name="connsiteY1" fmla="*/ 486070 h 864136"/>
              <a:gd name="connsiteX2" fmla="*/ 1965325 w 3444875"/>
              <a:gd name="connsiteY2" fmla="*/ 295 h 864136"/>
              <a:gd name="connsiteX3" fmla="*/ 1171575 w 3444875"/>
              <a:gd name="connsiteY3" fmla="*/ 660695 h 864136"/>
              <a:gd name="connsiteX4" fmla="*/ 631825 w 3444875"/>
              <a:gd name="connsiteY4" fmla="*/ 533695 h 864136"/>
              <a:gd name="connsiteX5" fmla="*/ 238125 w 3444875"/>
              <a:gd name="connsiteY5" fmla="*/ 863895 h 864136"/>
              <a:gd name="connsiteX6" fmla="*/ 0 w 3444875"/>
              <a:gd name="connsiteY6" fmla="*/ 473370 h 864136"/>
              <a:gd name="connsiteX0" fmla="*/ 3444875 w 3444875"/>
              <a:gd name="connsiteY0" fmla="*/ 486075 h 864143"/>
              <a:gd name="connsiteX1" fmla="*/ 2816225 w 3444875"/>
              <a:gd name="connsiteY1" fmla="*/ 486075 h 864143"/>
              <a:gd name="connsiteX2" fmla="*/ 1965325 w 3444875"/>
              <a:gd name="connsiteY2" fmla="*/ 300 h 864143"/>
              <a:gd name="connsiteX3" fmla="*/ 1171575 w 3444875"/>
              <a:gd name="connsiteY3" fmla="*/ 651175 h 864143"/>
              <a:gd name="connsiteX4" fmla="*/ 631825 w 3444875"/>
              <a:gd name="connsiteY4" fmla="*/ 533700 h 864143"/>
              <a:gd name="connsiteX5" fmla="*/ 238125 w 3444875"/>
              <a:gd name="connsiteY5" fmla="*/ 863900 h 864143"/>
              <a:gd name="connsiteX6" fmla="*/ 0 w 3444875"/>
              <a:gd name="connsiteY6" fmla="*/ 473375 h 864143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132"/>
              <a:gd name="connsiteX1" fmla="*/ 2816225 w 3444875"/>
              <a:gd name="connsiteY1" fmla="*/ 546376 h 902132"/>
              <a:gd name="connsiteX2" fmla="*/ 1984375 w 3444875"/>
              <a:gd name="connsiteY2" fmla="*/ 276 h 902132"/>
              <a:gd name="connsiteX3" fmla="*/ 1171575 w 3444875"/>
              <a:gd name="connsiteY3" fmla="*/ 711476 h 902132"/>
              <a:gd name="connsiteX4" fmla="*/ 635000 w 3444875"/>
              <a:gd name="connsiteY4" fmla="*/ 581301 h 902132"/>
              <a:gd name="connsiteX5" fmla="*/ 238125 w 3444875"/>
              <a:gd name="connsiteY5" fmla="*/ 901976 h 902132"/>
              <a:gd name="connsiteX6" fmla="*/ 0 w 3444875"/>
              <a:gd name="connsiteY6" fmla="*/ 533676 h 902132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4 h 892569"/>
              <a:gd name="connsiteX1" fmla="*/ 2816225 w 3444875"/>
              <a:gd name="connsiteY1" fmla="*/ 536854 h 892569"/>
              <a:gd name="connsiteX2" fmla="*/ 1984375 w 3444875"/>
              <a:gd name="connsiteY2" fmla="*/ 279 h 892569"/>
              <a:gd name="connsiteX3" fmla="*/ 1171575 w 3444875"/>
              <a:gd name="connsiteY3" fmla="*/ 701954 h 892569"/>
              <a:gd name="connsiteX4" fmla="*/ 635000 w 3444875"/>
              <a:gd name="connsiteY4" fmla="*/ 565429 h 892569"/>
              <a:gd name="connsiteX5" fmla="*/ 238125 w 3444875"/>
              <a:gd name="connsiteY5" fmla="*/ 892454 h 892569"/>
              <a:gd name="connsiteX6" fmla="*/ 0 w 3444875"/>
              <a:gd name="connsiteY6" fmla="*/ 524154 h 892569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73525"/>
              <a:gd name="connsiteX1" fmla="*/ 2816225 w 3444875"/>
              <a:gd name="connsiteY1" fmla="*/ 533680 h 873525"/>
              <a:gd name="connsiteX2" fmla="*/ 1984375 w 3444875"/>
              <a:gd name="connsiteY2" fmla="*/ 280 h 873525"/>
              <a:gd name="connsiteX3" fmla="*/ 1171575 w 3444875"/>
              <a:gd name="connsiteY3" fmla="*/ 698780 h 873525"/>
              <a:gd name="connsiteX4" fmla="*/ 635000 w 3444875"/>
              <a:gd name="connsiteY4" fmla="*/ 562255 h 873525"/>
              <a:gd name="connsiteX5" fmla="*/ 238125 w 3444875"/>
              <a:gd name="connsiteY5" fmla="*/ 873405 h 873525"/>
              <a:gd name="connsiteX6" fmla="*/ 0 w 3444875"/>
              <a:gd name="connsiteY6" fmla="*/ 520980 h 873525"/>
              <a:gd name="connsiteX0" fmla="*/ 3444875 w 3444875"/>
              <a:gd name="connsiteY0" fmla="*/ 533679 h 873448"/>
              <a:gd name="connsiteX1" fmla="*/ 2816225 w 3444875"/>
              <a:gd name="connsiteY1" fmla="*/ 533679 h 873448"/>
              <a:gd name="connsiteX2" fmla="*/ 1984375 w 3444875"/>
              <a:gd name="connsiteY2" fmla="*/ 279 h 873448"/>
              <a:gd name="connsiteX3" fmla="*/ 1171575 w 3444875"/>
              <a:gd name="connsiteY3" fmla="*/ 698779 h 873448"/>
              <a:gd name="connsiteX4" fmla="*/ 635000 w 3444875"/>
              <a:gd name="connsiteY4" fmla="*/ 546379 h 873448"/>
              <a:gd name="connsiteX5" fmla="*/ 238125 w 3444875"/>
              <a:gd name="connsiteY5" fmla="*/ 873404 h 873448"/>
              <a:gd name="connsiteX6" fmla="*/ 0 w 3444875"/>
              <a:gd name="connsiteY6" fmla="*/ 520979 h 873448"/>
              <a:gd name="connsiteX0" fmla="*/ 3444875 w 3444875"/>
              <a:gd name="connsiteY0" fmla="*/ 520984 h 860753"/>
              <a:gd name="connsiteX1" fmla="*/ 2816225 w 3444875"/>
              <a:gd name="connsiteY1" fmla="*/ 520984 h 860753"/>
              <a:gd name="connsiteX2" fmla="*/ 1984375 w 3444875"/>
              <a:gd name="connsiteY2" fmla="*/ 284 h 860753"/>
              <a:gd name="connsiteX3" fmla="*/ 1171575 w 3444875"/>
              <a:gd name="connsiteY3" fmla="*/ 686084 h 860753"/>
              <a:gd name="connsiteX4" fmla="*/ 635000 w 3444875"/>
              <a:gd name="connsiteY4" fmla="*/ 533684 h 860753"/>
              <a:gd name="connsiteX5" fmla="*/ 238125 w 3444875"/>
              <a:gd name="connsiteY5" fmla="*/ 860709 h 860753"/>
              <a:gd name="connsiteX6" fmla="*/ 0 w 3444875"/>
              <a:gd name="connsiteY6" fmla="*/ 508284 h 860753"/>
              <a:gd name="connsiteX0" fmla="*/ 3444875 w 3444875"/>
              <a:gd name="connsiteY0" fmla="*/ 520984 h 860753"/>
              <a:gd name="connsiteX1" fmla="*/ 2816225 w 3444875"/>
              <a:gd name="connsiteY1" fmla="*/ 520984 h 860753"/>
              <a:gd name="connsiteX2" fmla="*/ 1984375 w 3444875"/>
              <a:gd name="connsiteY2" fmla="*/ 284 h 860753"/>
              <a:gd name="connsiteX3" fmla="*/ 1171575 w 3444875"/>
              <a:gd name="connsiteY3" fmla="*/ 686084 h 860753"/>
              <a:gd name="connsiteX4" fmla="*/ 635000 w 3444875"/>
              <a:gd name="connsiteY4" fmla="*/ 533684 h 860753"/>
              <a:gd name="connsiteX5" fmla="*/ 238125 w 3444875"/>
              <a:gd name="connsiteY5" fmla="*/ 860709 h 860753"/>
              <a:gd name="connsiteX6" fmla="*/ 0 w 3444875"/>
              <a:gd name="connsiteY6" fmla="*/ 508284 h 860753"/>
              <a:gd name="connsiteX0" fmla="*/ 3444875 w 3444875"/>
              <a:gd name="connsiteY0" fmla="*/ 520984 h 867102"/>
              <a:gd name="connsiteX1" fmla="*/ 2816225 w 3444875"/>
              <a:gd name="connsiteY1" fmla="*/ 520984 h 867102"/>
              <a:gd name="connsiteX2" fmla="*/ 1984375 w 3444875"/>
              <a:gd name="connsiteY2" fmla="*/ 284 h 867102"/>
              <a:gd name="connsiteX3" fmla="*/ 1171575 w 3444875"/>
              <a:gd name="connsiteY3" fmla="*/ 686084 h 867102"/>
              <a:gd name="connsiteX4" fmla="*/ 635000 w 3444875"/>
              <a:gd name="connsiteY4" fmla="*/ 533684 h 867102"/>
              <a:gd name="connsiteX5" fmla="*/ 238125 w 3444875"/>
              <a:gd name="connsiteY5" fmla="*/ 867059 h 867102"/>
              <a:gd name="connsiteX6" fmla="*/ 0 w 3444875"/>
              <a:gd name="connsiteY6" fmla="*/ 508284 h 867102"/>
              <a:gd name="connsiteX0" fmla="*/ 3444875 w 3444875"/>
              <a:gd name="connsiteY0" fmla="*/ 520984 h 867142"/>
              <a:gd name="connsiteX1" fmla="*/ 2816225 w 3444875"/>
              <a:gd name="connsiteY1" fmla="*/ 520984 h 867142"/>
              <a:gd name="connsiteX2" fmla="*/ 1984375 w 3444875"/>
              <a:gd name="connsiteY2" fmla="*/ 284 h 867142"/>
              <a:gd name="connsiteX3" fmla="*/ 1171575 w 3444875"/>
              <a:gd name="connsiteY3" fmla="*/ 686084 h 867142"/>
              <a:gd name="connsiteX4" fmla="*/ 638175 w 3444875"/>
              <a:gd name="connsiteY4" fmla="*/ 543209 h 867142"/>
              <a:gd name="connsiteX5" fmla="*/ 238125 w 3444875"/>
              <a:gd name="connsiteY5" fmla="*/ 867059 h 867142"/>
              <a:gd name="connsiteX6" fmla="*/ 0 w 3444875"/>
              <a:gd name="connsiteY6" fmla="*/ 508284 h 867142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44875" h="867142">
                <a:moveTo>
                  <a:pt x="3444875" y="520984"/>
                </a:moveTo>
                <a:cubicBezTo>
                  <a:pt x="3244321" y="523365"/>
                  <a:pt x="3059642" y="525217"/>
                  <a:pt x="2816225" y="520984"/>
                </a:cubicBezTo>
                <a:cubicBezTo>
                  <a:pt x="2572808" y="516751"/>
                  <a:pt x="2255308" y="75955"/>
                  <a:pt x="1984375" y="284"/>
                </a:cubicBezTo>
                <a:cubicBezTo>
                  <a:pt x="1707092" y="-15062"/>
                  <a:pt x="1395942" y="595597"/>
                  <a:pt x="1171575" y="686084"/>
                </a:cubicBezTo>
                <a:cubicBezTo>
                  <a:pt x="947208" y="776571"/>
                  <a:pt x="793750" y="513047"/>
                  <a:pt x="638175" y="543209"/>
                </a:cubicBezTo>
                <a:cubicBezTo>
                  <a:pt x="482600" y="573372"/>
                  <a:pt x="344487" y="872880"/>
                  <a:pt x="238125" y="867059"/>
                </a:cubicBezTo>
                <a:cubicBezTo>
                  <a:pt x="131763" y="861238"/>
                  <a:pt x="69585" y="678675"/>
                  <a:pt x="0" y="508284"/>
                </a:cubicBezTo>
              </a:path>
            </a:pathLst>
          </a:custGeom>
          <a:noFill/>
          <a:ln w="12700">
            <a:solidFill>
              <a:srgbClr val="00CC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2" name="フリーフォーム 651"/>
          <p:cNvSpPr/>
          <p:nvPr/>
        </p:nvSpPr>
        <p:spPr>
          <a:xfrm>
            <a:off x="5216898" y="4715802"/>
            <a:ext cx="3444875" cy="844910"/>
          </a:xfrm>
          <a:custGeom>
            <a:avLst/>
            <a:gdLst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20002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19621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5635"/>
              <a:gd name="connsiteX1" fmla="*/ 2813050 w 3441700"/>
              <a:gd name="connsiteY1" fmla="*/ 486067 h 795635"/>
              <a:gd name="connsiteX2" fmla="*/ 1962150 w 3441700"/>
              <a:gd name="connsiteY2" fmla="*/ 292 h 795635"/>
              <a:gd name="connsiteX3" fmla="*/ 1168400 w 3441700"/>
              <a:gd name="connsiteY3" fmla="*/ 660692 h 795635"/>
              <a:gd name="connsiteX4" fmla="*/ 612775 w 3441700"/>
              <a:gd name="connsiteY4" fmla="*/ 479717 h 795635"/>
              <a:gd name="connsiteX5" fmla="*/ 241300 w 3441700"/>
              <a:gd name="connsiteY5" fmla="*/ 794042 h 795635"/>
              <a:gd name="connsiteX6" fmla="*/ 0 w 3441700"/>
              <a:gd name="connsiteY6" fmla="*/ 562267 h 795635"/>
              <a:gd name="connsiteX0" fmla="*/ 3441700 w 3441700"/>
              <a:gd name="connsiteY0" fmla="*/ 486067 h 864797"/>
              <a:gd name="connsiteX1" fmla="*/ 2813050 w 3441700"/>
              <a:gd name="connsiteY1" fmla="*/ 486067 h 864797"/>
              <a:gd name="connsiteX2" fmla="*/ 1962150 w 3441700"/>
              <a:gd name="connsiteY2" fmla="*/ 292 h 864797"/>
              <a:gd name="connsiteX3" fmla="*/ 1168400 w 3441700"/>
              <a:gd name="connsiteY3" fmla="*/ 660692 h 864797"/>
              <a:gd name="connsiteX4" fmla="*/ 612775 w 3441700"/>
              <a:gd name="connsiteY4" fmla="*/ 479717 h 864797"/>
              <a:gd name="connsiteX5" fmla="*/ 234950 w 3441700"/>
              <a:gd name="connsiteY5" fmla="*/ 863892 h 864797"/>
              <a:gd name="connsiteX6" fmla="*/ 0 w 3441700"/>
              <a:gd name="connsiteY6" fmla="*/ 562267 h 864797"/>
              <a:gd name="connsiteX0" fmla="*/ 3444875 w 3444875"/>
              <a:gd name="connsiteY0" fmla="*/ 486067 h 863894"/>
              <a:gd name="connsiteX1" fmla="*/ 2816225 w 3444875"/>
              <a:gd name="connsiteY1" fmla="*/ 486067 h 863894"/>
              <a:gd name="connsiteX2" fmla="*/ 1965325 w 3444875"/>
              <a:gd name="connsiteY2" fmla="*/ 292 h 863894"/>
              <a:gd name="connsiteX3" fmla="*/ 1171575 w 3444875"/>
              <a:gd name="connsiteY3" fmla="*/ 660692 h 863894"/>
              <a:gd name="connsiteX4" fmla="*/ 615950 w 3444875"/>
              <a:gd name="connsiteY4" fmla="*/ 479717 h 863894"/>
              <a:gd name="connsiteX5" fmla="*/ 238125 w 3444875"/>
              <a:gd name="connsiteY5" fmla="*/ 863892 h 863894"/>
              <a:gd name="connsiteX6" fmla="*/ 0 w 3444875"/>
              <a:gd name="connsiteY6" fmla="*/ 473367 h 863894"/>
              <a:gd name="connsiteX0" fmla="*/ 3444875 w 3444875"/>
              <a:gd name="connsiteY0" fmla="*/ 486070 h 864136"/>
              <a:gd name="connsiteX1" fmla="*/ 2816225 w 3444875"/>
              <a:gd name="connsiteY1" fmla="*/ 486070 h 864136"/>
              <a:gd name="connsiteX2" fmla="*/ 1965325 w 3444875"/>
              <a:gd name="connsiteY2" fmla="*/ 295 h 864136"/>
              <a:gd name="connsiteX3" fmla="*/ 1171575 w 3444875"/>
              <a:gd name="connsiteY3" fmla="*/ 660695 h 864136"/>
              <a:gd name="connsiteX4" fmla="*/ 631825 w 3444875"/>
              <a:gd name="connsiteY4" fmla="*/ 533695 h 864136"/>
              <a:gd name="connsiteX5" fmla="*/ 238125 w 3444875"/>
              <a:gd name="connsiteY5" fmla="*/ 863895 h 864136"/>
              <a:gd name="connsiteX6" fmla="*/ 0 w 3444875"/>
              <a:gd name="connsiteY6" fmla="*/ 473370 h 864136"/>
              <a:gd name="connsiteX0" fmla="*/ 3444875 w 3444875"/>
              <a:gd name="connsiteY0" fmla="*/ 486075 h 864143"/>
              <a:gd name="connsiteX1" fmla="*/ 2816225 w 3444875"/>
              <a:gd name="connsiteY1" fmla="*/ 486075 h 864143"/>
              <a:gd name="connsiteX2" fmla="*/ 1965325 w 3444875"/>
              <a:gd name="connsiteY2" fmla="*/ 300 h 864143"/>
              <a:gd name="connsiteX3" fmla="*/ 1171575 w 3444875"/>
              <a:gd name="connsiteY3" fmla="*/ 651175 h 864143"/>
              <a:gd name="connsiteX4" fmla="*/ 631825 w 3444875"/>
              <a:gd name="connsiteY4" fmla="*/ 533700 h 864143"/>
              <a:gd name="connsiteX5" fmla="*/ 238125 w 3444875"/>
              <a:gd name="connsiteY5" fmla="*/ 863900 h 864143"/>
              <a:gd name="connsiteX6" fmla="*/ 0 w 3444875"/>
              <a:gd name="connsiteY6" fmla="*/ 473375 h 864143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132"/>
              <a:gd name="connsiteX1" fmla="*/ 2816225 w 3444875"/>
              <a:gd name="connsiteY1" fmla="*/ 546376 h 902132"/>
              <a:gd name="connsiteX2" fmla="*/ 1984375 w 3444875"/>
              <a:gd name="connsiteY2" fmla="*/ 276 h 902132"/>
              <a:gd name="connsiteX3" fmla="*/ 1171575 w 3444875"/>
              <a:gd name="connsiteY3" fmla="*/ 711476 h 902132"/>
              <a:gd name="connsiteX4" fmla="*/ 635000 w 3444875"/>
              <a:gd name="connsiteY4" fmla="*/ 581301 h 902132"/>
              <a:gd name="connsiteX5" fmla="*/ 238125 w 3444875"/>
              <a:gd name="connsiteY5" fmla="*/ 901976 h 902132"/>
              <a:gd name="connsiteX6" fmla="*/ 0 w 3444875"/>
              <a:gd name="connsiteY6" fmla="*/ 533676 h 902132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4 h 892569"/>
              <a:gd name="connsiteX1" fmla="*/ 2816225 w 3444875"/>
              <a:gd name="connsiteY1" fmla="*/ 536854 h 892569"/>
              <a:gd name="connsiteX2" fmla="*/ 1984375 w 3444875"/>
              <a:gd name="connsiteY2" fmla="*/ 279 h 892569"/>
              <a:gd name="connsiteX3" fmla="*/ 1171575 w 3444875"/>
              <a:gd name="connsiteY3" fmla="*/ 701954 h 892569"/>
              <a:gd name="connsiteX4" fmla="*/ 635000 w 3444875"/>
              <a:gd name="connsiteY4" fmla="*/ 565429 h 892569"/>
              <a:gd name="connsiteX5" fmla="*/ 238125 w 3444875"/>
              <a:gd name="connsiteY5" fmla="*/ 892454 h 892569"/>
              <a:gd name="connsiteX6" fmla="*/ 0 w 3444875"/>
              <a:gd name="connsiteY6" fmla="*/ 524154 h 892569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73525"/>
              <a:gd name="connsiteX1" fmla="*/ 2816225 w 3444875"/>
              <a:gd name="connsiteY1" fmla="*/ 533680 h 873525"/>
              <a:gd name="connsiteX2" fmla="*/ 1984375 w 3444875"/>
              <a:gd name="connsiteY2" fmla="*/ 280 h 873525"/>
              <a:gd name="connsiteX3" fmla="*/ 1171575 w 3444875"/>
              <a:gd name="connsiteY3" fmla="*/ 698780 h 873525"/>
              <a:gd name="connsiteX4" fmla="*/ 635000 w 3444875"/>
              <a:gd name="connsiteY4" fmla="*/ 562255 h 873525"/>
              <a:gd name="connsiteX5" fmla="*/ 238125 w 3444875"/>
              <a:gd name="connsiteY5" fmla="*/ 873405 h 873525"/>
              <a:gd name="connsiteX6" fmla="*/ 0 w 3444875"/>
              <a:gd name="connsiteY6" fmla="*/ 520980 h 873525"/>
              <a:gd name="connsiteX0" fmla="*/ 3444875 w 3444875"/>
              <a:gd name="connsiteY0" fmla="*/ 533679 h 873448"/>
              <a:gd name="connsiteX1" fmla="*/ 2816225 w 3444875"/>
              <a:gd name="connsiteY1" fmla="*/ 533679 h 873448"/>
              <a:gd name="connsiteX2" fmla="*/ 1984375 w 3444875"/>
              <a:gd name="connsiteY2" fmla="*/ 279 h 873448"/>
              <a:gd name="connsiteX3" fmla="*/ 1171575 w 3444875"/>
              <a:gd name="connsiteY3" fmla="*/ 698779 h 873448"/>
              <a:gd name="connsiteX4" fmla="*/ 635000 w 3444875"/>
              <a:gd name="connsiteY4" fmla="*/ 546379 h 873448"/>
              <a:gd name="connsiteX5" fmla="*/ 238125 w 3444875"/>
              <a:gd name="connsiteY5" fmla="*/ 873404 h 873448"/>
              <a:gd name="connsiteX6" fmla="*/ 0 w 3444875"/>
              <a:gd name="connsiteY6" fmla="*/ 520979 h 873448"/>
              <a:gd name="connsiteX0" fmla="*/ 3444875 w 3444875"/>
              <a:gd name="connsiteY0" fmla="*/ 520984 h 860753"/>
              <a:gd name="connsiteX1" fmla="*/ 2816225 w 3444875"/>
              <a:gd name="connsiteY1" fmla="*/ 520984 h 860753"/>
              <a:gd name="connsiteX2" fmla="*/ 1984375 w 3444875"/>
              <a:gd name="connsiteY2" fmla="*/ 284 h 860753"/>
              <a:gd name="connsiteX3" fmla="*/ 1171575 w 3444875"/>
              <a:gd name="connsiteY3" fmla="*/ 686084 h 860753"/>
              <a:gd name="connsiteX4" fmla="*/ 635000 w 3444875"/>
              <a:gd name="connsiteY4" fmla="*/ 533684 h 860753"/>
              <a:gd name="connsiteX5" fmla="*/ 238125 w 3444875"/>
              <a:gd name="connsiteY5" fmla="*/ 860709 h 860753"/>
              <a:gd name="connsiteX6" fmla="*/ 0 w 3444875"/>
              <a:gd name="connsiteY6" fmla="*/ 508284 h 860753"/>
              <a:gd name="connsiteX0" fmla="*/ 3444875 w 3444875"/>
              <a:gd name="connsiteY0" fmla="*/ 520984 h 860753"/>
              <a:gd name="connsiteX1" fmla="*/ 2816225 w 3444875"/>
              <a:gd name="connsiteY1" fmla="*/ 520984 h 860753"/>
              <a:gd name="connsiteX2" fmla="*/ 1984375 w 3444875"/>
              <a:gd name="connsiteY2" fmla="*/ 284 h 860753"/>
              <a:gd name="connsiteX3" fmla="*/ 1171575 w 3444875"/>
              <a:gd name="connsiteY3" fmla="*/ 686084 h 860753"/>
              <a:gd name="connsiteX4" fmla="*/ 635000 w 3444875"/>
              <a:gd name="connsiteY4" fmla="*/ 533684 h 860753"/>
              <a:gd name="connsiteX5" fmla="*/ 238125 w 3444875"/>
              <a:gd name="connsiteY5" fmla="*/ 860709 h 860753"/>
              <a:gd name="connsiteX6" fmla="*/ 0 w 3444875"/>
              <a:gd name="connsiteY6" fmla="*/ 508284 h 860753"/>
              <a:gd name="connsiteX0" fmla="*/ 3444875 w 3444875"/>
              <a:gd name="connsiteY0" fmla="*/ 520984 h 851229"/>
              <a:gd name="connsiteX1" fmla="*/ 2816225 w 3444875"/>
              <a:gd name="connsiteY1" fmla="*/ 520984 h 851229"/>
              <a:gd name="connsiteX2" fmla="*/ 1984375 w 3444875"/>
              <a:gd name="connsiteY2" fmla="*/ 284 h 851229"/>
              <a:gd name="connsiteX3" fmla="*/ 1171575 w 3444875"/>
              <a:gd name="connsiteY3" fmla="*/ 686084 h 851229"/>
              <a:gd name="connsiteX4" fmla="*/ 635000 w 3444875"/>
              <a:gd name="connsiteY4" fmla="*/ 533684 h 851229"/>
              <a:gd name="connsiteX5" fmla="*/ 238125 w 3444875"/>
              <a:gd name="connsiteY5" fmla="*/ 851184 h 851229"/>
              <a:gd name="connsiteX6" fmla="*/ 0 w 3444875"/>
              <a:gd name="connsiteY6" fmla="*/ 508284 h 851229"/>
              <a:gd name="connsiteX0" fmla="*/ 3444875 w 3444875"/>
              <a:gd name="connsiteY0" fmla="*/ 520983 h 851200"/>
              <a:gd name="connsiteX1" fmla="*/ 2816225 w 3444875"/>
              <a:gd name="connsiteY1" fmla="*/ 520983 h 851200"/>
              <a:gd name="connsiteX2" fmla="*/ 1984375 w 3444875"/>
              <a:gd name="connsiteY2" fmla="*/ 283 h 851200"/>
              <a:gd name="connsiteX3" fmla="*/ 1171575 w 3444875"/>
              <a:gd name="connsiteY3" fmla="*/ 686083 h 851200"/>
              <a:gd name="connsiteX4" fmla="*/ 635000 w 3444875"/>
              <a:gd name="connsiteY4" fmla="*/ 524158 h 851200"/>
              <a:gd name="connsiteX5" fmla="*/ 238125 w 3444875"/>
              <a:gd name="connsiteY5" fmla="*/ 851183 h 851200"/>
              <a:gd name="connsiteX6" fmla="*/ 0 w 3444875"/>
              <a:gd name="connsiteY6" fmla="*/ 508283 h 851200"/>
              <a:gd name="connsiteX0" fmla="*/ 3444875 w 3444875"/>
              <a:gd name="connsiteY0" fmla="*/ 508288 h 838505"/>
              <a:gd name="connsiteX1" fmla="*/ 2816225 w 3444875"/>
              <a:gd name="connsiteY1" fmla="*/ 508288 h 838505"/>
              <a:gd name="connsiteX2" fmla="*/ 1981200 w 3444875"/>
              <a:gd name="connsiteY2" fmla="*/ 288 h 838505"/>
              <a:gd name="connsiteX3" fmla="*/ 1171575 w 3444875"/>
              <a:gd name="connsiteY3" fmla="*/ 673388 h 838505"/>
              <a:gd name="connsiteX4" fmla="*/ 635000 w 3444875"/>
              <a:gd name="connsiteY4" fmla="*/ 511463 h 838505"/>
              <a:gd name="connsiteX5" fmla="*/ 238125 w 3444875"/>
              <a:gd name="connsiteY5" fmla="*/ 838488 h 838505"/>
              <a:gd name="connsiteX6" fmla="*/ 0 w 3444875"/>
              <a:gd name="connsiteY6" fmla="*/ 495588 h 838505"/>
              <a:gd name="connsiteX0" fmla="*/ 3444875 w 3444875"/>
              <a:gd name="connsiteY0" fmla="*/ 508288 h 838505"/>
              <a:gd name="connsiteX1" fmla="*/ 2816225 w 3444875"/>
              <a:gd name="connsiteY1" fmla="*/ 508288 h 838505"/>
              <a:gd name="connsiteX2" fmla="*/ 1981200 w 3444875"/>
              <a:gd name="connsiteY2" fmla="*/ 288 h 838505"/>
              <a:gd name="connsiteX3" fmla="*/ 1171575 w 3444875"/>
              <a:gd name="connsiteY3" fmla="*/ 673388 h 838505"/>
              <a:gd name="connsiteX4" fmla="*/ 635000 w 3444875"/>
              <a:gd name="connsiteY4" fmla="*/ 511463 h 838505"/>
              <a:gd name="connsiteX5" fmla="*/ 238125 w 3444875"/>
              <a:gd name="connsiteY5" fmla="*/ 838488 h 838505"/>
              <a:gd name="connsiteX6" fmla="*/ 0 w 3444875"/>
              <a:gd name="connsiteY6" fmla="*/ 495588 h 838505"/>
              <a:gd name="connsiteX0" fmla="*/ 3444875 w 3444875"/>
              <a:gd name="connsiteY0" fmla="*/ 508288 h 844854"/>
              <a:gd name="connsiteX1" fmla="*/ 2816225 w 3444875"/>
              <a:gd name="connsiteY1" fmla="*/ 508288 h 844854"/>
              <a:gd name="connsiteX2" fmla="*/ 1981200 w 3444875"/>
              <a:gd name="connsiteY2" fmla="*/ 288 h 844854"/>
              <a:gd name="connsiteX3" fmla="*/ 1171575 w 3444875"/>
              <a:gd name="connsiteY3" fmla="*/ 673388 h 844854"/>
              <a:gd name="connsiteX4" fmla="*/ 635000 w 3444875"/>
              <a:gd name="connsiteY4" fmla="*/ 511463 h 844854"/>
              <a:gd name="connsiteX5" fmla="*/ 238125 w 3444875"/>
              <a:gd name="connsiteY5" fmla="*/ 844838 h 844854"/>
              <a:gd name="connsiteX6" fmla="*/ 0 w 3444875"/>
              <a:gd name="connsiteY6" fmla="*/ 495588 h 844854"/>
              <a:gd name="connsiteX0" fmla="*/ 3441700 w 3441700"/>
              <a:gd name="connsiteY0" fmla="*/ 508288 h 844930"/>
              <a:gd name="connsiteX1" fmla="*/ 2813050 w 3441700"/>
              <a:gd name="connsiteY1" fmla="*/ 508288 h 844930"/>
              <a:gd name="connsiteX2" fmla="*/ 1978025 w 3441700"/>
              <a:gd name="connsiteY2" fmla="*/ 288 h 844930"/>
              <a:gd name="connsiteX3" fmla="*/ 1168400 w 3441700"/>
              <a:gd name="connsiteY3" fmla="*/ 673388 h 844930"/>
              <a:gd name="connsiteX4" fmla="*/ 631825 w 3441700"/>
              <a:gd name="connsiteY4" fmla="*/ 511463 h 844930"/>
              <a:gd name="connsiteX5" fmla="*/ 234950 w 3441700"/>
              <a:gd name="connsiteY5" fmla="*/ 844838 h 844930"/>
              <a:gd name="connsiteX6" fmla="*/ 0 w 3441700"/>
              <a:gd name="connsiteY6" fmla="*/ 536863 h 844930"/>
              <a:gd name="connsiteX0" fmla="*/ 3444875 w 3444875"/>
              <a:gd name="connsiteY0" fmla="*/ 508288 h 844956"/>
              <a:gd name="connsiteX1" fmla="*/ 2816225 w 3444875"/>
              <a:gd name="connsiteY1" fmla="*/ 508288 h 844956"/>
              <a:gd name="connsiteX2" fmla="*/ 1981200 w 3444875"/>
              <a:gd name="connsiteY2" fmla="*/ 288 h 844956"/>
              <a:gd name="connsiteX3" fmla="*/ 1171575 w 3444875"/>
              <a:gd name="connsiteY3" fmla="*/ 673388 h 844956"/>
              <a:gd name="connsiteX4" fmla="*/ 635000 w 3444875"/>
              <a:gd name="connsiteY4" fmla="*/ 511463 h 844956"/>
              <a:gd name="connsiteX5" fmla="*/ 238125 w 3444875"/>
              <a:gd name="connsiteY5" fmla="*/ 844838 h 844956"/>
              <a:gd name="connsiteX6" fmla="*/ 0 w 3444875"/>
              <a:gd name="connsiteY6" fmla="*/ 540038 h 844956"/>
              <a:gd name="connsiteX0" fmla="*/ 3444875 w 3444875"/>
              <a:gd name="connsiteY0" fmla="*/ 508288 h 844910"/>
              <a:gd name="connsiteX1" fmla="*/ 2816225 w 3444875"/>
              <a:gd name="connsiteY1" fmla="*/ 508288 h 844910"/>
              <a:gd name="connsiteX2" fmla="*/ 1981200 w 3444875"/>
              <a:gd name="connsiteY2" fmla="*/ 288 h 844910"/>
              <a:gd name="connsiteX3" fmla="*/ 1171575 w 3444875"/>
              <a:gd name="connsiteY3" fmla="*/ 673388 h 844910"/>
              <a:gd name="connsiteX4" fmla="*/ 635000 w 3444875"/>
              <a:gd name="connsiteY4" fmla="*/ 517813 h 844910"/>
              <a:gd name="connsiteX5" fmla="*/ 238125 w 3444875"/>
              <a:gd name="connsiteY5" fmla="*/ 844838 h 844910"/>
              <a:gd name="connsiteX6" fmla="*/ 0 w 3444875"/>
              <a:gd name="connsiteY6" fmla="*/ 540038 h 84491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44875" h="844910">
                <a:moveTo>
                  <a:pt x="3444875" y="508288"/>
                </a:moveTo>
                <a:cubicBezTo>
                  <a:pt x="3244321" y="510669"/>
                  <a:pt x="3072871" y="513580"/>
                  <a:pt x="2816225" y="508288"/>
                </a:cubicBezTo>
                <a:cubicBezTo>
                  <a:pt x="2559579" y="502996"/>
                  <a:pt x="2252133" y="75959"/>
                  <a:pt x="1981200" y="288"/>
                </a:cubicBezTo>
                <a:cubicBezTo>
                  <a:pt x="1703917" y="-15058"/>
                  <a:pt x="1395942" y="587134"/>
                  <a:pt x="1171575" y="673388"/>
                </a:cubicBezTo>
                <a:cubicBezTo>
                  <a:pt x="947208" y="759642"/>
                  <a:pt x="790575" y="489238"/>
                  <a:pt x="635000" y="517813"/>
                </a:cubicBezTo>
                <a:cubicBezTo>
                  <a:pt x="479425" y="546388"/>
                  <a:pt x="343958" y="841134"/>
                  <a:pt x="238125" y="844838"/>
                </a:cubicBezTo>
                <a:cubicBezTo>
                  <a:pt x="132292" y="848542"/>
                  <a:pt x="69585" y="710429"/>
                  <a:pt x="0" y="540038"/>
                </a:cubicBezTo>
              </a:path>
            </a:pathLst>
          </a:custGeom>
          <a:noFill/>
          <a:ln w="12700"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3" name="フリーフォーム 652"/>
          <p:cNvSpPr/>
          <p:nvPr/>
        </p:nvSpPr>
        <p:spPr>
          <a:xfrm>
            <a:off x="5213724" y="4725406"/>
            <a:ext cx="3448050" cy="819893"/>
          </a:xfrm>
          <a:custGeom>
            <a:avLst/>
            <a:gdLst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20002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19621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5635"/>
              <a:gd name="connsiteX1" fmla="*/ 2813050 w 3441700"/>
              <a:gd name="connsiteY1" fmla="*/ 486067 h 795635"/>
              <a:gd name="connsiteX2" fmla="*/ 1962150 w 3441700"/>
              <a:gd name="connsiteY2" fmla="*/ 292 h 795635"/>
              <a:gd name="connsiteX3" fmla="*/ 1168400 w 3441700"/>
              <a:gd name="connsiteY3" fmla="*/ 660692 h 795635"/>
              <a:gd name="connsiteX4" fmla="*/ 612775 w 3441700"/>
              <a:gd name="connsiteY4" fmla="*/ 479717 h 795635"/>
              <a:gd name="connsiteX5" fmla="*/ 241300 w 3441700"/>
              <a:gd name="connsiteY5" fmla="*/ 794042 h 795635"/>
              <a:gd name="connsiteX6" fmla="*/ 0 w 3441700"/>
              <a:gd name="connsiteY6" fmla="*/ 562267 h 795635"/>
              <a:gd name="connsiteX0" fmla="*/ 3441700 w 3441700"/>
              <a:gd name="connsiteY0" fmla="*/ 486067 h 864797"/>
              <a:gd name="connsiteX1" fmla="*/ 2813050 w 3441700"/>
              <a:gd name="connsiteY1" fmla="*/ 486067 h 864797"/>
              <a:gd name="connsiteX2" fmla="*/ 1962150 w 3441700"/>
              <a:gd name="connsiteY2" fmla="*/ 292 h 864797"/>
              <a:gd name="connsiteX3" fmla="*/ 1168400 w 3441700"/>
              <a:gd name="connsiteY3" fmla="*/ 660692 h 864797"/>
              <a:gd name="connsiteX4" fmla="*/ 612775 w 3441700"/>
              <a:gd name="connsiteY4" fmla="*/ 479717 h 864797"/>
              <a:gd name="connsiteX5" fmla="*/ 234950 w 3441700"/>
              <a:gd name="connsiteY5" fmla="*/ 863892 h 864797"/>
              <a:gd name="connsiteX6" fmla="*/ 0 w 3441700"/>
              <a:gd name="connsiteY6" fmla="*/ 562267 h 864797"/>
              <a:gd name="connsiteX0" fmla="*/ 3444875 w 3444875"/>
              <a:gd name="connsiteY0" fmla="*/ 486067 h 863894"/>
              <a:gd name="connsiteX1" fmla="*/ 2816225 w 3444875"/>
              <a:gd name="connsiteY1" fmla="*/ 486067 h 863894"/>
              <a:gd name="connsiteX2" fmla="*/ 1965325 w 3444875"/>
              <a:gd name="connsiteY2" fmla="*/ 292 h 863894"/>
              <a:gd name="connsiteX3" fmla="*/ 1171575 w 3444875"/>
              <a:gd name="connsiteY3" fmla="*/ 660692 h 863894"/>
              <a:gd name="connsiteX4" fmla="*/ 615950 w 3444875"/>
              <a:gd name="connsiteY4" fmla="*/ 479717 h 863894"/>
              <a:gd name="connsiteX5" fmla="*/ 238125 w 3444875"/>
              <a:gd name="connsiteY5" fmla="*/ 863892 h 863894"/>
              <a:gd name="connsiteX6" fmla="*/ 0 w 3444875"/>
              <a:gd name="connsiteY6" fmla="*/ 473367 h 863894"/>
              <a:gd name="connsiteX0" fmla="*/ 3444875 w 3444875"/>
              <a:gd name="connsiteY0" fmla="*/ 486070 h 864136"/>
              <a:gd name="connsiteX1" fmla="*/ 2816225 w 3444875"/>
              <a:gd name="connsiteY1" fmla="*/ 486070 h 864136"/>
              <a:gd name="connsiteX2" fmla="*/ 1965325 w 3444875"/>
              <a:gd name="connsiteY2" fmla="*/ 295 h 864136"/>
              <a:gd name="connsiteX3" fmla="*/ 1171575 w 3444875"/>
              <a:gd name="connsiteY3" fmla="*/ 660695 h 864136"/>
              <a:gd name="connsiteX4" fmla="*/ 631825 w 3444875"/>
              <a:gd name="connsiteY4" fmla="*/ 533695 h 864136"/>
              <a:gd name="connsiteX5" fmla="*/ 238125 w 3444875"/>
              <a:gd name="connsiteY5" fmla="*/ 863895 h 864136"/>
              <a:gd name="connsiteX6" fmla="*/ 0 w 3444875"/>
              <a:gd name="connsiteY6" fmla="*/ 473370 h 864136"/>
              <a:gd name="connsiteX0" fmla="*/ 3444875 w 3444875"/>
              <a:gd name="connsiteY0" fmla="*/ 486075 h 864143"/>
              <a:gd name="connsiteX1" fmla="*/ 2816225 w 3444875"/>
              <a:gd name="connsiteY1" fmla="*/ 486075 h 864143"/>
              <a:gd name="connsiteX2" fmla="*/ 1965325 w 3444875"/>
              <a:gd name="connsiteY2" fmla="*/ 300 h 864143"/>
              <a:gd name="connsiteX3" fmla="*/ 1171575 w 3444875"/>
              <a:gd name="connsiteY3" fmla="*/ 651175 h 864143"/>
              <a:gd name="connsiteX4" fmla="*/ 631825 w 3444875"/>
              <a:gd name="connsiteY4" fmla="*/ 533700 h 864143"/>
              <a:gd name="connsiteX5" fmla="*/ 238125 w 3444875"/>
              <a:gd name="connsiteY5" fmla="*/ 863900 h 864143"/>
              <a:gd name="connsiteX6" fmla="*/ 0 w 3444875"/>
              <a:gd name="connsiteY6" fmla="*/ 473375 h 864143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234"/>
              <a:gd name="connsiteX1" fmla="*/ 2816225 w 3444875"/>
              <a:gd name="connsiteY1" fmla="*/ 546376 h 902234"/>
              <a:gd name="connsiteX2" fmla="*/ 1984375 w 3444875"/>
              <a:gd name="connsiteY2" fmla="*/ 276 h 902234"/>
              <a:gd name="connsiteX3" fmla="*/ 1171575 w 3444875"/>
              <a:gd name="connsiteY3" fmla="*/ 711476 h 902234"/>
              <a:gd name="connsiteX4" fmla="*/ 631825 w 3444875"/>
              <a:gd name="connsiteY4" fmla="*/ 594001 h 902234"/>
              <a:gd name="connsiteX5" fmla="*/ 238125 w 3444875"/>
              <a:gd name="connsiteY5" fmla="*/ 901976 h 902234"/>
              <a:gd name="connsiteX6" fmla="*/ 0 w 3444875"/>
              <a:gd name="connsiteY6" fmla="*/ 533676 h 902234"/>
              <a:gd name="connsiteX0" fmla="*/ 3444875 w 3444875"/>
              <a:gd name="connsiteY0" fmla="*/ 546376 h 902132"/>
              <a:gd name="connsiteX1" fmla="*/ 2816225 w 3444875"/>
              <a:gd name="connsiteY1" fmla="*/ 546376 h 902132"/>
              <a:gd name="connsiteX2" fmla="*/ 1984375 w 3444875"/>
              <a:gd name="connsiteY2" fmla="*/ 276 h 902132"/>
              <a:gd name="connsiteX3" fmla="*/ 1171575 w 3444875"/>
              <a:gd name="connsiteY3" fmla="*/ 711476 h 902132"/>
              <a:gd name="connsiteX4" fmla="*/ 635000 w 3444875"/>
              <a:gd name="connsiteY4" fmla="*/ 581301 h 902132"/>
              <a:gd name="connsiteX5" fmla="*/ 238125 w 3444875"/>
              <a:gd name="connsiteY5" fmla="*/ 901976 h 902132"/>
              <a:gd name="connsiteX6" fmla="*/ 0 w 3444875"/>
              <a:gd name="connsiteY6" fmla="*/ 533676 h 902132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5 h 892611"/>
              <a:gd name="connsiteX1" fmla="*/ 2816225 w 3444875"/>
              <a:gd name="connsiteY1" fmla="*/ 536855 h 892611"/>
              <a:gd name="connsiteX2" fmla="*/ 1984375 w 3444875"/>
              <a:gd name="connsiteY2" fmla="*/ 280 h 892611"/>
              <a:gd name="connsiteX3" fmla="*/ 1171575 w 3444875"/>
              <a:gd name="connsiteY3" fmla="*/ 701955 h 892611"/>
              <a:gd name="connsiteX4" fmla="*/ 635000 w 3444875"/>
              <a:gd name="connsiteY4" fmla="*/ 571780 h 892611"/>
              <a:gd name="connsiteX5" fmla="*/ 238125 w 3444875"/>
              <a:gd name="connsiteY5" fmla="*/ 892455 h 892611"/>
              <a:gd name="connsiteX6" fmla="*/ 0 w 3444875"/>
              <a:gd name="connsiteY6" fmla="*/ 524155 h 892611"/>
              <a:gd name="connsiteX0" fmla="*/ 3444875 w 3444875"/>
              <a:gd name="connsiteY0" fmla="*/ 536854 h 892569"/>
              <a:gd name="connsiteX1" fmla="*/ 2816225 w 3444875"/>
              <a:gd name="connsiteY1" fmla="*/ 536854 h 892569"/>
              <a:gd name="connsiteX2" fmla="*/ 1984375 w 3444875"/>
              <a:gd name="connsiteY2" fmla="*/ 279 h 892569"/>
              <a:gd name="connsiteX3" fmla="*/ 1171575 w 3444875"/>
              <a:gd name="connsiteY3" fmla="*/ 701954 h 892569"/>
              <a:gd name="connsiteX4" fmla="*/ 635000 w 3444875"/>
              <a:gd name="connsiteY4" fmla="*/ 565429 h 892569"/>
              <a:gd name="connsiteX5" fmla="*/ 238125 w 3444875"/>
              <a:gd name="connsiteY5" fmla="*/ 892454 h 892569"/>
              <a:gd name="connsiteX6" fmla="*/ 0 w 3444875"/>
              <a:gd name="connsiteY6" fmla="*/ 524154 h 892569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89395"/>
              <a:gd name="connsiteX1" fmla="*/ 2816225 w 3444875"/>
              <a:gd name="connsiteY1" fmla="*/ 533680 h 889395"/>
              <a:gd name="connsiteX2" fmla="*/ 1984375 w 3444875"/>
              <a:gd name="connsiteY2" fmla="*/ 280 h 889395"/>
              <a:gd name="connsiteX3" fmla="*/ 1171575 w 3444875"/>
              <a:gd name="connsiteY3" fmla="*/ 698780 h 889395"/>
              <a:gd name="connsiteX4" fmla="*/ 635000 w 3444875"/>
              <a:gd name="connsiteY4" fmla="*/ 562255 h 889395"/>
              <a:gd name="connsiteX5" fmla="*/ 238125 w 3444875"/>
              <a:gd name="connsiteY5" fmla="*/ 889280 h 889395"/>
              <a:gd name="connsiteX6" fmla="*/ 0 w 3444875"/>
              <a:gd name="connsiteY6" fmla="*/ 520980 h 889395"/>
              <a:gd name="connsiteX0" fmla="*/ 3444875 w 3444875"/>
              <a:gd name="connsiteY0" fmla="*/ 533680 h 873525"/>
              <a:gd name="connsiteX1" fmla="*/ 2816225 w 3444875"/>
              <a:gd name="connsiteY1" fmla="*/ 533680 h 873525"/>
              <a:gd name="connsiteX2" fmla="*/ 1984375 w 3444875"/>
              <a:gd name="connsiteY2" fmla="*/ 280 h 873525"/>
              <a:gd name="connsiteX3" fmla="*/ 1171575 w 3444875"/>
              <a:gd name="connsiteY3" fmla="*/ 698780 h 873525"/>
              <a:gd name="connsiteX4" fmla="*/ 635000 w 3444875"/>
              <a:gd name="connsiteY4" fmla="*/ 562255 h 873525"/>
              <a:gd name="connsiteX5" fmla="*/ 238125 w 3444875"/>
              <a:gd name="connsiteY5" fmla="*/ 873405 h 873525"/>
              <a:gd name="connsiteX6" fmla="*/ 0 w 3444875"/>
              <a:gd name="connsiteY6" fmla="*/ 520980 h 873525"/>
              <a:gd name="connsiteX0" fmla="*/ 3444875 w 3444875"/>
              <a:gd name="connsiteY0" fmla="*/ 533679 h 873448"/>
              <a:gd name="connsiteX1" fmla="*/ 2816225 w 3444875"/>
              <a:gd name="connsiteY1" fmla="*/ 533679 h 873448"/>
              <a:gd name="connsiteX2" fmla="*/ 1984375 w 3444875"/>
              <a:gd name="connsiteY2" fmla="*/ 279 h 873448"/>
              <a:gd name="connsiteX3" fmla="*/ 1171575 w 3444875"/>
              <a:gd name="connsiteY3" fmla="*/ 698779 h 873448"/>
              <a:gd name="connsiteX4" fmla="*/ 635000 w 3444875"/>
              <a:gd name="connsiteY4" fmla="*/ 546379 h 873448"/>
              <a:gd name="connsiteX5" fmla="*/ 238125 w 3444875"/>
              <a:gd name="connsiteY5" fmla="*/ 873404 h 873448"/>
              <a:gd name="connsiteX6" fmla="*/ 0 w 3444875"/>
              <a:gd name="connsiteY6" fmla="*/ 520979 h 873448"/>
              <a:gd name="connsiteX0" fmla="*/ 3444875 w 3444875"/>
              <a:gd name="connsiteY0" fmla="*/ 520984 h 860753"/>
              <a:gd name="connsiteX1" fmla="*/ 2816225 w 3444875"/>
              <a:gd name="connsiteY1" fmla="*/ 520984 h 860753"/>
              <a:gd name="connsiteX2" fmla="*/ 1984375 w 3444875"/>
              <a:gd name="connsiteY2" fmla="*/ 284 h 860753"/>
              <a:gd name="connsiteX3" fmla="*/ 1171575 w 3444875"/>
              <a:gd name="connsiteY3" fmla="*/ 686084 h 860753"/>
              <a:gd name="connsiteX4" fmla="*/ 635000 w 3444875"/>
              <a:gd name="connsiteY4" fmla="*/ 533684 h 860753"/>
              <a:gd name="connsiteX5" fmla="*/ 238125 w 3444875"/>
              <a:gd name="connsiteY5" fmla="*/ 860709 h 860753"/>
              <a:gd name="connsiteX6" fmla="*/ 0 w 3444875"/>
              <a:gd name="connsiteY6" fmla="*/ 508284 h 860753"/>
              <a:gd name="connsiteX0" fmla="*/ 3444875 w 3444875"/>
              <a:gd name="connsiteY0" fmla="*/ 520984 h 860753"/>
              <a:gd name="connsiteX1" fmla="*/ 2816225 w 3444875"/>
              <a:gd name="connsiteY1" fmla="*/ 520984 h 860753"/>
              <a:gd name="connsiteX2" fmla="*/ 1984375 w 3444875"/>
              <a:gd name="connsiteY2" fmla="*/ 284 h 860753"/>
              <a:gd name="connsiteX3" fmla="*/ 1171575 w 3444875"/>
              <a:gd name="connsiteY3" fmla="*/ 686084 h 860753"/>
              <a:gd name="connsiteX4" fmla="*/ 635000 w 3444875"/>
              <a:gd name="connsiteY4" fmla="*/ 533684 h 860753"/>
              <a:gd name="connsiteX5" fmla="*/ 238125 w 3444875"/>
              <a:gd name="connsiteY5" fmla="*/ 860709 h 860753"/>
              <a:gd name="connsiteX6" fmla="*/ 0 w 3444875"/>
              <a:gd name="connsiteY6" fmla="*/ 508284 h 860753"/>
              <a:gd name="connsiteX0" fmla="*/ 3444875 w 3444875"/>
              <a:gd name="connsiteY0" fmla="*/ 520984 h 851229"/>
              <a:gd name="connsiteX1" fmla="*/ 2816225 w 3444875"/>
              <a:gd name="connsiteY1" fmla="*/ 520984 h 851229"/>
              <a:gd name="connsiteX2" fmla="*/ 1984375 w 3444875"/>
              <a:gd name="connsiteY2" fmla="*/ 284 h 851229"/>
              <a:gd name="connsiteX3" fmla="*/ 1171575 w 3444875"/>
              <a:gd name="connsiteY3" fmla="*/ 686084 h 851229"/>
              <a:gd name="connsiteX4" fmla="*/ 635000 w 3444875"/>
              <a:gd name="connsiteY4" fmla="*/ 533684 h 851229"/>
              <a:gd name="connsiteX5" fmla="*/ 238125 w 3444875"/>
              <a:gd name="connsiteY5" fmla="*/ 851184 h 851229"/>
              <a:gd name="connsiteX6" fmla="*/ 0 w 3444875"/>
              <a:gd name="connsiteY6" fmla="*/ 508284 h 851229"/>
              <a:gd name="connsiteX0" fmla="*/ 3444875 w 3444875"/>
              <a:gd name="connsiteY0" fmla="*/ 520983 h 851200"/>
              <a:gd name="connsiteX1" fmla="*/ 2816225 w 3444875"/>
              <a:gd name="connsiteY1" fmla="*/ 520983 h 851200"/>
              <a:gd name="connsiteX2" fmla="*/ 1984375 w 3444875"/>
              <a:gd name="connsiteY2" fmla="*/ 283 h 851200"/>
              <a:gd name="connsiteX3" fmla="*/ 1171575 w 3444875"/>
              <a:gd name="connsiteY3" fmla="*/ 686083 h 851200"/>
              <a:gd name="connsiteX4" fmla="*/ 635000 w 3444875"/>
              <a:gd name="connsiteY4" fmla="*/ 524158 h 851200"/>
              <a:gd name="connsiteX5" fmla="*/ 238125 w 3444875"/>
              <a:gd name="connsiteY5" fmla="*/ 851183 h 851200"/>
              <a:gd name="connsiteX6" fmla="*/ 0 w 3444875"/>
              <a:gd name="connsiteY6" fmla="*/ 508283 h 851200"/>
              <a:gd name="connsiteX0" fmla="*/ 3444875 w 3444875"/>
              <a:gd name="connsiteY0" fmla="*/ 508288 h 838505"/>
              <a:gd name="connsiteX1" fmla="*/ 2816225 w 3444875"/>
              <a:gd name="connsiteY1" fmla="*/ 508288 h 838505"/>
              <a:gd name="connsiteX2" fmla="*/ 1981200 w 3444875"/>
              <a:gd name="connsiteY2" fmla="*/ 288 h 838505"/>
              <a:gd name="connsiteX3" fmla="*/ 1171575 w 3444875"/>
              <a:gd name="connsiteY3" fmla="*/ 673388 h 838505"/>
              <a:gd name="connsiteX4" fmla="*/ 635000 w 3444875"/>
              <a:gd name="connsiteY4" fmla="*/ 511463 h 838505"/>
              <a:gd name="connsiteX5" fmla="*/ 238125 w 3444875"/>
              <a:gd name="connsiteY5" fmla="*/ 838488 h 838505"/>
              <a:gd name="connsiteX6" fmla="*/ 0 w 3444875"/>
              <a:gd name="connsiteY6" fmla="*/ 495588 h 838505"/>
              <a:gd name="connsiteX0" fmla="*/ 3444875 w 3444875"/>
              <a:gd name="connsiteY0" fmla="*/ 508288 h 838505"/>
              <a:gd name="connsiteX1" fmla="*/ 2816225 w 3444875"/>
              <a:gd name="connsiteY1" fmla="*/ 508288 h 838505"/>
              <a:gd name="connsiteX2" fmla="*/ 1981200 w 3444875"/>
              <a:gd name="connsiteY2" fmla="*/ 288 h 838505"/>
              <a:gd name="connsiteX3" fmla="*/ 1171575 w 3444875"/>
              <a:gd name="connsiteY3" fmla="*/ 673388 h 838505"/>
              <a:gd name="connsiteX4" fmla="*/ 635000 w 3444875"/>
              <a:gd name="connsiteY4" fmla="*/ 511463 h 838505"/>
              <a:gd name="connsiteX5" fmla="*/ 238125 w 3444875"/>
              <a:gd name="connsiteY5" fmla="*/ 838488 h 838505"/>
              <a:gd name="connsiteX6" fmla="*/ 0 w 3444875"/>
              <a:gd name="connsiteY6" fmla="*/ 495588 h 838505"/>
              <a:gd name="connsiteX0" fmla="*/ 3444875 w 3444875"/>
              <a:gd name="connsiteY0" fmla="*/ 508288 h 828980"/>
              <a:gd name="connsiteX1" fmla="*/ 2816225 w 3444875"/>
              <a:gd name="connsiteY1" fmla="*/ 508288 h 828980"/>
              <a:gd name="connsiteX2" fmla="*/ 1981200 w 3444875"/>
              <a:gd name="connsiteY2" fmla="*/ 288 h 828980"/>
              <a:gd name="connsiteX3" fmla="*/ 1171575 w 3444875"/>
              <a:gd name="connsiteY3" fmla="*/ 673388 h 828980"/>
              <a:gd name="connsiteX4" fmla="*/ 635000 w 3444875"/>
              <a:gd name="connsiteY4" fmla="*/ 511463 h 828980"/>
              <a:gd name="connsiteX5" fmla="*/ 238125 w 3444875"/>
              <a:gd name="connsiteY5" fmla="*/ 828963 h 828980"/>
              <a:gd name="connsiteX6" fmla="*/ 0 w 3444875"/>
              <a:gd name="connsiteY6" fmla="*/ 495588 h 828980"/>
              <a:gd name="connsiteX0" fmla="*/ 3444875 w 3444875"/>
              <a:gd name="connsiteY0" fmla="*/ 508288 h 828969"/>
              <a:gd name="connsiteX1" fmla="*/ 2816225 w 3444875"/>
              <a:gd name="connsiteY1" fmla="*/ 508288 h 828969"/>
              <a:gd name="connsiteX2" fmla="*/ 1981200 w 3444875"/>
              <a:gd name="connsiteY2" fmla="*/ 288 h 828969"/>
              <a:gd name="connsiteX3" fmla="*/ 1171575 w 3444875"/>
              <a:gd name="connsiteY3" fmla="*/ 673388 h 828969"/>
              <a:gd name="connsiteX4" fmla="*/ 628650 w 3444875"/>
              <a:gd name="connsiteY4" fmla="*/ 505113 h 828969"/>
              <a:gd name="connsiteX5" fmla="*/ 238125 w 3444875"/>
              <a:gd name="connsiteY5" fmla="*/ 828963 h 828969"/>
              <a:gd name="connsiteX6" fmla="*/ 0 w 3444875"/>
              <a:gd name="connsiteY6" fmla="*/ 495588 h 828969"/>
              <a:gd name="connsiteX0" fmla="*/ 3444875 w 3444875"/>
              <a:gd name="connsiteY0" fmla="*/ 498766 h 819447"/>
              <a:gd name="connsiteX1" fmla="*/ 2816225 w 3444875"/>
              <a:gd name="connsiteY1" fmla="*/ 498766 h 819447"/>
              <a:gd name="connsiteX2" fmla="*/ 1981200 w 3444875"/>
              <a:gd name="connsiteY2" fmla="*/ 291 h 819447"/>
              <a:gd name="connsiteX3" fmla="*/ 1171575 w 3444875"/>
              <a:gd name="connsiteY3" fmla="*/ 663866 h 819447"/>
              <a:gd name="connsiteX4" fmla="*/ 628650 w 3444875"/>
              <a:gd name="connsiteY4" fmla="*/ 495591 h 819447"/>
              <a:gd name="connsiteX5" fmla="*/ 238125 w 3444875"/>
              <a:gd name="connsiteY5" fmla="*/ 819441 h 819447"/>
              <a:gd name="connsiteX6" fmla="*/ 0 w 3444875"/>
              <a:gd name="connsiteY6" fmla="*/ 486066 h 819447"/>
              <a:gd name="connsiteX0" fmla="*/ 3444875 w 3444875"/>
              <a:gd name="connsiteY0" fmla="*/ 498766 h 819447"/>
              <a:gd name="connsiteX1" fmla="*/ 2816225 w 3444875"/>
              <a:gd name="connsiteY1" fmla="*/ 498766 h 819447"/>
              <a:gd name="connsiteX2" fmla="*/ 1981200 w 3444875"/>
              <a:gd name="connsiteY2" fmla="*/ 291 h 819447"/>
              <a:gd name="connsiteX3" fmla="*/ 1171575 w 3444875"/>
              <a:gd name="connsiteY3" fmla="*/ 663866 h 819447"/>
              <a:gd name="connsiteX4" fmla="*/ 628650 w 3444875"/>
              <a:gd name="connsiteY4" fmla="*/ 495591 h 819447"/>
              <a:gd name="connsiteX5" fmla="*/ 238125 w 3444875"/>
              <a:gd name="connsiteY5" fmla="*/ 819441 h 819447"/>
              <a:gd name="connsiteX6" fmla="*/ 0 w 3444875"/>
              <a:gd name="connsiteY6" fmla="*/ 486066 h 819447"/>
              <a:gd name="connsiteX0" fmla="*/ 3448050 w 3448050"/>
              <a:gd name="connsiteY0" fmla="*/ 498766 h 819893"/>
              <a:gd name="connsiteX1" fmla="*/ 2819400 w 3448050"/>
              <a:gd name="connsiteY1" fmla="*/ 498766 h 819893"/>
              <a:gd name="connsiteX2" fmla="*/ 1984375 w 3448050"/>
              <a:gd name="connsiteY2" fmla="*/ 291 h 819893"/>
              <a:gd name="connsiteX3" fmla="*/ 1174750 w 3448050"/>
              <a:gd name="connsiteY3" fmla="*/ 663866 h 819893"/>
              <a:gd name="connsiteX4" fmla="*/ 631825 w 3448050"/>
              <a:gd name="connsiteY4" fmla="*/ 495591 h 819893"/>
              <a:gd name="connsiteX5" fmla="*/ 241300 w 3448050"/>
              <a:gd name="connsiteY5" fmla="*/ 819441 h 819893"/>
              <a:gd name="connsiteX6" fmla="*/ 0 w 3448050"/>
              <a:gd name="connsiteY6" fmla="*/ 546391 h 8198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48050" h="819893">
                <a:moveTo>
                  <a:pt x="3448050" y="498766"/>
                </a:moveTo>
                <a:cubicBezTo>
                  <a:pt x="3247496" y="501147"/>
                  <a:pt x="3053821" y="502470"/>
                  <a:pt x="2819400" y="498766"/>
                </a:cubicBezTo>
                <a:cubicBezTo>
                  <a:pt x="2584979" y="495062"/>
                  <a:pt x="2255308" y="75962"/>
                  <a:pt x="1984375" y="291"/>
                </a:cubicBezTo>
                <a:cubicBezTo>
                  <a:pt x="1707092" y="-15055"/>
                  <a:pt x="1400175" y="581316"/>
                  <a:pt x="1174750" y="663866"/>
                </a:cubicBezTo>
                <a:cubicBezTo>
                  <a:pt x="949325" y="746416"/>
                  <a:pt x="787400" y="469662"/>
                  <a:pt x="631825" y="495591"/>
                </a:cubicBezTo>
                <a:cubicBezTo>
                  <a:pt x="476250" y="521520"/>
                  <a:pt x="346604" y="810974"/>
                  <a:pt x="241300" y="819441"/>
                </a:cubicBezTo>
                <a:cubicBezTo>
                  <a:pt x="135996" y="827908"/>
                  <a:pt x="69585" y="716782"/>
                  <a:pt x="0" y="546391"/>
                </a:cubicBezTo>
              </a:path>
            </a:pathLst>
          </a:custGeom>
          <a:noFill/>
          <a:ln w="12700"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フリーフォーム 11"/>
          <p:cNvSpPr/>
          <p:nvPr/>
        </p:nvSpPr>
        <p:spPr>
          <a:xfrm>
            <a:off x="5222875" y="4733633"/>
            <a:ext cx="3441700" cy="795635"/>
          </a:xfrm>
          <a:custGeom>
            <a:avLst/>
            <a:gdLst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20002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19621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5635"/>
              <a:gd name="connsiteX1" fmla="*/ 2813050 w 3441700"/>
              <a:gd name="connsiteY1" fmla="*/ 486067 h 795635"/>
              <a:gd name="connsiteX2" fmla="*/ 1962150 w 3441700"/>
              <a:gd name="connsiteY2" fmla="*/ 292 h 795635"/>
              <a:gd name="connsiteX3" fmla="*/ 1168400 w 3441700"/>
              <a:gd name="connsiteY3" fmla="*/ 660692 h 795635"/>
              <a:gd name="connsiteX4" fmla="*/ 612775 w 3441700"/>
              <a:gd name="connsiteY4" fmla="*/ 479717 h 795635"/>
              <a:gd name="connsiteX5" fmla="*/ 241300 w 3441700"/>
              <a:gd name="connsiteY5" fmla="*/ 794042 h 795635"/>
              <a:gd name="connsiteX6" fmla="*/ 0 w 3441700"/>
              <a:gd name="connsiteY6" fmla="*/ 562267 h 79563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41700" h="795635">
                <a:moveTo>
                  <a:pt x="3441700" y="486067"/>
                </a:moveTo>
                <a:cubicBezTo>
                  <a:pt x="3241146" y="488448"/>
                  <a:pt x="3069167" y="484479"/>
                  <a:pt x="2813050" y="486067"/>
                </a:cubicBezTo>
                <a:cubicBezTo>
                  <a:pt x="2556933" y="487655"/>
                  <a:pt x="2233083" y="75963"/>
                  <a:pt x="1962150" y="292"/>
                </a:cubicBezTo>
                <a:cubicBezTo>
                  <a:pt x="1684867" y="-15054"/>
                  <a:pt x="1393296" y="580788"/>
                  <a:pt x="1168400" y="660692"/>
                </a:cubicBezTo>
                <a:cubicBezTo>
                  <a:pt x="943504" y="740596"/>
                  <a:pt x="767292" y="457492"/>
                  <a:pt x="612775" y="479717"/>
                </a:cubicBezTo>
                <a:cubicBezTo>
                  <a:pt x="458258" y="501942"/>
                  <a:pt x="343429" y="780284"/>
                  <a:pt x="241300" y="794042"/>
                </a:cubicBezTo>
                <a:cubicBezTo>
                  <a:pt x="139171" y="807800"/>
                  <a:pt x="69585" y="732658"/>
                  <a:pt x="0" y="562267"/>
                </a:cubicBezTo>
              </a:path>
            </a:pathLst>
          </a:cu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50" name="フリーフォーム 649"/>
          <p:cNvSpPr/>
          <p:nvPr/>
        </p:nvSpPr>
        <p:spPr>
          <a:xfrm>
            <a:off x="5215706" y="4675361"/>
            <a:ext cx="3444875" cy="924444"/>
          </a:xfrm>
          <a:custGeom>
            <a:avLst/>
            <a:gdLst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20002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7173 h 795217"/>
              <a:gd name="connsiteX1" fmla="*/ 2813050 w 3441700"/>
              <a:gd name="connsiteY1" fmla="*/ 487173 h 795217"/>
              <a:gd name="connsiteX2" fmla="*/ 1962150 w 3441700"/>
              <a:gd name="connsiteY2" fmla="*/ 1398 h 795217"/>
              <a:gd name="connsiteX3" fmla="*/ 1168400 w 3441700"/>
              <a:gd name="connsiteY3" fmla="*/ 661798 h 795217"/>
              <a:gd name="connsiteX4" fmla="*/ 612775 w 3441700"/>
              <a:gd name="connsiteY4" fmla="*/ 480823 h 795217"/>
              <a:gd name="connsiteX5" fmla="*/ 241300 w 3441700"/>
              <a:gd name="connsiteY5" fmla="*/ 795148 h 795217"/>
              <a:gd name="connsiteX6" fmla="*/ 0 w 3441700"/>
              <a:gd name="connsiteY6" fmla="*/ 449073 h 795217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4111"/>
              <a:gd name="connsiteX1" fmla="*/ 2813050 w 3441700"/>
              <a:gd name="connsiteY1" fmla="*/ 486067 h 794111"/>
              <a:gd name="connsiteX2" fmla="*/ 1962150 w 3441700"/>
              <a:gd name="connsiteY2" fmla="*/ 292 h 794111"/>
              <a:gd name="connsiteX3" fmla="*/ 1168400 w 3441700"/>
              <a:gd name="connsiteY3" fmla="*/ 660692 h 794111"/>
              <a:gd name="connsiteX4" fmla="*/ 612775 w 3441700"/>
              <a:gd name="connsiteY4" fmla="*/ 479717 h 794111"/>
              <a:gd name="connsiteX5" fmla="*/ 241300 w 3441700"/>
              <a:gd name="connsiteY5" fmla="*/ 794042 h 794111"/>
              <a:gd name="connsiteX6" fmla="*/ 0 w 3441700"/>
              <a:gd name="connsiteY6" fmla="*/ 447967 h 794111"/>
              <a:gd name="connsiteX0" fmla="*/ 3441700 w 3441700"/>
              <a:gd name="connsiteY0" fmla="*/ 486067 h 795635"/>
              <a:gd name="connsiteX1" fmla="*/ 2813050 w 3441700"/>
              <a:gd name="connsiteY1" fmla="*/ 486067 h 795635"/>
              <a:gd name="connsiteX2" fmla="*/ 1962150 w 3441700"/>
              <a:gd name="connsiteY2" fmla="*/ 292 h 795635"/>
              <a:gd name="connsiteX3" fmla="*/ 1168400 w 3441700"/>
              <a:gd name="connsiteY3" fmla="*/ 660692 h 795635"/>
              <a:gd name="connsiteX4" fmla="*/ 612775 w 3441700"/>
              <a:gd name="connsiteY4" fmla="*/ 479717 h 795635"/>
              <a:gd name="connsiteX5" fmla="*/ 241300 w 3441700"/>
              <a:gd name="connsiteY5" fmla="*/ 794042 h 795635"/>
              <a:gd name="connsiteX6" fmla="*/ 0 w 3441700"/>
              <a:gd name="connsiteY6" fmla="*/ 562267 h 795635"/>
              <a:gd name="connsiteX0" fmla="*/ 3441700 w 3441700"/>
              <a:gd name="connsiteY0" fmla="*/ 486067 h 864797"/>
              <a:gd name="connsiteX1" fmla="*/ 2813050 w 3441700"/>
              <a:gd name="connsiteY1" fmla="*/ 486067 h 864797"/>
              <a:gd name="connsiteX2" fmla="*/ 1962150 w 3441700"/>
              <a:gd name="connsiteY2" fmla="*/ 292 h 864797"/>
              <a:gd name="connsiteX3" fmla="*/ 1168400 w 3441700"/>
              <a:gd name="connsiteY3" fmla="*/ 660692 h 864797"/>
              <a:gd name="connsiteX4" fmla="*/ 612775 w 3441700"/>
              <a:gd name="connsiteY4" fmla="*/ 479717 h 864797"/>
              <a:gd name="connsiteX5" fmla="*/ 234950 w 3441700"/>
              <a:gd name="connsiteY5" fmla="*/ 863892 h 864797"/>
              <a:gd name="connsiteX6" fmla="*/ 0 w 3441700"/>
              <a:gd name="connsiteY6" fmla="*/ 562267 h 864797"/>
              <a:gd name="connsiteX0" fmla="*/ 3444875 w 3444875"/>
              <a:gd name="connsiteY0" fmla="*/ 486067 h 863894"/>
              <a:gd name="connsiteX1" fmla="*/ 2816225 w 3444875"/>
              <a:gd name="connsiteY1" fmla="*/ 486067 h 863894"/>
              <a:gd name="connsiteX2" fmla="*/ 1965325 w 3444875"/>
              <a:gd name="connsiteY2" fmla="*/ 292 h 863894"/>
              <a:gd name="connsiteX3" fmla="*/ 1171575 w 3444875"/>
              <a:gd name="connsiteY3" fmla="*/ 660692 h 863894"/>
              <a:gd name="connsiteX4" fmla="*/ 615950 w 3444875"/>
              <a:gd name="connsiteY4" fmla="*/ 479717 h 863894"/>
              <a:gd name="connsiteX5" fmla="*/ 238125 w 3444875"/>
              <a:gd name="connsiteY5" fmla="*/ 863892 h 863894"/>
              <a:gd name="connsiteX6" fmla="*/ 0 w 3444875"/>
              <a:gd name="connsiteY6" fmla="*/ 473367 h 863894"/>
              <a:gd name="connsiteX0" fmla="*/ 3444875 w 3444875"/>
              <a:gd name="connsiteY0" fmla="*/ 486070 h 864136"/>
              <a:gd name="connsiteX1" fmla="*/ 2816225 w 3444875"/>
              <a:gd name="connsiteY1" fmla="*/ 486070 h 864136"/>
              <a:gd name="connsiteX2" fmla="*/ 1965325 w 3444875"/>
              <a:gd name="connsiteY2" fmla="*/ 295 h 864136"/>
              <a:gd name="connsiteX3" fmla="*/ 1171575 w 3444875"/>
              <a:gd name="connsiteY3" fmla="*/ 660695 h 864136"/>
              <a:gd name="connsiteX4" fmla="*/ 631825 w 3444875"/>
              <a:gd name="connsiteY4" fmla="*/ 533695 h 864136"/>
              <a:gd name="connsiteX5" fmla="*/ 238125 w 3444875"/>
              <a:gd name="connsiteY5" fmla="*/ 863895 h 864136"/>
              <a:gd name="connsiteX6" fmla="*/ 0 w 3444875"/>
              <a:gd name="connsiteY6" fmla="*/ 473370 h 864136"/>
              <a:gd name="connsiteX0" fmla="*/ 3444875 w 3444875"/>
              <a:gd name="connsiteY0" fmla="*/ 486075 h 864143"/>
              <a:gd name="connsiteX1" fmla="*/ 2816225 w 3444875"/>
              <a:gd name="connsiteY1" fmla="*/ 486075 h 864143"/>
              <a:gd name="connsiteX2" fmla="*/ 1965325 w 3444875"/>
              <a:gd name="connsiteY2" fmla="*/ 300 h 864143"/>
              <a:gd name="connsiteX3" fmla="*/ 1171575 w 3444875"/>
              <a:gd name="connsiteY3" fmla="*/ 651175 h 864143"/>
              <a:gd name="connsiteX4" fmla="*/ 631825 w 3444875"/>
              <a:gd name="connsiteY4" fmla="*/ 533700 h 864143"/>
              <a:gd name="connsiteX5" fmla="*/ 238125 w 3444875"/>
              <a:gd name="connsiteY5" fmla="*/ 863900 h 864143"/>
              <a:gd name="connsiteX6" fmla="*/ 0 w 3444875"/>
              <a:gd name="connsiteY6" fmla="*/ 473375 h 864143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6532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  <a:gd name="connsiteX0" fmla="*/ 3444875 w 3444875"/>
              <a:gd name="connsiteY0" fmla="*/ 546376 h 924444"/>
              <a:gd name="connsiteX1" fmla="*/ 2816225 w 3444875"/>
              <a:gd name="connsiteY1" fmla="*/ 546376 h 924444"/>
              <a:gd name="connsiteX2" fmla="*/ 1984375 w 3444875"/>
              <a:gd name="connsiteY2" fmla="*/ 276 h 924444"/>
              <a:gd name="connsiteX3" fmla="*/ 1171575 w 3444875"/>
              <a:gd name="connsiteY3" fmla="*/ 711476 h 924444"/>
              <a:gd name="connsiteX4" fmla="*/ 631825 w 3444875"/>
              <a:gd name="connsiteY4" fmla="*/ 594001 h 924444"/>
              <a:gd name="connsiteX5" fmla="*/ 238125 w 3444875"/>
              <a:gd name="connsiteY5" fmla="*/ 924201 h 924444"/>
              <a:gd name="connsiteX6" fmla="*/ 0 w 3444875"/>
              <a:gd name="connsiteY6" fmla="*/ 533676 h 9244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</a:cxnLst>
            <a:rect l="l" t="t" r="r" b="b"/>
            <a:pathLst>
              <a:path w="3444875" h="924444">
                <a:moveTo>
                  <a:pt x="3444875" y="546376"/>
                </a:moveTo>
                <a:cubicBezTo>
                  <a:pt x="3244321" y="548757"/>
                  <a:pt x="3059642" y="545318"/>
                  <a:pt x="2816225" y="546376"/>
                </a:cubicBezTo>
                <a:cubicBezTo>
                  <a:pt x="2572808" y="547434"/>
                  <a:pt x="2255308" y="75947"/>
                  <a:pt x="1984375" y="276"/>
                </a:cubicBezTo>
                <a:cubicBezTo>
                  <a:pt x="1707092" y="-15070"/>
                  <a:pt x="1397000" y="612522"/>
                  <a:pt x="1171575" y="711476"/>
                </a:cubicBezTo>
                <a:cubicBezTo>
                  <a:pt x="946150" y="810430"/>
                  <a:pt x="787400" y="558547"/>
                  <a:pt x="631825" y="594001"/>
                </a:cubicBezTo>
                <a:cubicBezTo>
                  <a:pt x="476250" y="629455"/>
                  <a:pt x="343429" y="934255"/>
                  <a:pt x="238125" y="924201"/>
                </a:cubicBezTo>
                <a:cubicBezTo>
                  <a:pt x="132821" y="914147"/>
                  <a:pt x="69585" y="704067"/>
                  <a:pt x="0" y="533676"/>
                </a:cubicBezTo>
              </a:path>
            </a:pathLst>
          </a:cu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1" name="正方形/長方形 630"/>
          <p:cNvSpPr/>
          <p:nvPr/>
        </p:nvSpPr>
        <p:spPr>
          <a:xfrm>
            <a:off x="5206878" y="4120652"/>
            <a:ext cx="3456384" cy="21514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71</TotalTime>
  <Words>339</Words>
  <Application>Microsoft Office PowerPoint</Application>
  <PresentationFormat>画面に合わせる (4:3)</PresentationFormat>
  <Paragraphs>16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Symbol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kamoto</dc:creator>
  <cp:lastModifiedBy>kashiwagi</cp:lastModifiedBy>
  <cp:revision>149</cp:revision>
  <cp:lastPrinted>2016-06-23T00:03:39Z</cp:lastPrinted>
  <dcterms:created xsi:type="dcterms:W3CDTF">2012-04-07T04:22:22Z</dcterms:created>
  <dcterms:modified xsi:type="dcterms:W3CDTF">2016-07-09T00:17:36Z</dcterms:modified>
</cp:coreProperties>
</file>